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9"/>
  </p:notesMasterIdLst>
  <p:sldIdLst>
    <p:sldId id="262" r:id="rId2"/>
    <p:sldId id="265" r:id="rId3"/>
    <p:sldId id="266" r:id="rId4"/>
    <p:sldId id="267" r:id="rId5"/>
    <p:sldId id="263" r:id="rId6"/>
    <p:sldId id="264" r:id="rId7"/>
    <p:sldId id="268" r:id="rId8"/>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browse/>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2693"/>
    <p:restoredTop sz="92128"/>
  </p:normalViewPr>
  <p:slideViewPr>
    <p:cSldViewPr snapToGrid="0">
      <p:cViewPr varScale="1">
        <p:scale>
          <a:sx n="126" d="100"/>
          <a:sy n="126" d="100"/>
        </p:scale>
        <p:origin x="984" y="20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A45903C-8B8C-C244-8D71-D7234DE389D6}" type="datetimeFigureOut">
              <a:rPr lang="fr-FR" smtClean="0"/>
              <a:t>12/10/2023</a:t>
            </a:fld>
            <a:endParaRPr lang="fr-FR"/>
          </a:p>
        </p:txBody>
      </p:sp>
      <p:sp>
        <p:nvSpPr>
          <p:cNvPr id="4" name="Espace réservé de l'image des diapositives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not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04A034B-D414-FF47-BFDB-D7ACC97BE082}" type="slidenum">
              <a:rPr lang="fr-FR" smtClean="0"/>
              <a:t>‹N°›</a:t>
            </a:fld>
            <a:endParaRPr lang="fr-FR"/>
          </a:p>
        </p:txBody>
      </p:sp>
    </p:spTree>
    <p:extLst>
      <p:ext uri="{BB962C8B-B14F-4D97-AF65-F5344CB8AC3E}">
        <p14:creationId xmlns:p14="http://schemas.microsoft.com/office/powerpoint/2010/main" val="22477351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5"/>
          </p:nvPr>
        </p:nvSpPr>
        <p:spPr/>
        <p:txBody>
          <a:bodyPr/>
          <a:lstStyle/>
          <a:p>
            <a:fld id="{704A034B-D414-FF47-BFDB-D7ACC97BE082}" type="slidenum">
              <a:rPr lang="fr-FR" smtClean="0"/>
              <a:t>1</a:t>
            </a:fld>
            <a:endParaRPr lang="fr-FR"/>
          </a:p>
        </p:txBody>
      </p:sp>
    </p:spTree>
    <p:extLst>
      <p:ext uri="{BB962C8B-B14F-4D97-AF65-F5344CB8AC3E}">
        <p14:creationId xmlns:p14="http://schemas.microsoft.com/office/powerpoint/2010/main" val="151441790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5"/>
          </p:nvPr>
        </p:nvSpPr>
        <p:spPr/>
        <p:txBody>
          <a:bodyPr/>
          <a:lstStyle/>
          <a:p>
            <a:fld id="{704A034B-D414-FF47-BFDB-D7ACC97BE082}" type="slidenum">
              <a:rPr lang="fr-FR" smtClean="0"/>
              <a:t>2</a:t>
            </a:fld>
            <a:endParaRPr lang="fr-FR"/>
          </a:p>
        </p:txBody>
      </p:sp>
    </p:spTree>
    <p:extLst>
      <p:ext uri="{BB962C8B-B14F-4D97-AF65-F5344CB8AC3E}">
        <p14:creationId xmlns:p14="http://schemas.microsoft.com/office/powerpoint/2010/main" val="153580420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5"/>
          </p:nvPr>
        </p:nvSpPr>
        <p:spPr/>
        <p:txBody>
          <a:bodyPr/>
          <a:lstStyle/>
          <a:p>
            <a:fld id="{704A034B-D414-FF47-BFDB-D7ACC97BE082}" type="slidenum">
              <a:rPr lang="fr-FR" smtClean="0"/>
              <a:t>3</a:t>
            </a:fld>
            <a:endParaRPr lang="fr-FR"/>
          </a:p>
        </p:txBody>
      </p:sp>
    </p:spTree>
    <p:extLst>
      <p:ext uri="{BB962C8B-B14F-4D97-AF65-F5344CB8AC3E}">
        <p14:creationId xmlns:p14="http://schemas.microsoft.com/office/powerpoint/2010/main" val="144104421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5"/>
          </p:nvPr>
        </p:nvSpPr>
        <p:spPr/>
        <p:txBody>
          <a:bodyPr/>
          <a:lstStyle/>
          <a:p>
            <a:fld id="{704A034B-D414-FF47-BFDB-D7ACC97BE082}" type="slidenum">
              <a:rPr lang="fr-FR" smtClean="0"/>
              <a:t>4</a:t>
            </a:fld>
            <a:endParaRPr lang="fr-FR"/>
          </a:p>
        </p:txBody>
      </p:sp>
    </p:spTree>
    <p:extLst>
      <p:ext uri="{BB962C8B-B14F-4D97-AF65-F5344CB8AC3E}">
        <p14:creationId xmlns:p14="http://schemas.microsoft.com/office/powerpoint/2010/main" val="39819506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5"/>
          </p:nvPr>
        </p:nvSpPr>
        <p:spPr/>
        <p:txBody>
          <a:bodyPr/>
          <a:lstStyle/>
          <a:p>
            <a:fld id="{704A034B-D414-FF47-BFDB-D7ACC97BE082}" type="slidenum">
              <a:rPr lang="fr-FR" smtClean="0"/>
              <a:t>5</a:t>
            </a:fld>
            <a:endParaRPr lang="fr-FR"/>
          </a:p>
        </p:txBody>
      </p:sp>
    </p:spTree>
    <p:extLst>
      <p:ext uri="{BB962C8B-B14F-4D97-AF65-F5344CB8AC3E}">
        <p14:creationId xmlns:p14="http://schemas.microsoft.com/office/powerpoint/2010/main" val="365097646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5"/>
          </p:nvPr>
        </p:nvSpPr>
        <p:spPr/>
        <p:txBody>
          <a:bodyPr/>
          <a:lstStyle/>
          <a:p>
            <a:fld id="{704A034B-D414-FF47-BFDB-D7ACC97BE082}" type="slidenum">
              <a:rPr lang="fr-FR" smtClean="0"/>
              <a:t>6</a:t>
            </a:fld>
            <a:endParaRPr lang="fr-FR"/>
          </a:p>
        </p:txBody>
      </p:sp>
    </p:spTree>
    <p:extLst>
      <p:ext uri="{BB962C8B-B14F-4D97-AF65-F5344CB8AC3E}">
        <p14:creationId xmlns:p14="http://schemas.microsoft.com/office/powerpoint/2010/main" val="382720133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5"/>
          </p:nvPr>
        </p:nvSpPr>
        <p:spPr/>
        <p:txBody>
          <a:bodyPr/>
          <a:lstStyle/>
          <a:p>
            <a:fld id="{704A034B-D414-FF47-BFDB-D7ACC97BE082}" type="slidenum">
              <a:rPr lang="fr-FR" smtClean="0"/>
              <a:t>7</a:t>
            </a:fld>
            <a:endParaRPr lang="fr-FR"/>
          </a:p>
        </p:txBody>
      </p:sp>
    </p:spTree>
    <p:extLst>
      <p:ext uri="{BB962C8B-B14F-4D97-AF65-F5344CB8AC3E}">
        <p14:creationId xmlns:p14="http://schemas.microsoft.com/office/powerpoint/2010/main" val="175103444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97C08C81-B15D-E8F3-63AD-B972C590130F}"/>
              </a:ext>
            </a:extLst>
          </p:cNvPr>
          <p:cNvSpPr>
            <a:spLocks noGrp="1"/>
          </p:cNvSpPr>
          <p:nvPr>
            <p:ph type="ctrTitle"/>
          </p:nvPr>
        </p:nvSpPr>
        <p:spPr>
          <a:xfrm>
            <a:off x="1524000" y="1122363"/>
            <a:ext cx="9144000" cy="2387600"/>
          </a:xfrm>
        </p:spPr>
        <p:txBody>
          <a:bodyPr anchor="b"/>
          <a:lstStyle>
            <a:lvl1pPr algn="ctr">
              <a:defRPr sz="6000"/>
            </a:lvl1pPr>
          </a:lstStyle>
          <a:p>
            <a:r>
              <a:rPr lang="fr-FR"/>
              <a:t>Modifiez le style du titre</a:t>
            </a:r>
          </a:p>
        </p:txBody>
      </p:sp>
      <p:sp>
        <p:nvSpPr>
          <p:cNvPr id="3" name="Sous-titre 2">
            <a:extLst>
              <a:ext uri="{FF2B5EF4-FFF2-40B4-BE49-F238E27FC236}">
                <a16:creationId xmlns:a16="http://schemas.microsoft.com/office/drawing/2014/main" id="{C06FD581-729A-B40D-0680-712F9649F7A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z le style des sous-titres du masque</a:t>
            </a:r>
          </a:p>
        </p:txBody>
      </p:sp>
      <p:sp>
        <p:nvSpPr>
          <p:cNvPr id="4" name="Espace réservé de la date 3">
            <a:extLst>
              <a:ext uri="{FF2B5EF4-FFF2-40B4-BE49-F238E27FC236}">
                <a16:creationId xmlns:a16="http://schemas.microsoft.com/office/drawing/2014/main" id="{A5C5B899-35F2-FA9B-610F-1E882D4ED2CC}"/>
              </a:ext>
            </a:extLst>
          </p:cNvPr>
          <p:cNvSpPr>
            <a:spLocks noGrp="1"/>
          </p:cNvSpPr>
          <p:nvPr>
            <p:ph type="dt" sz="half" idx="10"/>
          </p:nvPr>
        </p:nvSpPr>
        <p:spPr/>
        <p:txBody>
          <a:bodyPr/>
          <a:lstStyle/>
          <a:p>
            <a:fld id="{C860001E-C3EE-4E41-8104-9E8900339DA9}" type="datetimeFigureOut">
              <a:rPr lang="fr-FR" smtClean="0"/>
              <a:t>12/10/2023</a:t>
            </a:fld>
            <a:endParaRPr lang="fr-FR"/>
          </a:p>
        </p:txBody>
      </p:sp>
      <p:sp>
        <p:nvSpPr>
          <p:cNvPr id="5" name="Espace réservé du pied de page 4">
            <a:extLst>
              <a:ext uri="{FF2B5EF4-FFF2-40B4-BE49-F238E27FC236}">
                <a16:creationId xmlns:a16="http://schemas.microsoft.com/office/drawing/2014/main" id="{48719C23-01F8-1AC9-967F-94D642012420}"/>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EDFBEA87-7F5B-7C1D-382B-7F74287FA87E}"/>
              </a:ext>
            </a:extLst>
          </p:cNvPr>
          <p:cNvSpPr>
            <a:spLocks noGrp="1"/>
          </p:cNvSpPr>
          <p:nvPr>
            <p:ph type="sldNum" sz="quarter" idx="12"/>
          </p:nvPr>
        </p:nvSpPr>
        <p:spPr/>
        <p:txBody>
          <a:bodyPr/>
          <a:lstStyle/>
          <a:p>
            <a:fld id="{57556956-394E-164A-9B01-1ED1280184D2}" type="slidenum">
              <a:rPr lang="fr-FR" smtClean="0"/>
              <a:t>‹N°›</a:t>
            </a:fld>
            <a:endParaRPr lang="fr-FR"/>
          </a:p>
        </p:txBody>
      </p:sp>
    </p:spTree>
    <p:extLst>
      <p:ext uri="{BB962C8B-B14F-4D97-AF65-F5344CB8AC3E}">
        <p14:creationId xmlns:p14="http://schemas.microsoft.com/office/powerpoint/2010/main" val="246683909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9388F089-630F-6B2F-31D5-CF96187DE01E}"/>
              </a:ext>
            </a:extLst>
          </p:cNvPr>
          <p:cNvSpPr>
            <a:spLocks noGrp="1"/>
          </p:cNvSpPr>
          <p:nvPr>
            <p:ph type="title"/>
          </p:nvPr>
        </p:nvSpPr>
        <p:spPr/>
        <p:txBody>
          <a:bodyPr/>
          <a:lstStyle/>
          <a:p>
            <a:r>
              <a:rPr lang="fr-FR"/>
              <a:t>Modifiez le style du titre</a:t>
            </a:r>
          </a:p>
        </p:txBody>
      </p:sp>
      <p:sp>
        <p:nvSpPr>
          <p:cNvPr id="3" name="Espace réservé du texte vertical 2">
            <a:extLst>
              <a:ext uri="{FF2B5EF4-FFF2-40B4-BE49-F238E27FC236}">
                <a16:creationId xmlns:a16="http://schemas.microsoft.com/office/drawing/2014/main" id="{B0163FCD-7B91-2A00-B2F6-1B455917B9C5}"/>
              </a:ext>
            </a:extLst>
          </p:cNvPr>
          <p:cNvSpPr>
            <a:spLocks noGrp="1"/>
          </p:cNvSpPr>
          <p:nvPr>
            <p:ph type="body" orient="vert" idx="1"/>
          </p:nvPr>
        </p:nvSpPr>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F54B8AD4-59EB-B6D2-DCC4-A8C3B8D3A386}"/>
              </a:ext>
            </a:extLst>
          </p:cNvPr>
          <p:cNvSpPr>
            <a:spLocks noGrp="1"/>
          </p:cNvSpPr>
          <p:nvPr>
            <p:ph type="dt" sz="half" idx="10"/>
          </p:nvPr>
        </p:nvSpPr>
        <p:spPr/>
        <p:txBody>
          <a:bodyPr/>
          <a:lstStyle/>
          <a:p>
            <a:fld id="{C860001E-C3EE-4E41-8104-9E8900339DA9}" type="datetimeFigureOut">
              <a:rPr lang="fr-FR" smtClean="0"/>
              <a:t>12/10/2023</a:t>
            </a:fld>
            <a:endParaRPr lang="fr-FR"/>
          </a:p>
        </p:txBody>
      </p:sp>
      <p:sp>
        <p:nvSpPr>
          <p:cNvPr id="5" name="Espace réservé du pied de page 4">
            <a:extLst>
              <a:ext uri="{FF2B5EF4-FFF2-40B4-BE49-F238E27FC236}">
                <a16:creationId xmlns:a16="http://schemas.microsoft.com/office/drawing/2014/main" id="{2B79DA4A-F73C-180B-4427-F775AE06C884}"/>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F25B3100-0825-F6E1-AF8C-F896DC26CA62}"/>
              </a:ext>
            </a:extLst>
          </p:cNvPr>
          <p:cNvSpPr>
            <a:spLocks noGrp="1"/>
          </p:cNvSpPr>
          <p:nvPr>
            <p:ph type="sldNum" sz="quarter" idx="12"/>
          </p:nvPr>
        </p:nvSpPr>
        <p:spPr/>
        <p:txBody>
          <a:bodyPr/>
          <a:lstStyle/>
          <a:p>
            <a:fld id="{57556956-394E-164A-9B01-1ED1280184D2}" type="slidenum">
              <a:rPr lang="fr-FR" smtClean="0"/>
              <a:t>‹N°›</a:t>
            </a:fld>
            <a:endParaRPr lang="fr-FR"/>
          </a:p>
        </p:txBody>
      </p:sp>
    </p:spTree>
    <p:extLst>
      <p:ext uri="{BB962C8B-B14F-4D97-AF65-F5344CB8AC3E}">
        <p14:creationId xmlns:p14="http://schemas.microsoft.com/office/powerpoint/2010/main" val="401476632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a:extLst>
              <a:ext uri="{FF2B5EF4-FFF2-40B4-BE49-F238E27FC236}">
                <a16:creationId xmlns:a16="http://schemas.microsoft.com/office/drawing/2014/main" id="{5CCE5E55-511B-1CA3-04D8-1D4F8D02D636}"/>
              </a:ext>
            </a:extLst>
          </p:cNvPr>
          <p:cNvSpPr>
            <a:spLocks noGrp="1"/>
          </p:cNvSpPr>
          <p:nvPr>
            <p:ph type="title" orient="vert"/>
          </p:nvPr>
        </p:nvSpPr>
        <p:spPr>
          <a:xfrm>
            <a:off x="8724900" y="365125"/>
            <a:ext cx="2628900" cy="5811838"/>
          </a:xfrm>
        </p:spPr>
        <p:txBody>
          <a:bodyPr vert="eaVert"/>
          <a:lstStyle/>
          <a:p>
            <a:r>
              <a:rPr lang="fr-FR"/>
              <a:t>Modifiez le style du titre</a:t>
            </a:r>
          </a:p>
        </p:txBody>
      </p:sp>
      <p:sp>
        <p:nvSpPr>
          <p:cNvPr id="3" name="Espace réservé du texte vertical 2">
            <a:extLst>
              <a:ext uri="{FF2B5EF4-FFF2-40B4-BE49-F238E27FC236}">
                <a16:creationId xmlns:a16="http://schemas.microsoft.com/office/drawing/2014/main" id="{83FE390D-617D-97C7-13A5-1ECA6C5966E5}"/>
              </a:ext>
            </a:extLst>
          </p:cNvPr>
          <p:cNvSpPr>
            <a:spLocks noGrp="1"/>
          </p:cNvSpPr>
          <p:nvPr>
            <p:ph type="body" orient="vert" idx="1"/>
          </p:nvPr>
        </p:nvSpPr>
        <p:spPr>
          <a:xfrm>
            <a:off x="838200" y="365125"/>
            <a:ext cx="7734300" cy="5811838"/>
          </a:xfrm>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EC29DD73-0591-8C16-8F94-4453A5C14EBD}"/>
              </a:ext>
            </a:extLst>
          </p:cNvPr>
          <p:cNvSpPr>
            <a:spLocks noGrp="1"/>
          </p:cNvSpPr>
          <p:nvPr>
            <p:ph type="dt" sz="half" idx="10"/>
          </p:nvPr>
        </p:nvSpPr>
        <p:spPr/>
        <p:txBody>
          <a:bodyPr/>
          <a:lstStyle/>
          <a:p>
            <a:fld id="{C860001E-C3EE-4E41-8104-9E8900339DA9}" type="datetimeFigureOut">
              <a:rPr lang="fr-FR" smtClean="0"/>
              <a:t>12/10/2023</a:t>
            </a:fld>
            <a:endParaRPr lang="fr-FR"/>
          </a:p>
        </p:txBody>
      </p:sp>
      <p:sp>
        <p:nvSpPr>
          <p:cNvPr id="5" name="Espace réservé du pied de page 4">
            <a:extLst>
              <a:ext uri="{FF2B5EF4-FFF2-40B4-BE49-F238E27FC236}">
                <a16:creationId xmlns:a16="http://schemas.microsoft.com/office/drawing/2014/main" id="{51DCD8D2-0D4D-0300-FA26-B261DF95DBF4}"/>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4D40F219-D800-F0EB-6569-AE0FDA9F15E0}"/>
              </a:ext>
            </a:extLst>
          </p:cNvPr>
          <p:cNvSpPr>
            <a:spLocks noGrp="1"/>
          </p:cNvSpPr>
          <p:nvPr>
            <p:ph type="sldNum" sz="quarter" idx="12"/>
          </p:nvPr>
        </p:nvSpPr>
        <p:spPr/>
        <p:txBody>
          <a:bodyPr/>
          <a:lstStyle/>
          <a:p>
            <a:fld id="{57556956-394E-164A-9B01-1ED1280184D2}" type="slidenum">
              <a:rPr lang="fr-FR" smtClean="0"/>
              <a:t>‹N°›</a:t>
            </a:fld>
            <a:endParaRPr lang="fr-FR"/>
          </a:p>
        </p:txBody>
      </p:sp>
    </p:spTree>
    <p:extLst>
      <p:ext uri="{BB962C8B-B14F-4D97-AF65-F5344CB8AC3E}">
        <p14:creationId xmlns:p14="http://schemas.microsoft.com/office/powerpoint/2010/main" val="17062801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95276EB4-1D64-AF98-9B37-EEEE5D9B2F07}"/>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id="{AE77695D-0274-FD34-84EE-792D28A3AEC4}"/>
              </a:ext>
            </a:extLst>
          </p:cNvPr>
          <p:cNvSpPr>
            <a:spLocks noGrp="1"/>
          </p:cNvSpPr>
          <p:nvPr>
            <p:ph idx="1"/>
          </p:nvPr>
        </p:nvSpPr>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4CE5D2C9-E221-AA1A-A48F-6CA05C8F2F63}"/>
              </a:ext>
            </a:extLst>
          </p:cNvPr>
          <p:cNvSpPr>
            <a:spLocks noGrp="1"/>
          </p:cNvSpPr>
          <p:nvPr>
            <p:ph type="dt" sz="half" idx="10"/>
          </p:nvPr>
        </p:nvSpPr>
        <p:spPr/>
        <p:txBody>
          <a:bodyPr/>
          <a:lstStyle/>
          <a:p>
            <a:fld id="{C860001E-C3EE-4E41-8104-9E8900339DA9}" type="datetimeFigureOut">
              <a:rPr lang="fr-FR" smtClean="0"/>
              <a:t>12/10/2023</a:t>
            </a:fld>
            <a:endParaRPr lang="fr-FR"/>
          </a:p>
        </p:txBody>
      </p:sp>
      <p:sp>
        <p:nvSpPr>
          <p:cNvPr id="5" name="Espace réservé du pied de page 4">
            <a:extLst>
              <a:ext uri="{FF2B5EF4-FFF2-40B4-BE49-F238E27FC236}">
                <a16:creationId xmlns:a16="http://schemas.microsoft.com/office/drawing/2014/main" id="{A608223B-CE9D-3609-F012-A60F6976CB39}"/>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17F202E4-04BA-FFAC-670A-F17D9A7819F7}"/>
              </a:ext>
            </a:extLst>
          </p:cNvPr>
          <p:cNvSpPr>
            <a:spLocks noGrp="1"/>
          </p:cNvSpPr>
          <p:nvPr>
            <p:ph type="sldNum" sz="quarter" idx="12"/>
          </p:nvPr>
        </p:nvSpPr>
        <p:spPr/>
        <p:txBody>
          <a:bodyPr/>
          <a:lstStyle/>
          <a:p>
            <a:fld id="{57556956-394E-164A-9B01-1ED1280184D2}" type="slidenum">
              <a:rPr lang="fr-FR" smtClean="0"/>
              <a:t>‹N°›</a:t>
            </a:fld>
            <a:endParaRPr lang="fr-FR"/>
          </a:p>
        </p:txBody>
      </p:sp>
    </p:spTree>
    <p:extLst>
      <p:ext uri="{BB962C8B-B14F-4D97-AF65-F5344CB8AC3E}">
        <p14:creationId xmlns:p14="http://schemas.microsoft.com/office/powerpoint/2010/main" val="309313353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607EA639-8561-58C9-C1BF-0F34BC2F3472}"/>
              </a:ext>
            </a:extLst>
          </p:cNvPr>
          <p:cNvSpPr>
            <a:spLocks noGrp="1"/>
          </p:cNvSpPr>
          <p:nvPr>
            <p:ph type="title"/>
          </p:nvPr>
        </p:nvSpPr>
        <p:spPr>
          <a:xfrm>
            <a:off x="831850" y="1709738"/>
            <a:ext cx="10515600" cy="2852737"/>
          </a:xfrm>
        </p:spPr>
        <p:txBody>
          <a:bodyPr anchor="b"/>
          <a:lstStyle>
            <a:lvl1pPr>
              <a:defRPr sz="6000"/>
            </a:lvl1pPr>
          </a:lstStyle>
          <a:p>
            <a:r>
              <a:rPr lang="fr-FR"/>
              <a:t>Modifiez le style du titre</a:t>
            </a:r>
          </a:p>
        </p:txBody>
      </p:sp>
      <p:sp>
        <p:nvSpPr>
          <p:cNvPr id="3" name="Espace réservé du texte 2">
            <a:extLst>
              <a:ext uri="{FF2B5EF4-FFF2-40B4-BE49-F238E27FC236}">
                <a16:creationId xmlns:a16="http://schemas.microsoft.com/office/drawing/2014/main" id="{1E189A4A-582F-6BA9-F34F-63007A1C115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a:t>Cliquez pour modifier les styles du texte du masque</a:t>
            </a:r>
          </a:p>
        </p:txBody>
      </p:sp>
      <p:sp>
        <p:nvSpPr>
          <p:cNvPr id="4" name="Espace réservé de la date 3">
            <a:extLst>
              <a:ext uri="{FF2B5EF4-FFF2-40B4-BE49-F238E27FC236}">
                <a16:creationId xmlns:a16="http://schemas.microsoft.com/office/drawing/2014/main" id="{DA5DCA5D-EA39-847B-3FB0-A2429C08B4AE}"/>
              </a:ext>
            </a:extLst>
          </p:cNvPr>
          <p:cNvSpPr>
            <a:spLocks noGrp="1"/>
          </p:cNvSpPr>
          <p:nvPr>
            <p:ph type="dt" sz="half" idx="10"/>
          </p:nvPr>
        </p:nvSpPr>
        <p:spPr/>
        <p:txBody>
          <a:bodyPr/>
          <a:lstStyle/>
          <a:p>
            <a:fld id="{C860001E-C3EE-4E41-8104-9E8900339DA9}" type="datetimeFigureOut">
              <a:rPr lang="fr-FR" smtClean="0"/>
              <a:t>12/10/2023</a:t>
            </a:fld>
            <a:endParaRPr lang="fr-FR"/>
          </a:p>
        </p:txBody>
      </p:sp>
      <p:sp>
        <p:nvSpPr>
          <p:cNvPr id="5" name="Espace réservé du pied de page 4">
            <a:extLst>
              <a:ext uri="{FF2B5EF4-FFF2-40B4-BE49-F238E27FC236}">
                <a16:creationId xmlns:a16="http://schemas.microsoft.com/office/drawing/2014/main" id="{1B002581-0B8C-603F-DAC0-7EC040858410}"/>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5C517771-E004-4D5E-3287-0985F5F5CC3E}"/>
              </a:ext>
            </a:extLst>
          </p:cNvPr>
          <p:cNvSpPr>
            <a:spLocks noGrp="1"/>
          </p:cNvSpPr>
          <p:nvPr>
            <p:ph type="sldNum" sz="quarter" idx="12"/>
          </p:nvPr>
        </p:nvSpPr>
        <p:spPr/>
        <p:txBody>
          <a:bodyPr/>
          <a:lstStyle/>
          <a:p>
            <a:fld id="{57556956-394E-164A-9B01-1ED1280184D2}" type="slidenum">
              <a:rPr lang="fr-FR" smtClean="0"/>
              <a:t>‹N°›</a:t>
            </a:fld>
            <a:endParaRPr lang="fr-FR"/>
          </a:p>
        </p:txBody>
      </p:sp>
    </p:spTree>
    <p:extLst>
      <p:ext uri="{BB962C8B-B14F-4D97-AF65-F5344CB8AC3E}">
        <p14:creationId xmlns:p14="http://schemas.microsoft.com/office/powerpoint/2010/main" val="149527711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4EB3D80A-BB70-30BC-BC99-2F24615A90F4}"/>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id="{E782FB62-EC29-243C-5748-2E884A534416}"/>
              </a:ext>
            </a:extLst>
          </p:cNvPr>
          <p:cNvSpPr>
            <a:spLocks noGrp="1"/>
          </p:cNvSpPr>
          <p:nvPr>
            <p:ph sz="half" idx="1"/>
          </p:nvPr>
        </p:nvSpPr>
        <p:spPr>
          <a:xfrm>
            <a:off x="838200" y="1825625"/>
            <a:ext cx="5181600" cy="435133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contenu 3">
            <a:extLst>
              <a:ext uri="{FF2B5EF4-FFF2-40B4-BE49-F238E27FC236}">
                <a16:creationId xmlns:a16="http://schemas.microsoft.com/office/drawing/2014/main" id="{7B4D9325-1BFB-7BF5-A0A2-EF26F80D8BDF}"/>
              </a:ext>
            </a:extLst>
          </p:cNvPr>
          <p:cNvSpPr>
            <a:spLocks noGrp="1"/>
          </p:cNvSpPr>
          <p:nvPr>
            <p:ph sz="half" idx="2"/>
          </p:nvPr>
        </p:nvSpPr>
        <p:spPr>
          <a:xfrm>
            <a:off x="6172200" y="1825625"/>
            <a:ext cx="5181600" cy="435133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e la date 4">
            <a:extLst>
              <a:ext uri="{FF2B5EF4-FFF2-40B4-BE49-F238E27FC236}">
                <a16:creationId xmlns:a16="http://schemas.microsoft.com/office/drawing/2014/main" id="{5E5EB4E3-CE6A-5643-96A8-70388B10F1AD}"/>
              </a:ext>
            </a:extLst>
          </p:cNvPr>
          <p:cNvSpPr>
            <a:spLocks noGrp="1"/>
          </p:cNvSpPr>
          <p:nvPr>
            <p:ph type="dt" sz="half" idx="10"/>
          </p:nvPr>
        </p:nvSpPr>
        <p:spPr/>
        <p:txBody>
          <a:bodyPr/>
          <a:lstStyle/>
          <a:p>
            <a:fld id="{C860001E-C3EE-4E41-8104-9E8900339DA9}" type="datetimeFigureOut">
              <a:rPr lang="fr-FR" smtClean="0"/>
              <a:t>12/10/2023</a:t>
            </a:fld>
            <a:endParaRPr lang="fr-FR"/>
          </a:p>
        </p:txBody>
      </p:sp>
      <p:sp>
        <p:nvSpPr>
          <p:cNvPr id="6" name="Espace réservé du pied de page 5">
            <a:extLst>
              <a:ext uri="{FF2B5EF4-FFF2-40B4-BE49-F238E27FC236}">
                <a16:creationId xmlns:a16="http://schemas.microsoft.com/office/drawing/2014/main" id="{9DFB02BA-9005-5078-002B-F9661DAB56FC}"/>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D49EE6A3-A78A-BC5E-19ED-293BB44C2E03}"/>
              </a:ext>
            </a:extLst>
          </p:cNvPr>
          <p:cNvSpPr>
            <a:spLocks noGrp="1"/>
          </p:cNvSpPr>
          <p:nvPr>
            <p:ph type="sldNum" sz="quarter" idx="12"/>
          </p:nvPr>
        </p:nvSpPr>
        <p:spPr/>
        <p:txBody>
          <a:bodyPr/>
          <a:lstStyle/>
          <a:p>
            <a:fld id="{57556956-394E-164A-9B01-1ED1280184D2}" type="slidenum">
              <a:rPr lang="fr-FR" smtClean="0"/>
              <a:t>‹N°›</a:t>
            </a:fld>
            <a:endParaRPr lang="fr-FR"/>
          </a:p>
        </p:txBody>
      </p:sp>
    </p:spTree>
    <p:extLst>
      <p:ext uri="{BB962C8B-B14F-4D97-AF65-F5344CB8AC3E}">
        <p14:creationId xmlns:p14="http://schemas.microsoft.com/office/powerpoint/2010/main" val="5557577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EB570C35-DE13-1BB5-B69B-69E6155292AE}"/>
              </a:ext>
            </a:extLst>
          </p:cNvPr>
          <p:cNvSpPr>
            <a:spLocks noGrp="1"/>
          </p:cNvSpPr>
          <p:nvPr>
            <p:ph type="title"/>
          </p:nvPr>
        </p:nvSpPr>
        <p:spPr>
          <a:xfrm>
            <a:off x="839788" y="365125"/>
            <a:ext cx="10515600" cy="1325563"/>
          </a:xfrm>
        </p:spPr>
        <p:txBody>
          <a:bodyPr/>
          <a:lstStyle/>
          <a:p>
            <a:r>
              <a:rPr lang="fr-FR"/>
              <a:t>Modifiez le style du titre</a:t>
            </a:r>
          </a:p>
        </p:txBody>
      </p:sp>
      <p:sp>
        <p:nvSpPr>
          <p:cNvPr id="3" name="Espace réservé du texte 2">
            <a:extLst>
              <a:ext uri="{FF2B5EF4-FFF2-40B4-BE49-F238E27FC236}">
                <a16:creationId xmlns:a16="http://schemas.microsoft.com/office/drawing/2014/main" id="{CC69FADB-1AA0-B981-3ABE-D35EF60CD44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Cliquez pour modifier les styles du texte du masque</a:t>
            </a:r>
          </a:p>
        </p:txBody>
      </p:sp>
      <p:sp>
        <p:nvSpPr>
          <p:cNvPr id="4" name="Espace réservé du contenu 3">
            <a:extLst>
              <a:ext uri="{FF2B5EF4-FFF2-40B4-BE49-F238E27FC236}">
                <a16:creationId xmlns:a16="http://schemas.microsoft.com/office/drawing/2014/main" id="{58E7D7F5-C10C-C8B2-D8E5-04E38C7D1372}"/>
              </a:ext>
            </a:extLst>
          </p:cNvPr>
          <p:cNvSpPr>
            <a:spLocks noGrp="1"/>
          </p:cNvSpPr>
          <p:nvPr>
            <p:ph sz="half" idx="2"/>
          </p:nvPr>
        </p:nvSpPr>
        <p:spPr>
          <a:xfrm>
            <a:off x="839788" y="2505075"/>
            <a:ext cx="5157787" cy="368458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u texte 4">
            <a:extLst>
              <a:ext uri="{FF2B5EF4-FFF2-40B4-BE49-F238E27FC236}">
                <a16:creationId xmlns:a16="http://schemas.microsoft.com/office/drawing/2014/main" id="{522461A0-895F-F8D6-3476-9D96330CF12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Cliquez pour modifier les styles du texte du masque</a:t>
            </a:r>
          </a:p>
        </p:txBody>
      </p:sp>
      <p:sp>
        <p:nvSpPr>
          <p:cNvPr id="6" name="Espace réservé du contenu 5">
            <a:extLst>
              <a:ext uri="{FF2B5EF4-FFF2-40B4-BE49-F238E27FC236}">
                <a16:creationId xmlns:a16="http://schemas.microsoft.com/office/drawing/2014/main" id="{BC83291A-A18B-D653-9534-5C079AB6DD35}"/>
              </a:ext>
            </a:extLst>
          </p:cNvPr>
          <p:cNvSpPr>
            <a:spLocks noGrp="1"/>
          </p:cNvSpPr>
          <p:nvPr>
            <p:ph sz="quarter" idx="4"/>
          </p:nvPr>
        </p:nvSpPr>
        <p:spPr>
          <a:xfrm>
            <a:off x="6172200" y="2505075"/>
            <a:ext cx="5183188" cy="368458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7" name="Espace réservé de la date 6">
            <a:extLst>
              <a:ext uri="{FF2B5EF4-FFF2-40B4-BE49-F238E27FC236}">
                <a16:creationId xmlns:a16="http://schemas.microsoft.com/office/drawing/2014/main" id="{E6A546D0-4191-3F53-903E-4525C3976079}"/>
              </a:ext>
            </a:extLst>
          </p:cNvPr>
          <p:cNvSpPr>
            <a:spLocks noGrp="1"/>
          </p:cNvSpPr>
          <p:nvPr>
            <p:ph type="dt" sz="half" idx="10"/>
          </p:nvPr>
        </p:nvSpPr>
        <p:spPr/>
        <p:txBody>
          <a:bodyPr/>
          <a:lstStyle/>
          <a:p>
            <a:fld id="{C860001E-C3EE-4E41-8104-9E8900339DA9}" type="datetimeFigureOut">
              <a:rPr lang="fr-FR" smtClean="0"/>
              <a:t>12/10/2023</a:t>
            </a:fld>
            <a:endParaRPr lang="fr-FR"/>
          </a:p>
        </p:txBody>
      </p:sp>
      <p:sp>
        <p:nvSpPr>
          <p:cNvPr id="8" name="Espace réservé du pied de page 7">
            <a:extLst>
              <a:ext uri="{FF2B5EF4-FFF2-40B4-BE49-F238E27FC236}">
                <a16:creationId xmlns:a16="http://schemas.microsoft.com/office/drawing/2014/main" id="{5573D520-4F6D-71E3-3E7B-7118C74EF32F}"/>
              </a:ext>
            </a:extLst>
          </p:cNvPr>
          <p:cNvSpPr>
            <a:spLocks noGrp="1"/>
          </p:cNvSpPr>
          <p:nvPr>
            <p:ph type="ftr" sz="quarter" idx="11"/>
          </p:nvPr>
        </p:nvSpPr>
        <p:spPr/>
        <p:txBody>
          <a:bodyPr/>
          <a:lstStyle/>
          <a:p>
            <a:endParaRPr lang="fr-FR"/>
          </a:p>
        </p:txBody>
      </p:sp>
      <p:sp>
        <p:nvSpPr>
          <p:cNvPr id="9" name="Espace réservé du numéro de diapositive 8">
            <a:extLst>
              <a:ext uri="{FF2B5EF4-FFF2-40B4-BE49-F238E27FC236}">
                <a16:creationId xmlns:a16="http://schemas.microsoft.com/office/drawing/2014/main" id="{B1868781-E5ED-F930-4ADF-0E23D93DAEFA}"/>
              </a:ext>
            </a:extLst>
          </p:cNvPr>
          <p:cNvSpPr>
            <a:spLocks noGrp="1"/>
          </p:cNvSpPr>
          <p:nvPr>
            <p:ph type="sldNum" sz="quarter" idx="12"/>
          </p:nvPr>
        </p:nvSpPr>
        <p:spPr/>
        <p:txBody>
          <a:bodyPr/>
          <a:lstStyle/>
          <a:p>
            <a:fld id="{57556956-394E-164A-9B01-1ED1280184D2}" type="slidenum">
              <a:rPr lang="fr-FR" smtClean="0"/>
              <a:t>‹N°›</a:t>
            </a:fld>
            <a:endParaRPr lang="fr-FR"/>
          </a:p>
        </p:txBody>
      </p:sp>
    </p:spTree>
    <p:extLst>
      <p:ext uri="{BB962C8B-B14F-4D97-AF65-F5344CB8AC3E}">
        <p14:creationId xmlns:p14="http://schemas.microsoft.com/office/powerpoint/2010/main" val="107575396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2AE35300-563D-EDE0-44C5-446EB2CACFA8}"/>
              </a:ext>
            </a:extLst>
          </p:cNvPr>
          <p:cNvSpPr>
            <a:spLocks noGrp="1"/>
          </p:cNvSpPr>
          <p:nvPr>
            <p:ph type="title"/>
          </p:nvPr>
        </p:nvSpPr>
        <p:spPr/>
        <p:txBody>
          <a:bodyPr/>
          <a:lstStyle/>
          <a:p>
            <a:r>
              <a:rPr lang="fr-FR"/>
              <a:t>Modifiez le style du titre</a:t>
            </a:r>
          </a:p>
        </p:txBody>
      </p:sp>
      <p:sp>
        <p:nvSpPr>
          <p:cNvPr id="3" name="Espace réservé de la date 2">
            <a:extLst>
              <a:ext uri="{FF2B5EF4-FFF2-40B4-BE49-F238E27FC236}">
                <a16:creationId xmlns:a16="http://schemas.microsoft.com/office/drawing/2014/main" id="{E5929351-0656-3641-BE35-F645AA907A68}"/>
              </a:ext>
            </a:extLst>
          </p:cNvPr>
          <p:cNvSpPr>
            <a:spLocks noGrp="1"/>
          </p:cNvSpPr>
          <p:nvPr>
            <p:ph type="dt" sz="half" idx="10"/>
          </p:nvPr>
        </p:nvSpPr>
        <p:spPr/>
        <p:txBody>
          <a:bodyPr/>
          <a:lstStyle/>
          <a:p>
            <a:fld id="{C860001E-C3EE-4E41-8104-9E8900339DA9}" type="datetimeFigureOut">
              <a:rPr lang="fr-FR" smtClean="0"/>
              <a:t>12/10/2023</a:t>
            </a:fld>
            <a:endParaRPr lang="fr-FR"/>
          </a:p>
        </p:txBody>
      </p:sp>
      <p:sp>
        <p:nvSpPr>
          <p:cNvPr id="4" name="Espace réservé du pied de page 3">
            <a:extLst>
              <a:ext uri="{FF2B5EF4-FFF2-40B4-BE49-F238E27FC236}">
                <a16:creationId xmlns:a16="http://schemas.microsoft.com/office/drawing/2014/main" id="{0368B770-1664-D45F-4BD9-B5C2C5293F75}"/>
              </a:ext>
            </a:extLst>
          </p:cNvPr>
          <p:cNvSpPr>
            <a:spLocks noGrp="1"/>
          </p:cNvSpPr>
          <p:nvPr>
            <p:ph type="ftr" sz="quarter" idx="11"/>
          </p:nvPr>
        </p:nvSpPr>
        <p:spPr/>
        <p:txBody>
          <a:bodyPr/>
          <a:lstStyle/>
          <a:p>
            <a:endParaRPr lang="fr-FR"/>
          </a:p>
        </p:txBody>
      </p:sp>
      <p:sp>
        <p:nvSpPr>
          <p:cNvPr id="5" name="Espace réservé du numéro de diapositive 4">
            <a:extLst>
              <a:ext uri="{FF2B5EF4-FFF2-40B4-BE49-F238E27FC236}">
                <a16:creationId xmlns:a16="http://schemas.microsoft.com/office/drawing/2014/main" id="{7AA8EDCF-1238-9258-7B94-67297F1C1CB5}"/>
              </a:ext>
            </a:extLst>
          </p:cNvPr>
          <p:cNvSpPr>
            <a:spLocks noGrp="1"/>
          </p:cNvSpPr>
          <p:nvPr>
            <p:ph type="sldNum" sz="quarter" idx="12"/>
          </p:nvPr>
        </p:nvSpPr>
        <p:spPr/>
        <p:txBody>
          <a:bodyPr/>
          <a:lstStyle/>
          <a:p>
            <a:fld id="{57556956-394E-164A-9B01-1ED1280184D2}" type="slidenum">
              <a:rPr lang="fr-FR" smtClean="0"/>
              <a:t>‹N°›</a:t>
            </a:fld>
            <a:endParaRPr lang="fr-FR"/>
          </a:p>
        </p:txBody>
      </p:sp>
    </p:spTree>
    <p:extLst>
      <p:ext uri="{BB962C8B-B14F-4D97-AF65-F5344CB8AC3E}">
        <p14:creationId xmlns:p14="http://schemas.microsoft.com/office/powerpoint/2010/main" val="266265003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a:extLst>
              <a:ext uri="{FF2B5EF4-FFF2-40B4-BE49-F238E27FC236}">
                <a16:creationId xmlns:a16="http://schemas.microsoft.com/office/drawing/2014/main" id="{CFB0C30D-BB53-15DF-9ABD-CBD038883C86}"/>
              </a:ext>
            </a:extLst>
          </p:cNvPr>
          <p:cNvSpPr>
            <a:spLocks noGrp="1"/>
          </p:cNvSpPr>
          <p:nvPr>
            <p:ph type="dt" sz="half" idx="10"/>
          </p:nvPr>
        </p:nvSpPr>
        <p:spPr/>
        <p:txBody>
          <a:bodyPr/>
          <a:lstStyle/>
          <a:p>
            <a:fld id="{C860001E-C3EE-4E41-8104-9E8900339DA9}" type="datetimeFigureOut">
              <a:rPr lang="fr-FR" smtClean="0"/>
              <a:t>12/10/2023</a:t>
            </a:fld>
            <a:endParaRPr lang="fr-FR"/>
          </a:p>
        </p:txBody>
      </p:sp>
      <p:sp>
        <p:nvSpPr>
          <p:cNvPr id="3" name="Espace réservé du pied de page 2">
            <a:extLst>
              <a:ext uri="{FF2B5EF4-FFF2-40B4-BE49-F238E27FC236}">
                <a16:creationId xmlns:a16="http://schemas.microsoft.com/office/drawing/2014/main" id="{CFDE3857-8070-E58C-88F0-795A905CC7BE}"/>
              </a:ext>
            </a:extLst>
          </p:cNvPr>
          <p:cNvSpPr>
            <a:spLocks noGrp="1"/>
          </p:cNvSpPr>
          <p:nvPr>
            <p:ph type="ftr" sz="quarter" idx="11"/>
          </p:nvPr>
        </p:nvSpPr>
        <p:spPr/>
        <p:txBody>
          <a:bodyPr/>
          <a:lstStyle/>
          <a:p>
            <a:endParaRPr lang="fr-FR"/>
          </a:p>
        </p:txBody>
      </p:sp>
      <p:sp>
        <p:nvSpPr>
          <p:cNvPr id="4" name="Espace réservé du numéro de diapositive 3">
            <a:extLst>
              <a:ext uri="{FF2B5EF4-FFF2-40B4-BE49-F238E27FC236}">
                <a16:creationId xmlns:a16="http://schemas.microsoft.com/office/drawing/2014/main" id="{99A40649-7AD1-1710-A381-1D58CAA05741}"/>
              </a:ext>
            </a:extLst>
          </p:cNvPr>
          <p:cNvSpPr>
            <a:spLocks noGrp="1"/>
          </p:cNvSpPr>
          <p:nvPr>
            <p:ph type="sldNum" sz="quarter" idx="12"/>
          </p:nvPr>
        </p:nvSpPr>
        <p:spPr/>
        <p:txBody>
          <a:bodyPr/>
          <a:lstStyle/>
          <a:p>
            <a:fld id="{57556956-394E-164A-9B01-1ED1280184D2}" type="slidenum">
              <a:rPr lang="fr-FR" smtClean="0"/>
              <a:t>‹N°›</a:t>
            </a:fld>
            <a:endParaRPr lang="fr-FR"/>
          </a:p>
        </p:txBody>
      </p:sp>
    </p:spTree>
    <p:extLst>
      <p:ext uri="{BB962C8B-B14F-4D97-AF65-F5344CB8AC3E}">
        <p14:creationId xmlns:p14="http://schemas.microsoft.com/office/powerpoint/2010/main" val="237779158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1B87DA76-0C61-08D2-2AF8-2B8054712933}"/>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du contenu 2">
            <a:extLst>
              <a:ext uri="{FF2B5EF4-FFF2-40B4-BE49-F238E27FC236}">
                <a16:creationId xmlns:a16="http://schemas.microsoft.com/office/drawing/2014/main" id="{03E18DAA-0615-B48A-1570-543D895B424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texte 3">
            <a:extLst>
              <a:ext uri="{FF2B5EF4-FFF2-40B4-BE49-F238E27FC236}">
                <a16:creationId xmlns:a16="http://schemas.microsoft.com/office/drawing/2014/main" id="{9EE9B1E2-CE0E-C1F5-2996-5E8A1542FF7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Cliquez pour modifier les styles du texte du masque</a:t>
            </a:r>
          </a:p>
        </p:txBody>
      </p:sp>
      <p:sp>
        <p:nvSpPr>
          <p:cNvPr id="5" name="Espace réservé de la date 4">
            <a:extLst>
              <a:ext uri="{FF2B5EF4-FFF2-40B4-BE49-F238E27FC236}">
                <a16:creationId xmlns:a16="http://schemas.microsoft.com/office/drawing/2014/main" id="{9C647F83-3DC6-FC61-604A-CDFDF105AC80}"/>
              </a:ext>
            </a:extLst>
          </p:cNvPr>
          <p:cNvSpPr>
            <a:spLocks noGrp="1"/>
          </p:cNvSpPr>
          <p:nvPr>
            <p:ph type="dt" sz="half" idx="10"/>
          </p:nvPr>
        </p:nvSpPr>
        <p:spPr/>
        <p:txBody>
          <a:bodyPr/>
          <a:lstStyle/>
          <a:p>
            <a:fld id="{C860001E-C3EE-4E41-8104-9E8900339DA9}" type="datetimeFigureOut">
              <a:rPr lang="fr-FR" smtClean="0"/>
              <a:t>12/10/2023</a:t>
            </a:fld>
            <a:endParaRPr lang="fr-FR"/>
          </a:p>
        </p:txBody>
      </p:sp>
      <p:sp>
        <p:nvSpPr>
          <p:cNvPr id="6" name="Espace réservé du pied de page 5">
            <a:extLst>
              <a:ext uri="{FF2B5EF4-FFF2-40B4-BE49-F238E27FC236}">
                <a16:creationId xmlns:a16="http://schemas.microsoft.com/office/drawing/2014/main" id="{A684DBFC-8C30-7173-D417-3D7D86550523}"/>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8FFC5F97-394F-11AC-9C14-C6AA208DE6A7}"/>
              </a:ext>
            </a:extLst>
          </p:cNvPr>
          <p:cNvSpPr>
            <a:spLocks noGrp="1"/>
          </p:cNvSpPr>
          <p:nvPr>
            <p:ph type="sldNum" sz="quarter" idx="12"/>
          </p:nvPr>
        </p:nvSpPr>
        <p:spPr/>
        <p:txBody>
          <a:bodyPr/>
          <a:lstStyle/>
          <a:p>
            <a:fld id="{57556956-394E-164A-9B01-1ED1280184D2}" type="slidenum">
              <a:rPr lang="fr-FR" smtClean="0"/>
              <a:t>‹N°›</a:t>
            </a:fld>
            <a:endParaRPr lang="fr-FR"/>
          </a:p>
        </p:txBody>
      </p:sp>
    </p:spTree>
    <p:extLst>
      <p:ext uri="{BB962C8B-B14F-4D97-AF65-F5344CB8AC3E}">
        <p14:creationId xmlns:p14="http://schemas.microsoft.com/office/powerpoint/2010/main" val="343726735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5D035827-ABB4-4ABF-2824-C3DD41CDB862}"/>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pour une image  2">
            <a:extLst>
              <a:ext uri="{FF2B5EF4-FFF2-40B4-BE49-F238E27FC236}">
                <a16:creationId xmlns:a16="http://schemas.microsoft.com/office/drawing/2014/main" id="{85038C9A-481D-2EA6-7FE5-C78517A6243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a:extLst>
              <a:ext uri="{FF2B5EF4-FFF2-40B4-BE49-F238E27FC236}">
                <a16:creationId xmlns:a16="http://schemas.microsoft.com/office/drawing/2014/main" id="{FC9491EA-1356-191D-5DF3-E9F8691DC69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Cliquez pour modifier les styles du texte du masque</a:t>
            </a:r>
          </a:p>
        </p:txBody>
      </p:sp>
      <p:sp>
        <p:nvSpPr>
          <p:cNvPr id="5" name="Espace réservé de la date 4">
            <a:extLst>
              <a:ext uri="{FF2B5EF4-FFF2-40B4-BE49-F238E27FC236}">
                <a16:creationId xmlns:a16="http://schemas.microsoft.com/office/drawing/2014/main" id="{B99AFE7B-AA7B-8359-BD8D-46A7C933E967}"/>
              </a:ext>
            </a:extLst>
          </p:cNvPr>
          <p:cNvSpPr>
            <a:spLocks noGrp="1"/>
          </p:cNvSpPr>
          <p:nvPr>
            <p:ph type="dt" sz="half" idx="10"/>
          </p:nvPr>
        </p:nvSpPr>
        <p:spPr/>
        <p:txBody>
          <a:bodyPr/>
          <a:lstStyle/>
          <a:p>
            <a:fld id="{C860001E-C3EE-4E41-8104-9E8900339DA9}" type="datetimeFigureOut">
              <a:rPr lang="fr-FR" smtClean="0"/>
              <a:t>12/10/2023</a:t>
            </a:fld>
            <a:endParaRPr lang="fr-FR"/>
          </a:p>
        </p:txBody>
      </p:sp>
      <p:sp>
        <p:nvSpPr>
          <p:cNvPr id="6" name="Espace réservé du pied de page 5">
            <a:extLst>
              <a:ext uri="{FF2B5EF4-FFF2-40B4-BE49-F238E27FC236}">
                <a16:creationId xmlns:a16="http://schemas.microsoft.com/office/drawing/2014/main" id="{14BC68D5-8CED-A136-F755-4762D4D01641}"/>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F71B685A-5507-00AF-D9D7-580063C1B464}"/>
              </a:ext>
            </a:extLst>
          </p:cNvPr>
          <p:cNvSpPr>
            <a:spLocks noGrp="1"/>
          </p:cNvSpPr>
          <p:nvPr>
            <p:ph type="sldNum" sz="quarter" idx="12"/>
          </p:nvPr>
        </p:nvSpPr>
        <p:spPr/>
        <p:txBody>
          <a:bodyPr/>
          <a:lstStyle/>
          <a:p>
            <a:fld id="{57556956-394E-164A-9B01-1ED1280184D2}" type="slidenum">
              <a:rPr lang="fr-FR" smtClean="0"/>
              <a:t>‹N°›</a:t>
            </a:fld>
            <a:endParaRPr lang="fr-FR"/>
          </a:p>
        </p:txBody>
      </p:sp>
    </p:spTree>
    <p:extLst>
      <p:ext uri="{BB962C8B-B14F-4D97-AF65-F5344CB8AC3E}">
        <p14:creationId xmlns:p14="http://schemas.microsoft.com/office/powerpoint/2010/main" val="235666731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a:extLst>
              <a:ext uri="{FF2B5EF4-FFF2-40B4-BE49-F238E27FC236}">
                <a16:creationId xmlns:a16="http://schemas.microsoft.com/office/drawing/2014/main" id="{45026CEA-2386-C4FE-790F-C8E7E225373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a:t>Modifiez le style du titre</a:t>
            </a:r>
          </a:p>
        </p:txBody>
      </p:sp>
      <p:sp>
        <p:nvSpPr>
          <p:cNvPr id="3" name="Espace réservé du texte 2">
            <a:extLst>
              <a:ext uri="{FF2B5EF4-FFF2-40B4-BE49-F238E27FC236}">
                <a16:creationId xmlns:a16="http://schemas.microsoft.com/office/drawing/2014/main" id="{A15F410B-C354-2861-B99A-BADBD82FC1F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D9E72830-1C1C-02FC-AF62-0E343610469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860001E-C3EE-4E41-8104-9E8900339DA9}" type="datetimeFigureOut">
              <a:rPr lang="fr-FR" smtClean="0"/>
              <a:t>12/10/2023</a:t>
            </a:fld>
            <a:endParaRPr lang="fr-FR"/>
          </a:p>
        </p:txBody>
      </p:sp>
      <p:sp>
        <p:nvSpPr>
          <p:cNvPr id="5" name="Espace réservé du pied de page 4">
            <a:extLst>
              <a:ext uri="{FF2B5EF4-FFF2-40B4-BE49-F238E27FC236}">
                <a16:creationId xmlns:a16="http://schemas.microsoft.com/office/drawing/2014/main" id="{5AE2BD64-8513-CBB7-D2FF-762AE16159D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a:extLst>
              <a:ext uri="{FF2B5EF4-FFF2-40B4-BE49-F238E27FC236}">
                <a16:creationId xmlns:a16="http://schemas.microsoft.com/office/drawing/2014/main" id="{8D20440D-8F27-BF53-545D-FE2F5FBCBA3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7556956-394E-164A-9B01-1ED1280184D2}" type="slidenum">
              <a:rPr lang="fr-FR" smtClean="0"/>
              <a:t>‹N°›</a:t>
            </a:fld>
            <a:endParaRPr lang="fr-FR"/>
          </a:p>
        </p:txBody>
      </p:sp>
    </p:spTree>
    <p:extLst>
      <p:ext uri="{BB962C8B-B14F-4D97-AF65-F5344CB8AC3E}">
        <p14:creationId xmlns:p14="http://schemas.microsoft.com/office/powerpoint/2010/main" val="177305250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xml"/><Relationship Id="rId1" Type="http://schemas.openxmlformats.org/officeDocument/2006/relationships/slideLayout" Target="../slideLayouts/slideLayout1.xml"/><Relationship Id="rId5" Type="http://schemas.openxmlformats.org/officeDocument/2006/relationships/image" Target="../media/image5.png"/><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3.xml"/><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4.xml"/><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5.xml"/><Relationship Id="rId1" Type="http://schemas.openxmlformats.org/officeDocument/2006/relationships/slideLayout" Target="../slideLayouts/slideLayout1.xml"/><Relationship Id="rId6" Type="http://schemas.openxmlformats.org/officeDocument/2006/relationships/image" Target="../media/image9.png"/><Relationship Id="rId5" Type="http://schemas.openxmlformats.org/officeDocument/2006/relationships/image" Target="../media/image8.jpg"/><Relationship Id="rId4" Type="http://schemas.openxmlformats.org/officeDocument/2006/relationships/image" Target="../media/image3.png"/></Relationships>
</file>

<file path=ppt/slides/_rels/slide6.xml.rels><?xml version="1.0" encoding="UTF-8" standalone="yes"?>
<Relationships xmlns="http://schemas.openxmlformats.org/package/2006/relationships"><Relationship Id="rId8" Type="http://schemas.openxmlformats.org/officeDocument/2006/relationships/image" Target="../media/image9.png"/><Relationship Id="rId13" Type="http://schemas.openxmlformats.org/officeDocument/2006/relationships/image" Target="../media/image17.png"/><Relationship Id="rId3" Type="http://schemas.openxmlformats.org/officeDocument/2006/relationships/image" Target="../media/image10.png"/><Relationship Id="rId7" Type="http://schemas.openxmlformats.org/officeDocument/2006/relationships/image" Target="../media/image8.jpg"/><Relationship Id="rId12" Type="http://schemas.openxmlformats.org/officeDocument/2006/relationships/image" Target="../media/image16.png"/><Relationship Id="rId2" Type="http://schemas.openxmlformats.org/officeDocument/2006/relationships/notesSlide" Target="../notesSlides/notesSlide6.xml"/><Relationship Id="rId1" Type="http://schemas.openxmlformats.org/officeDocument/2006/relationships/slideLayout" Target="../slideLayouts/slideLayout1.xml"/><Relationship Id="rId6" Type="http://schemas.openxmlformats.org/officeDocument/2006/relationships/image" Target="../media/image13.png"/><Relationship Id="rId11" Type="http://schemas.openxmlformats.org/officeDocument/2006/relationships/image" Target="../media/image15.png"/><Relationship Id="rId5" Type="http://schemas.openxmlformats.org/officeDocument/2006/relationships/image" Target="../media/image12.png"/><Relationship Id="rId15" Type="http://schemas.openxmlformats.org/officeDocument/2006/relationships/image" Target="../media/image3.png"/><Relationship Id="rId10" Type="http://schemas.openxmlformats.org/officeDocument/2006/relationships/image" Target="../media/image14.png"/><Relationship Id="rId4" Type="http://schemas.openxmlformats.org/officeDocument/2006/relationships/image" Target="../media/image11.png"/><Relationship Id="rId9" Type="http://schemas.openxmlformats.org/officeDocument/2006/relationships/image" Target="../media/image7.png"/><Relationship Id="rId14" Type="http://schemas.openxmlformats.org/officeDocument/2006/relationships/image" Target="../media/image18.png"/></Relationships>
</file>

<file path=ppt/slides/_rels/slide7.xml.rels><?xml version="1.0" encoding="UTF-8" standalone="yes"?>
<Relationships xmlns="http://schemas.openxmlformats.org/package/2006/relationships"><Relationship Id="rId3" Type="http://schemas.openxmlformats.org/officeDocument/2006/relationships/image" Target="../media/image19.jpeg"/><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62E49103-83E1-E43E-03D1-84FBE4D166FA}"/>
              </a:ext>
            </a:extLst>
          </p:cNvPr>
          <p:cNvSpPr txBox="1"/>
          <p:nvPr/>
        </p:nvSpPr>
        <p:spPr>
          <a:xfrm>
            <a:off x="-1001727" y="37990"/>
            <a:ext cx="1095172" cy="369332"/>
          </a:xfrm>
          <a:prstGeom prst="rect">
            <a:avLst/>
          </a:prstGeom>
          <a:noFill/>
        </p:spPr>
        <p:txBody>
          <a:bodyPr wrap="none" rtlCol="0">
            <a:spAutoFit/>
          </a:bodyPr>
          <a:lstStyle/>
          <a:p>
            <a:r>
              <a:rPr lang="fr-FR" dirty="0">
                <a:latin typeface="Arial" panose="020B0604020202020204" pitchFamily="34" charset="0"/>
                <a:cs typeface="Arial" panose="020B0604020202020204" pitchFamily="34" charset="0"/>
              </a:rPr>
              <a:t>Figure 1.</a:t>
            </a:r>
            <a:endParaRPr lang="fr-FR" dirty="0">
              <a:highlight>
                <a:srgbClr val="FFFF00"/>
              </a:highlight>
              <a:latin typeface="Arial" panose="020B0604020202020204" pitchFamily="34" charset="0"/>
              <a:cs typeface="Arial" panose="020B0604020202020204" pitchFamily="34" charset="0"/>
            </a:endParaRPr>
          </a:p>
        </p:txBody>
      </p:sp>
      <p:sp>
        <p:nvSpPr>
          <p:cNvPr id="3" name="Rectangle : coins arrondis 2">
            <a:extLst>
              <a:ext uri="{FF2B5EF4-FFF2-40B4-BE49-F238E27FC236}">
                <a16:creationId xmlns:a16="http://schemas.microsoft.com/office/drawing/2014/main" id="{2A60742E-AAB1-4B3E-367E-56B448032195}"/>
              </a:ext>
            </a:extLst>
          </p:cNvPr>
          <p:cNvSpPr>
            <a:spLocks noChangeAspect="1"/>
          </p:cNvSpPr>
          <p:nvPr/>
        </p:nvSpPr>
        <p:spPr>
          <a:xfrm>
            <a:off x="553646" y="1092199"/>
            <a:ext cx="519289" cy="518400"/>
          </a:xfrm>
          <a:prstGeom prst="roundRect">
            <a:avLst/>
          </a:prstGeom>
          <a:solidFill>
            <a:schemeClr val="bg1">
              <a:lumMod val="6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fr-FR" sz="2000" dirty="0">
                <a:solidFill>
                  <a:schemeClr val="tx1"/>
                </a:solidFill>
                <a:latin typeface="Arial" panose="020B0604020202020204" pitchFamily="34" charset="0"/>
                <a:cs typeface="Arial" panose="020B0604020202020204" pitchFamily="34" charset="0"/>
              </a:rPr>
              <a:t>C</a:t>
            </a:r>
          </a:p>
        </p:txBody>
      </p:sp>
      <p:sp>
        <p:nvSpPr>
          <p:cNvPr id="5" name="Rectangle : coins arrondis 4">
            <a:extLst>
              <a:ext uri="{FF2B5EF4-FFF2-40B4-BE49-F238E27FC236}">
                <a16:creationId xmlns:a16="http://schemas.microsoft.com/office/drawing/2014/main" id="{D28E735D-B287-A09A-9E88-93524426396F}"/>
              </a:ext>
            </a:extLst>
          </p:cNvPr>
          <p:cNvSpPr>
            <a:spLocks noChangeAspect="1"/>
          </p:cNvSpPr>
          <p:nvPr/>
        </p:nvSpPr>
        <p:spPr>
          <a:xfrm>
            <a:off x="1188646" y="1092199"/>
            <a:ext cx="519289" cy="518400"/>
          </a:xfrm>
          <a:prstGeom prst="roundRect">
            <a:avLst/>
          </a:prstGeom>
          <a:solidFill>
            <a:schemeClr val="bg1">
              <a:lumMod val="6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fr-FR" sz="2000" dirty="0">
                <a:solidFill>
                  <a:schemeClr val="tx1"/>
                </a:solidFill>
                <a:latin typeface="Arial" panose="020B0604020202020204" pitchFamily="34" charset="0"/>
                <a:cs typeface="Arial" panose="020B0604020202020204" pitchFamily="34" charset="0"/>
              </a:rPr>
              <a:t>G</a:t>
            </a:r>
          </a:p>
        </p:txBody>
      </p:sp>
      <p:sp>
        <p:nvSpPr>
          <p:cNvPr id="6" name="Rectangle : coins arrondis 5">
            <a:extLst>
              <a:ext uri="{FF2B5EF4-FFF2-40B4-BE49-F238E27FC236}">
                <a16:creationId xmlns:a16="http://schemas.microsoft.com/office/drawing/2014/main" id="{D38BDE98-642A-539B-B1F2-1D9878E79C15}"/>
              </a:ext>
            </a:extLst>
          </p:cNvPr>
          <p:cNvSpPr>
            <a:spLocks noChangeAspect="1"/>
          </p:cNvSpPr>
          <p:nvPr/>
        </p:nvSpPr>
        <p:spPr>
          <a:xfrm>
            <a:off x="1833523" y="1092199"/>
            <a:ext cx="519289" cy="518400"/>
          </a:xfrm>
          <a:prstGeom prst="roundRect">
            <a:avLst/>
          </a:prstGeom>
          <a:solidFill>
            <a:schemeClr val="bg1">
              <a:lumMod val="6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fr-FR" sz="2000" dirty="0">
                <a:solidFill>
                  <a:schemeClr val="tx1"/>
                </a:solidFill>
                <a:latin typeface="Arial" panose="020B0604020202020204" pitchFamily="34" charset="0"/>
                <a:cs typeface="Arial" panose="020B0604020202020204" pitchFamily="34" charset="0"/>
              </a:rPr>
              <a:t>A</a:t>
            </a:r>
          </a:p>
        </p:txBody>
      </p:sp>
      <p:sp>
        <p:nvSpPr>
          <p:cNvPr id="7" name="Rectangle : coins arrondis 6">
            <a:extLst>
              <a:ext uri="{FF2B5EF4-FFF2-40B4-BE49-F238E27FC236}">
                <a16:creationId xmlns:a16="http://schemas.microsoft.com/office/drawing/2014/main" id="{5F349B5E-5A6C-6477-131D-7CC5D7536535}"/>
              </a:ext>
            </a:extLst>
          </p:cNvPr>
          <p:cNvSpPr>
            <a:spLocks noChangeAspect="1"/>
          </p:cNvSpPr>
          <p:nvPr/>
        </p:nvSpPr>
        <p:spPr>
          <a:xfrm>
            <a:off x="2468523" y="1092199"/>
            <a:ext cx="519289" cy="518400"/>
          </a:xfrm>
          <a:prstGeom prst="roundRect">
            <a:avLst/>
          </a:prstGeom>
          <a:solidFill>
            <a:schemeClr val="bg1">
              <a:lumMod val="6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fr-FR" sz="2000" dirty="0">
                <a:solidFill>
                  <a:schemeClr val="tx1"/>
                </a:solidFill>
                <a:latin typeface="Arial" panose="020B0604020202020204" pitchFamily="34" charset="0"/>
                <a:cs typeface="Arial" panose="020B0604020202020204" pitchFamily="34" charset="0"/>
              </a:rPr>
              <a:t>U</a:t>
            </a:r>
          </a:p>
        </p:txBody>
      </p:sp>
      <p:sp>
        <p:nvSpPr>
          <p:cNvPr id="8" name="ZoneTexte 7">
            <a:extLst>
              <a:ext uri="{FF2B5EF4-FFF2-40B4-BE49-F238E27FC236}">
                <a16:creationId xmlns:a16="http://schemas.microsoft.com/office/drawing/2014/main" id="{A821AA29-8600-99C0-11A8-21EA15940658}"/>
              </a:ext>
            </a:extLst>
          </p:cNvPr>
          <p:cNvSpPr txBox="1"/>
          <p:nvPr/>
        </p:nvSpPr>
        <p:spPr>
          <a:xfrm>
            <a:off x="477470" y="1657927"/>
            <a:ext cx="2460930" cy="276999"/>
          </a:xfrm>
          <a:prstGeom prst="rect">
            <a:avLst/>
          </a:prstGeom>
          <a:noFill/>
        </p:spPr>
        <p:txBody>
          <a:bodyPr wrap="none" rtlCol="0">
            <a:spAutoFit/>
          </a:bodyPr>
          <a:lstStyle/>
          <a:p>
            <a:pPr algn="ctr"/>
            <a:r>
              <a:rPr lang="en-US" sz="1200" dirty="0">
                <a:latin typeface="Arial" panose="020B0604020202020204" pitchFamily="34" charset="0"/>
                <a:cs typeface="Arial" panose="020B0604020202020204" pitchFamily="34" charset="0"/>
              </a:rPr>
              <a:t>4 bases of ribonucleic acid (RNA)</a:t>
            </a:r>
          </a:p>
        </p:txBody>
      </p:sp>
      <p:cxnSp>
        <p:nvCxnSpPr>
          <p:cNvPr id="10" name="Connecteur droit avec flèche 9">
            <a:extLst>
              <a:ext uri="{FF2B5EF4-FFF2-40B4-BE49-F238E27FC236}">
                <a16:creationId xmlns:a16="http://schemas.microsoft.com/office/drawing/2014/main" id="{BFD7D580-0C49-3C84-4FBF-ADE6F257D072}"/>
              </a:ext>
            </a:extLst>
          </p:cNvPr>
          <p:cNvCxnSpPr>
            <a:cxnSpLocks/>
          </p:cNvCxnSpPr>
          <p:nvPr/>
        </p:nvCxnSpPr>
        <p:spPr>
          <a:xfrm>
            <a:off x="3247434" y="1351399"/>
            <a:ext cx="595019" cy="0"/>
          </a:xfrm>
          <a:prstGeom prst="straightConnector1">
            <a:avLst/>
          </a:prstGeom>
          <a:ln w="12700">
            <a:solidFill>
              <a:schemeClr val="tx1">
                <a:lumMod val="95000"/>
                <a:lumOff val="5000"/>
              </a:schemeClr>
            </a:solidFill>
            <a:tailEnd type="triangle" w="lg" len="lg"/>
          </a:ln>
        </p:spPr>
        <p:style>
          <a:lnRef idx="1">
            <a:schemeClr val="accent1"/>
          </a:lnRef>
          <a:fillRef idx="0">
            <a:schemeClr val="accent1"/>
          </a:fillRef>
          <a:effectRef idx="0">
            <a:schemeClr val="accent1"/>
          </a:effectRef>
          <a:fontRef idx="minor">
            <a:schemeClr val="tx1"/>
          </a:fontRef>
        </p:style>
      </p:cxnSp>
      <p:sp>
        <p:nvSpPr>
          <p:cNvPr id="11" name="ZoneTexte 10">
            <a:extLst>
              <a:ext uri="{FF2B5EF4-FFF2-40B4-BE49-F238E27FC236}">
                <a16:creationId xmlns:a16="http://schemas.microsoft.com/office/drawing/2014/main" id="{D6EB00A4-2C41-6D4B-24B6-5EC36ECEFB4A}"/>
              </a:ext>
            </a:extLst>
          </p:cNvPr>
          <p:cNvSpPr txBox="1"/>
          <p:nvPr/>
        </p:nvSpPr>
        <p:spPr>
          <a:xfrm>
            <a:off x="862744" y="393582"/>
            <a:ext cx="1941557" cy="369332"/>
          </a:xfrm>
          <a:prstGeom prst="rect">
            <a:avLst/>
          </a:prstGeom>
          <a:noFill/>
        </p:spPr>
        <p:txBody>
          <a:bodyPr wrap="none" rtlCol="0">
            <a:spAutoFit/>
          </a:bodyPr>
          <a:lstStyle/>
          <a:p>
            <a:pPr algn="ctr"/>
            <a:r>
              <a:rPr lang="en-US" dirty="0">
                <a:latin typeface="Arial" panose="020B0604020202020204" pitchFamily="34" charset="0"/>
                <a:cs typeface="Arial" panose="020B0604020202020204" pitchFamily="34" charset="0"/>
              </a:rPr>
              <a:t>Primary structure</a:t>
            </a:r>
          </a:p>
        </p:txBody>
      </p:sp>
      <p:sp>
        <p:nvSpPr>
          <p:cNvPr id="13" name="ZoneTexte 12">
            <a:extLst>
              <a:ext uri="{FF2B5EF4-FFF2-40B4-BE49-F238E27FC236}">
                <a16:creationId xmlns:a16="http://schemas.microsoft.com/office/drawing/2014/main" id="{EE1AE3DE-A258-7B6F-813F-DF9BECADEDF6}"/>
              </a:ext>
            </a:extLst>
          </p:cNvPr>
          <p:cNvSpPr txBox="1"/>
          <p:nvPr/>
        </p:nvSpPr>
        <p:spPr>
          <a:xfrm>
            <a:off x="4643951" y="393582"/>
            <a:ext cx="2249335" cy="369332"/>
          </a:xfrm>
          <a:prstGeom prst="rect">
            <a:avLst/>
          </a:prstGeom>
          <a:noFill/>
        </p:spPr>
        <p:txBody>
          <a:bodyPr wrap="none" rtlCol="0">
            <a:spAutoFit/>
          </a:bodyPr>
          <a:lstStyle/>
          <a:p>
            <a:pPr algn="ctr"/>
            <a:r>
              <a:rPr lang="en-US" dirty="0">
                <a:latin typeface="Arial" panose="020B0604020202020204" pitchFamily="34" charset="0"/>
                <a:cs typeface="Arial" panose="020B0604020202020204" pitchFamily="34" charset="0"/>
              </a:rPr>
              <a:t>Secondary structure</a:t>
            </a:r>
          </a:p>
        </p:txBody>
      </p:sp>
      <p:sp>
        <p:nvSpPr>
          <p:cNvPr id="14" name="ZoneTexte 13">
            <a:extLst>
              <a:ext uri="{FF2B5EF4-FFF2-40B4-BE49-F238E27FC236}">
                <a16:creationId xmlns:a16="http://schemas.microsoft.com/office/drawing/2014/main" id="{A4FB6B8D-3026-3017-67A8-5D314716CEE4}"/>
              </a:ext>
            </a:extLst>
          </p:cNvPr>
          <p:cNvSpPr txBox="1"/>
          <p:nvPr/>
        </p:nvSpPr>
        <p:spPr>
          <a:xfrm>
            <a:off x="8955338" y="393582"/>
            <a:ext cx="2390399" cy="369332"/>
          </a:xfrm>
          <a:prstGeom prst="rect">
            <a:avLst/>
          </a:prstGeom>
          <a:noFill/>
        </p:spPr>
        <p:txBody>
          <a:bodyPr wrap="none" rtlCol="0">
            <a:spAutoFit/>
          </a:bodyPr>
          <a:lstStyle/>
          <a:p>
            <a:pPr algn="ctr"/>
            <a:r>
              <a:rPr lang="en-US" dirty="0">
                <a:latin typeface="Arial" panose="020B0604020202020204" pitchFamily="34" charset="0"/>
                <a:cs typeface="Arial" panose="020B0604020202020204" pitchFamily="34" charset="0"/>
              </a:rPr>
              <a:t>3D representation ex.</a:t>
            </a:r>
          </a:p>
        </p:txBody>
      </p:sp>
      <p:pic>
        <p:nvPicPr>
          <p:cNvPr id="1026" name="Picture 2" descr="Figure A1. Elements of RNA secondary structure: helix, hairpin loop,... |  Download Scientific Diagram">
            <a:extLst>
              <a:ext uri="{FF2B5EF4-FFF2-40B4-BE49-F238E27FC236}">
                <a16:creationId xmlns:a16="http://schemas.microsoft.com/office/drawing/2014/main" id="{765996E6-9BDF-D48B-3D72-26B5A2FE4479}"/>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b="56831"/>
          <a:stretch/>
        </p:blipFill>
        <p:spPr bwMode="auto">
          <a:xfrm>
            <a:off x="4154407" y="919628"/>
            <a:ext cx="1981893" cy="955046"/>
          </a:xfrm>
          <a:prstGeom prst="rect">
            <a:avLst/>
          </a:prstGeom>
          <a:noFill/>
          <a:extLst>
            <a:ext uri="{909E8E84-426E-40DD-AFC4-6F175D3DCCD1}">
              <a14:hiddenFill xmlns:a14="http://schemas.microsoft.com/office/drawing/2010/main">
                <a:solidFill>
                  <a:srgbClr val="FFFFFF"/>
                </a:solidFill>
              </a14:hiddenFill>
            </a:ext>
          </a:extLst>
        </p:spPr>
      </p:pic>
      <p:pic>
        <p:nvPicPr>
          <p:cNvPr id="15" name="Picture 2" descr="Figure A1. Elements of RNA secondary structure: helix, hairpin loop,... |  Download Scientific Diagram">
            <a:extLst>
              <a:ext uri="{FF2B5EF4-FFF2-40B4-BE49-F238E27FC236}">
                <a16:creationId xmlns:a16="http://schemas.microsoft.com/office/drawing/2014/main" id="{0F92AA93-19A8-57B5-0D6E-3BDA9843356A}"/>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t="57139" b="-5321"/>
          <a:stretch/>
        </p:blipFill>
        <p:spPr bwMode="auto">
          <a:xfrm>
            <a:off x="6136300" y="911735"/>
            <a:ext cx="1981893" cy="1065936"/>
          </a:xfrm>
          <a:prstGeom prst="rect">
            <a:avLst/>
          </a:prstGeom>
          <a:noFill/>
          <a:extLst>
            <a:ext uri="{909E8E84-426E-40DD-AFC4-6F175D3DCCD1}">
              <a14:hiddenFill xmlns:a14="http://schemas.microsoft.com/office/drawing/2010/main">
                <a:solidFill>
                  <a:srgbClr val="FFFFFF"/>
                </a:solidFill>
              </a14:hiddenFill>
            </a:ext>
          </a:extLst>
        </p:spPr>
      </p:pic>
      <p:pic>
        <p:nvPicPr>
          <p:cNvPr id="18" name="Image 17" descr="Une image contenant Police, diagramme, Graphique, texte&#10;&#10;Description générée automatiquement">
            <a:extLst>
              <a:ext uri="{FF2B5EF4-FFF2-40B4-BE49-F238E27FC236}">
                <a16:creationId xmlns:a16="http://schemas.microsoft.com/office/drawing/2014/main" id="{1809C17D-3561-0F8F-6A07-A0BABF0FE051}"/>
              </a:ext>
            </a:extLst>
          </p:cNvPr>
          <p:cNvPicPr>
            <a:picLocks noChangeAspect="1"/>
          </p:cNvPicPr>
          <p:nvPr/>
        </p:nvPicPr>
        <p:blipFill rotWithShape="1">
          <a:blip r:embed="rId4"/>
          <a:srcRect l="4300" t="36871" r="53750" b="20930"/>
          <a:stretch/>
        </p:blipFill>
        <p:spPr>
          <a:xfrm>
            <a:off x="9316669" y="872571"/>
            <a:ext cx="1566834" cy="1093123"/>
          </a:xfrm>
          <a:prstGeom prst="rect">
            <a:avLst/>
          </a:prstGeom>
        </p:spPr>
      </p:pic>
      <p:sp>
        <p:nvSpPr>
          <p:cNvPr id="22" name="ZoneTexte 21">
            <a:extLst>
              <a:ext uri="{FF2B5EF4-FFF2-40B4-BE49-F238E27FC236}">
                <a16:creationId xmlns:a16="http://schemas.microsoft.com/office/drawing/2014/main" id="{51899C76-ED38-A53C-F19D-132403C2C727}"/>
              </a:ext>
            </a:extLst>
          </p:cNvPr>
          <p:cNvSpPr txBox="1"/>
          <p:nvPr/>
        </p:nvSpPr>
        <p:spPr>
          <a:xfrm>
            <a:off x="-990690" y="440316"/>
            <a:ext cx="407484" cy="461665"/>
          </a:xfrm>
          <a:prstGeom prst="rect">
            <a:avLst/>
          </a:prstGeom>
          <a:noFill/>
        </p:spPr>
        <p:txBody>
          <a:bodyPr wrap="none" rtlCol="0">
            <a:spAutoFit/>
          </a:bodyPr>
          <a:lstStyle/>
          <a:p>
            <a:pPr algn="ctr"/>
            <a:r>
              <a:rPr lang="fr-FR" sz="2400" b="1" dirty="0">
                <a:latin typeface="Arial" panose="020B0604020202020204" pitchFamily="34" charset="0"/>
                <a:cs typeface="Arial" panose="020B0604020202020204" pitchFamily="34" charset="0"/>
              </a:rPr>
              <a:t>A</a:t>
            </a:r>
          </a:p>
        </p:txBody>
      </p:sp>
      <p:sp>
        <p:nvSpPr>
          <p:cNvPr id="23" name="ZoneTexte 22">
            <a:extLst>
              <a:ext uri="{FF2B5EF4-FFF2-40B4-BE49-F238E27FC236}">
                <a16:creationId xmlns:a16="http://schemas.microsoft.com/office/drawing/2014/main" id="{4E330E4F-1C47-C20E-2ED7-9E21D2C4A8CE}"/>
              </a:ext>
            </a:extLst>
          </p:cNvPr>
          <p:cNvSpPr txBox="1"/>
          <p:nvPr/>
        </p:nvSpPr>
        <p:spPr>
          <a:xfrm>
            <a:off x="-990690" y="2124236"/>
            <a:ext cx="407484" cy="461665"/>
          </a:xfrm>
          <a:prstGeom prst="rect">
            <a:avLst/>
          </a:prstGeom>
          <a:noFill/>
        </p:spPr>
        <p:txBody>
          <a:bodyPr wrap="none" rtlCol="0">
            <a:spAutoFit/>
          </a:bodyPr>
          <a:lstStyle/>
          <a:p>
            <a:pPr algn="ctr"/>
            <a:r>
              <a:rPr lang="fr-FR" sz="2400" b="1" dirty="0">
                <a:latin typeface="Arial" panose="020B0604020202020204" pitchFamily="34" charset="0"/>
                <a:cs typeface="Arial" panose="020B0604020202020204" pitchFamily="34" charset="0"/>
              </a:rPr>
              <a:t>B</a:t>
            </a:r>
          </a:p>
        </p:txBody>
      </p:sp>
      <p:sp>
        <p:nvSpPr>
          <p:cNvPr id="24" name="ZoneTexte 23">
            <a:extLst>
              <a:ext uri="{FF2B5EF4-FFF2-40B4-BE49-F238E27FC236}">
                <a16:creationId xmlns:a16="http://schemas.microsoft.com/office/drawing/2014/main" id="{408CFE83-6AFD-4DBF-BFFC-80CEF1B50F1B}"/>
              </a:ext>
            </a:extLst>
          </p:cNvPr>
          <p:cNvSpPr txBox="1"/>
          <p:nvPr/>
        </p:nvSpPr>
        <p:spPr>
          <a:xfrm>
            <a:off x="-990690" y="3682507"/>
            <a:ext cx="407484" cy="461665"/>
          </a:xfrm>
          <a:prstGeom prst="rect">
            <a:avLst/>
          </a:prstGeom>
          <a:noFill/>
        </p:spPr>
        <p:txBody>
          <a:bodyPr wrap="none" rtlCol="0">
            <a:spAutoFit/>
          </a:bodyPr>
          <a:lstStyle/>
          <a:p>
            <a:pPr algn="ctr"/>
            <a:r>
              <a:rPr lang="fr-FR" sz="2400" b="1" dirty="0">
                <a:latin typeface="Arial" panose="020B0604020202020204" pitchFamily="34" charset="0"/>
                <a:cs typeface="Arial" panose="020B0604020202020204" pitchFamily="34" charset="0"/>
              </a:rPr>
              <a:t>C</a:t>
            </a:r>
          </a:p>
        </p:txBody>
      </p:sp>
      <p:cxnSp>
        <p:nvCxnSpPr>
          <p:cNvPr id="17" name="Connecteur droit avec flèche 16">
            <a:extLst>
              <a:ext uri="{FF2B5EF4-FFF2-40B4-BE49-F238E27FC236}">
                <a16:creationId xmlns:a16="http://schemas.microsoft.com/office/drawing/2014/main" id="{6718512F-67EC-4D5A-A5CB-067CC6D60398}"/>
              </a:ext>
            </a:extLst>
          </p:cNvPr>
          <p:cNvCxnSpPr>
            <a:cxnSpLocks/>
          </p:cNvCxnSpPr>
          <p:nvPr/>
        </p:nvCxnSpPr>
        <p:spPr>
          <a:xfrm>
            <a:off x="8360319" y="1289013"/>
            <a:ext cx="595019" cy="0"/>
          </a:xfrm>
          <a:prstGeom prst="straightConnector1">
            <a:avLst/>
          </a:prstGeom>
          <a:ln w="12700">
            <a:solidFill>
              <a:schemeClr val="tx1">
                <a:lumMod val="95000"/>
                <a:lumOff val="5000"/>
              </a:schemeClr>
            </a:solidFill>
            <a:tailEnd type="triangle" w="lg" len="lg"/>
          </a:ln>
        </p:spPr>
        <p:style>
          <a:lnRef idx="1">
            <a:schemeClr val="accent1"/>
          </a:lnRef>
          <a:fillRef idx="0">
            <a:schemeClr val="accent1"/>
          </a:fillRef>
          <a:effectRef idx="0">
            <a:schemeClr val="accent1"/>
          </a:effectRef>
          <a:fontRef idx="minor">
            <a:schemeClr val="tx1"/>
          </a:fontRef>
        </p:style>
      </p:cxnSp>
      <p:sp>
        <p:nvSpPr>
          <p:cNvPr id="30" name="ZoneTexte 29">
            <a:extLst>
              <a:ext uri="{FF2B5EF4-FFF2-40B4-BE49-F238E27FC236}">
                <a16:creationId xmlns:a16="http://schemas.microsoft.com/office/drawing/2014/main" id="{E57E762B-5174-CD07-D26D-69B099C5A9F4}"/>
              </a:ext>
            </a:extLst>
          </p:cNvPr>
          <p:cNvSpPr txBox="1"/>
          <p:nvPr/>
        </p:nvSpPr>
        <p:spPr>
          <a:xfrm>
            <a:off x="-990690" y="5422475"/>
            <a:ext cx="407484" cy="461665"/>
          </a:xfrm>
          <a:prstGeom prst="rect">
            <a:avLst/>
          </a:prstGeom>
          <a:noFill/>
        </p:spPr>
        <p:txBody>
          <a:bodyPr wrap="none" rtlCol="0">
            <a:spAutoFit/>
          </a:bodyPr>
          <a:lstStyle/>
          <a:p>
            <a:pPr algn="ctr"/>
            <a:r>
              <a:rPr lang="fr-FR" sz="2400" b="1" dirty="0">
                <a:latin typeface="Arial" panose="020B0604020202020204" pitchFamily="34" charset="0"/>
                <a:cs typeface="Arial" panose="020B0604020202020204" pitchFamily="34" charset="0"/>
              </a:rPr>
              <a:t>D</a:t>
            </a:r>
          </a:p>
        </p:txBody>
      </p:sp>
    </p:spTree>
    <p:extLst>
      <p:ext uri="{BB962C8B-B14F-4D97-AF65-F5344CB8AC3E}">
        <p14:creationId xmlns:p14="http://schemas.microsoft.com/office/powerpoint/2010/main" val="71526840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62E49103-83E1-E43E-03D1-84FBE4D166FA}"/>
              </a:ext>
            </a:extLst>
          </p:cNvPr>
          <p:cNvSpPr txBox="1"/>
          <p:nvPr/>
        </p:nvSpPr>
        <p:spPr>
          <a:xfrm>
            <a:off x="-1013016" y="37990"/>
            <a:ext cx="1095172" cy="369332"/>
          </a:xfrm>
          <a:prstGeom prst="rect">
            <a:avLst/>
          </a:prstGeom>
          <a:noFill/>
        </p:spPr>
        <p:txBody>
          <a:bodyPr wrap="none" rtlCol="0">
            <a:spAutoFit/>
          </a:bodyPr>
          <a:lstStyle/>
          <a:p>
            <a:r>
              <a:rPr lang="fr-FR" dirty="0">
                <a:latin typeface="Arial" panose="020B0604020202020204" pitchFamily="34" charset="0"/>
                <a:cs typeface="Arial" panose="020B0604020202020204" pitchFamily="34" charset="0"/>
              </a:rPr>
              <a:t>Figure 1.</a:t>
            </a:r>
            <a:endParaRPr lang="fr-FR" dirty="0">
              <a:highlight>
                <a:srgbClr val="FFFF00"/>
              </a:highlight>
              <a:latin typeface="Arial" panose="020B0604020202020204" pitchFamily="34" charset="0"/>
              <a:cs typeface="Arial" panose="020B0604020202020204" pitchFamily="34" charset="0"/>
            </a:endParaRPr>
          </a:p>
        </p:txBody>
      </p:sp>
      <p:sp>
        <p:nvSpPr>
          <p:cNvPr id="22" name="ZoneTexte 21">
            <a:extLst>
              <a:ext uri="{FF2B5EF4-FFF2-40B4-BE49-F238E27FC236}">
                <a16:creationId xmlns:a16="http://schemas.microsoft.com/office/drawing/2014/main" id="{51899C76-ED38-A53C-F19D-132403C2C727}"/>
              </a:ext>
            </a:extLst>
          </p:cNvPr>
          <p:cNvSpPr txBox="1"/>
          <p:nvPr/>
        </p:nvSpPr>
        <p:spPr>
          <a:xfrm>
            <a:off x="-990690" y="440316"/>
            <a:ext cx="407484" cy="461665"/>
          </a:xfrm>
          <a:prstGeom prst="rect">
            <a:avLst/>
          </a:prstGeom>
          <a:noFill/>
        </p:spPr>
        <p:txBody>
          <a:bodyPr wrap="none" rtlCol="0">
            <a:spAutoFit/>
          </a:bodyPr>
          <a:lstStyle/>
          <a:p>
            <a:pPr algn="ctr"/>
            <a:r>
              <a:rPr lang="fr-FR" sz="2400" b="1" dirty="0">
                <a:latin typeface="Arial" panose="020B0604020202020204" pitchFamily="34" charset="0"/>
                <a:cs typeface="Arial" panose="020B0604020202020204" pitchFamily="34" charset="0"/>
              </a:rPr>
              <a:t>A</a:t>
            </a:r>
          </a:p>
        </p:txBody>
      </p:sp>
      <p:sp>
        <p:nvSpPr>
          <p:cNvPr id="23" name="ZoneTexte 22">
            <a:extLst>
              <a:ext uri="{FF2B5EF4-FFF2-40B4-BE49-F238E27FC236}">
                <a16:creationId xmlns:a16="http://schemas.microsoft.com/office/drawing/2014/main" id="{4E330E4F-1C47-C20E-2ED7-9E21D2C4A8CE}"/>
              </a:ext>
            </a:extLst>
          </p:cNvPr>
          <p:cNvSpPr txBox="1"/>
          <p:nvPr/>
        </p:nvSpPr>
        <p:spPr>
          <a:xfrm>
            <a:off x="-990690" y="2124236"/>
            <a:ext cx="407484" cy="461665"/>
          </a:xfrm>
          <a:prstGeom prst="rect">
            <a:avLst/>
          </a:prstGeom>
          <a:noFill/>
        </p:spPr>
        <p:txBody>
          <a:bodyPr wrap="none" rtlCol="0">
            <a:spAutoFit/>
          </a:bodyPr>
          <a:lstStyle/>
          <a:p>
            <a:pPr algn="ctr"/>
            <a:r>
              <a:rPr lang="fr-FR" sz="2400" b="1" dirty="0">
                <a:latin typeface="Arial" panose="020B0604020202020204" pitchFamily="34" charset="0"/>
                <a:cs typeface="Arial" panose="020B0604020202020204" pitchFamily="34" charset="0"/>
              </a:rPr>
              <a:t>B</a:t>
            </a:r>
          </a:p>
        </p:txBody>
      </p:sp>
      <p:sp>
        <p:nvSpPr>
          <p:cNvPr id="24" name="ZoneTexte 23">
            <a:extLst>
              <a:ext uri="{FF2B5EF4-FFF2-40B4-BE49-F238E27FC236}">
                <a16:creationId xmlns:a16="http://schemas.microsoft.com/office/drawing/2014/main" id="{408CFE83-6AFD-4DBF-BFFC-80CEF1B50F1B}"/>
              </a:ext>
            </a:extLst>
          </p:cNvPr>
          <p:cNvSpPr txBox="1"/>
          <p:nvPr/>
        </p:nvSpPr>
        <p:spPr>
          <a:xfrm>
            <a:off x="-990690" y="3682507"/>
            <a:ext cx="407484" cy="461665"/>
          </a:xfrm>
          <a:prstGeom prst="rect">
            <a:avLst/>
          </a:prstGeom>
          <a:noFill/>
        </p:spPr>
        <p:txBody>
          <a:bodyPr wrap="none" rtlCol="0">
            <a:spAutoFit/>
          </a:bodyPr>
          <a:lstStyle/>
          <a:p>
            <a:pPr algn="ctr"/>
            <a:r>
              <a:rPr lang="fr-FR" sz="2400" b="1" dirty="0">
                <a:latin typeface="Arial" panose="020B0604020202020204" pitchFamily="34" charset="0"/>
                <a:cs typeface="Arial" panose="020B0604020202020204" pitchFamily="34" charset="0"/>
              </a:rPr>
              <a:t>C</a:t>
            </a:r>
          </a:p>
        </p:txBody>
      </p:sp>
      <p:pic>
        <p:nvPicPr>
          <p:cNvPr id="42" name="Image 41" descr="Une image contenant ballon, violet&#10;&#10;Description générée automatiquement">
            <a:extLst>
              <a:ext uri="{FF2B5EF4-FFF2-40B4-BE49-F238E27FC236}">
                <a16:creationId xmlns:a16="http://schemas.microsoft.com/office/drawing/2014/main" id="{70881D76-DF7C-B3CB-D46F-AF5360C484E1}"/>
              </a:ext>
            </a:extLst>
          </p:cNvPr>
          <p:cNvPicPr>
            <a:picLocks noChangeAspect="1"/>
          </p:cNvPicPr>
          <p:nvPr/>
        </p:nvPicPr>
        <p:blipFill>
          <a:blip r:embed="rId3"/>
          <a:stretch>
            <a:fillRect/>
          </a:stretch>
        </p:blipFill>
        <p:spPr>
          <a:xfrm>
            <a:off x="3153142" y="2883149"/>
            <a:ext cx="684428" cy="330905"/>
          </a:xfrm>
          <a:prstGeom prst="rect">
            <a:avLst/>
          </a:prstGeom>
        </p:spPr>
      </p:pic>
      <p:sp>
        <p:nvSpPr>
          <p:cNvPr id="43" name="ZoneTexte 42">
            <a:extLst>
              <a:ext uri="{FF2B5EF4-FFF2-40B4-BE49-F238E27FC236}">
                <a16:creationId xmlns:a16="http://schemas.microsoft.com/office/drawing/2014/main" id="{BE03EC00-1E55-336E-26E5-62D5E40BC848}"/>
              </a:ext>
            </a:extLst>
          </p:cNvPr>
          <p:cNvSpPr txBox="1"/>
          <p:nvPr/>
        </p:nvSpPr>
        <p:spPr>
          <a:xfrm>
            <a:off x="2850126" y="3155910"/>
            <a:ext cx="1223412" cy="461665"/>
          </a:xfrm>
          <a:prstGeom prst="rect">
            <a:avLst/>
          </a:prstGeom>
          <a:noFill/>
        </p:spPr>
        <p:txBody>
          <a:bodyPr wrap="none" rtlCol="0">
            <a:spAutoFit/>
          </a:bodyPr>
          <a:lstStyle/>
          <a:p>
            <a:pPr algn="ctr"/>
            <a:r>
              <a:rPr lang="fr-FR" sz="1200" dirty="0">
                <a:latin typeface="Arial" panose="020B0604020202020204" pitchFamily="34" charset="0"/>
                <a:cs typeface="Arial" panose="020B0604020202020204" pitchFamily="34" charset="0"/>
              </a:rPr>
              <a:t>Small </a:t>
            </a:r>
            <a:r>
              <a:rPr lang="fr-FR" sz="1200" dirty="0" err="1">
                <a:latin typeface="Arial" panose="020B0604020202020204" pitchFamily="34" charset="0"/>
                <a:cs typeface="Arial" panose="020B0604020202020204" pitchFamily="34" charset="0"/>
              </a:rPr>
              <a:t>molecule</a:t>
            </a:r>
            <a:endParaRPr lang="fr-FR" sz="1200" dirty="0">
              <a:latin typeface="Arial" panose="020B0604020202020204" pitchFamily="34" charset="0"/>
              <a:cs typeface="Arial" panose="020B0604020202020204" pitchFamily="34" charset="0"/>
            </a:endParaRPr>
          </a:p>
          <a:p>
            <a:pPr algn="ctr"/>
            <a:r>
              <a:rPr lang="fr-FR" sz="1200" dirty="0">
                <a:latin typeface="Arial" panose="020B0604020202020204" pitchFamily="34" charset="0"/>
                <a:cs typeface="Arial" panose="020B0604020202020204" pitchFamily="34" charset="0"/>
              </a:rPr>
              <a:t>(SM)</a:t>
            </a:r>
          </a:p>
        </p:txBody>
      </p:sp>
      <p:pic>
        <p:nvPicPr>
          <p:cNvPr id="35" name="Image 34" descr="Une image contenant ligne, conception&#10;&#10;Description générée automatiquement">
            <a:extLst>
              <a:ext uri="{FF2B5EF4-FFF2-40B4-BE49-F238E27FC236}">
                <a16:creationId xmlns:a16="http://schemas.microsoft.com/office/drawing/2014/main" id="{8CA8D178-290B-78A9-ED80-DD6BD0F68229}"/>
              </a:ext>
            </a:extLst>
          </p:cNvPr>
          <p:cNvPicPr>
            <a:picLocks noChangeAspect="1"/>
          </p:cNvPicPr>
          <p:nvPr/>
        </p:nvPicPr>
        <p:blipFill rotWithShape="1">
          <a:blip r:embed="rId4"/>
          <a:srcRect b="33757"/>
          <a:stretch/>
        </p:blipFill>
        <p:spPr>
          <a:xfrm rot="10800000">
            <a:off x="5304794" y="2372930"/>
            <a:ext cx="1156447" cy="266174"/>
          </a:xfrm>
          <a:prstGeom prst="rect">
            <a:avLst/>
          </a:prstGeom>
        </p:spPr>
      </p:pic>
      <p:grpSp>
        <p:nvGrpSpPr>
          <p:cNvPr id="46" name="Groupe 45">
            <a:extLst>
              <a:ext uri="{FF2B5EF4-FFF2-40B4-BE49-F238E27FC236}">
                <a16:creationId xmlns:a16="http://schemas.microsoft.com/office/drawing/2014/main" id="{197E7028-FD43-EB5A-7E1B-D66318DA65F2}"/>
              </a:ext>
            </a:extLst>
          </p:cNvPr>
          <p:cNvGrpSpPr/>
          <p:nvPr/>
        </p:nvGrpSpPr>
        <p:grpSpPr>
          <a:xfrm>
            <a:off x="422074" y="2613141"/>
            <a:ext cx="2249319" cy="271358"/>
            <a:chOff x="1813741" y="2652596"/>
            <a:chExt cx="2249319" cy="271358"/>
          </a:xfrm>
        </p:grpSpPr>
        <p:pic>
          <p:nvPicPr>
            <p:cNvPr id="44" name="Image 43" descr="Une image contenant Police, ligne, conception&#10;&#10;Description générée automatiquement">
              <a:extLst>
                <a:ext uri="{FF2B5EF4-FFF2-40B4-BE49-F238E27FC236}">
                  <a16:creationId xmlns:a16="http://schemas.microsoft.com/office/drawing/2014/main" id="{195991D8-1C9C-6C87-2467-8D7C6D7E4D3F}"/>
                </a:ext>
              </a:extLst>
            </p:cNvPr>
            <p:cNvPicPr>
              <a:picLocks noChangeAspect="1"/>
            </p:cNvPicPr>
            <p:nvPr/>
          </p:nvPicPr>
          <p:blipFill rotWithShape="1">
            <a:blip r:embed="rId5"/>
            <a:srcRect r="2748" b="32467"/>
            <a:stretch/>
          </p:blipFill>
          <p:spPr>
            <a:xfrm>
              <a:off x="1813741" y="2652596"/>
              <a:ext cx="1124660" cy="271358"/>
            </a:xfrm>
            <a:prstGeom prst="rect">
              <a:avLst/>
            </a:prstGeom>
          </p:spPr>
        </p:pic>
        <p:pic>
          <p:nvPicPr>
            <p:cNvPr id="45" name="Image 44" descr="Une image contenant Police, ligne, conception&#10;&#10;Description générée automatiquement">
              <a:extLst>
                <a:ext uri="{FF2B5EF4-FFF2-40B4-BE49-F238E27FC236}">
                  <a16:creationId xmlns:a16="http://schemas.microsoft.com/office/drawing/2014/main" id="{7CB59089-B57C-0A3A-4AFC-FF7942CB013C}"/>
                </a:ext>
              </a:extLst>
            </p:cNvPr>
            <p:cNvPicPr>
              <a:picLocks noChangeAspect="1"/>
            </p:cNvPicPr>
            <p:nvPr/>
          </p:nvPicPr>
          <p:blipFill rotWithShape="1">
            <a:blip r:embed="rId5"/>
            <a:srcRect l="2748" b="32467"/>
            <a:stretch/>
          </p:blipFill>
          <p:spPr>
            <a:xfrm>
              <a:off x="2938400" y="2652596"/>
              <a:ext cx="1124660" cy="271358"/>
            </a:xfrm>
            <a:prstGeom prst="rect">
              <a:avLst/>
            </a:prstGeom>
          </p:spPr>
        </p:pic>
      </p:grpSp>
      <p:sp>
        <p:nvSpPr>
          <p:cNvPr id="47" name="ZoneTexte 46">
            <a:extLst>
              <a:ext uri="{FF2B5EF4-FFF2-40B4-BE49-F238E27FC236}">
                <a16:creationId xmlns:a16="http://schemas.microsoft.com/office/drawing/2014/main" id="{D291255A-7CA0-F42C-DF1B-35E0278E6F56}"/>
              </a:ext>
            </a:extLst>
          </p:cNvPr>
          <p:cNvSpPr txBox="1"/>
          <p:nvPr/>
        </p:nvSpPr>
        <p:spPr>
          <a:xfrm>
            <a:off x="1228376" y="2907884"/>
            <a:ext cx="636713" cy="276999"/>
          </a:xfrm>
          <a:prstGeom prst="rect">
            <a:avLst/>
          </a:prstGeom>
          <a:noFill/>
        </p:spPr>
        <p:txBody>
          <a:bodyPr wrap="none" rtlCol="0">
            <a:spAutoFit/>
          </a:bodyPr>
          <a:lstStyle/>
          <a:p>
            <a:pPr algn="ctr"/>
            <a:r>
              <a:rPr lang="fr-FR" sz="1200" dirty="0" err="1">
                <a:latin typeface="Arial" panose="020B0604020202020204" pitchFamily="34" charset="0"/>
                <a:cs typeface="Arial" panose="020B0604020202020204" pitchFamily="34" charset="0"/>
              </a:rPr>
              <a:t>mRNA</a:t>
            </a:r>
            <a:endParaRPr lang="fr-FR" sz="1200" dirty="0">
              <a:latin typeface="Arial" panose="020B0604020202020204" pitchFamily="34" charset="0"/>
              <a:cs typeface="Arial" panose="020B0604020202020204" pitchFamily="34" charset="0"/>
            </a:endParaRPr>
          </a:p>
        </p:txBody>
      </p:sp>
      <p:grpSp>
        <p:nvGrpSpPr>
          <p:cNvPr id="48" name="Groupe 47">
            <a:extLst>
              <a:ext uri="{FF2B5EF4-FFF2-40B4-BE49-F238E27FC236}">
                <a16:creationId xmlns:a16="http://schemas.microsoft.com/office/drawing/2014/main" id="{77D99986-4552-B563-3D82-7CBACFF0DE2F}"/>
              </a:ext>
            </a:extLst>
          </p:cNvPr>
          <p:cNvGrpSpPr/>
          <p:nvPr/>
        </p:nvGrpSpPr>
        <p:grpSpPr>
          <a:xfrm>
            <a:off x="4212197" y="2608139"/>
            <a:ext cx="2249319" cy="271358"/>
            <a:chOff x="1813741" y="2652596"/>
            <a:chExt cx="2249319" cy="271358"/>
          </a:xfrm>
        </p:grpSpPr>
        <p:pic>
          <p:nvPicPr>
            <p:cNvPr id="49" name="Image 48" descr="Une image contenant Police, ligne, conception&#10;&#10;Description générée automatiquement">
              <a:extLst>
                <a:ext uri="{FF2B5EF4-FFF2-40B4-BE49-F238E27FC236}">
                  <a16:creationId xmlns:a16="http://schemas.microsoft.com/office/drawing/2014/main" id="{6433FDF6-02C1-F107-A750-A7814CC045DD}"/>
                </a:ext>
              </a:extLst>
            </p:cNvPr>
            <p:cNvPicPr>
              <a:picLocks noChangeAspect="1"/>
            </p:cNvPicPr>
            <p:nvPr/>
          </p:nvPicPr>
          <p:blipFill rotWithShape="1">
            <a:blip r:embed="rId5"/>
            <a:srcRect r="2748" b="32467"/>
            <a:stretch/>
          </p:blipFill>
          <p:spPr>
            <a:xfrm>
              <a:off x="1813741" y="2652596"/>
              <a:ext cx="1124660" cy="271358"/>
            </a:xfrm>
            <a:prstGeom prst="rect">
              <a:avLst/>
            </a:prstGeom>
          </p:spPr>
        </p:pic>
        <p:pic>
          <p:nvPicPr>
            <p:cNvPr id="50" name="Image 49" descr="Une image contenant Police, ligne, conception&#10;&#10;Description générée automatiquement">
              <a:extLst>
                <a:ext uri="{FF2B5EF4-FFF2-40B4-BE49-F238E27FC236}">
                  <a16:creationId xmlns:a16="http://schemas.microsoft.com/office/drawing/2014/main" id="{0119B22F-83C0-05B0-7C8C-6C4BE59E6516}"/>
                </a:ext>
              </a:extLst>
            </p:cNvPr>
            <p:cNvPicPr>
              <a:picLocks noChangeAspect="1"/>
            </p:cNvPicPr>
            <p:nvPr/>
          </p:nvPicPr>
          <p:blipFill rotWithShape="1">
            <a:blip r:embed="rId5"/>
            <a:srcRect l="2748" b="32467"/>
            <a:stretch/>
          </p:blipFill>
          <p:spPr>
            <a:xfrm>
              <a:off x="2938400" y="2652596"/>
              <a:ext cx="1124660" cy="271358"/>
            </a:xfrm>
            <a:prstGeom prst="rect">
              <a:avLst/>
            </a:prstGeom>
          </p:spPr>
        </p:pic>
      </p:grpSp>
      <p:sp>
        <p:nvSpPr>
          <p:cNvPr id="51" name="ZoneTexte 50">
            <a:extLst>
              <a:ext uri="{FF2B5EF4-FFF2-40B4-BE49-F238E27FC236}">
                <a16:creationId xmlns:a16="http://schemas.microsoft.com/office/drawing/2014/main" id="{15BAF559-B3F8-9367-DF31-5F47C0DC2874}"/>
              </a:ext>
            </a:extLst>
          </p:cNvPr>
          <p:cNvSpPr txBox="1"/>
          <p:nvPr/>
        </p:nvSpPr>
        <p:spPr>
          <a:xfrm>
            <a:off x="4229930" y="2912148"/>
            <a:ext cx="2218429" cy="276999"/>
          </a:xfrm>
          <a:prstGeom prst="rect">
            <a:avLst/>
          </a:prstGeom>
          <a:noFill/>
        </p:spPr>
        <p:txBody>
          <a:bodyPr wrap="none" rtlCol="0">
            <a:spAutoFit/>
          </a:bodyPr>
          <a:lstStyle/>
          <a:p>
            <a:pPr algn="ctr"/>
            <a:r>
              <a:rPr lang="fr-FR" sz="1200" dirty="0">
                <a:latin typeface="Arial" panose="020B0604020202020204" pitchFamily="34" charset="0"/>
                <a:cs typeface="Arial" panose="020B0604020202020204" pitchFamily="34" charset="0"/>
              </a:rPr>
              <a:t>SM vs ASO binding  to </a:t>
            </a:r>
            <a:r>
              <a:rPr lang="fr-FR" sz="1200" dirty="0" err="1">
                <a:latin typeface="Arial" panose="020B0604020202020204" pitchFamily="34" charset="0"/>
                <a:cs typeface="Arial" panose="020B0604020202020204" pitchFamily="34" charset="0"/>
              </a:rPr>
              <a:t>mRNA</a:t>
            </a:r>
            <a:endParaRPr lang="fr-FR" sz="1200" dirty="0">
              <a:latin typeface="Arial" panose="020B0604020202020204" pitchFamily="34" charset="0"/>
              <a:cs typeface="Arial" panose="020B0604020202020204" pitchFamily="34" charset="0"/>
            </a:endParaRPr>
          </a:p>
        </p:txBody>
      </p:sp>
      <p:pic>
        <p:nvPicPr>
          <p:cNvPr id="52" name="Image 51" descr="Une image contenant ligne, conception&#10;&#10;Description générée automatiquement">
            <a:extLst>
              <a:ext uri="{FF2B5EF4-FFF2-40B4-BE49-F238E27FC236}">
                <a16:creationId xmlns:a16="http://schemas.microsoft.com/office/drawing/2014/main" id="{891710A7-E88A-9019-8A33-07DF144BFD2C}"/>
              </a:ext>
            </a:extLst>
          </p:cNvPr>
          <p:cNvPicPr>
            <a:picLocks noChangeAspect="1"/>
          </p:cNvPicPr>
          <p:nvPr/>
        </p:nvPicPr>
        <p:blipFill rotWithShape="1">
          <a:blip r:embed="rId4"/>
          <a:srcRect b="33757"/>
          <a:stretch/>
        </p:blipFill>
        <p:spPr>
          <a:xfrm rot="10800000">
            <a:off x="3060317" y="2427352"/>
            <a:ext cx="893276" cy="205601"/>
          </a:xfrm>
          <a:prstGeom prst="rect">
            <a:avLst/>
          </a:prstGeom>
        </p:spPr>
      </p:pic>
      <p:sp>
        <p:nvSpPr>
          <p:cNvPr id="53" name="ZoneTexte 52">
            <a:extLst>
              <a:ext uri="{FF2B5EF4-FFF2-40B4-BE49-F238E27FC236}">
                <a16:creationId xmlns:a16="http://schemas.microsoft.com/office/drawing/2014/main" id="{C0F360F4-0D0E-EBB4-28D4-8399B153A4C7}"/>
              </a:ext>
            </a:extLst>
          </p:cNvPr>
          <p:cNvSpPr txBox="1"/>
          <p:nvPr/>
        </p:nvSpPr>
        <p:spPr>
          <a:xfrm>
            <a:off x="3223602" y="2134259"/>
            <a:ext cx="510076" cy="276999"/>
          </a:xfrm>
          <a:prstGeom prst="rect">
            <a:avLst/>
          </a:prstGeom>
          <a:noFill/>
        </p:spPr>
        <p:txBody>
          <a:bodyPr wrap="none" rtlCol="0">
            <a:spAutoFit/>
          </a:bodyPr>
          <a:lstStyle/>
          <a:p>
            <a:pPr algn="ctr"/>
            <a:r>
              <a:rPr lang="fr-FR" sz="1200" dirty="0">
                <a:latin typeface="Arial" panose="020B0604020202020204" pitchFamily="34" charset="0"/>
                <a:cs typeface="Arial" panose="020B0604020202020204" pitchFamily="34" charset="0"/>
              </a:rPr>
              <a:t>ASO</a:t>
            </a:r>
          </a:p>
        </p:txBody>
      </p:sp>
      <p:cxnSp>
        <p:nvCxnSpPr>
          <p:cNvPr id="54" name="Connecteur droit avec flèche 53">
            <a:extLst>
              <a:ext uri="{FF2B5EF4-FFF2-40B4-BE49-F238E27FC236}">
                <a16:creationId xmlns:a16="http://schemas.microsoft.com/office/drawing/2014/main" id="{05012932-FB87-9791-5090-E6D1107DC0ED}"/>
              </a:ext>
            </a:extLst>
          </p:cNvPr>
          <p:cNvCxnSpPr>
            <a:cxnSpLocks/>
          </p:cNvCxnSpPr>
          <p:nvPr/>
        </p:nvCxnSpPr>
        <p:spPr>
          <a:xfrm>
            <a:off x="3197846" y="2755881"/>
            <a:ext cx="595019" cy="0"/>
          </a:xfrm>
          <a:prstGeom prst="straightConnector1">
            <a:avLst/>
          </a:prstGeom>
          <a:ln w="12700">
            <a:solidFill>
              <a:schemeClr val="tx1">
                <a:lumMod val="95000"/>
                <a:lumOff val="5000"/>
              </a:schemeClr>
            </a:solidFill>
            <a:tailEnd type="triangle" w="lg" len="lg"/>
          </a:ln>
        </p:spPr>
        <p:style>
          <a:lnRef idx="1">
            <a:schemeClr val="accent1"/>
          </a:lnRef>
          <a:fillRef idx="0">
            <a:schemeClr val="accent1"/>
          </a:fillRef>
          <a:effectRef idx="0">
            <a:schemeClr val="accent1"/>
          </a:effectRef>
          <a:fontRef idx="minor">
            <a:schemeClr val="tx1"/>
          </a:fontRef>
        </p:style>
      </p:cxnSp>
      <p:pic>
        <p:nvPicPr>
          <p:cNvPr id="41" name="Image 40" descr="Une image contenant ballon, violet&#10;&#10;Description générée automatiquement">
            <a:extLst>
              <a:ext uri="{FF2B5EF4-FFF2-40B4-BE49-F238E27FC236}">
                <a16:creationId xmlns:a16="http://schemas.microsoft.com/office/drawing/2014/main" id="{7037D7E2-C518-9171-B793-3F777E74D4A4}"/>
              </a:ext>
            </a:extLst>
          </p:cNvPr>
          <p:cNvPicPr>
            <a:picLocks noChangeAspect="1"/>
          </p:cNvPicPr>
          <p:nvPr/>
        </p:nvPicPr>
        <p:blipFill>
          <a:blip r:embed="rId3"/>
          <a:stretch>
            <a:fillRect/>
          </a:stretch>
        </p:blipFill>
        <p:spPr>
          <a:xfrm rot="18495622">
            <a:off x="4381939" y="2457486"/>
            <a:ext cx="586839" cy="283723"/>
          </a:xfrm>
          <a:prstGeom prst="rect">
            <a:avLst/>
          </a:prstGeom>
        </p:spPr>
      </p:pic>
      <p:sp>
        <p:nvSpPr>
          <p:cNvPr id="55" name="ZoneTexte 54">
            <a:extLst>
              <a:ext uri="{FF2B5EF4-FFF2-40B4-BE49-F238E27FC236}">
                <a16:creationId xmlns:a16="http://schemas.microsoft.com/office/drawing/2014/main" id="{7E13D4E2-164A-265C-3B3B-C22DD2B73EC1}"/>
              </a:ext>
            </a:extLst>
          </p:cNvPr>
          <p:cNvSpPr txBox="1"/>
          <p:nvPr/>
        </p:nvSpPr>
        <p:spPr>
          <a:xfrm>
            <a:off x="4494424" y="2151330"/>
            <a:ext cx="415499" cy="276999"/>
          </a:xfrm>
          <a:prstGeom prst="rect">
            <a:avLst/>
          </a:prstGeom>
          <a:noFill/>
        </p:spPr>
        <p:txBody>
          <a:bodyPr wrap="none" rtlCol="0">
            <a:spAutoFit/>
          </a:bodyPr>
          <a:lstStyle/>
          <a:p>
            <a:pPr algn="ctr"/>
            <a:r>
              <a:rPr lang="fr-FR" sz="1200" dirty="0">
                <a:latin typeface="Arial" panose="020B0604020202020204" pitchFamily="34" charset="0"/>
                <a:cs typeface="Arial" panose="020B0604020202020204" pitchFamily="34" charset="0"/>
              </a:rPr>
              <a:t>SM</a:t>
            </a:r>
          </a:p>
        </p:txBody>
      </p:sp>
      <p:sp>
        <p:nvSpPr>
          <p:cNvPr id="56" name="ZoneTexte 55">
            <a:extLst>
              <a:ext uri="{FF2B5EF4-FFF2-40B4-BE49-F238E27FC236}">
                <a16:creationId xmlns:a16="http://schemas.microsoft.com/office/drawing/2014/main" id="{39F2F2AF-DC2B-1887-238B-ADC25120B9F6}"/>
              </a:ext>
            </a:extLst>
          </p:cNvPr>
          <p:cNvSpPr txBox="1"/>
          <p:nvPr/>
        </p:nvSpPr>
        <p:spPr>
          <a:xfrm>
            <a:off x="5619513" y="2115790"/>
            <a:ext cx="510076" cy="276999"/>
          </a:xfrm>
          <a:prstGeom prst="rect">
            <a:avLst/>
          </a:prstGeom>
          <a:noFill/>
        </p:spPr>
        <p:txBody>
          <a:bodyPr wrap="none" rtlCol="0">
            <a:spAutoFit/>
          </a:bodyPr>
          <a:lstStyle/>
          <a:p>
            <a:pPr algn="ctr"/>
            <a:r>
              <a:rPr lang="fr-FR" sz="1200" dirty="0">
                <a:latin typeface="Arial" panose="020B0604020202020204" pitchFamily="34" charset="0"/>
                <a:cs typeface="Arial" panose="020B0604020202020204" pitchFamily="34" charset="0"/>
              </a:rPr>
              <a:t>ASO</a:t>
            </a:r>
          </a:p>
        </p:txBody>
      </p:sp>
      <p:sp>
        <p:nvSpPr>
          <p:cNvPr id="30" name="ZoneTexte 29">
            <a:extLst>
              <a:ext uri="{FF2B5EF4-FFF2-40B4-BE49-F238E27FC236}">
                <a16:creationId xmlns:a16="http://schemas.microsoft.com/office/drawing/2014/main" id="{E57E762B-5174-CD07-D26D-69B099C5A9F4}"/>
              </a:ext>
            </a:extLst>
          </p:cNvPr>
          <p:cNvSpPr txBox="1"/>
          <p:nvPr/>
        </p:nvSpPr>
        <p:spPr>
          <a:xfrm>
            <a:off x="-990690" y="5422475"/>
            <a:ext cx="407484" cy="461665"/>
          </a:xfrm>
          <a:prstGeom prst="rect">
            <a:avLst/>
          </a:prstGeom>
          <a:noFill/>
        </p:spPr>
        <p:txBody>
          <a:bodyPr wrap="none" rtlCol="0">
            <a:spAutoFit/>
          </a:bodyPr>
          <a:lstStyle/>
          <a:p>
            <a:pPr algn="ctr"/>
            <a:r>
              <a:rPr lang="fr-FR" sz="2400" b="1" dirty="0">
                <a:latin typeface="Arial" panose="020B0604020202020204" pitchFamily="34" charset="0"/>
                <a:cs typeface="Arial" panose="020B0604020202020204" pitchFamily="34" charset="0"/>
              </a:rPr>
              <a:t>D</a:t>
            </a:r>
          </a:p>
        </p:txBody>
      </p:sp>
      <p:sp>
        <p:nvSpPr>
          <p:cNvPr id="31" name="ZoneTexte 30">
            <a:extLst>
              <a:ext uri="{FF2B5EF4-FFF2-40B4-BE49-F238E27FC236}">
                <a16:creationId xmlns:a16="http://schemas.microsoft.com/office/drawing/2014/main" id="{422E13CF-EA4A-C7FC-D7C2-39A2B1276AFE}"/>
              </a:ext>
            </a:extLst>
          </p:cNvPr>
          <p:cNvSpPr txBox="1"/>
          <p:nvPr/>
        </p:nvSpPr>
        <p:spPr>
          <a:xfrm>
            <a:off x="6640480" y="2249396"/>
            <a:ext cx="5551520" cy="923330"/>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Targeting RNA</a:t>
            </a:r>
          </a:p>
          <a:p>
            <a:pPr marL="285750" indent="-285750">
              <a:buFont typeface="Arial" panose="020B0604020202020204" pitchFamily="34" charset="0"/>
              <a:buChar char="•"/>
            </a:pPr>
            <a:r>
              <a:rPr lang="en-US" dirty="0">
                <a:latin typeface="Arial" panose="020B0604020202020204" pitchFamily="34" charset="0"/>
                <a:cs typeface="Arial" panose="020B0604020202020204" pitchFamily="34" charset="0"/>
              </a:rPr>
              <a:t>ASO: high specificity but delivery issues</a:t>
            </a:r>
          </a:p>
          <a:p>
            <a:pPr marL="285750" indent="-285750">
              <a:buFont typeface="Arial" panose="020B0604020202020204" pitchFamily="34" charset="0"/>
              <a:buChar char="•"/>
            </a:pPr>
            <a:r>
              <a:rPr lang="en-US" dirty="0">
                <a:latin typeface="Arial" panose="020B0604020202020204" pitchFamily="34" charset="0"/>
                <a:cs typeface="Arial" panose="020B0604020202020204" pitchFamily="34" charset="0"/>
              </a:rPr>
              <a:t>Small molecule: reasonable cost and less specific</a:t>
            </a:r>
          </a:p>
        </p:txBody>
      </p:sp>
    </p:spTree>
    <p:extLst>
      <p:ext uri="{BB962C8B-B14F-4D97-AF65-F5344CB8AC3E}">
        <p14:creationId xmlns:p14="http://schemas.microsoft.com/office/powerpoint/2010/main" val="131303941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62E49103-83E1-E43E-03D1-84FBE4D166FA}"/>
              </a:ext>
            </a:extLst>
          </p:cNvPr>
          <p:cNvSpPr txBox="1"/>
          <p:nvPr/>
        </p:nvSpPr>
        <p:spPr>
          <a:xfrm>
            <a:off x="-1001727" y="37990"/>
            <a:ext cx="1095172" cy="369332"/>
          </a:xfrm>
          <a:prstGeom prst="rect">
            <a:avLst/>
          </a:prstGeom>
          <a:noFill/>
        </p:spPr>
        <p:txBody>
          <a:bodyPr wrap="none" rtlCol="0">
            <a:spAutoFit/>
          </a:bodyPr>
          <a:lstStyle/>
          <a:p>
            <a:r>
              <a:rPr lang="fr-FR" dirty="0">
                <a:latin typeface="Arial" panose="020B0604020202020204" pitchFamily="34" charset="0"/>
                <a:cs typeface="Arial" panose="020B0604020202020204" pitchFamily="34" charset="0"/>
              </a:rPr>
              <a:t>Figure 1.</a:t>
            </a:r>
            <a:endParaRPr lang="fr-FR" dirty="0">
              <a:highlight>
                <a:srgbClr val="FFFF00"/>
              </a:highlight>
              <a:latin typeface="Arial" panose="020B0604020202020204" pitchFamily="34" charset="0"/>
              <a:cs typeface="Arial" panose="020B0604020202020204" pitchFamily="34" charset="0"/>
            </a:endParaRPr>
          </a:p>
        </p:txBody>
      </p:sp>
      <p:pic>
        <p:nvPicPr>
          <p:cNvPr id="19" name="Image 18" descr="Une image contenant art&#10;&#10;Description générée automatiquement">
            <a:extLst>
              <a:ext uri="{FF2B5EF4-FFF2-40B4-BE49-F238E27FC236}">
                <a16:creationId xmlns:a16="http://schemas.microsoft.com/office/drawing/2014/main" id="{D0845451-D0B5-50FE-CB05-AF17A56E38AB}"/>
              </a:ext>
            </a:extLst>
          </p:cNvPr>
          <p:cNvPicPr>
            <a:picLocks noChangeAspect="1"/>
          </p:cNvPicPr>
          <p:nvPr/>
        </p:nvPicPr>
        <p:blipFill>
          <a:blip r:embed="rId3"/>
          <a:stretch>
            <a:fillRect/>
          </a:stretch>
        </p:blipFill>
        <p:spPr>
          <a:xfrm>
            <a:off x="825804" y="3923491"/>
            <a:ext cx="1711127" cy="955047"/>
          </a:xfrm>
          <a:prstGeom prst="rect">
            <a:avLst/>
          </a:prstGeom>
        </p:spPr>
      </p:pic>
      <p:sp>
        <p:nvSpPr>
          <p:cNvPr id="20" name="ZoneTexte 19">
            <a:extLst>
              <a:ext uri="{FF2B5EF4-FFF2-40B4-BE49-F238E27FC236}">
                <a16:creationId xmlns:a16="http://schemas.microsoft.com/office/drawing/2014/main" id="{927B4414-87CA-3F33-0CE1-BD53C0B98658}"/>
              </a:ext>
            </a:extLst>
          </p:cNvPr>
          <p:cNvSpPr txBox="1"/>
          <p:nvPr/>
        </p:nvSpPr>
        <p:spPr>
          <a:xfrm>
            <a:off x="683209" y="4876009"/>
            <a:ext cx="2060179" cy="276999"/>
          </a:xfrm>
          <a:prstGeom prst="rect">
            <a:avLst/>
          </a:prstGeom>
          <a:noFill/>
        </p:spPr>
        <p:txBody>
          <a:bodyPr wrap="none" rtlCol="0">
            <a:spAutoFit/>
          </a:bodyPr>
          <a:lstStyle/>
          <a:p>
            <a:pPr algn="ctr"/>
            <a:r>
              <a:rPr lang="en-US" sz="1200" dirty="0">
                <a:latin typeface="Arial" panose="020B0604020202020204" pitchFamily="34" charset="0"/>
                <a:cs typeface="Arial" panose="020B0604020202020204" pitchFamily="34" charset="0"/>
              </a:rPr>
              <a:t>RNA-Binding Protein (RBP)</a:t>
            </a:r>
          </a:p>
        </p:txBody>
      </p:sp>
      <p:pic>
        <p:nvPicPr>
          <p:cNvPr id="21" name="Image 20" descr="Une image contenant ballon, violet&#10;&#10;Description générée automatiquement">
            <a:extLst>
              <a:ext uri="{FF2B5EF4-FFF2-40B4-BE49-F238E27FC236}">
                <a16:creationId xmlns:a16="http://schemas.microsoft.com/office/drawing/2014/main" id="{B725D99B-A2B9-34DB-B43F-EA7FE308F844}"/>
              </a:ext>
            </a:extLst>
          </p:cNvPr>
          <p:cNvPicPr>
            <a:picLocks noChangeAspect="1"/>
          </p:cNvPicPr>
          <p:nvPr/>
        </p:nvPicPr>
        <p:blipFill>
          <a:blip r:embed="rId4"/>
          <a:stretch>
            <a:fillRect/>
          </a:stretch>
        </p:blipFill>
        <p:spPr>
          <a:xfrm>
            <a:off x="2574705" y="3728708"/>
            <a:ext cx="986025" cy="476720"/>
          </a:xfrm>
          <a:prstGeom prst="rect">
            <a:avLst/>
          </a:prstGeom>
        </p:spPr>
      </p:pic>
      <p:sp>
        <p:nvSpPr>
          <p:cNvPr id="22" name="ZoneTexte 21">
            <a:extLst>
              <a:ext uri="{FF2B5EF4-FFF2-40B4-BE49-F238E27FC236}">
                <a16:creationId xmlns:a16="http://schemas.microsoft.com/office/drawing/2014/main" id="{51899C76-ED38-A53C-F19D-132403C2C727}"/>
              </a:ext>
            </a:extLst>
          </p:cNvPr>
          <p:cNvSpPr txBox="1"/>
          <p:nvPr/>
        </p:nvSpPr>
        <p:spPr>
          <a:xfrm>
            <a:off x="-990690" y="440316"/>
            <a:ext cx="407484" cy="461665"/>
          </a:xfrm>
          <a:prstGeom prst="rect">
            <a:avLst/>
          </a:prstGeom>
          <a:noFill/>
        </p:spPr>
        <p:txBody>
          <a:bodyPr wrap="none" rtlCol="0">
            <a:spAutoFit/>
          </a:bodyPr>
          <a:lstStyle/>
          <a:p>
            <a:pPr algn="ctr"/>
            <a:r>
              <a:rPr lang="fr-FR" sz="2400" b="1" dirty="0">
                <a:latin typeface="Arial" panose="020B0604020202020204" pitchFamily="34" charset="0"/>
                <a:cs typeface="Arial" panose="020B0604020202020204" pitchFamily="34" charset="0"/>
              </a:rPr>
              <a:t>A</a:t>
            </a:r>
          </a:p>
        </p:txBody>
      </p:sp>
      <p:sp>
        <p:nvSpPr>
          <p:cNvPr id="23" name="ZoneTexte 22">
            <a:extLst>
              <a:ext uri="{FF2B5EF4-FFF2-40B4-BE49-F238E27FC236}">
                <a16:creationId xmlns:a16="http://schemas.microsoft.com/office/drawing/2014/main" id="{4E330E4F-1C47-C20E-2ED7-9E21D2C4A8CE}"/>
              </a:ext>
            </a:extLst>
          </p:cNvPr>
          <p:cNvSpPr txBox="1"/>
          <p:nvPr/>
        </p:nvSpPr>
        <p:spPr>
          <a:xfrm>
            <a:off x="-990690" y="2124236"/>
            <a:ext cx="407484" cy="461665"/>
          </a:xfrm>
          <a:prstGeom prst="rect">
            <a:avLst/>
          </a:prstGeom>
          <a:noFill/>
        </p:spPr>
        <p:txBody>
          <a:bodyPr wrap="none" rtlCol="0">
            <a:spAutoFit/>
          </a:bodyPr>
          <a:lstStyle/>
          <a:p>
            <a:pPr algn="ctr"/>
            <a:r>
              <a:rPr lang="fr-FR" sz="2400" b="1" dirty="0">
                <a:latin typeface="Arial" panose="020B0604020202020204" pitchFamily="34" charset="0"/>
                <a:cs typeface="Arial" panose="020B0604020202020204" pitchFamily="34" charset="0"/>
              </a:rPr>
              <a:t>B</a:t>
            </a:r>
          </a:p>
        </p:txBody>
      </p:sp>
      <p:sp>
        <p:nvSpPr>
          <p:cNvPr id="24" name="ZoneTexte 23">
            <a:extLst>
              <a:ext uri="{FF2B5EF4-FFF2-40B4-BE49-F238E27FC236}">
                <a16:creationId xmlns:a16="http://schemas.microsoft.com/office/drawing/2014/main" id="{408CFE83-6AFD-4DBF-BFFC-80CEF1B50F1B}"/>
              </a:ext>
            </a:extLst>
          </p:cNvPr>
          <p:cNvSpPr txBox="1"/>
          <p:nvPr/>
        </p:nvSpPr>
        <p:spPr>
          <a:xfrm>
            <a:off x="-990690" y="3682507"/>
            <a:ext cx="407484" cy="461665"/>
          </a:xfrm>
          <a:prstGeom prst="rect">
            <a:avLst/>
          </a:prstGeom>
          <a:noFill/>
        </p:spPr>
        <p:txBody>
          <a:bodyPr wrap="none" rtlCol="0">
            <a:spAutoFit/>
          </a:bodyPr>
          <a:lstStyle/>
          <a:p>
            <a:pPr algn="ctr"/>
            <a:r>
              <a:rPr lang="fr-FR" sz="2400" b="1" dirty="0">
                <a:latin typeface="Arial" panose="020B0604020202020204" pitchFamily="34" charset="0"/>
                <a:cs typeface="Arial" panose="020B0604020202020204" pitchFamily="34" charset="0"/>
              </a:rPr>
              <a:t>C</a:t>
            </a:r>
          </a:p>
        </p:txBody>
      </p:sp>
      <p:cxnSp>
        <p:nvCxnSpPr>
          <p:cNvPr id="25" name="Connecteur droit avec flèche 24">
            <a:extLst>
              <a:ext uri="{FF2B5EF4-FFF2-40B4-BE49-F238E27FC236}">
                <a16:creationId xmlns:a16="http://schemas.microsoft.com/office/drawing/2014/main" id="{9C96781B-9B8C-E067-8EEA-D9A41808173B}"/>
              </a:ext>
            </a:extLst>
          </p:cNvPr>
          <p:cNvCxnSpPr>
            <a:cxnSpLocks/>
          </p:cNvCxnSpPr>
          <p:nvPr/>
        </p:nvCxnSpPr>
        <p:spPr>
          <a:xfrm>
            <a:off x="2688584" y="4447036"/>
            <a:ext cx="595019" cy="0"/>
          </a:xfrm>
          <a:prstGeom prst="straightConnector1">
            <a:avLst/>
          </a:prstGeom>
          <a:ln w="12700">
            <a:solidFill>
              <a:schemeClr val="tx1">
                <a:lumMod val="95000"/>
                <a:lumOff val="5000"/>
              </a:schemeClr>
            </a:solidFill>
            <a:tailEnd type="triangle" w="lg" len="lg"/>
          </a:ln>
        </p:spPr>
        <p:style>
          <a:lnRef idx="1">
            <a:schemeClr val="accent1"/>
          </a:lnRef>
          <a:fillRef idx="0">
            <a:schemeClr val="accent1"/>
          </a:fillRef>
          <a:effectRef idx="0">
            <a:schemeClr val="accent1"/>
          </a:effectRef>
          <a:fontRef idx="minor">
            <a:schemeClr val="tx1"/>
          </a:fontRef>
        </p:style>
      </p:cxnSp>
      <p:pic>
        <p:nvPicPr>
          <p:cNvPr id="26" name="Image 25" descr="Une image contenant art&#10;&#10;Description générée automatiquement">
            <a:extLst>
              <a:ext uri="{FF2B5EF4-FFF2-40B4-BE49-F238E27FC236}">
                <a16:creationId xmlns:a16="http://schemas.microsoft.com/office/drawing/2014/main" id="{40196487-FF02-DFD1-E2AE-8AE078EF30AA}"/>
              </a:ext>
            </a:extLst>
          </p:cNvPr>
          <p:cNvPicPr>
            <a:picLocks noChangeAspect="1"/>
          </p:cNvPicPr>
          <p:nvPr/>
        </p:nvPicPr>
        <p:blipFill>
          <a:blip r:embed="rId3"/>
          <a:stretch>
            <a:fillRect/>
          </a:stretch>
        </p:blipFill>
        <p:spPr>
          <a:xfrm>
            <a:off x="3850789" y="3917285"/>
            <a:ext cx="1711127" cy="955047"/>
          </a:xfrm>
          <a:prstGeom prst="rect">
            <a:avLst/>
          </a:prstGeom>
        </p:spPr>
      </p:pic>
      <p:pic>
        <p:nvPicPr>
          <p:cNvPr id="27" name="Image 26" descr="Une image contenant ballon, violet&#10;&#10;Description générée automatiquement">
            <a:extLst>
              <a:ext uri="{FF2B5EF4-FFF2-40B4-BE49-F238E27FC236}">
                <a16:creationId xmlns:a16="http://schemas.microsoft.com/office/drawing/2014/main" id="{5EB20456-EC77-7208-5B66-F99192D42DD0}"/>
              </a:ext>
            </a:extLst>
          </p:cNvPr>
          <p:cNvPicPr>
            <a:picLocks noChangeAspect="1"/>
          </p:cNvPicPr>
          <p:nvPr/>
        </p:nvPicPr>
        <p:blipFill>
          <a:blip r:embed="rId4"/>
          <a:stretch>
            <a:fillRect/>
          </a:stretch>
        </p:blipFill>
        <p:spPr>
          <a:xfrm rot="15955117">
            <a:off x="4037769" y="4348015"/>
            <a:ext cx="980474" cy="474037"/>
          </a:xfrm>
          <a:prstGeom prst="rect">
            <a:avLst/>
          </a:prstGeom>
        </p:spPr>
      </p:pic>
      <p:sp>
        <p:nvSpPr>
          <p:cNvPr id="28" name="ZoneTexte 27">
            <a:extLst>
              <a:ext uri="{FF2B5EF4-FFF2-40B4-BE49-F238E27FC236}">
                <a16:creationId xmlns:a16="http://schemas.microsoft.com/office/drawing/2014/main" id="{D43912CD-A576-A092-CF13-31142841B165}"/>
              </a:ext>
            </a:extLst>
          </p:cNvPr>
          <p:cNvSpPr txBox="1"/>
          <p:nvPr/>
        </p:nvSpPr>
        <p:spPr>
          <a:xfrm>
            <a:off x="2374387" y="4103563"/>
            <a:ext cx="1223412" cy="276999"/>
          </a:xfrm>
          <a:prstGeom prst="rect">
            <a:avLst/>
          </a:prstGeom>
          <a:noFill/>
        </p:spPr>
        <p:txBody>
          <a:bodyPr wrap="none" rtlCol="0">
            <a:spAutoFit/>
          </a:bodyPr>
          <a:lstStyle/>
          <a:p>
            <a:pPr algn="ctr"/>
            <a:r>
              <a:rPr lang="fr-FR" sz="1200" dirty="0">
                <a:latin typeface="Arial" panose="020B0604020202020204" pitchFamily="34" charset="0"/>
                <a:cs typeface="Arial" panose="020B0604020202020204" pitchFamily="34" charset="0"/>
              </a:rPr>
              <a:t>Small </a:t>
            </a:r>
            <a:r>
              <a:rPr lang="fr-FR" sz="1200" dirty="0" err="1">
                <a:latin typeface="Arial" panose="020B0604020202020204" pitchFamily="34" charset="0"/>
                <a:cs typeface="Arial" panose="020B0604020202020204" pitchFamily="34" charset="0"/>
              </a:rPr>
              <a:t>molecule</a:t>
            </a:r>
            <a:endParaRPr lang="fr-FR" sz="1200" dirty="0">
              <a:latin typeface="Arial" panose="020B0604020202020204" pitchFamily="34" charset="0"/>
              <a:cs typeface="Arial" panose="020B0604020202020204" pitchFamily="34" charset="0"/>
            </a:endParaRPr>
          </a:p>
        </p:txBody>
      </p:sp>
      <p:sp>
        <p:nvSpPr>
          <p:cNvPr id="2" name="ZoneTexte 1">
            <a:extLst>
              <a:ext uri="{FF2B5EF4-FFF2-40B4-BE49-F238E27FC236}">
                <a16:creationId xmlns:a16="http://schemas.microsoft.com/office/drawing/2014/main" id="{FF582248-675F-6AD0-8C8A-B307F31D6741}"/>
              </a:ext>
            </a:extLst>
          </p:cNvPr>
          <p:cNvSpPr txBox="1"/>
          <p:nvPr/>
        </p:nvSpPr>
        <p:spPr>
          <a:xfrm>
            <a:off x="5561916" y="3985371"/>
            <a:ext cx="3768980" cy="923330"/>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Targeting RBP</a:t>
            </a:r>
          </a:p>
          <a:p>
            <a:pPr marL="285750" indent="-285750">
              <a:buFont typeface="Arial" panose="020B0604020202020204" pitchFamily="34" charset="0"/>
              <a:buChar char="•"/>
            </a:pPr>
            <a:r>
              <a:rPr lang="en-US" dirty="0">
                <a:latin typeface="Arial" panose="020B0604020202020204" pitchFamily="34" charset="0"/>
                <a:cs typeface="Arial" panose="020B0604020202020204" pitchFamily="34" charset="0"/>
              </a:rPr>
              <a:t>Limited due to weak </a:t>
            </a:r>
            <a:r>
              <a:rPr lang="en-US" dirty="0" err="1">
                <a:latin typeface="Arial" panose="020B0604020202020204" pitchFamily="34" charset="0"/>
                <a:cs typeface="Arial" panose="020B0604020202020204" pitchFamily="34" charset="0"/>
              </a:rPr>
              <a:t>druggability</a:t>
            </a:r>
            <a:endParaRPr lang="en-US" dirty="0">
              <a:latin typeface="Arial" panose="020B0604020202020204" pitchFamily="34" charset="0"/>
              <a:cs typeface="Arial" panose="020B0604020202020204" pitchFamily="34" charset="0"/>
            </a:endParaRPr>
          </a:p>
          <a:p>
            <a:pPr marL="285750" indent="-285750">
              <a:buFont typeface="Arial" panose="020B0604020202020204" pitchFamily="34" charset="0"/>
              <a:buChar char="•"/>
            </a:pPr>
            <a:r>
              <a:rPr lang="en-US" dirty="0">
                <a:latin typeface="Arial" panose="020B0604020202020204" pitchFamily="34" charset="0"/>
                <a:cs typeface="Arial" panose="020B0604020202020204" pitchFamily="34" charset="0"/>
              </a:rPr>
              <a:t>Inhibition of interaction</a:t>
            </a:r>
          </a:p>
        </p:txBody>
      </p:sp>
      <p:sp>
        <p:nvSpPr>
          <p:cNvPr id="30" name="ZoneTexte 29">
            <a:extLst>
              <a:ext uri="{FF2B5EF4-FFF2-40B4-BE49-F238E27FC236}">
                <a16:creationId xmlns:a16="http://schemas.microsoft.com/office/drawing/2014/main" id="{E57E762B-5174-CD07-D26D-69B099C5A9F4}"/>
              </a:ext>
            </a:extLst>
          </p:cNvPr>
          <p:cNvSpPr txBox="1"/>
          <p:nvPr/>
        </p:nvSpPr>
        <p:spPr>
          <a:xfrm>
            <a:off x="-990690" y="5422475"/>
            <a:ext cx="407484" cy="461665"/>
          </a:xfrm>
          <a:prstGeom prst="rect">
            <a:avLst/>
          </a:prstGeom>
          <a:noFill/>
        </p:spPr>
        <p:txBody>
          <a:bodyPr wrap="none" rtlCol="0">
            <a:spAutoFit/>
          </a:bodyPr>
          <a:lstStyle/>
          <a:p>
            <a:pPr algn="ctr"/>
            <a:r>
              <a:rPr lang="fr-FR" sz="2400" b="1" dirty="0">
                <a:latin typeface="Arial" panose="020B0604020202020204" pitchFamily="34" charset="0"/>
                <a:cs typeface="Arial" panose="020B0604020202020204" pitchFamily="34" charset="0"/>
              </a:rPr>
              <a:t>D</a:t>
            </a:r>
          </a:p>
        </p:txBody>
      </p:sp>
    </p:spTree>
    <p:extLst>
      <p:ext uri="{BB962C8B-B14F-4D97-AF65-F5344CB8AC3E}">
        <p14:creationId xmlns:p14="http://schemas.microsoft.com/office/powerpoint/2010/main" val="82717316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62E49103-83E1-E43E-03D1-84FBE4D166FA}"/>
              </a:ext>
            </a:extLst>
          </p:cNvPr>
          <p:cNvSpPr txBox="1"/>
          <p:nvPr/>
        </p:nvSpPr>
        <p:spPr>
          <a:xfrm>
            <a:off x="-1001727" y="37990"/>
            <a:ext cx="1095172" cy="369332"/>
          </a:xfrm>
          <a:prstGeom prst="rect">
            <a:avLst/>
          </a:prstGeom>
          <a:noFill/>
        </p:spPr>
        <p:txBody>
          <a:bodyPr wrap="none" rtlCol="0">
            <a:spAutoFit/>
          </a:bodyPr>
          <a:lstStyle/>
          <a:p>
            <a:r>
              <a:rPr lang="fr-FR" dirty="0">
                <a:latin typeface="Arial" panose="020B0604020202020204" pitchFamily="34" charset="0"/>
                <a:cs typeface="Arial" panose="020B0604020202020204" pitchFamily="34" charset="0"/>
              </a:rPr>
              <a:t>Figure 1.</a:t>
            </a:r>
            <a:endParaRPr lang="fr-FR" dirty="0">
              <a:highlight>
                <a:srgbClr val="FFFF00"/>
              </a:highlight>
              <a:latin typeface="Arial" panose="020B0604020202020204" pitchFamily="34" charset="0"/>
              <a:cs typeface="Arial" panose="020B0604020202020204" pitchFamily="34" charset="0"/>
            </a:endParaRPr>
          </a:p>
        </p:txBody>
      </p:sp>
      <p:sp>
        <p:nvSpPr>
          <p:cNvPr id="22" name="ZoneTexte 21">
            <a:extLst>
              <a:ext uri="{FF2B5EF4-FFF2-40B4-BE49-F238E27FC236}">
                <a16:creationId xmlns:a16="http://schemas.microsoft.com/office/drawing/2014/main" id="{51899C76-ED38-A53C-F19D-132403C2C727}"/>
              </a:ext>
            </a:extLst>
          </p:cNvPr>
          <p:cNvSpPr txBox="1"/>
          <p:nvPr/>
        </p:nvSpPr>
        <p:spPr>
          <a:xfrm>
            <a:off x="-990690" y="440316"/>
            <a:ext cx="407484" cy="461665"/>
          </a:xfrm>
          <a:prstGeom prst="rect">
            <a:avLst/>
          </a:prstGeom>
          <a:noFill/>
        </p:spPr>
        <p:txBody>
          <a:bodyPr wrap="none" rtlCol="0">
            <a:spAutoFit/>
          </a:bodyPr>
          <a:lstStyle/>
          <a:p>
            <a:pPr algn="ctr"/>
            <a:r>
              <a:rPr lang="fr-FR" sz="2400" b="1" dirty="0">
                <a:latin typeface="Arial" panose="020B0604020202020204" pitchFamily="34" charset="0"/>
                <a:cs typeface="Arial" panose="020B0604020202020204" pitchFamily="34" charset="0"/>
              </a:rPr>
              <a:t>A</a:t>
            </a:r>
          </a:p>
        </p:txBody>
      </p:sp>
      <p:sp>
        <p:nvSpPr>
          <p:cNvPr id="23" name="ZoneTexte 22">
            <a:extLst>
              <a:ext uri="{FF2B5EF4-FFF2-40B4-BE49-F238E27FC236}">
                <a16:creationId xmlns:a16="http://schemas.microsoft.com/office/drawing/2014/main" id="{4E330E4F-1C47-C20E-2ED7-9E21D2C4A8CE}"/>
              </a:ext>
            </a:extLst>
          </p:cNvPr>
          <p:cNvSpPr txBox="1"/>
          <p:nvPr/>
        </p:nvSpPr>
        <p:spPr>
          <a:xfrm>
            <a:off x="-990690" y="2124236"/>
            <a:ext cx="407484" cy="461665"/>
          </a:xfrm>
          <a:prstGeom prst="rect">
            <a:avLst/>
          </a:prstGeom>
          <a:noFill/>
        </p:spPr>
        <p:txBody>
          <a:bodyPr wrap="none" rtlCol="0">
            <a:spAutoFit/>
          </a:bodyPr>
          <a:lstStyle/>
          <a:p>
            <a:pPr algn="ctr"/>
            <a:r>
              <a:rPr lang="fr-FR" sz="2400" b="1" dirty="0">
                <a:latin typeface="Arial" panose="020B0604020202020204" pitchFamily="34" charset="0"/>
                <a:cs typeface="Arial" panose="020B0604020202020204" pitchFamily="34" charset="0"/>
              </a:rPr>
              <a:t>B</a:t>
            </a:r>
          </a:p>
        </p:txBody>
      </p:sp>
      <p:sp>
        <p:nvSpPr>
          <p:cNvPr id="24" name="ZoneTexte 23">
            <a:extLst>
              <a:ext uri="{FF2B5EF4-FFF2-40B4-BE49-F238E27FC236}">
                <a16:creationId xmlns:a16="http://schemas.microsoft.com/office/drawing/2014/main" id="{408CFE83-6AFD-4DBF-BFFC-80CEF1B50F1B}"/>
              </a:ext>
            </a:extLst>
          </p:cNvPr>
          <p:cNvSpPr txBox="1"/>
          <p:nvPr/>
        </p:nvSpPr>
        <p:spPr>
          <a:xfrm>
            <a:off x="-990690" y="3682507"/>
            <a:ext cx="407484" cy="461665"/>
          </a:xfrm>
          <a:prstGeom prst="rect">
            <a:avLst/>
          </a:prstGeom>
          <a:noFill/>
        </p:spPr>
        <p:txBody>
          <a:bodyPr wrap="none" rtlCol="0">
            <a:spAutoFit/>
          </a:bodyPr>
          <a:lstStyle/>
          <a:p>
            <a:pPr algn="ctr"/>
            <a:r>
              <a:rPr lang="fr-FR" sz="2400" b="1" dirty="0">
                <a:latin typeface="Arial" panose="020B0604020202020204" pitchFamily="34" charset="0"/>
                <a:cs typeface="Arial" panose="020B0604020202020204" pitchFamily="34" charset="0"/>
              </a:rPr>
              <a:t>C</a:t>
            </a:r>
          </a:p>
        </p:txBody>
      </p:sp>
      <p:pic>
        <p:nvPicPr>
          <p:cNvPr id="29" name="Image 28" descr="Une image contenant art&#10;&#10;Description générée automatiquement">
            <a:extLst>
              <a:ext uri="{FF2B5EF4-FFF2-40B4-BE49-F238E27FC236}">
                <a16:creationId xmlns:a16="http://schemas.microsoft.com/office/drawing/2014/main" id="{12FAA195-89A9-7820-BFB2-CE197D1361F6}"/>
              </a:ext>
            </a:extLst>
          </p:cNvPr>
          <p:cNvPicPr>
            <a:picLocks noChangeAspect="1"/>
          </p:cNvPicPr>
          <p:nvPr/>
        </p:nvPicPr>
        <p:blipFill>
          <a:blip r:embed="rId3"/>
          <a:stretch>
            <a:fillRect/>
          </a:stretch>
        </p:blipFill>
        <p:spPr>
          <a:xfrm>
            <a:off x="854809" y="5513395"/>
            <a:ext cx="1801573" cy="1005529"/>
          </a:xfrm>
          <a:prstGeom prst="rect">
            <a:avLst/>
          </a:prstGeom>
        </p:spPr>
      </p:pic>
      <p:cxnSp>
        <p:nvCxnSpPr>
          <p:cNvPr id="36" name="Connecteur droit avec flèche 35">
            <a:extLst>
              <a:ext uri="{FF2B5EF4-FFF2-40B4-BE49-F238E27FC236}">
                <a16:creationId xmlns:a16="http://schemas.microsoft.com/office/drawing/2014/main" id="{90A419B0-64BB-7FF1-51C6-6C3BF37DB702}"/>
              </a:ext>
            </a:extLst>
          </p:cNvPr>
          <p:cNvCxnSpPr>
            <a:cxnSpLocks/>
          </p:cNvCxnSpPr>
          <p:nvPr/>
        </p:nvCxnSpPr>
        <p:spPr>
          <a:xfrm>
            <a:off x="2810487" y="6217599"/>
            <a:ext cx="595019" cy="0"/>
          </a:xfrm>
          <a:prstGeom prst="straightConnector1">
            <a:avLst/>
          </a:prstGeom>
          <a:ln w="12700">
            <a:solidFill>
              <a:schemeClr val="tx1">
                <a:lumMod val="95000"/>
                <a:lumOff val="5000"/>
              </a:schemeClr>
            </a:solidFill>
            <a:tailEnd type="triangle" w="lg" len="lg"/>
          </a:ln>
        </p:spPr>
        <p:style>
          <a:lnRef idx="1">
            <a:schemeClr val="accent1"/>
          </a:lnRef>
          <a:fillRef idx="0">
            <a:schemeClr val="accent1"/>
          </a:fillRef>
          <a:effectRef idx="0">
            <a:schemeClr val="accent1"/>
          </a:effectRef>
          <a:fontRef idx="minor">
            <a:schemeClr val="tx1"/>
          </a:fontRef>
        </p:style>
      </p:cxnSp>
      <p:pic>
        <p:nvPicPr>
          <p:cNvPr id="37" name="Image 36" descr="Une image contenant ballon, violet&#10;&#10;Description générée automatiquement">
            <a:extLst>
              <a:ext uri="{FF2B5EF4-FFF2-40B4-BE49-F238E27FC236}">
                <a16:creationId xmlns:a16="http://schemas.microsoft.com/office/drawing/2014/main" id="{83A5C646-0229-A6A5-99A0-24E666D26089}"/>
              </a:ext>
            </a:extLst>
          </p:cNvPr>
          <p:cNvPicPr>
            <a:picLocks noChangeAspect="1"/>
          </p:cNvPicPr>
          <p:nvPr/>
        </p:nvPicPr>
        <p:blipFill>
          <a:blip r:embed="rId4"/>
          <a:stretch>
            <a:fillRect/>
          </a:stretch>
        </p:blipFill>
        <p:spPr>
          <a:xfrm>
            <a:off x="2581398" y="5460207"/>
            <a:ext cx="1053196" cy="509196"/>
          </a:xfrm>
          <a:prstGeom prst="rect">
            <a:avLst/>
          </a:prstGeom>
        </p:spPr>
      </p:pic>
      <p:sp>
        <p:nvSpPr>
          <p:cNvPr id="38" name="ZoneTexte 37">
            <a:extLst>
              <a:ext uri="{FF2B5EF4-FFF2-40B4-BE49-F238E27FC236}">
                <a16:creationId xmlns:a16="http://schemas.microsoft.com/office/drawing/2014/main" id="{7684C48A-FBF0-CFC0-FD6C-B765BD937CAE}"/>
              </a:ext>
            </a:extLst>
          </p:cNvPr>
          <p:cNvSpPr txBox="1"/>
          <p:nvPr/>
        </p:nvSpPr>
        <p:spPr>
          <a:xfrm>
            <a:off x="2536931" y="5885669"/>
            <a:ext cx="1223412" cy="276999"/>
          </a:xfrm>
          <a:prstGeom prst="rect">
            <a:avLst/>
          </a:prstGeom>
          <a:noFill/>
        </p:spPr>
        <p:txBody>
          <a:bodyPr wrap="none" rtlCol="0">
            <a:spAutoFit/>
          </a:bodyPr>
          <a:lstStyle/>
          <a:p>
            <a:pPr algn="ctr"/>
            <a:r>
              <a:rPr lang="fr-FR" sz="1200" dirty="0">
                <a:latin typeface="Arial" panose="020B0604020202020204" pitchFamily="34" charset="0"/>
                <a:cs typeface="Arial" panose="020B0604020202020204" pitchFamily="34" charset="0"/>
              </a:rPr>
              <a:t>Small </a:t>
            </a:r>
            <a:r>
              <a:rPr lang="fr-FR" sz="1200" dirty="0" err="1">
                <a:latin typeface="Arial" panose="020B0604020202020204" pitchFamily="34" charset="0"/>
                <a:cs typeface="Arial" panose="020B0604020202020204" pitchFamily="34" charset="0"/>
              </a:rPr>
              <a:t>molecule</a:t>
            </a:r>
            <a:endParaRPr lang="fr-FR" sz="1200" dirty="0">
              <a:latin typeface="Arial" panose="020B0604020202020204" pitchFamily="34" charset="0"/>
              <a:cs typeface="Arial" panose="020B0604020202020204" pitchFamily="34" charset="0"/>
            </a:endParaRPr>
          </a:p>
        </p:txBody>
      </p:sp>
      <p:sp>
        <p:nvSpPr>
          <p:cNvPr id="9" name="ZoneTexte 8">
            <a:extLst>
              <a:ext uri="{FF2B5EF4-FFF2-40B4-BE49-F238E27FC236}">
                <a16:creationId xmlns:a16="http://schemas.microsoft.com/office/drawing/2014/main" id="{BDF8A5BA-5CAB-3597-46FA-7E4A2FAD4068}"/>
              </a:ext>
            </a:extLst>
          </p:cNvPr>
          <p:cNvSpPr txBox="1"/>
          <p:nvPr/>
        </p:nvSpPr>
        <p:spPr>
          <a:xfrm>
            <a:off x="5561916" y="5606285"/>
            <a:ext cx="4314001" cy="923330"/>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Targeting </a:t>
            </a:r>
            <a:r>
              <a:rPr lang="en-US" dirty="0" err="1">
                <a:latin typeface="Arial" panose="020B0604020202020204" pitchFamily="34" charset="0"/>
                <a:cs typeface="Arial" panose="020B0604020202020204" pitchFamily="34" charset="0"/>
              </a:rPr>
              <a:t>RNA:protein</a:t>
            </a:r>
            <a:r>
              <a:rPr lang="en-US" dirty="0">
                <a:latin typeface="Arial" panose="020B0604020202020204" pitchFamily="34" charset="0"/>
                <a:cs typeface="Arial" panose="020B0604020202020204" pitchFamily="34" charset="0"/>
              </a:rPr>
              <a:t> interface</a:t>
            </a:r>
          </a:p>
          <a:p>
            <a:pPr marL="285750" indent="-285750">
              <a:buFont typeface="Arial" panose="020B0604020202020204" pitchFamily="34" charset="0"/>
              <a:buChar char="•"/>
            </a:pPr>
            <a:r>
              <a:rPr lang="en-US" dirty="0">
                <a:latin typeface="Arial" panose="020B0604020202020204" pitchFamily="34" charset="0"/>
                <a:cs typeface="Arial" panose="020B0604020202020204" pitchFamily="34" charset="0"/>
              </a:rPr>
              <a:t>Increased structural diversity</a:t>
            </a:r>
          </a:p>
          <a:p>
            <a:pPr marL="285750" indent="-285750">
              <a:buFont typeface="Arial" panose="020B0604020202020204" pitchFamily="34" charset="0"/>
              <a:buChar char="•"/>
            </a:pPr>
            <a:r>
              <a:rPr lang="en-US" dirty="0">
                <a:latin typeface="Arial" panose="020B0604020202020204" pitchFamily="34" charset="0"/>
                <a:cs typeface="Arial" panose="020B0604020202020204" pitchFamily="34" charset="0"/>
              </a:rPr>
              <a:t>Modulation = inhibition or stabilization</a:t>
            </a:r>
          </a:p>
        </p:txBody>
      </p:sp>
      <p:pic>
        <p:nvPicPr>
          <p:cNvPr id="12" name="Image 11" descr="Une image contenant art&#10;&#10;Description générée automatiquement">
            <a:extLst>
              <a:ext uri="{FF2B5EF4-FFF2-40B4-BE49-F238E27FC236}">
                <a16:creationId xmlns:a16="http://schemas.microsoft.com/office/drawing/2014/main" id="{B038876E-7523-6303-7D58-65880E56B15B}"/>
              </a:ext>
            </a:extLst>
          </p:cNvPr>
          <p:cNvPicPr>
            <a:picLocks noChangeAspect="1"/>
          </p:cNvPicPr>
          <p:nvPr/>
        </p:nvPicPr>
        <p:blipFill>
          <a:blip r:embed="rId3"/>
          <a:stretch>
            <a:fillRect/>
          </a:stretch>
        </p:blipFill>
        <p:spPr>
          <a:xfrm>
            <a:off x="3760343" y="5537497"/>
            <a:ext cx="1801573" cy="1005529"/>
          </a:xfrm>
          <a:prstGeom prst="rect">
            <a:avLst/>
          </a:prstGeom>
        </p:spPr>
      </p:pic>
      <p:pic>
        <p:nvPicPr>
          <p:cNvPr id="34" name="Image 33" descr="Une image contenant ballon, violet&#10;&#10;Description générée automatiquement">
            <a:extLst>
              <a:ext uri="{FF2B5EF4-FFF2-40B4-BE49-F238E27FC236}">
                <a16:creationId xmlns:a16="http://schemas.microsoft.com/office/drawing/2014/main" id="{B5FC6E08-BAB4-DD5F-74E5-50D863E8406F}"/>
              </a:ext>
            </a:extLst>
          </p:cNvPr>
          <p:cNvPicPr>
            <a:picLocks noChangeAspect="1"/>
          </p:cNvPicPr>
          <p:nvPr/>
        </p:nvPicPr>
        <p:blipFill>
          <a:blip r:embed="rId4"/>
          <a:stretch>
            <a:fillRect/>
          </a:stretch>
        </p:blipFill>
        <p:spPr>
          <a:xfrm rot="15746426">
            <a:off x="3955231" y="6009290"/>
            <a:ext cx="845683" cy="408868"/>
          </a:xfrm>
          <a:prstGeom prst="rect">
            <a:avLst/>
          </a:prstGeom>
        </p:spPr>
      </p:pic>
      <p:sp>
        <p:nvSpPr>
          <p:cNvPr id="16" name="ZoneTexte 15">
            <a:extLst>
              <a:ext uri="{FF2B5EF4-FFF2-40B4-BE49-F238E27FC236}">
                <a16:creationId xmlns:a16="http://schemas.microsoft.com/office/drawing/2014/main" id="{CB220C0E-1B03-68CF-BCAC-61EA46AD647B}"/>
              </a:ext>
            </a:extLst>
          </p:cNvPr>
          <p:cNvSpPr txBox="1"/>
          <p:nvPr/>
        </p:nvSpPr>
        <p:spPr>
          <a:xfrm>
            <a:off x="974723" y="6518924"/>
            <a:ext cx="1478738" cy="276999"/>
          </a:xfrm>
          <a:prstGeom prst="rect">
            <a:avLst/>
          </a:prstGeom>
          <a:noFill/>
        </p:spPr>
        <p:txBody>
          <a:bodyPr wrap="none" rtlCol="0">
            <a:spAutoFit/>
          </a:bodyPr>
          <a:lstStyle/>
          <a:p>
            <a:pPr algn="ctr"/>
            <a:r>
              <a:rPr lang="fr-FR" sz="1200" dirty="0">
                <a:latin typeface="Arial" panose="020B0604020202020204" pitchFamily="34" charset="0"/>
                <a:cs typeface="Arial" panose="020B0604020202020204" pitchFamily="34" charset="0"/>
              </a:rPr>
              <a:t>RNA:RBP </a:t>
            </a:r>
            <a:r>
              <a:rPr lang="fr-FR" sz="1200" dirty="0" err="1">
                <a:latin typeface="Arial" panose="020B0604020202020204" pitchFamily="34" charset="0"/>
                <a:cs typeface="Arial" panose="020B0604020202020204" pitchFamily="34" charset="0"/>
              </a:rPr>
              <a:t>complex</a:t>
            </a:r>
            <a:endParaRPr lang="fr-FR" sz="1200" dirty="0">
              <a:latin typeface="Arial" panose="020B0604020202020204" pitchFamily="34" charset="0"/>
              <a:cs typeface="Arial" panose="020B0604020202020204" pitchFamily="34" charset="0"/>
            </a:endParaRPr>
          </a:p>
        </p:txBody>
      </p:sp>
      <p:sp>
        <p:nvSpPr>
          <p:cNvPr id="30" name="ZoneTexte 29">
            <a:extLst>
              <a:ext uri="{FF2B5EF4-FFF2-40B4-BE49-F238E27FC236}">
                <a16:creationId xmlns:a16="http://schemas.microsoft.com/office/drawing/2014/main" id="{E57E762B-5174-CD07-D26D-69B099C5A9F4}"/>
              </a:ext>
            </a:extLst>
          </p:cNvPr>
          <p:cNvSpPr txBox="1"/>
          <p:nvPr/>
        </p:nvSpPr>
        <p:spPr>
          <a:xfrm>
            <a:off x="-990690" y="5422475"/>
            <a:ext cx="407484" cy="461665"/>
          </a:xfrm>
          <a:prstGeom prst="rect">
            <a:avLst/>
          </a:prstGeom>
          <a:noFill/>
        </p:spPr>
        <p:txBody>
          <a:bodyPr wrap="none" rtlCol="0">
            <a:spAutoFit/>
          </a:bodyPr>
          <a:lstStyle/>
          <a:p>
            <a:pPr algn="ctr"/>
            <a:r>
              <a:rPr lang="fr-FR" sz="2400" b="1" dirty="0">
                <a:latin typeface="Arial" panose="020B0604020202020204" pitchFamily="34" charset="0"/>
                <a:cs typeface="Arial" panose="020B0604020202020204" pitchFamily="34" charset="0"/>
              </a:rPr>
              <a:t>D</a:t>
            </a:r>
          </a:p>
        </p:txBody>
      </p:sp>
    </p:spTree>
    <p:extLst>
      <p:ext uri="{BB962C8B-B14F-4D97-AF65-F5344CB8AC3E}">
        <p14:creationId xmlns:p14="http://schemas.microsoft.com/office/powerpoint/2010/main" val="2134009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62E49103-83E1-E43E-03D1-84FBE4D166FA}"/>
              </a:ext>
            </a:extLst>
          </p:cNvPr>
          <p:cNvSpPr txBox="1"/>
          <p:nvPr/>
        </p:nvSpPr>
        <p:spPr>
          <a:xfrm>
            <a:off x="-1012727" y="0"/>
            <a:ext cx="1095172" cy="369332"/>
          </a:xfrm>
          <a:prstGeom prst="rect">
            <a:avLst/>
          </a:prstGeom>
          <a:noFill/>
        </p:spPr>
        <p:txBody>
          <a:bodyPr wrap="none" rtlCol="0">
            <a:spAutoFit/>
          </a:bodyPr>
          <a:lstStyle/>
          <a:p>
            <a:r>
              <a:rPr lang="fr-FR" dirty="0">
                <a:latin typeface="Arial" panose="020B0604020202020204" pitchFamily="34" charset="0"/>
                <a:cs typeface="Arial" panose="020B0604020202020204" pitchFamily="34" charset="0"/>
              </a:rPr>
              <a:t>Figure 2.</a:t>
            </a:r>
            <a:endParaRPr lang="fr-FR" dirty="0">
              <a:highlight>
                <a:srgbClr val="FFFF00"/>
              </a:highlight>
              <a:latin typeface="Arial" panose="020B0604020202020204" pitchFamily="34" charset="0"/>
              <a:cs typeface="Arial" panose="020B0604020202020204" pitchFamily="34" charset="0"/>
            </a:endParaRPr>
          </a:p>
        </p:txBody>
      </p:sp>
      <p:sp>
        <p:nvSpPr>
          <p:cNvPr id="5" name="Trapèze 4">
            <a:extLst>
              <a:ext uri="{FF2B5EF4-FFF2-40B4-BE49-F238E27FC236}">
                <a16:creationId xmlns:a16="http://schemas.microsoft.com/office/drawing/2014/main" id="{6A252411-F114-8AC3-1B32-E0964AAA516E}"/>
              </a:ext>
            </a:extLst>
          </p:cNvPr>
          <p:cNvSpPr/>
          <p:nvPr/>
        </p:nvSpPr>
        <p:spPr>
          <a:xfrm rot="10800000">
            <a:off x="1443228" y="828428"/>
            <a:ext cx="3418767" cy="824089"/>
          </a:xfrm>
          <a:prstGeom prst="trapezoid">
            <a:avLst/>
          </a:prstGeom>
          <a:solidFill>
            <a:schemeClr val="bg1">
              <a:lumMod val="5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dirty="0"/>
          </a:p>
        </p:txBody>
      </p:sp>
      <p:sp>
        <p:nvSpPr>
          <p:cNvPr id="6" name="Trapèze 5">
            <a:extLst>
              <a:ext uri="{FF2B5EF4-FFF2-40B4-BE49-F238E27FC236}">
                <a16:creationId xmlns:a16="http://schemas.microsoft.com/office/drawing/2014/main" id="{DD75FCE2-CFC3-775A-8B1B-C16DE44F0059}"/>
              </a:ext>
            </a:extLst>
          </p:cNvPr>
          <p:cNvSpPr/>
          <p:nvPr/>
        </p:nvSpPr>
        <p:spPr>
          <a:xfrm rot="10800000">
            <a:off x="1667240" y="1807715"/>
            <a:ext cx="2957688" cy="824089"/>
          </a:xfrm>
          <a:prstGeom prst="trapezoid">
            <a:avLst/>
          </a:prstGeom>
          <a:solidFill>
            <a:schemeClr val="bg1">
              <a:lumMod val="6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7" name="Trapèze 6">
            <a:extLst>
              <a:ext uri="{FF2B5EF4-FFF2-40B4-BE49-F238E27FC236}">
                <a16:creationId xmlns:a16="http://schemas.microsoft.com/office/drawing/2014/main" id="{88A85668-2703-57DC-F57E-2D8ECE80CFBD}"/>
              </a:ext>
            </a:extLst>
          </p:cNvPr>
          <p:cNvSpPr/>
          <p:nvPr/>
        </p:nvSpPr>
        <p:spPr>
          <a:xfrm rot="10800000">
            <a:off x="1893017" y="2787001"/>
            <a:ext cx="2501368" cy="824089"/>
          </a:xfrm>
          <a:prstGeom prst="trapezoid">
            <a:avLst/>
          </a:prstGeom>
          <a:solidFill>
            <a:schemeClr val="bg1">
              <a:lumMod val="7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 name="Trapèze 7">
            <a:extLst>
              <a:ext uri="{FF2B5EF4-FFF2-40B4-BE49-F238E27FC236}">
                <a16:creationId xmlns:a16="http://schemas.microsoft.com/office/drawing/2014/main" id="{8FC0415C-CEF2-3F24-F60B-F62B537FB895}"/>
              </a:ext>
            </a:extLst>
          </p:cNvPr>
          <p:cNvSpPr/>
          <p:nvPr/>
        </p:nvSpPr>
        <p:spPr>
          <a:xfrm rot="10800000">
            <a:off x="2118795" y="3766285"/>
            <a:ext cx="2043288" cy="824089"/>
          </a:xfrm>
          <a:prstGeom prst="trapezoid">
            <a:avLst/>
          </a:prstGeom>
          <a:solidFill>
            <a:schemeClr val="bg1">
              <a:lumMod val="8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 name="ZoneTexte 8">
            <a:extLst>
              <a:ext uri="{FF2B5EF4-FFF2-40B4-BE49-F238E27FC236}">
                <a16:creationId xmlns:a16="http://schemas.microsoft.com/office/drawing/2014/main" id="{9273FFF2-89C0-210E-0A87-592A86F378E5}"/>
              </a:ext>
            </a:extLst>
          </p:cNvPr>
          <p:cNvSpPr txBox="1"/>
          <p:nvPr/>
        </p:nvSpPr>
        <p:spPr>
          <a:xfrm>
            <a:off x="2704411" y="1055806"/>
            <a:ext cx="896399" cy="369332"/>
          </a:xfrm>
          <a:prstGeom prst="rect">
            <a:avLst/>
          </a:prstGeom>
          <a:noFill/>
        </p:spPr>
        <p:txBody>
          <a:bodyPr wrap="none" rtlCol="0">
            <a:spAutoFit/>
          </a:bodyPr>
          <a:lstStyle/>
          <a:p>
            <a:pPr algn="ctr"/>
            <a:r>
              <a:rPr lang="fr-FR" dirty="0">
                <a:solidFill>
                  <a:schemeClr val="bg1"/>
                </a:solidFill>
                <a:latin typeface="Arial" panose="020B0604020202020204" pitchFamily="34" charset="0"/>
                <a:cs typeface="Arial" panose="020B0604020202020204" pitchFamily="34" charset="0"/>
              </a:rPr>
              <a:t>100M+</a:t>
            </a:r>
          </a:p>
        </p:txBody>
      </p:sp>
      <p:sp>
        <p:nvSpPr>
          <p:cNvPr id="10" name="ZoneTexte 9">
            <a:extLst>
              <a:ext uri="{FF2B5EF4-FFF2-40B4-BE49-F238E27FC236}">
                <a16:creationId xmlns:a16="http://schemas.microsoft.com/office/drawing/2014/main" id="{4B244C07-FB51-12EE-A781-5DB4EEEEE854}"/>
              </a:ext>
            </a:extLst>
          </p:cNvPr>
          <p:cNvSpPr txBox="1"/>
          <p:nvPr/>
        </p:nvSpPr>
        <p:spPr>
          <a:xfrm>
            <a:off x="2768531" y="2035094"/>
            <a:ext cx="768159" cy="369332"/>
          </a:xfrm>
          <a:prstGeom prst="rect">
            <a:avLst/>
          </a:prstGeom>
          <a:noFill/>
        </p:spPr>
        <p:txBody>
          <a:bodyPr wrap="none" rtlCol="0">
            <a:spAutoFit/>
          </a:bodyPr>
          <a:lstStyle/>
          <a:p>
            <a:pPr algn="ctr"/>
            <a:r>
              <a:rPr lang="fr-FR" dirty="0">
                <a:latin typeface="Arial" panose="020B0604020202020204" pitchFamily="34" charset="0"/>
                <a:cs typeface="Arial" panose="020B0604020202020204" pitchFamily="34" charset="0"/>
              </a:rPr>
              <a:t>10M+</a:t>
            </a:r>
          </a:p>
        </p:txBody>
      </p:sp>
      <p:sp>
        <p:nvSpPr>
          <p:cNvPr id="11" name="ZoneTexte 10">
            <a:extLst>
              <a:ext uri="{FF2B5EF4-FFF2-40B4-BE49-F238E27FC236}">
                <a16:creationId xmlns:a16="http://schemas.microsoft.com/office/drawing/2014/main" id="{00EFFD86-296C-E0BB-898D-3F842BFDCDFA}"/>
              </a:ext>
            </a:extLst>
          </p:cNvPr>
          <p:cNvSpPr txBox="1"/>
          <p:nvPr/>
        </p:nvSpPr>
        <p:spPr>
          <a:xfrm>
            <a:off x="2711474" y="3018195"/>
            <a:ext cx="857927" cy="369332"/>
          </a:xfrm>
          <a:prstGeom prst="rect">
            <a:avLst/>
          </a:prstGeom>
          <a:noFill/>
        </p:spPr>
        <p:txBody>
          <a:bodyPr wrap="none" rtlCol="0">
            <a:spAutoFit/>
          </a:bodyPr>
          <a:lstStyle/>
          <a:p>
            <a:pPr algn="ctr"/>
            <a:r>
              <a:rPr lang="fr-FR" dirty="0">
                <a:latin typeface="Arial" panose="020B0604020202020204" pitchFamily="34" charset="0"/>
                <a:cs typeface="Arial" panose="020B0604020202020204" pitchFamily="34" charset="0"/>
              </a:rPr>
              <a:t>100K+</a:t>
            </a:r>
          </a:p>
        </p:txBody>
      </p:sp>
      <p:sp>
        <p:nvSpPr>
          <p:cNvPr id="12" name="ZoneTexte 11">
            <a:extLst>
              <a:ext uri="{FF2B5EF4-FFF2-40B4-BE49-F238E27FC236}">
                <a16:creationId xmlns:a16="http://schemas.microsoft.com/office/drawing/2014/main" id="{93F709DF-441D-6D72-8ED4-D460CAE01FF2}"/>
              </a:ext>
            </a:extLst>
          </p:cNvPr>
          <p:cNvSpPr txBox="1"/>
          <p:nvPr/>
        </p:nvSpPr>
        <p:spPr>
          <a:xfrm>
            <a:off x="2673001" y="3993663"/>
            <a:ext cx="934872" cy="369332"/>
          </a:xfrm>
          <a:prstGeom prst="rect">
            <a:avLst/>
          </a:prstGeom>
          <a:noFill/>
        </p:spPr>
        <p:txBody>
          <a:bodyPr wrap="none" rtlCol="0">
            <a:spAutoFit/>
          </a:bodyPr>
          <a:lstStyle/>
          <a:p>
            <a:pPr algn="ctr"/>
            <a:r>
              <a:rPr lang="fr-FR" dirty="0">
                <a:latin typeface="Arial" panose="020B0604020202020204" pitchFamily="34" charset="0"/>
                <a:cs typeface="Arial" panose="020B0604020202020204" pitchFamily="34" charset="0"/>
              </a:rPr>
              <a:t>1-10K+</a:t>
            </a:r>
          </a:p>
        </p:txBody>
      </p:sp>
      <p:sp>
        <p:nvSpPr>
          <p:cNvPr id="13" name="Triangle 12">
            <a:extLst>
              <a:ext uri="{FF2B5EF4-FFF2-40B4-BE49-F238E27FC236}">
                <a16:creationId xmlns:a16="http://schemas.microsoft.com/office/drawing/2014/main" id="{B5B5B046-4798-9D69-DCD8-54CD901C52A3}"/>
              </a:ext>
            </a:extLst>
          </p:cNvPr>
          <p:cNvSpPr/>
          <p:nvPr/>
        </p:nvSpPr>
        <p:spPr>
          <a:xfrm rot="10800000">
            <a:off x="2363988" y="4745568"/>
            <a:ext cx="1552896" cy="824089"/>
          </a:xfrm>
          <a:prstGeom prst="triangle">
            <a:avLst/>
          </a:prstGeom>
          <a:solidFill>
            <a:schemeClr val="accent1">
              <a:lumMod val="20000"/>
              <a:lumOff val="8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4" name="ZoneTexte 13">
            <a:extLst>
              <a:ext uri="{FF2B5EF4-FFF2-40B4-BE49-F238E27FC236}">
                <a16:creationId xmlns:a16="http://schemas.microsoft.com/office/drawing/2014/main" id="{BEEC97A2-C6E6-3E19-E0ED-E05523BF97A1}"/>
              </a:ext>
            </a:extLst>
          </p:cNvPr>
          <p:cNvSpPr txBox="1"/>
          <p:nvPr/>
        </p:nvSpPr>
        <p:spPr>
          <a:xfrm>
            <a:off x="2689030" y="4853173"/>
            <a:ext cx="902812" cy="369332"/>
          </a:xfrm>
          <a:prstGeom prst="rect">
            <a:avLst/>
          </a:prstGeom>
          <a:noFill/>
        </p:spPr>
        <p:txBody>
          <a:bodyPr wrap="none" rtlCol="0">
            <a:spAutoFit/>
          </a:bodyPr>
          <a:lstStyle/>
          <a:p>
            <a:pPr algn="ctr"/>
            <a:r>
              <a:rPr lang="fr-FR" dirty="0">
                <a:latin typeface="Arial" panose="020B0604020202020204" pitchFamily="34" charset="0"/>
                <a:cs typeface="Arial" panose="020B0604020202020204" pitchFamily="34" charset="0"/>
              </a:rPr>
              <a:t>10-100</a:t>
            </a:r>
          </a:p>
        </p:txBody>
      </p:sp>
      <p:sp>
        <p:nvSpPr>
          <p:cNvPr id="15" name="ZoneTexte 14">
            <a:extLst>
              <a:ext uri="{FF2B5EF4-FFF2-40B4-BE49-F238E27FC236}">
                <a16:creationId xmlns:a16="http://schemas.microsoft.com/office/drawing/2014/main" id="{DEAF23DE-E6B3-515C-E370-B9C88EE74097}"/>
              </a:ext>
            </a:extLst>
          </p:cNvPr>
          <p:cNvSpPr txBox="1"/>
          <p:nvPr/>
        </p:nvSpPr>
        <p:spPr>
          <a:xfrm>
            <a:off x="1291212" y="171058"/>
            <a:ext cx="3698449" cy="646331"/>
          </a:xfrm>
          <a:prstGeom prst="rect">
            <a:avLst/>
          </a:prstGeom>
          <a:noFill/>
        </p:spPr>
        <p:txBody>
          <a:bodyPr wrap="none" rtlCol="0">
            <a:spAutoFit/>
          </a:bodyPr>
          <a:lstStyle/>
          <a:p>
            <a:pPr algn="ctr"/>
            <a:r>
              <a:rPr lang="en-US" b="1" dirty="0">
                <a:latin typeface="Arial" panose="020B0604020202020204" pitchFamily="34" charset="0"/>
                <a:cs typeface="Arial" panose="020B0604020202020204" pitchFamily="34" charset="0"/>
              </a:rPr>
              <a:t>Commercial libraries</a:t>
            </a:r>
          </a:p>
          <a:p>
            <a:pPr algn="ctr"/>
            <a:r>
              <a:rPr lang="en-US" dirty="0">
                <a:latin typeface="Arial" panose="020B0604020202020204" pitchFamily="34" charset="0"/>
                <a:cs typeface="Arial" panose="020B0604020202020204" pitchFamily="34" charset="0"/>
              </a:rPr>
              <a:t>(ZINC, Enamine, </a:t>
            </a:r>
            <a:r>
              <a:rPr lang="en-US" dirty="0" err="1">
                <a:latin typeface="Arial" panose="020B0604020202020204" pitchFamily="34" charset="0"/>
                <a:cs typeface="Arial" panose="020B0604020202020204" pitchFamily="34" charset="0"/>
              </a:rPr>
              <a:t>Mcule</a:t>
            </a:r>
            <a:r>
              <a:rPr lang="en-US" dirty="0">
                <a:latin typeface="Arial" panose="020B0604020202020204" pitchFamily="34" charset="0"/>
                <a:cs typeface="Arial" panose="020B0604020202020204" pitchFamily="34" charset="0"/>
              </a:rPr>
              <a:t>, </a:t>
            </a:r>
            <a:r>
              <a:rPr lang="en-US" dirty="0" err="1">
                <a:latin typeface="Arial" panose="020B0604020202020204" pitchFamily="34" charset="0"/>
                <a:cs typeface="Arial" panose="020B0604020202020204" pitchFamily="34" charset="0"/>
              </a:rPr>
              <a:t>MolPort</a:t>
            </a:r>
            <a:r>
              <a:rPr lang="en-US" dirty="0">
                <a:latin typeface="Arial" panose="020B0604020202020204" pitchFamily="34" charset="0"/>
                <a:cs typeface="Arial" panose="020B0604020202020204" pitchFamily="34" charset="0"/>
              </a:rPr>
              <a:t>)</a:t>
            </a:r>
          </a:p>
        </p:txBody>
      </p:sp>
      <p:sp>
        <p:nvSpPr>
          <p:cNvPr id="18" name="Rectangle : coins arrondis 17">
            <a:extLst>
              <a:ext uri="{FF2B5EF4-FFF2-40B4-BE49-F238E27FC236}">
                <a16:creationId xmlns:a16="http://schemas.microsoft.com/office/drawing/2014/main" id="{6A658711-89C3-D186-F8A8-7170FD2971D9}"/>
              </a:ext>
            </a:extLst>
          </p:cNvPr>
          <p:cNvSpPr/>
          <p:nvPr/>
        </p:nvSpPr>
        <p:spPr>
          <a:xfrm>
            <a:off x="1251672" y="1531272"/>
            <a:ext cx="3777521" cy="412045"/>
          </a:xfrm>
          <a:prstGeom prst="roundRect">
            <a:avLst/>
          </a:prstGeom>
          <a:solidFill>
            <a:schemeClr val="accent1">
              <a:lumMod val="40000"/>
              <a:lumOff val="6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latin typeface="Arial" panose="020B0604020202020204" pitchFamily="34" charset="0"/>
                <a:cs typeface="Arial" panose="020B0604020202020204" pitchFamily="34" charset="0"/>
              </a:rPr>
              <a:t>Virtual screening LBDD </a:t>
            </a:r>
          </a:p>
        </p:txBody>
      </p:sp>
      <p:sp>
        <p:nvSpPr>
          <p:cNvPr id="19" name="ZoneTexte 18">
            <a:extLst>
              <a:ext uri="{FF2B5EF4-FFF2-40B4-BE49-F238E27FC236}">
                <a16:creationId xmlns:a16="http://schemas.microsoft.com/office/drawing/2014/main" id="{DC0258B7-F17C-22A9-1BB9-2EFD25EC19AF}"/>
              </a:ext>
            </a:extLst>
          </p:cNvPr>
          <p:cNvSpPr txBox="1"/>
          <p:nvPr/>
        </p:nvSpPr>
        <p:spPr>
          <a:xfrm>
            <a:off x="5445435" y="885044"/>
            <a:ext cx="3198311" cy="1200329"/>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Injection of experimental data</a:t>
            </a:r>
          </a:p>
          <a:p>
            <a:pPr marL="285750" indent="-285750">
              <a:buFont typeface="Arial" panose="020B0604020202020204" pitchFamily="34" charset="0"/>
              <a:buChar char="•"/>
            </a:pPr>
            <a:r>
              <a:rPr lang="en-US" dirty="0">
                <a:latin typeface="Arial" panose="020B0604020202020204" pitchFamily="34" charset="0"/>
                <a:cs typeface="Arial" panose="020B0604020202020204" pitchFamily="34" charset="0"/>
              </a:rPr>
              <a:t>Structural biology: NMR</a:t>
            </a:r>
          </a:p>
          <a:p>
            <a:pPr marL="285750" indent="-285750">
              <a:buFont typeface="Arial" panose="020B0604020202020204" pitchFamily="34" charset="0"/>
              <a:buChar char="•"/>
            </a:pPr>
            <a:r>
              <a:rPr lang="en-US" dirty="0">
                <a:latin typeface="Arial" panose="020B0604020202020204" pitchFamily="34" charset="0"/>
                <a:cs typeface="Arial" panose="020B0604020202020204" pitchFamily="34" charset="0"/>
              </a:rPr>
              <a:t>Protein Data Bank (PDB)</a:t>
            </a:r>
          </a:p>
          <a:p>
            <a:pPr marL="285750" indent="-285750">
              <a:buFont typeface="Arial" panose="020B0604020202020204" pitchFamily="34" charset="0"/>
              <a:buChar char="•"/>
            </a:pPr>
            <a:r>
              <a:rPr lang="en-US" dirty="0" err="1">
                <a:latin typeface="Arial" panose="020B0604020202020204" pitchFamily="34" charset="0"/>
                <a:cs typeface="Arial" panose="020B0604020202020204" pitchFamily="34" charset="0"/>
              </a:rPr>
              <a:t>AlphaFold</a:t>
            </a:r>
            <a:endParaRPr lang="en-US" dirty="0">
              <a:latin typeface="Arial" panose="020B0604020202020204" pitchFamily="34" charset="0"/>
              <a:cs typeface="Arial" panose="020B0604020202020204" pitchFamily="34" charset="0"/>
            </a:endParaRPr>
          </a:p>
        </p:txBody>
      </p:sp>
      <p:sp>
        <p:nvSpPr>
          <p:cNvPr id="23" name="Rectangle : coins arrondis 22">
            <a:extLst>
              <a:ext uri="{FF2B5EF4-FFF2-40B4-BE49-F238E27FC236}">
                <a16:creationId xmlns:a16="http://schemas.microsoft.com/office/drawing/2014/main" id="{503930F7-2017-F6DC-FC92-28DAFB359D67}"/>
              </a:ext>
            </a:extLst>
          </p:cNvPr>
          <p:cNvSpPr/>
          <p:nvPr/>
        </p:nvSpPr>
        <p:spPr>
          <a:xfrm>
            <a:off x="1263849" y="2485257"/>
            <a:ext cx="3777521" cy="412045"/>
          </a:xfrm>
          <a:prstGeom prst="roundRect">
            <a:avLst/>
          </a:prstGeom>
          <a:solidFill>
            <a:schemeClr val="accent1">
              <a:lumMod val="40000"/>
              <a:lumOff val="6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latin typeface="Arial" panose="020B0604020202020204" pitchFamily="34" charset="0"/>
                <a:cs typeface="Arial" panose="020B0604020202020204" pitchFamily="34" charset="0"/>
              </a:rPr>
              <a:t>Virtual screening FBDD &amp; TBDD</a:t>
            </a:r>
          </a:p>
        </p:txBody>
      </p:sp>
      <p:sp>
        <p:nvSpPr>
          <p:cNvPr id="24" name="Rectangle : coins arrondis 23">
            <a:extLst>
              <a:ext uri="{FF2B5EF4-FFF2-40B4-BE49-F238E27FC236}">
                <a16:creationId xmlns:a16="http://schemas.microsoft.com/office/drawing/2014/main" id="{5F27FFD2-E00B-B3A2-9814-229EC3B0077F}"/>
              </a:ext>
            </a:extLst>
          </p:cNvPr>
          <p:cNvSpPr/>
          <p:nvPr/>
        </p:nvSpPr>
        <p:spPr>
          <a:xfrm>
            <a:off x="1251671" y="3432430"/>
            <a:ext cx="3777521" cy="412045"/>
          </a:xfrm>
          <a:prstGeom prst="roundRect">
            <a:avLst/>
          </a:prstGeom>
          <a:solidFill>
            <a:schemeClr val="accent1">
              <a:lumMod val="40000"/>
              <a:lumOff val="6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latin typeface="Arial" panose="020B0604020202020204" pitchFamily="34" charset="0"/>
                <a:cs typeface="Arial" panose="020B0604020202020204" pitchFamily="34" charset="0"/>
              </a:rPr>
              <a:t>In silico filtering</a:t>
            </a:r>
          </a:p>
        </p:txBody>
      </p:sp>
      <p:sp>
        <p:nvSpPr>
          <p:cNvPr id="25" name="Rectangle : coins arrondis 24">
            <a:extLst>
              <a:ext uri="{FF2B5EF4-FFF2-40B4-BE49-F238E27FC236}">
                <a16:creationId xmlns:a16="http://schemas.microsoft.com/office/drawing/2014/main" id="{B64B452E-1C55-4AAC-B8DC-22E12607F38B}"/>
              </a:ext>
            </a:extLst>
          </p:cNvPr>
          <p:cNvSpPr/>
          <p:nvPr/>
        </p:nvSpPr>
        <p:spPr>
          <a:xfrm>
            <a:off x="1263849" y="4414772"/>
            <a:ext cx="3777521" cy="412045"/>
          </a:xfrm>
          <a:prstGeom prst="roundRect">
            <a:avLst/>
          </a:prstGeom>
          <a:solidFill>
            <a:schemeClr val="accent1">
              <a:lumMod val="40000"/>
              <a:lumOff val="6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latin typeface="Arial" panose="020B0604020202020204" pitchFamily="34" charset="0"/>
                <a:cs typeface="Arial" panose="020B0604020202020204" pitchFamily="34" charset="0"/>
              </a:rPr>
              <a:t>Refinement + MD simulation</a:t>
            </a:r>
          </a:p>
        </p:txBody>
      </p:sp>
      <p:pic>
        <p:nvPicPr>
          <p:cNvPr id="26" name="Image 25" descr="Une image contenant art&#10;&#10;Description générée automatiquement">
            <a:extLst>
              <a:ext uri="{FF2B5EF4-FFF2-40B4-BE49-F238E27FC236}">
                <a16:creationId xmlns:a16="http://schemas.microsoft.com/office/drawing/2014/main" id="{A9E6539C-6AC8-1DA4-51E8-3FABC04B8A8D}"/>
              </a:ext>
            </a:extLst>
          </p:cNvPr>
          <p:cNvPicPr>
            <a:picLocks noChangeAspect="1"/>
          </p:cNvPicPr>
          <p:nvPr/>
        </p:nvPicPr>
        <p:blipFill>
          <a:blip r:embed="rId3"/>
          <a:stretch>
            <a:fillRect/>
          </a:stretch>
        </p:blipFill>
        <p:spPr>
          <a:xfrm>
            <a:off x="8761199" y="329902"/>
            <a:ext cx="2024457" cy="1129929"/>
          </a:xfrm>
          <a:prstGeom prst="rect">
            <a:avLst/>
          </a:prstGeom>
        </p:spPr>
      </p:pic>
      <p:sp>
        <p:nvSpPr>
          <p:cNvPr id="27" name="ZoneTexte 26">
            <a:extLst>
              <a:ext uri="{FF2B5EF4-FFF2-40B4-BE49-F238E27FC236}">
                <a16:creationId xmlns:a16="http://schemas.microsoft.com/office/drawing/2014/main" id="{C9AAA320-C44B-72CD-A66C-78E9382386C5}"/>
              </a:ext>
            </a:extLst>
          </p:cNvPr>
          <p:cNvSpPr txBox="1"/>
          <p:nvPr/>
        </p:nvSpPr>
        <p:spPr>
          <a:xfrm>
            <a:off x="5445435" y="3129752"/>
            <a:ext cx="2822119" cy="923330"/>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Screen assays HTS/LTS: </a:t>
            </a:r>
          </a:p>
          <a:p>
            <a:pPr marL="285750" indent="-285750">
              <a:buFont typeface="Arial" panose="020B0604020202020204" pitchFamily="34" charset="0"/>
              <a:buChar char="•"/>
            </a:pPr>
            <a:r>
              <a:rPr lang="en-US" dirty="0">
                <a:latin typeface="Arial" panose="020B0604020202020204" pitchFamily="34" charset="0"/>
                <a:cs typeface="Arial" panose="020B0604020202020204" pitchFamily="34" charset="0"/>
              </a:rPr>
              <a:t>Cellular FRET</a:t>
            </a:r>
          </a:p>
          <a:p>
            <a:pPr marL="285750" indent="-285750">
              <a:buFont typeface="Arial" panose="020B0604020202020204" pitchFamily="34" charset="0"/>
              <a:buChar char="•"/>
            </a:pPr>
            <a:r>
              <a:rPr lang="en-US" dirty="0" err="1">
                <a:latin typeface="Arial" panose="020B0604020202020204" pitchFamily="34" charset="0"/>
                <a:cs typeface="Arial" panose="020B0604020202020204" pitchFamily="34" charset="0"/>
              </a:rPr>
              <a:t>MTBench</a:t>
            </a:r>
            <a:r>
              <a:rPr lang="en-US" baseline="30000" dirty="0">
                <a:latin typeface="Arial" panose="020B0604020202020204" pitchFamily="34" charset="0"/>
                <a:cs typeface="Arial" panose="020B0604020202020204" pitchFamily="34" charset="0"/>
              </a:rPr>
              <a:t>®</a:t>
            </a:r>
          </a:p>
        </p:txBody>
      </p:sp>
      <p:sp>
        <p:nvSpPr>
          <p:cNvPr id="28" name="Virage 27">
            <a:extLst>
              <a:ext uri="{FF2B5EF4-FFF2-40B4-BE49-F238E27FC236}">
                <a16:creationId xmlns:a16="http://schemas.microsoft.com/office/drawing/2014/main" id="{A59D2A27-298E-8B4F-915B-343F70BCF43E}"/>
              </a:ext>
            </a:extLst>
          </p:cNvPr>
          <p:cNvSpPr/>
          <p:nvPr/>
        </p:nvSpPr>
        <p:spPr>
          <a:xfrm rot="10800000">
            <a:off x="5203740" y="2141988"/>
            <a:ext cx="933596" cy="755314"/>
          </a:xfrm>
          <a:prstGeom prst="bentArrow">
            <a:avLst/>
          </a:prstGeom>
          <a:solidFill>
            <a:schemeClr val="accent2">
              <a:lumMod val="60000"/>
              <a:lumOff val="4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29" name="Virage 28">
            <a:extLst>
              <a:ext uri="{FF2B5EF4-FFF2-40B4-BE49-F238E27FC236}">
                <a16:creationId xmlns:a16="http://schemas.microsoft.com/office/drawing/2014/main" id="{953D1699-C9EA-A0C7-EEB1-815504A90FFB}"/>
              </a:ext>
            </a:extLst>
          </p:cNvPr>
          <p:cNvSpPr/>
          <p:nvPr/>
        </p:nvSpPr>
        <p:spPr>
          <a:xfrm rot="10800000">
            <a:off x="5218252" y="4071503"/>
            <a:ext cx="933596" cy="755314"/>
          </a:xfrm>
          <a:prstGeom prst="bentArrow">
            <a:avLst/>
          </a:prstGeom>
          <a:solidFill>
            <a:schemeClr val="accent2">
              <a:lumMod val="60000"/>
              <a:lumOff val="4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pic>
        <p:nvPicPr>
          <p:cNvPr id="32" name="Image 31" descr="Une image contenant ballon, violet&#10;&#10;Description générée automatiquement">
            <a:extLst>
              <a:ext uri="{FF2B5EF4-FFF2-40B4-BE49-F238E27FC236}">
                <a16:creationId xmlns:a16="http://schemas.microsoft.com/office/drawing/2014/main" id="{34CB0EA8-6ADB-36B3-B442-FEC93468A28B}"/>
              </a:ext>
            </a:extLst>
          </p:cNvPr>
          <p:cNvPicPr>
            <a:picLocks noChangeAspect="1"/>
          </p:cNvPicPr>
          <p:nvPr/>
        </p:nvPicPr>
        <p:blipFill>
          <a:blip r:embed="rId4"/>
          <a:stretch>
            <a:fillRect/>
          </a:stretch>
        </p:blipFill>
        <p:spPr>
          <a:xfrm>
            <a:off x="2407588" y="5632209"/>
            <a:ext cx="857791" cy="414722"/>
          </a:xfrm>
          <a:prstGeom prst="rect">
            <a:avLst/>
          </a:prstGeom>
        </p:spPr>
      </p:pic>
      <p:pic>
        <p:nvPicPr>
          <p:cNvPr id="33" name="Image 32" descr="Une image contenant ballon, violet&#10;&#10;Description générée automatiquement">
            <a:extLst>
              <a:ext uri="{FF2B5EF4-FFF2-40B4-BE49-F238E27FC236}">
                <a16:creationId xmlns:a16="http://schemas.microsoft.com/office/drawing/2014/main" id="{7F61CBAE-753E-7204-24AF-A2C6A854D69A}"/>
              </a:ext>
            </a:extLst>
          </p:cNvPr>
          <p:cNvPicPr>
            <a:picLocks noChangeAspect="1"/>
          </p:cNvPicPr>
          <p:nvPr/>
        </p:nvPicPr>
        <p:blipFill>
          <a:blip r:embed="rId4">
            <a:duotone>
              <a:schemeClr val="accent6">
                <a:shade val="45000"/>
                <a:satMod val="135000"/>
              </a:schemeClr>
              <a:prstClr val="white"/>
            </a:duotone>
          </a:blip>
          <a:stretch>
            <a:fillRect/>
          </a:stretch>
        </p:blipFill>
        <p:spPr>
          <a:xfrm>
            <a:off x="3022342" y="5482694"/>
            <a:ext cx="793594" cy="383684"/>
          </a:xfrm>
          <a:prstGeom prst="rect">
            <a:avLst/>
          </a:prstGeom>
        </p:spPr>
      </p:pic>
      <p:pic>
        <p:nvPicPr>
          <p:cNvPr id="34" name="Image 33" descr="Une image contenant ballon, violet&#10;&#10;Description générée automatiquement">
            <a:extLst>
              <a:ext uri="{FF2B5EF4-FFF2-40B4-BE49-F238E27FC236}">
                <a16:creationId xmlns:a16="http://schemas.microsoft.com/office/drawing/2014/main" id="{D3FDB8B2-3FCF-035B-FCDB-71AC27D72B07}"/>
              </a:ext>
            </a:extLst>
          </p:cNvPr>
          <p:cNvPicPr>
            <a:picLocks noChangeAspect="1"/>
          </p:cNvPicPr>
          <p:nvPr/>
        </p:nvPicPr>
        <p:blipFill>
          <a:blip r:embed="rId4">
            <a:duotone>
              <a:schemeClr val="accent4">
                <a:shade val="45000"/>
                <a:satMod val="135000"/>
              </a:schemeClr>
              <a:prstClr val="white"/>
            </a:duotone>
          </a:blip>
          <a:stretch>
            <a:fillRect/>
          </a:stretch>
        </p:blipFill>
        <p:spPr>
          <a:xfrm>
            <a:off x="2711474" y="5838168"/>
            <a:ext cx="791784" cy="382809"/>
          </a:xfrm>
          <a:prstGeom prst="rect">
            <a:avLst/>
          </a:prstGeom>
        </p:spPr>
      </p:pic>
      <p:pic>
        <p:nvPicPr>
          <p:cNvPr id="35" name="Image 34">
            <a:extLst>
              <a:ext uri="{FF2B5EF4-FFF2-40B4-BE49-F238E27FC236}">
                <a16:creationId xmlns:a16="http://schemas.microsoft.com/office/drawing/2014/main" id="{2D044778-A1DD-3569-42B7-A4F6669E9C73}"/>
              </a:ext>
            </a:extLst>
          </p:cNvPr>
          <p:cNvPicPr>
            <a:picLocks noChangeAspect="1"/>
          </p:cNvPicPr>
          <p:nvPr/>
        </p:nvPicPr>
        <p:blipFill>
          <a:blip r:embed="rId5"/>
          <a:stretch/>
        </p:blipFill>
        <p:spPr bwMode="auto">
          <a:xfrm>
            <a:off x="9201871" y="3056445"/>
            <a:ext cx="1069944" cy="1069944"/>
          </a:xfrm>
          <a:prstGeom prst="rect">
            <a:avLst/>
          </a:prstGeom>
        </p:spPr>
      </p:pic>
      <p:sp>
        <p:nvSpPr>
          <p:cNvPr id="36" name="ZoneTexte 35">
            <a:extLst>
              <a:ext uri="{FF2B5EF4-FFF2-40B4-BE49-F238E27FC236}">
                <a16:creationId xmlns:a16="http://schemas.microsoft.com/office/drawing/2014/main" id="{FF6707DB-BCCB-1D0E-F9FA-477E6643C83D}"/>
              </a:ext>
            </a:extLst>
          </p:cNvPr>
          <p:cNvSpPr txBox="1"/>
          <p:nvPr/>
        </p:nvSpPr>
        <p:spPr>
          <a:xfrm>
            <a:off x="1836228" y="6226211"/>
            <a:ext cx="2608406" cy="369332"/>
          </a:xfrm>
          <a:prstGeom prst="rect">
            <a:avLst/>
          </a:prstGeom>
          <a:noFill/>
        </p:spPr>
        <p:txBody>
          <a:bodyPr wrap="none" rtlCol="0">
            <a:spAutoFit/>
          </a:bodyPr>
          <a:lstStyle/>
          <a:p>
            <a:pPr algn="ctr"/>
            <a:r>
              <a:rPr lang="en-US" dirty="0">
                <a:latin typeface="Arial" panose="020B0604020202020204" pitchFamily="34" charset="0"/>
                <a:cs typeface="Arial" panose="020B0604020202020204" pitchFamily="34" charset="0"/>
              </a:rPr>
              <a:t>Identified molecular hits</a:t>
            </a:r>
          </a:p>
        </p:txBody>
      </p:sp>
      <p:pic>
        <p:nvPicPr>
          <p:cNvPr id="37" name="Image 36" descr="Une image contenant cercle, texte, Police, conception&#10;&#10;Description générée automatiquement">
            <a:extLst>
              <a:ext uri="{FF2B5EF4-FFF2-40B4-BE49-F238E27FC236}">
                <a16:creationId xmlns:a16="http://schemas.microsoft.com/office/drawing/2014/main" id="{392636A8-060C-A957-0010-322A4ED2F1E8}"/>
              </a:ext>
            </a:extLst>
          </p:cNvPr>
          <p:cNvPicPr>
            <a:picLocks noChangeAspect="1"/>
          </p:cNvPicPr>
          <p:nvPr/>
        </p:nvPicPr>
        <p:blipFill>
          <a:blip r:embed="rId6"/>
          <a:stretch>
            <a:fillRect/>
          </a:stretch>
        </p:blipFill>
        <p:spPr>
          <a:xfrm>
            <a:off x="8854745" y="1638363"/>
            <a:ext cx="1837364" cy="646827"/>
          </a:xfrm>
          <a:prstGeom prst="rect">
            <a:avLst/>
          </a:prstGeom>
        </p:spPr>
      </p:pic>
      <p:sp>
        <p:nvSpPr>
          <p:cNvPr id="2" name="ZoneTexte 1">
            <a:extLst>
              <a:ext uri="{FF2B5EF4-FFF2-40B4-BE49-F238E27FC236}">
                <a16:creationId xmlns:a16="http://schemas.microsoft.com/office/drawing/2014/main" id="{4545AA00-5494-A50C-AC4E-B514C3FD327C}"/>
              </a:ext>
            </a:extLst>
          </p:cNvPr>
          <p:cNvSpPr txBox="1"/>
          <p:nvPr/>
        </p:nvSpPr>
        <p:spPr>
          <a:xfrm>
            <a:off x="9278224" y="4126389"/>
            <a:ext cx="917239" cy="276999"/>
          </a:xfrm>
          <a:prstGeom prst="rect">
            <a:avLst/>
          </a:prstGeom>
          <a:noFill/>
        </p:spPr>
        <p:txBody>
          <a:bodyPr wrap="none" rtlCol="0">
            <a:spAutoFit/>
          </a:bodyPr>
          <a:lstStyle/>
          <a:p>
            <a:pPr algn="ctr"/>
            <a:r>
              <a:rPr lang="en-US" sz="1200" i="1" dirty="0" err="1">
                <a:latin typeface="Arial" panose="020B0604020202020204" pitchFamily="34" charset="0"/>
                <a:cs typeface="Arial" panose="020B0604020202020204" pitchFamily="34" charset="0"/>
              </a:rPr>
              <a:t>MTBench</a:t>
            </a:r>
            <a:r>
              <a:rPr lang="en-US" sz="1200" i="1" baseline="30000" dirty="0">
                <a:latin typeface="Arial" panose="020B0604020202020204" pitchFamily="34" charset="0"/>
                <a:cs typeface="Arial" panose="020B0604020202020204" pitchFamily="34" charset="0"/>
              </a:rPr>
              <a:t>®</a:t>
            </a:r>
          </a:p>
        </p:txBody>
      </p:sp>
      <p:sp>
        <p:nvSpPr>
          <p:cNvPr id="3" name="ZoneTexte 2">
            <a:extLst>
              <a:ext uri="{FF2B5EF4-FFF2-40B4-BE49-F238E27FC236}">
                <a16:creationId xmlns:a16="http://schemas.microsoft.com/office/drawing/2014/main" id="{E86EF58F-B2C1-465E-1D81-24A4AA1C7180}"/>
              </a:ext>
            </a:extLst>
          </p:cNvPr>
          <p:cNvSpPr txBox="1"/>
          <p:nvPr/>
        </p:nvSpPr>
        <p:spPr>
          <a:xfrm>
            <a:off x="9431309" y="1382396"/>
            <a:ext cx="611065" cy="276999"/>
          </a:xfrm>
          <a:prstGeom prst="rect">
            <a:avLst/>
          </a:prstGeom>
          <a:noFill/>
        </p:spPr>
        <p:txBody>
          <a:bodyPr wrap="none" rtlCol="0">
            <a:spAutoFit/>
          </a:bodyPr>
          <a:lstStyle/>
          <a:p>
            <a:pPr algn="ctr"/>
            <a:r>
              <a:rPr lang="en-US" sz="1200" i="1" dirty="0">
                <a:latin typeface="Arial" panose="020B0604020202020204" pitchFamily="34" charset="0"/>
                <a:cs typeface="Arial" panose="020B0604020202020204" pitchFamily="34" charset="0"/>
              </a:rPr>
              <a:t>X-Ray</a:t>
            </a:r>
          </a:p>
        </p:txBody>
      </p:sp>
      <p:sp>
        <p:nvSpPr>
          <p:cNvPr id="17" name="ZoneTexte 16">
            <a:extLst>
              <a:ext uri="{FF2B5EF4-FFF2-40B4-BE49-F238E27FC236}">
                <a16:creationId xmlns:a16="http://schemas.microsoft.com/office/drawing/2014/main" id="{52B52CB2-C146-9856-DCE1-A72B6E97C79A}"/>
              </a:ext>
            </a:extLst>
          </p:cNvPr>
          <p:cNvSpPr txBox="1"/>
          <p:nvPr/>
        </p:nvSpPr>
        <p:spPr>
          <a:xfrm>
            <a:off x="9469781" y="2319172"/>
            <a:ext cx="534122" cy="276999"/>
          </a:xfrm>
          <a:prstGeom prst="rect">
            <a:avLst/>
          </a:prstGeom>
          <a:noFill/>
        </p:spPr>
        <p:txBody>
          <a:bodyPr wrap="none" rtlCol="0">
            <a:spAutoFit/>
          </a:bodyPr>
          <a:lstStyle/>
          <a:p>
            <a:pPr algn="ctr"/>
            <a:r>
              <a:rPr lang="en-US" sz="1200" i="1" dirty="0">
                <a:latin typeface="Arial" panose="020B0604020202020204" pitchFamily="34" charset="0"/>
                <a:cs typeface="Arial" panose="020B0604020202020204" pitchFamily="34" charset="0"/>
              </a:rPr>
              <a:t>NMR</a:t>
            </a:r>
          </a:p>
        </p:txBody>
      </p:sp>
    </p:spTree>
    <p:extLst>
      <p:ext uri="{BB962C8B-B14F-4D97-AF65-F5344CB8AC3E}">
        <p14:creationId xmlns:p14="http://schemas.microsoft.com/office/powerpoint/2010/main" val="312995824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 name="Double flèche verticale 17">
            <a:extLst>
              <a:ext uri="{FF2B5EF4-FFF2-40B4-BE49-F238E27FC236}">
                <a16:creationId xmlns:a16="http://schemas.microsoft.com/office/drawing/2014/main" id="{64D80E15-A956-7660-9AEE-E7BDAE6FA34F}"/>
              </a:ext>
            </a:extLst>
          </p:cNvPr>
          <p:cNvSpPr/>
          <p:nvPr/>
        </p:nvSpPr>
        <p:spPr>
          <a:xfrm rot="16200000">
            <a:off x="6061089" y="3970845"/>
            <a:ext cx="369332" cy="1263972"/>
          </a:xfrm>
          <a:prstGeom prst="upDownArrow">
            <a:avLst/>
          </a:prstGeom>
          <a:solidFill>
            <a:schemeClr val="bg1">
              <a:lumMod val="7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7" name="Flèche vers la droite 26">
            <a:extLst>
              <a:ext uri="{FF2B5EF4-FFF2-40B4-BE49-F238E27FC236}">
                <a16:creationId xmlns:a16="http://schemas.microsoft.com/office/drawing/2014/main" id="{42341607-9BE4-F801-4616-499B38C5F508}"/>
              </a:ext>
            </a:extLst>
          </p:cNvPr>
          <p:cNvSpPr/>
          <p:nvPr/>
        </p:nvSpPr>
        <p:spPr>
          <a:xfrm rot="5400000">
            <a:off x="4570182" y="3414201"/>
            <a:ext cx="1184013" cy="354716"/>
          </a:xfrm>
          <a:prstGeom prst="rightArrow">
            <a:avLst/>
          </a:prstGeom>
          <a:solidFill>
            <a:schemeClr val="bg1">
              <a:lumMod val="7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 name="Flèche vers la droite 37">
            <a:extLst>
              <a:ext uri="{FF2B5EF4-FFF2-40B4-BE49-F238E27FC236}">
                <a16:creationId xmlns:a16="http://schemas.microsoft.com/office/drawing/2014/main" id="{9BD60FF3-F714-A59F-574A-8874647017A6}"/>
              </a:ext>
            </a:extLst>
          </p:cNvPr>
          <p:cNvSpPr/>
          <p:nvPr/>
        </p:nvSpPr>
        <p:spPr>
          <a:xfrm rot="5400000">
            <a:off x="6740558" y="3401608"/>
            <a:ext cx="1184013" cy="354716"/>
          </a:xfrm>
          <a:prstGeom prst="rightArrow">
            <a:avLst/>
          </a:prstGeom>
          <a:solidFill>
            <a:schemeClr val="bg1">
              <a:lumMod val="7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Flèche vers la droite 25">
            <a:extLst>
              <a:ext uri="{FF2B5EF4-FFF2-40B4-BE49-F238E27FC236}">
                <a16:creationId xmlns:a16="http://schemas.microsoft.com/office/drawing/2014/main" id="{9286838E-CB32-CE69-5EAB-E8239F8DF4B3}"/>
              </a:ext>
            </a:extLst>
          </p:cNvPr>
          <p:cNvSpPr/>
          <p:nvPr/>
        </p:nvSpPr>
        <p:spPr>
          <a:xfrm>
            <a:off x="5630315" y="2452594"/>
            <a:ext cx="1196626" cy="354716"/>
          </a:xfrm>
          <a:prstGeom prst="rightArrow">
            <a:avLst/>
          </a:prstGeom>
          <a:solidFill>
            <a:schemeClr val="bg1">
              <a:lumMod val="7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ZoneTexte 3">
            <a:extLst>
              <a:ext uri="{FF2B5EF4-FFF2-40B4-BE49-F238E27FC236}">
                <a16:creationId xmlns:a16="http://schemas.microsoft.com/office/drawing/2014/main" id="{62E49103-83E1-E43E-03D1-84FBE4D166FA}"/>
              </a:ext>
            </a:extLst>
          </p:cNvPr>
          <p:cNvSpPr txBox="1"/>
          <p:nvPr/>
        </p:nvSpPr>
        <p:spPr>
          <a:xfrm>
            <a:off x="-978861" y="0"/>
            <a:ext cx="1095172" cy="369332"/>
          </a:xfrm>
          <a:prstGeom prst="rect">
            <a:avLst/>
          </a:prstGeom>
          <a:noFill/>
        </p:spPr>
        <p:txBody>
          <a:bodyPr wrap="none" rtlCol="0">
            <a:spAutoFit/>
          </a:bodyPr>
          <a:lstStyle/>
          <a:p>
            <a:r>
              <a:rPr lang="fr-FR" dirty="0">
                <a:latin typeface="Arial" panose="020B0604020202020204" pitchFamily="34" charset="0"/>
                <a:cs typeface="Arial" panose="020B0604020202020204" pitchFamily="34" charset="0"/>
              </a:rPr>
              <a:t>Figure 3.</a:t>
            </a:r>
            <a:endParaRPr lang="fr-FR" dirty="0">
              <a:highlight>
                <a:srgbClr val="FFFF00"/>
              </a:highlight>
              <a:latin typeface="Arial" panose="020B0604020202020204" pitchFamily="34" charset="0"/>
              <a:cs typeface="Arial" panose="020B0604020202020204" pitchFamily="34" charset="0"/>
            </a:endParaRPr>
          </a:p>
        </p:txBody>
      </p:sp>
      <p:sp>
        <p:nvSpPr>
          <p:cNvPr id="3" name="Rectangle : coins arrondis 2">
            <a:extLst>
              <a:ext uri="{FF2B5EF4-FFF2-40B4-BE49-F238E27FC236}">
                <a16:creationId xmlns:a16="http://schemas.microsoft.com/office/drawing/2014/main" id="{865BBEA8-B32F-F2D6-9653-46B4C72E4E95}"/>
              </a:ext>
            </a:extLst>
          </p:cNvPr>
          <p:cNvSpPr/>
          <p:nvPr/>
        </p:nvSpPr>
        <p:spPr>
          <a:xfrm>
            <a:off x="6826941" y="605920"/>
            <a:ext cx="4768770" cy="2412179"/>
          </a:xfrm>
          <a:prstGeom prst="roundRect">
            <a:avLst>
              <a:gd name="adj" fmla="val 5151"/>
            </a:avLst>
          </a:prstGeom>
          <a:solidFill>
            <a:schemeClr val="bg1"/>
          </a:solidFill>
          <a:ln>
            <a:solidFill>
              <a:schemeClr val="bg1">
                <a:lumMod val="7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 name="Rectangle : coins arrondis 4">
            <a:extLst>
              <a:ext uri="{FF2B5EF4-FFF2-40B4-BE49-F238E27FC236}">
                <a16:creationId xmlns:a16="http://schemas.microsoft.com/office/drawing/2014/main" id="{D0513892-D8FC-A7F9-8A79-99D178A063E7}"/>
              </a:ext>
            </a:extLst>
          </p:cNvPr>
          <p:cNvSpPr/>
          <p:nvPr/>
        </p:nvSpPr>
        <p:spPr>
          <a:xfrm>
            <a:off x="861248" y="605920"/>
            <a:ext cx="4768770" cy="2412179"/>
          </a:xfrm>
          <a:prstGeom prst="roundRect">
            <a:avLst>
              <a:gd name="adj" fmla="val 5151"/>
            </a:avLst>
          </a:prstGeom>
          <a:solidFill>
            <a:schemeClr val="bg1"/>
          </a:solidFill>
          <a:ln>
            <a:solidFill>
              <a:schemeClr val="bg1">
                <a:lumMod val="7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6" name="Rectangle : coins arrondis 5">
            <a:extLst>
              <a:ext uri="{FF2B5EF4-FFF2-40B4-BE49-F238E27FC236}">
                <a16:creationId xmlns:a16="http://schemas.microsoft.com/office/drawing/2014/main" id="{F18BCEBE-E0F1-E955-6379-5750045AD473}"/>
              </a:ext>
            </a:extLst>
          </p:cNvPr>
          <p:cNvSpPr/>
          <p:nvPr/>
        </p:nvSpPr>
        <p:spPr>
          <a:xfrm>
            <a:off x="6826941" y="4158776"/>
            <a:ext cx="4768770" cy="2412179"/>
          </a:xfrm>
          <a:prstGeom prst="roundRect">
            <a:avLst>
              <a:gd name="adj" fmla="val 5151"/>
            </a:avLst>
          </a:prstGeom>
          <a:solidFill>
            <a:schemeClr val="bg1"/>
          </a:solidFill>
          <a:ln>
            <a:solidFill>
              <a:schemeClr val="bg1">
                <a:lumMod val="7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 name="Rectangle : coins arrondis 7">
            <a:extLst>
              <a:ext uri="{FF2B5EF4-FFF2-40B4-BE49-F238E27FC236}">
                <a16:creationId xmlns:a16="http://schemas.microsoft.com/office/drawing/2014/main" id="{E1A66A2C-30C4-25BF-93F0-894FBAB6331A}"/>
              </a:ext>
            </a:extLst>
          </p:cNvPr>
          <p:cNvSpPr/>
          <p:nvPr/>
        </p:nvSpPr>
        <p:spPr>
          <a:xfrm>
            <a:off x="861248" y="4158776"/>
            <a:ext cx="4768770" cy="2412179"/>
          </a:xfrm>
          <a:prstGeom prst="roundRect">
            <a:avLst>
              <a:gd name="adj" fmla="val 5151"/>
            </a:avLst>
          </a:prstGeom>
          <a:solidFill>
            <a:schemeClr val="bg1"/>
          </a:solidFill>
          <a:ln>
            <a:solidFill>
              <a:schemeClr val="bg1">
                <a:lumMod val="7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 name="ZoneTexte 12">
            <a:extLst>
              <a:ext uri="{FF2B5EF4-FFF2-40B4-BE49-F238E27FC236}">
                <a16:creationId xmlns:a16="http://schemas.microsoft.com/office/drawing/2014/main" id="{B0C2BF01-3571-7AF7-94B1-9A7FC15ED7B8}"/>
              </a:ext>
            </a:extLst>
          </p:cNvPr>
          <p:cNvSpPr txBox="1"/>
          <p:nvPr/>
        </p:nvSpPr>
        <p:spPr>
          <a:xfrm>
            <a:off x="6835500" y="607379"/>
            <a:ext cx="2210862" cy="369332"/>
          </a:xfrm>
          <a:prstGeom prst="rect">
            <a:avLst/>
          </a:prstGeom>
          <a:noFill/>
        </p:spPr>
        <p:txBody>
          <a:bodyPr wrap="none" rtlCol="0">
            <a:spAutoFit/>
          </a:bodyPr>
          <a:lstStyle/>
          <a:p>
            <a:pPr algn="ctr"/>
            <a:r>
              <a:rPr lang="en-US" b="1" dirty="0">
                <a:latin typeface="Arial" panose="020B0604020202020204" pitchFamily="34" charset="0"/>
                <a:cs typeface="Arial" panose="020B0604020202020204" pitchFamily="34" charset="0"/>
              </a:rPr>
              <a:t>2. Low-throughput</a:t>
            </a:r>
          </a:p>
        </p:txBody>
      </p:sp>
      <p:sp>
        <p:nvSpPr>
          <p:cNvPr id="14" name="ZoneTexte 13">
            <a:extLst>
              <a:ext uri="{FF2B5EF4-FFF2-40B4-BE49-F238E27FC236}">
                <a16:creationId xmlns:a16="http://schemas.microsoft.com/office/drawing/2014/main" id="{B7995E8F-546D-E197-DA6A-18342FD24277}"/>
              </a:ext>
            </a:extLst>
          </p:cNvPr>
          <p:cNvSpPr txBox="1"/>
          <p:nvPr/>
        </p:nvSpPr>
        <p:spPr>
          <a:xfrm>
            <a:off x="6844445" y="4165900"/>
            <a:ext cx="1608134" cy="369332"/>
          </a:xfrm>
          <a:prstGeom prst="rect">
            <a:avLst/>
          </a:prstGeom>
          <a:noFill/>
        </p:spPr>
        <p:txBody>
          <a:bodyPr wrap="none" rtlCol="0">
            <a:spAutoFit/>
          </a:bodyPr>
          <a:lstStyle/>
          <a:p>
            <a:pPr algn="ctr"/>
            <a:r>
              <a:rPr lang="en-US" b="1" dirty="0">
                <a:latin typeface="Arial" panose="020B0604020202020204" pitchFamily="34" charset="0"/>
                <a:cs typeface="Arial" panose="020B0604020202020204" pitchFamily="34" charset="0"/>
              </a:rPr>
              <a:t>3. Functional</a:t>
            </a:r>
          </a:p>
        </p:txBody>
      </p:sp>
      <p:sp>
        <p:nvSpPr>
          <p:cNvPr id="15" name="ZoneTexte 14">
            <a:extLst>
              <a:ext uri="{FF2B5EF4-FFF2-40B4-BE49-F238E27FC236}">
                <a16:creationId xmlns:a16="http://schemas.microsoft.com/office/drawing/2014/main" id="{BF1B65A7-C004-7D82-4B3B-D3A22925FE95}"/>
              </a:ext>
            </a:extLst>
          </p:cNvPr>
          <p:cNvSpPr txBox="1"/>
          <p:nvPr/>
        </p:nvSpPr>
        <p:spPr>
          <a:xfrm>
            <a:off x="871401" y="4158776"/>
            <a:ext cx="1531189" cy="369332"/>
          </a:xfrm>
          <a:prstGeom prst="rect">
            <a:avLst/>
          </a:prstGeom>
          <a:noFill/>
        </p:spPr>
        <p:txBody>
          <a:bodyPr wrap="none" rtlCol="0">
            <a:spAutoFit/>
          </a:bodyPr>
          <a:lstStyle/>
          <a:p>
            <a:pPr algn="ctr"/>
            <a:r>
              <a:rPr lang="fr-FR" b="1" dirty="0">
                <a:latin typeface="Arial" panose="020B0604020202020204" pitchFamily="34" charset="0"/>
                <a:cs typeface="Arial" panose="020B0604020202020204" pitchFamily="34" charset="0"/>
              </a:rPr>
              <a:t>4. Structural</a:t>
            </a:r>
          </a:p>
        </p:txBody>
      </p:sp>
      <p:sp>
        <p:nvSpPr>
          <p:cNvPr id="12" name="ZoneTexte 11">
            <a:extLst>
              <a:ext uri="{FF2B5EF4-FFF2-40B4-BE49-F238E27FC236}">
                <a16:creationId xmlns:a16="http://schemas.microsoft.com/office/drawing/2014/main" id="{6EC6D9AA-1E89-0BC1-FD69-DB8E3069A60E}"/>
              </a:ext>
            </a:extLst>
          </p:cNvPr>
          <p:cNvSpPr txBox="1"/>
          <p:nvPr/>
        </p:nvSpPr>
        <p:spPr>
          <a:xfrm>
            <a:off x="862394" y="624851"/>
            <a:ext cx="2262158" cy="369332"/>
          </a:xfrm>
          <a:prstGeom prst="rect">
            <a:avLst/>
          </a:prstGeom>
          <a:noFill/>
        </p:spPr>
        <p:txBody>
          <a:bodyPr wrap="none" rtlCol="0">
            <a:spAutoFit/>
          </a:bodyPr>
          <a:lstStyle/>
          <a:p>
            <a:pPr algn="ctr"/>
            <a:r>
              <a:rPr lang="en-US" b="1" dirty="0">
                <a:latin typeface="Arial" panose="020B0604020202020204" pitchFamily="34" charset="0"/>
                <a:cs typeface="Arial" panose="020B0604020202020204" pitchFamily="34" charset="0"/>
              </a:rPr>
              <a:t>1. High-throughput</a:t>
            </a:r>
          </a:p>
        </p:txBody>
      </p:sp>
      <p:sp>
        <p:nvSpPr>
          <p:cNvPr id="37" name="ZoneTexte 36">
            <a:extLst>
              <a:ext uri="{FF2B5EF4-FFF2-40B4-BE49-F238E27FC236}">
                <a16:creationId xmlns:a16="http://schemas.microsoft.com/office/drawing/2014/main" id="{19A7AF13-7563-439A-C665-75A03E24698C}"/>
              </a:ext>
            </a:extLst>
          </p:cNvPr>
          <p:cNvSpPr txBox="1"/>
          <p:nvPr/>
        </p:nvSpPr>
        <p:spPr>
          <a:xfrm>
            <a:off x="1546307" y="1974674"/>
            <a:ext cx="1880945" cy="923330"/>
          </a:xfrm>
          <a:prstGeom prst="rect">
            <a:avLst/>
          </a:prstGeom>
          <a:noFill/>
        </p:spPr>
        <p:txBody>
          <a:bodyPr wrap="square">
            <a:spAutoFit/>
          </a:bodyPr>
          <a:lstStyle/>
          <a:p>
            <a:r>
              <a:rPr lang="en-US" dirty="0">
                <a:latin typeface="Arial" panose="020B0604020202020204" pitchFamily="34" charset="0"/>
                <a:cs typeface="Arial" panose="020B0604020202020204" pitchFamily="34" charset="0"/>
              </a:rPr>
              <a:t>? Cellular FRET</a:t>
            </a:r>
          </a:p>
          <a:p>
            <a:r>
              <a:rPr lang="en-US" dirty="0" err="1">
                <a:latin typeface="Arial" panose="020B0604020202020204" pitchFamily="34" charset="0"/>
                <a:cs typeface="Arial" panose="020B0604020202020204" pitchFamily="34" charset="0"/>
              </a:rPr>
              <a:t>MTBench</a:t>
            </a:r>
            <a:r>
              <a:rPr lang="en-US" baseline="30000" dirty="0">
                <a:latin typeface="Arial" panose="020B0604020202020204" pitchFamily="34" charset="0"/>
                <a:cs typeface="Arial" panose="020B0604020202020204" pitchFamily="34" charset="0"/>
              </a:rPr>
              <a:t>®</a:t>
            </a:r>
          </a:p>
          <a:p>
            <a:r>
              <a:rPr lang="en-US" dirty="0">
                <a:latin typeface="Arial" panose="020B0604020202020204" pitchFamily="34" charset="0"/>
                <a:cs typeface="Arial" panose="020B0604020202020204" pitchFamily="34" charset="0"/>
              </a:rPr>
              <a:t>? PLA</a:t>
            </a:r>
          </a:p>
        </p:txBody>
      </p:sp>
      <p:sp>
        <p:nvSpPr>
          <p:cNvPr id="39" name="ZoneTexte 38">
            <a:extLst>
              <a:ext uri="{FF2B5EF4-FFF2-40B4-BE49-F238E27FC236}">
                <a16:creationId xmlns:a16="http://schemas.microsoft.com/office/drawing/2014/main" id="{0CF157D5-D773-9283-E4B8-8F332FC8DF18}"/>
              </a:ext>
            </a:extLst>
          </p:cNvPr>
          <p:cNvSpPr txBox="1"/>
          <p:nvPr/>
        </p:nvSpPr>
        <p:spPr>
          <a:xfrm>
            <a:off x="1556988" y="1018267"/>
            <a:ext cx="4165212" cy="923330"/>
          </a:xfrm>
          <a:prstGeom prst="rect">
            <a:avLst/>
          </a:prstGeom>
          <a:noFill/>
        </p:spPr>
        <p:txBody>
          <a:bodyPr wrap="square">
            <a:spAutoFit/>
          </a:bodyPr>
          <a:lstStyle/>
          <a:p>
            <a:r>
              <a:rPr lang="en-US" dirty="0">
                <a:latin typeface="Arial" panose="020B0604020202020204" pitchFamily="34" charset="0"/>
                <a:cs typeface="Arial" panose="020B0604020202020204" pitchFamily="34" charset="0"/>
              </a:rPr>
              <a:t>Fluorescence polarization</a:t>
            </a:r>
          </a:p>
          <a:p>
            <a:r>
              <a:rPr lang="en-US" dirty="0">
                <a:latin typeface="Arial" panose="020B0604020202020204" pitchFamily="34" charset="0"/>
                <a:cs typeface="Arial" panose="020B0604020202020204" pitchFamily="34" charset="0"/>
              </a:rPr>
              <a:t>? FRET-based </a:t>
            </a:r>
          </a:p>
          <a:p>
            <a:r>
              <a:rPr lang="en-US" dirty="0">
                <a:latin typeface="Arial" panose="020B0604020202020204" pitchFamily="34" charset="0"/>
                <a:cs typeface="Arial" panose="020B0604020202020204" pitchFamily="34" charset="0"/>
              </a:rPr>
              <a:t>(HTRF, </a:t>
            </a:r>
            <a:r>
              <a:rPr lang="en-US" dirty="0" err="1">
                <a:latin typeface="Arial" panose="020B0604020202020204" pitchFamily="34" charset="0"/>
                <a:cs typeface="Arial" panose="020B0604020202020204" pitchFamily="34" charset="0"/>
              </a:rPr>
              <a:t>AlphaScreen</a:t>
            </a:r>
            <a:r>
              <a:rPr lang="en-US" dirty="0">
                <a:latin typeface="Arial" panose="020B0604020202020204" pitchFamily="34" charset="0"/>
                <a:cs typeface="Arial" panose="020B0604020202020204" pitchFamily="34" charset="0"/>
              </a:rPr>
              <a:t>)</a:t>
            </a:r>
          </a:p>
        </p:txBody>
      </p:sp>
      <p:sp>
        <p:nvSpPr>
          <p:cNvPr id="41" name="ZoneTexte 40">
            <a:extLst>
              <a:ext uri="{FF2B5EF4-FFF2-40B4-BE49-F238E27FC236}">
                <a16:creationId xmlns:a16="http://schemas.microsoft.com/office/drawing/2014/main" id="{965BB7D4-7601-2DB4-6D4A-25601A6002AD}"/>
              </a:ext>
            </a:extLst>
          </p:cNvPr>
          <p:cNvSpPr txBox="1"/>
          <p:nvPr/>
        </p:nvSpPr>
        <p:spPr>
          <a:xfrm>
            <a:off x="7498752" y="974068"/>
            <a:ext cx="1664462" cy="923330"/>
          </a:xfrm>
          <a:prstGeom prst="rect">
            <a:avLst/>
          </a:prstGeom>
          <a:noFill/>
        </p:spPr>
        <p:txBody>
          <a:bodyPr wrap="square">
            <a:spAutoFit/>
          </a:bodyPr>
          <a:lstStyle/>
          <a:p>
            <a:r>
              <a:rPr lang="en-US" dirty="0">
                <a:latin typeface="Arial" panose="020B0604020202020204" pitchFamily="34" charset="0"/>
                <a:cs typeface="Arial" panose="020B0604020202020204" pitchFamily="34" charset="0"/>
              </a:rPr>
              <a:t>ITC</a:t>
            </a:r>
          </a:p>
          <a:p>
            <a:r>
              <a:rPr lang="en-US" dirty="0">
                <a:latin typeface="Arial" panose="020B0604020202020204" pitchFamily="34" charset="0"/>
                <a:cs typeface="Arial" panose="020B0604020202020204" pitchFamily="34" charset="0"/>
              </a:rPr>
              <a:t>SPR</a:t>
            </a:r>
          </a:p>
          <a:p>
            <a:r>
              <a:rPr lang="en-US" dirty="0">
                <a:latin typeface="Arial" panose="020B0604020202020204" pitchFamily="34" charset="0"/>
                <a:cs typeface="Arial" panose="020B0604020202020204" pitchFamily="34" charset="0"/>
              </a:rPr>
              <a:t>Gel shift</a:t>
            </a:r>
          </a:p>
        </p:txBody>
      </p:sp>
      <p:sp>
        <p:nvSpPr>
          <p:cNvPr id="43" name="ZoneTexte 42">
            <a:extLst>
              <a:ext uri="{FF2B5EF4-FFF2-40B4-BE49-F238E27FC236}">
                <a16:creationId xmlns:a16="http://schemas.microsoft.com/office/drawing/2014/main" id="{6164C086-A362-7C86-3CF9-791EC88AD33F}"/>
              </a:ext>
            </a:extLst>
          </p:cNvPr>
          <p:cNvSpPr txBox="1"/>
          <p:nvPr/>
        </p:nvSpPr>
        <p:spPr>
          <a:xfrm>
            <a:off x="7482925" y="1859419"/>
            <a:ext cx="1880945" cy="923330"/>
          </a:xfrm>
          <a:prstGeom prst="rect">
            <a:avLst/>
          </a:prstGeom>
          <a:noFill/>
        </p:spPr>
        <p:txBody>
          <a:bodyPr wrap="square">
            <a:spAutoFit/>
          </a:bodyPr>
          <a:lstStyle/>
          <a:p>
            <a:r>
              <a:rPr lang="en-US" dirty="0">
                <a:latin typeface="Arial" panose="020B0604020202020204" pitchFamily="34" charset="0"/>
                <a:cs typeface="Arial" panose="020B0604020202020204" pitchFamily="34" charset="0"/>
              </a:rPr>
              <a:t>Pull-down</a:t>
            </a:r>
          </a:p>
          <a:p>
            <a:r>
              <a:rPr lang="en-US" dirty="0">
                <a:latin typeface="Arial" panose="020B0604020202020204" pitchFamily="34" charset="0"/>
                <a:cs typeface="Arial" panose="020B0604020202020204" pitchFamily="34" charset="0"/>
              </a:rPr>
              <a:t>Transcriptomic</a:t>
            </a:r>
          </a:p>
          <a:p>
            <a:r>
              <a:rPr lang="en-US" dirty="0">
                <a:latin typeface="Arial" panose="020B0604020202020204" pitchFamily="34" charset="0"/>
                <a:cs typeface="Arial" panose="020B0604020202020204" pitchFamily="34" charset="0"/>
              </a:rPr>
              <a:t>CETSA</a:t>
            </a:r>
          </a:p>
        </p:txBody>
      </p:sp>
      <p:sp>
        <p:nvSpPr>
          <p:cNvPr id="45" name="ZoneTexte 44">
            <a:extLst>
              <a:ext uri="{FF2B5EF4-FFF2-40B4-BE49-F238E27FC236}">
                <a16:creationId xmlns:a16="http://schemas.microsoft.com/office/drawing/2014/main" id="{0B0CFF6E-F928-339C-0BC7-6D977C2DFEB5}"/>
              </a:ext>
            </a:extLst>
          </p:cNvPr>
          <p:cNvSpPr txBox="1"/>
          <p:nvPr/>
        </p:nvSpPr>
        <p:spPr>
          <a:xfrm>
            <a:off x="1496172" y="4762653"/>
            <a:ext cx="2259267" cy="1754326"/>
          </a:xfrm>
          <a:prstGeom prst="rect">
            <a:avLst/>
          </a:prstGeom>
          <a:noFill/>
        </p:spPr>
        <p:txBody>
          <a:bodyPr wrap="square">
            <a:spAutoFit/>
          </a:bodyPr>
          <a:lstStyle/>
          <a:p>
            <a:r>
              <a:rPr lang="en-US" dirty="0">
                <a:latin typeface="Arial" panose="020B0604020202020204" pitchFamily="34" charset="0"/>
                <a:cs typeface="Arial" panose="020B0604020202020204" pitchFamily="34" charset="0"/>
              </a:rPr>
              <a:t>X-Ray</a:t>
            </a:r>
          </a:p>
          <a:p>
            <a:r>
              <a:rPr lang="en-US" dirty="0">
                <a:latin typeface="Arial" panose="020B0604020202020204" pitchFamily="34" charset="0"/>
                <a:cs typeface="Arial" panose="020B0604020202020204" pitchFamily="34" charset="0"/>
              </a:rPr>
              <a:t>NMR</a:t>
            </a:r>
          </a:p>
          <a:p>
            <a:r>
              <a:rPr lang="en-US" dirty="0">
                <a:latin typeface="Arial" panose="020B0604020202020204" pitchFamily="34" charset="0"/>
                <a:cs typeface="Arial" panose="020B0604020202020204" pitchFamily="34" charset="0"/>
              </a:rPr>
              <a:t>? Cryo-EM</a:t>
            </a:r>
          </a:p>
          <a:p>
            <a:endParaRPr lang="en-US" dirty="0">
              <a:latin typeface="Arial" panose="020B0604020202020204" pitchFamily="34" charset="0"/>
              <a:cs typeface="Arial" panose="020B0604020202020204" pitchFamily="34" charset="0"/>
            </a:endParaRPr>
          </a:p>
          <a:p>
            <a:r>
              <a:rPr lang="en-US" dirty="0">
                <a:latin typeface="Arial" panose="020B0604020202020204" pitchFamily="34" charset="0"/>
                <a:cs typeface="Arial" panose="020B0604020202020204" pitchFamily="34" charset="0"/>
              </a:rPr>
              <a:t>MD simulation Medicinal chemistry</a:t>
            </a:r>
          </a:p>
        </p:txBody>
      </p:sp>
      <p:sp>
        <p:nvSpPr>
          <p:cNvPr id="47" name="ZoneTexte 46">
            <a:extLst>
              <a:ext uri="{FF2B5EF4-FFF2-40B4-BE49-F238E27FC236}">
                <a16:creationId xmlns:a16="http://schemas.microsoft.com/office/drawing/2014/main" id="{DD68FF1E-C1F6-8887-6A14-D49F72CF3FF5}"/>
              </a:ext>
            </a:extLst>
          </p:cNvPr>
          <p:cNvSpPr txBox="1"/>
          <p:nvPr/>
        </p:nvSpPr>
        <p:spPr>
          <a:xfrm>
            <a:off x="7498752" y="4514981"/>
            <a:ext cx="3832000" cy="1200329"/>
          </a:xfrm>
          <a:prstGeom prst="rect">
            <a:avLst/>
          </a:prstGeom>
          <a:noFill/>
        </p:spPr>
        <p:txBody>
          <a:bodyPr wrap="square">
            <a:spAutoFit/>
          </a:bodyPr>
          <a:lstStyle/>
          <a:p>
            <a:r>
              <a:rPr lang="en-US" dirty="0">
                <a:latin typeface="Arial" panose="020B0604020202020204" pitchFamily="34" charset="0"/>
                <a:cs typeface="Arial" panose="020B0604020202020204" pitchFamily="34" charset="0"/>
              </a:rPr>
              <a:t>Splicing reporter</a:t>
            </a:r>
          </a:p>
          <a:p>
            <a:r>
              <a:rPr lang="en-US" dirty="0">
                <a:latin typeface="Arial" panose="020B0604020202020204" pitchFamily="34" charset="0"/>
                <a:cs typeface="Arial" panose="020B0604020202020204" pitchFamily="34" charset="0"/>
              </a:rPr>
              <a:t>Translation reporter</a:t>
            </a:r>
          </a:p>
          <a:p>
            <a:r>
              <a:rPr lang="en-US" dirty="0">
                <a:latin typeface="Arial" panose="020B0604020202020204" pitchFamily="34" charset="0"/>
                <a:cs typeface="Arial" panose="020B0604020202020204" pitchFamily="34" charset="0"/>
              </a:rPr>
              <a:t>Proliferation (siRNA, shRNA)</a:t>
            </a:r>
          </a:p>
          <a:p>
            <a:r>
              <a:rPr lang="en-US" dirty="0">
                <a:latin typeface="Arial" panose="020B0604020202020204" pitchFamily="34" charset="0"/>
                <a:cs typeface="Arial" panose="020B0604020202020204" pitchFamily="34" charset="0"/>
              </a:rPr>
              <a:t>Cell survival</a:t>
            </a:r>
          </a:p>
        </p:txBody>
      </p:sp>
      <p:pic>
        <p:nvPicPr>
          <p:cNvPr id="49" name="Image 48">
            <a:extLst>
              <a:ext uri="{FF2B5EF4-FFF2-40B4-BE49-F238E27FC236}">
                <a16:creationId xmlns:a16="http://schemas.microsoft.com/office/drawing/2014/main" id="{FBB36F79-C0F9-9D33-3CDF-DE4D8C62173C}"/>
              </a:ext>
            </a:extLst>
          </p:cNvPr>
          <p:cNvPicPr>
            <a:picLocks noChangeAspect="1"/>
          </p:cNvPicPr>
          <p:nvPr/>
        </p:nvPicPr>
        <p:blipFill>
          <a:blip r:embed="rId3"/>
          <a:stretch>
            <a:fillRect/>
          </a:stretch>
        </p:blipFill>
        <p:spPr>
          <a:xfrm>
            <a:off x="1120313" y="1088952"/>
            <a:ext cx="343431" cy="566661"/>
          </a:xfrm>
          <a:prstGeom prst="rect">
            <a:avLst/>
          </a:prstGeom>
        </p:spPr>
      </p:pic>
      <p:pic>
        <p:nvPicPr>
          <p:cNvPr id="51" name="Image 50" descr="Une image contenant cercle, rose, Magenta, poudre&#10;&#10;Description générée automatiquement">
            <a:extLst>
              <a:ext uri="{FF2B5EF4-FFF2-40B4-BE49-F238E27FC236}">
                <a16:creationId xmlns:a16="http://schemas.microsoft.com/office/drawing/2014/main" id="{3C2AD33C-21D1-A449-BC34-7D8AC1B626FD}"/>
              </a:ext>
            </a:extLst>
          </p:cNvPr>
          <p:cNvPicPr>
            <a:picLocks noChangeAspect="1"/>
          </p:cNvPicPr>
          <p:nvPr/>
        </p:nvPicPr>
        <p:blipFill>
          <a:blip r:embed="rId4"/>
          <a:stretch>
            <a:fillRect/>
          </a:stretch>
        </p:blipFill>
        <p:spPr>
          <a:xfrm>
            <a:off x="1009317" y="2167603"/>
            <a:ext cx="531649" cy="531649"/>
          </a:xfrm>
          <a:prstGeom prst="rect">
            <a:avLst/>
          </a:prstGeom>
        </p:spPr>
      </p:pic>
      <p:pic>
        <p:nvPicPr>
          <p:cNvPr id="52" name="Image 51">
            <a:extLst>
              <a:ext uri="{FF2B5EF4-FFF2-40B4-BE49-F238E27FC236}">
                <a16:creationId xmlns:a16="http://schemas.microsoft.com/office/drawing/2014/main" id="{8EE9B643-77B6-03C1-3A95-E089333C12D3}"/>
              </a:ext>
            </a:extLst>
          </p:cNvPr>
          <p:cNvPicPr>
            <a:picLocks noChangeAspect="1"/>
          </p:cNvPicPr>
          <p:nvPr/>
        </p:nvPicPr>
        <p:blipFill>
          <a:blip r:embed="rId3"/>
          <a:stretch>
            <a:fillRect/>
          </a:stretch>
        </p:blipFill>
        <p:spPr>
          <a:xfrm>
            <a:off x="7063139" y="1135975"/>
            <a:ext cx="343431" cy="566661"/>
          </a:xfrm>
          <a:prstGeom prst="rect">
            <a:avLst/>
          </a:prstGeom>
        </p:spPr>
      </p:pic>
      <p:pic>
        <p:nvPicPr>
          <p:cNvPr id="53" name="Image 52" descr="Une image contenant cercle, rose, Magenta, poudre&#10;&#10;Description générée automatiquement">
            <a:extLst>
              <a:ext uri="{FF2B5EF4-FFF2-40B4-BE49-F238E27FC236}">
                <a16:creationId xmlns:a16="http://schemas.microsoft.com/office/drawing/2014/main" id="{14941DF6-BBDB-804C-C3DB-E3BB08F622F8}"/>
              </a:ext>
            </a:extLst>
          </p:cNvPr>
          <p:cNvPicPr>
            <a:picLocks noChangeAspect="1"/>
          </p:cNvPicPr>
          <p:nvPr/>
        </p:nvPicPr>
        <p:blipFill>
          <a:blip r:embed="rId4"/>
          <a:stretch>
            <a:fillRect/>
          </a:stretch>
        </p:blipFill>
        <p:spPr>
          <a:xfrm>
            <a:off x="6952143" y="2078099"/>
            <a:ext cx="531649" cy="531649"/>
          </a:xfrm>
          <a:prstGeom prst="rect">
            <a:avLst/>
          </a:prstGeom>
        </p:spPr>
      </p:pic>
      <p:pic>
        <p:nvPicPr>
          <p:cNvPr id="54" name="Image 53" descr="Une image contenant cercle, rose, Magenta, poudre&#10;&#10;Description générée automatiquement">
            <a:extLst>
              <a:ext uri="{FF2B5EF4-FFF2-40B4-BE49-F238E27FC236}">
                <a16:creationId xmlns:a16="http://schemas.microsoft.com/office/drawing/2014/main" id="{12642E27-FB92-1E40-2791-337F2281E9BC}"/>
              </a:ext>
            </a:extLst>
          </p:cNvPr>
          <p:cNvPicPr>
            <a:picLocks noChangeAspect="1"/>
          </p:cNvPicPr>
          <p:nvPr/>
        </p:nvPicPr>
        <p:blipFill>
          <a:blip r:embed="rId4"/>
          <a:stretch>
            <a:fillRect/>
          </a:stretch>
        </p:blipFill>
        <p:spPr>
          <a:xfrm>
            <a:off x="6948895" y="4789964"/>
            <a:ext cx="531649" cy="531649"/>
          </a:xfrm>
          <a:prstGeom prst="rect">
            <a:avLst/>
          </a:prstGeom>
        </p:spPr>
      </p:pic>
      <p:pic>
        <p:nvPicPr>
          <p:cNvPr id="1026" name="Picture 2" descr="NMR tube Nuclear magnetic resonance spectroscopy Test Tubes, nmr tube,  angle, text, rectangle png | PNGWing">
            <a:extLst>
              <a:ext uri="{FF2B5EF4-FFF2-40B4-BE49-F238E27FC236}">
                <a16:creationId xmlns:a16="http://schemas.microsoft.com/office/drawing/2014/main" id="{017B0CB8-D6B2-3D4A-DDA7-F7ECCF4198CE}"/>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1137669" y="4792184"/>
            <a:ext cx="355093" cy="1026088"/>
          </a:xfrm>
          <a:prstGeom prst="rect">
            <a:avLst/>
          </a:prstGeom>
          <a:noFill/>
          <a:extLst>
            <a:ext uri="{909E8E84-426E-40DD-AFC4-6F175D3DCCD1}">
              <a14:hiddenFill xmlns:a14="http://schemas.microsoft.com/office/drawing/2010/main">
                <a:solidFill>
                  <a:srgbClr val="FFFFFF"/>
                </a:solidFill>
              </a14:hiddenFill>
            </a:ext>
          </a:extLst>
        </p:spPr>
      </p:pic>
      <p:sp>
        <p:nvSpPr>
          <p:cNvPr id="7" name="ZoneTexte 6">
            <a:extLst>
              <a:ext uri="{FF2B5EF4-FFF2-40B4-BE49-F238E27FC236}">
                <a16:creationId xmlns:a16="http://schemas.microsoft.com/office/drawing/2014/main" id="{CC2D1075-D40A-6723-EDEB-CA3AE8E1AD18}"/>
              </a:ext>
            </a:extLst>
          </p:cNvPr>
          <p:cNvSpPr txBox="1"/>
          <p:nvPr/>
        </p:nvSpPr>
        <p:spPr>
          <a:xfrm>
            <a:off x="10436418" y="603731"/>
            <a:ext cx="1159293" cy="369332"/>
          </a:xfrm>
          <a:prstGeom prst="rect">
            <a:avLst/>
          </a:prstGeom>
          <a:noFill/>
        </p:spPr>
        <p:txBody>
          <a:bodyPr wrap="none" rtlCol="0">
            <a:spAutoFit/>
          </a:bodyPr>
          <a:lstStyle/>
          <a:p>
            <a:pPr algn="ctr"/>
            <a:r>
              <a:rPr lang="en-US" dirty="0">
                <a:latin typeface="Arial" panose="020B0604020202020204" pitchFamily="34" charset="0"/>
                <a:cs typeface="Arial" panose="020B0604020202020204" pitchFamily="34" charset="0"/>
              </a:rPr>
              <a:t>On-target</a:t>
            </a:r>
          </a:p>
        </p:txBody>
      </p:sp>
      <p:sp>
        <p:nvSpPr>
          <p:cNvPr id="9" name="ZoneTexte 8">
            <a:extLst>
              <a:ext uri="{FF2B5EF4-FFF2-40B4-BE49-F238E27FC236}">
                <a16:creationId xmlns:a16="http://schemas.microsoft.com/office/drawing/2014/main" id="{FA4D4B39-2696-8D31-C4F1-A98D362E2E5E}"/>
              </a:ext>
            </a:extLst>
          </p:cNvPr>
          <p:cNvSpPr txBox="1"/>
          <p:nvPr/>
        </p:nvSpPr>
        <p:spPr>
          <a:xfrm>
            <a:off x="4489540" y="564872"/>
            <a:ext cx="1159293" cy="369332"/>
          </a:xfrm>
          <a:prstGeom prst="rect">
            <a:avLst/>
          </a:prstGeom>
          <a:noFill/>
        </p:spPr>
        <p:txBody>
          <a:bodyPr wrap="none" rtlCol="0">
            <a:spAutoFit/>
          </a:bodyPr>
          <a:lstStyle/>
          <a:p>
            <a:pPr algn="ctr"/>
            <a:r>
              <a:rPr lang="en-US" dirty="0">
                <a:latin typeface="Arial" panose="020B0604020202020204" pitchFamily="34" charset="0"/>
                <a:cs typeface="Arial" panose="020B0604020202020204" pitchFamily="34" charset="0"/>
              </a:rPr>
              <a:t>On-target</a:t>
            </a:r>
          </a:p>
        </p:txBody>
      </p:sp>
      <p:sp>
        <p:nvSpPr>
          <p:cNvPr id="10" name="Double flèche verticale 9">
            <a:extLst>
              <a:ext uri="{FF2B5EF4-FFF2-40B4-BE49-F238E27FC236}">
                <a16:creationId xmlns:a16="http://schemas.microsoft.com/office/drawing/2014/main" id="{53C2752D-9290-EEF7-79B8-24566568A901}"/>
              </a:ext>
            </a:extLst>
          </p:cNvPr>
          <p:cNvSpPr/>
          <p:nvPr/>
        </p:nvSpPr>
        <p:spPr>
          <a:xfrm rot="18817205">
            <a:off x="6089927" y="2635995"/>
            <a:ext cx="271247" cy="1888738"/>
          </a:xfrm>
          <a:prstGeom prst="upDownArrow">
            <a:avLst/>
          </a:prstGeom>
          <a:solidFill>
            <a:schemeClr val="bg1">
              <a:lumMod val="7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1" name="Double flèche verticale 10">
            <a:extLst>
              <a:ext uri="{FF2B5EF4-FFF2-40B4-BE49-F238E27FC236}">
                <a16:creationId xmlns:a16="http://schemas.microsoft.com/office/drawing/2014/main" id="{E58BC432-9117-A438-78E2-38228A34DEC0}"/>
              </a:ext>
            </a:extLst>
          </p:cNvPr>
          <p:cNvSpPr/>
          <p:nvPr/>
        </p:nvSpPr>
        <p:spPr>
          <a:xfrm rot="13583129">
            <a:off x="6098608" y="2638358"/>
            <a:ext cx="271247" cy="1943006"/>
          </a:xfrm>
          <a:prstGeom prst="upDownArrow">
            <a:avLst/>
          </a:prstGeom>
          <a:solidFill>
            <a:schemeClr val="bg1">
              <a:lumMod val="7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6" name="Image 15" descr="Une image contenant croquis, conception&#10;&#10;Description générée automatiquement">
            <a:extLst>
              <a:ext uri="{FF2B5EF4-FFF2-40B4-BE49-F238E27FC236}">
                <a16:creationId xmlns:a16="http://schemas.microsoft.com/office/drawing/2014/main" id="{F6410E50-AAB4-C086-7293-0CCB419CD0DF}"/>
              </a:ext>
            </a:extLst>
          </p:cNvPr>
          <p:cNvPicPr>
            <a:picLocks noChangeAspect="1"/>
          </p:cNvPicPr>
          <p:nvPr/>
        </p:nvPicPr>
        <p:blipFill>
          <a:blip r:embed="rId6"/>
          <a:stretch>
            <a:fillRect/>
          </a:stretch>
        </p:blipFill>
        <p:spPr>
          <a:xfrm>
            <a:off x="899614" y="5084657"/>
            <a:ext cx="315985" cy="369333"/>
          </a:xfrm>
          <a:prstGeom prst="rect">
            <a:avLst/>
          </a:prstGeom>
        </p:spPr>
      </p:pic>
      <p:pic>
        <p:nvPicPr>
          <p:cNvPr id="19" name="Image 18">
            <a:extLst>
              <a:ext uri="{FF2B5EF4-FFF2-40B4-BE49-F238E27FC236}">
                <a16:creationId xmlns:a16="http://schemas.microsoft.com/office/drawing/2014/main" id="{E9159AAF-AF33-C645-D572-2AACF2B86047}"/>
              </a:ext>
            </a:extLst>
          </p:cNvPr>
          <p:cNvPicPr>
            <a:picLocks noChangeAspect="1"/>
          </p:cNvPicPr>
          <p:nvPr/>
        </p:nvPicPr>
        <p:blipFill>
          <a:blip r:embed="rId7"/>
          <a:stretch/>
        </p:blipFill>
        <p:spPr bwMode="auto">
          <a:xfrm>
            <a:off x="3552454" y="1997333"/>
            <a:ext cx="776903" cy="776903"/>
          </a:xfrm>
          <a:prstGeom prst="rect">
            <a:avLst/>
          </a:prstGeom>
        </p:spPr>
      </p:pic>
      <p:sp>
        <p:nvSpPr>
          <p:cNvPr id="20" name="ZoneTexte 19">
            <a:extLst>
              <a:ext uri="{FF2B5EF4-FFF2-40B4-BE49-F238E27FC236}">
                <a16:creationId xmlns:a16="http://schemas.microsoft.com/office/drawing/2014/main" id="{1E67D6B2-ADD3-5358-5801-D095379F5325}"/>
              </a:ext>
            </a:extLst>
          </p:cNvPr>
          <p:cNvSpPr txBox="1"/>
          <p:nvPr/>
        </p:nvSpPr>
        <p:spPr>
          <a:xfrm>
            <a:off x="3480897" y="2741100"/>
            <a:ext cx="841897" cy="276999"/>
          </a:xfrm>
          <a:prstGeom prst="rect">
            <a:avLst/>
          </a:prstGeom>
          <a:noFill/>
        </p:spPr>
        <p:txBody>
          <a:bodyPr wrap="none" rtlCol="0">
            <a:spAutoFit/>
          </a:bodyPr>
          <a:lstStyle/>
          <a:p>
            <a:pPr algn="ctr"/>
            <a:r>
              <a:rPr lang="en-US" sz="1200" i="1" dirty="0" err="1">
                <a:latin typeface="Arial" panose="020B0604020202020204" pitchFamily="34" charset="0"/>
                <a:cs typeface="Arial" panose="020B0604020202020204" pitchFamily="34" charset="0"/>
              </a:rPr>
              <a:t>MTBench</a:t>
            </a:r>
            <a:endParaRPr lang="en-US" sz="1200" i="1" dirty="0">
              <a:latin typeface="Arial" panose="020B0604020202020204" pitchFamily="34" charset="0"/>
              <a:cs typeface="Arial" panose="020B0604020202020204" pitchFamily="34" charset="0"/>
            </a:endParaRPr>
          </a:p>
        </p:txBody>
      </p:sp>
      <p:pic>
        <p:nvPicPr>
          <p:cNvPr id="21" name="Image 20" descr="Une image contenant cercle, texte, Police, conception&#10;&#10;Description générée automatiquement">
            <a:extLst>
              <a:ext uri="{FF2B5EF4-FFF2-40B4-BE49-F238E27FC236}">
                <a16:creationId xmlns:a16="http://schemas.microsoft.com/office/drawing/2014/main" id="{A770FAAF-7570-83AF-8942-FCE609B947BD}"/>
              </a:ext>
            </a:extLst>
          </p:cNvPr>
          <p:cNvPicPr>
            <a:picLocks noChangeAspect="1"/>
          </p:cNvPicPr>
          <p:nvPr/>
        </p:nvPicPr>
        <p:blipFill>
          <a:blip r:embed="rId8"/>
          <a:stretch>
            <a:fillRect/>
          </a:stretch>
        </p:blipFill>
        <p:spPr>
          <a:xfrm>
            <a:off x="3734950" y="5507801"/>
            <a:ext cx="1837364" cy="646827"/>
          </a:xfrm>
          <a:prstGeom prst="rect">
            <a:avLst/>
          </a:prstGeom>
        </p:spPr>
      </p:pic>
      <p:pic>
        <p:nvPicPr>
          <p:cNvPr id="22" name="Image 21" descr="Une image contenant art&#10;&#10;Description générée automatiquement">
            <a:extLst>
              <a:ext uri="{FF2B5EF4-FFF2-40B4-BE49-F238E27FC236}">
                <a16:creationId xmlns:a16="http://schemas.microsoft.com/office/drawing/2014/main" id="{9FB63DFE-1631-BC70-63AF-9077044B6CB9}"/>
              </a:ext>
            </a:extLst>
          </p:cNvPr>
          <p:cNvPicPr>
            <a:picLocks noChangeAspect="1"/>
          </p:cNvPicPr>
          <p:nvPr/>
        </p:nvPicPr>
        <p:blipFill>
          <a:blip r:embed="rId9"/>
          <a:stretch>
            <a:fillRect/>
          </a:stretch>
        </p:blipFill>
        <p:spPr>
          <a:xfrm>
            <a:off x="3790135" y="4410014"/>
            <a:ext cx="1536281" cy="857459"/>
          </a:xfrm>
          <a:prstGeom prst="rect">
            <a:avLst/>
          </a:prstGeom>
        </p:spPr>
      </p:pic>
      <p:sp>
        <p:nvSpPr>
          <p:cNvPr id="40" name="ZoneTexte 39">
            <a:extLst>
              <a:ext uri="{FF2B5EF4-FFF2-40B4-BE49-F238E27FC236}">
                <a16:creationId xmlns:a16="http://schemas.microsoft.com/office/drawing/2014/main" id="{1D4CD9A2-E5FC-3C32-E36F-524B2128315F}"/>
              </a:ext>
            </a:extLst>
          </p:cNvPr>
          <p:cNvSpPr txBox="1"/>
          <p:nvPr/>
        </p:nvSpPr>
        <p:spPr>
          <a:xfrm>
            <a:off x="4184007" y="5183474"/>
            <a:ext cx="611065" cy="276999"/>
          </a:xfrm>
          <a:prstGeom prst="rect">
            <a:avLst/>
          </a:prstGeom>
          <a:noFill/>
        </p:spPr>
        <p:txBody>
          <a:bodyPr wrap="none" rtlCol="0">
            <a:spAutoFit/>
          </a:bodyPr>
          <a:lstStyle/>
          <a:p>
            <a:pPr algn="ctr"/>
            <a:r>
              <a:rPr lang="en-US" sz="1200" i="1" dirty="0">
                <a:latin typeface="Arial" panose="020B0604020202020204" pitchFamily="34" charset="0"/>
                <a:cs typeface="Arial" panose="020B0604020202020204" pitchFamily="34" charset="0"/>
              </a:rPr>
              <a:t>X-Ray</a:t>
            </a:r>
          </a:p>
        </p:txBody>
      </p:sp>
      <p:sp>
        <p:nvSpPr>
          <p:cNvPr id="42" name="ZoneTexte 41">
            <a:extLst>
              <a:ext uri="{FF2B5EF4-FFF2-40B4-BE49-F238E27FC236}">
                <a16:creationId xmlns:a16="http://schemas.microsoft.com/office/drawing/2014/main" id="{36EFB596-4E9C-F247-3059-3BA66EAE121B}"/>
              </a:ext>
            </a:extLst>
          </p:cNvPr>
          <p:cNvSpPr txBox="1"/>
          <p:nvPr/>
        </p:nvSpPr>
        <p:spPr>
          <a:xfrm>
            <a:off x="4346461" y="6225159"/>
            <a:ext cx="534122" cy="276999"/>
          </a:xfrm>
          <a:prstGeom prst="rect">
            <a:avLst/>
          </a:prstGeom>
          <a:noFill/>
        </p:spPr>
        <p:txBody>
          <a:bodyPr wrap="none" rtlCol="0">
            <a:spAutoFit/>
          </a:bodyPr>
          <a:lstStyle/>
          <a:p>
            <a:pPr algn="ctr"/>
            <a:r>
              <a:rPr lang="en-US" sz="1200" i="1" dirty="0">
                <a:latin typeface="Arial" panose="020B0604020202020204" pitchFamily="34" charset="0"/>
                <a:cs typeface="Arial" panose="020B0604020202020204" pitchFamily="34" charset="0"/>
              </a:rPr>
              <a:t>NMR</a:t>
            </a:r>
          </a:p>
        </p:txBody>
      </p:sp>
      <p:pic>
        <p:nvPicPr>
          <p:cNvPr id="46" name="Image 45" descr="Une image contenant symbole, logo, Graphique, conception&#10;&#10;Description générée automatiquement">
            <a:extLst>
              <a:ext uri="{FF2B5EF4-FFF2-40B4-BE49-F238E27FC236}">
                <a16:creationId xmlns:a16="http://schemas.microsoft.com/office/drawing/2014/main" id="{363F5267-A96A-F09F-DA3C-F3406F72EFF9}"/>
              </a:ext>
            </a:extLst>
          </p:cNvPr>
          <p:cNvPicPr>
            <a:picLocks noChangeAspect="1"/>
          </p:cNvPicPr>
          <p:nvPr/>
        </p:nvPicPr>
        <p:blipFill>
          <a:blip r:embed="rId10"/>
          <a:stretch>
            <a:fillRect/>
          </a:stretch>
        </p:blipFill>
        <p:spPr>
          <a:xfrm>
            <a:off x="4643359" y="956188"/>
            <a:ext cx="648603" cy="771696"/>
          </a:xfrm>
          <a:prstGeom prst="rect">
            <a:avLst/>
          </a:prstGeom>
        </p:spPr>
      </p:pic>
      <p:sp>
        <p:nvSpPr>
          <p:cNvPr id="48" name="ZoneTexte 47">
            <a:extLst>
              <a:ext uri="{FF2B5EF4-FFF2-40B4-BE49-F238E27FC236}">
                <a16:creationId xmlns:a16="http://schemas.microsoft.com/office/drawing/2014/main" id="{2ADA598B-0506-80E0-27C3-35080D80618C}"/>
              </a:ext>
            </a:extLst>
          </p:cNvPr>
          <p:cNvSpPr txBox="1"/>
          <p:nvPr/>
        </p:nvSpPr>
        <p:spPr>
          <a:xfrm>
            <a:off x="4850928" y="1663854"/>
            <a:ext cx="381836" cy="276999"/>
          </a:xfrm>
          <a:prstGeom prst="rect">
            <a:avLst/>
          </a:prstGeom>
          <a:noFill/>
        </p:spPr>
        <p:txBody>
          <a:bodyPr wrap="none" rtlCol="0">
            <a:spAutoFit/>
          </a:bodyPr>
          <a:lstStyle/>
          <a:p>
            <a:pPr algn="ctr"/>
            <a:r>
              <a:rPr lang="en-US" sz="1200" i="1" dirty="0">
                <a:latin typeface="Arial" panose="020B0604020202020204" pitchFamily="34" charset="0"/>
                <a:cs typeface="Arial" panose="020B0604020202020204" pitchFamily="34" charset="0"/>
              </a:rPr>
              <a:t>FP</a:t>
            </a:r>
          </a:p>
        </p:txBody>
      </p:sp>
      <p:pic>
        <p:nvPicPr>
          <p:cNvPr id="50" name="Picture 2" descr="Surface Plasmon Resonance Assay Services | Reaction Biology">
            <a:extLst>
              <a:ext uri="{FF2B5EF4-FFF2-40B4-BE49-F238E27FC236}">
                <a16:creationId xmlns:a16="http://schemas.microsoft.com/office/drawing/2014/main" id="{CE8C87B3-38F9-2B4E-9BF1-CE5295C868BA}"/>
              </a:ext>
            </a:extLst>
          </p:cNvPr>
          <p:cNvPicPr>
            <a:picLocks noChangeAspect="1" noChangeArrowheads="1"/>
          </p:cNvPicPr>
          <p:nvPr/>
        </p:nvPicPr>
        <p:blipFill>
          <a:blip r:embed="rId11">
            <a:extLst>
              <a:ext uri="{28A0092B-C50C-407E-A947-70E740481C1C}">
                <a14:useLocalDpi xmlns:a14="http://schemas.microsoft.com/office/drawing/2010/main" val="0"/>
              </a:ext>
            </a:extLst>
          </a:blip>
          <a:srcRect/>
          <a:stretch>
            <a:fillRect/>
          </a:stretch>
        </p:blipFill>
        <p:spPr bwMode="auto">
          <a:xfrm>
            <a:off x="9815644" y="983671"/>
            <a:ext cx="1262940" cy="893531"/>
          </a:xfrm>
          <a:prstGeom prst="rect">
            <a:avLst/>
          </a:prstGeom>
          <a:noFill/>
          <a:extLst>
            <a:ext uri="{909E8E84-426E-40DD-AFC4-6F175D3DCCD1}">
              <a14:hiddenFill xmlns:a14="http://schemas.microsoft.com/office/drawing/2010/main">
                <a:solidFill>
                  <a:srgbClr val="FFFFFF"/>
                </a:solidFill>
              </a14:hiddenFill>
            </a:ext>
          </a:extLst>
        </p:spPr>
      </p:pic>
      <p:sp>
        <p:nvSpPr>
          <p:cNvPr id="55" name="ZoneTexte 54">
            <a:extLst>
              <a:ext uri="{FF2B5EF4-FFF2-40B4-BE49-F238E27FC236}">
                <a16:creationId xmlns:a16="http://schemas.microsoft.com/office/drawing/2014/main" id="{6FA2E195-9D9E-DBF8-5C38-B2004794F7B1}"/>
              </a:ext>
            </a:extLst>
          </p:cNvPr>
          <p:cNvSpPr txBox="1"/>
          <p:nvPr/>
        </p:nvSpPr>
        <p:spPr>
          <a:xfrm>
            <a:off x="10033189" y="1769199"/>
            <a:ext cx="827850" cy="276999"/>
          </a:xfrm>
          <a:prstGeom prst="rect">
            <a:avLst/>
          </a:prstGeom>
          <a:noFill/>
        </p:spPr>
        <p:txBody>
          <a:bodyPr wrap="square" rtlCol="0">
            <a:spAutoFit/>
          </a:bodyPr>
          <a:lstStyle/>
          <a:p>
            <a:pPr algn="ctr"/>
            <a:r>
              <a:rPr lang="en-US" sz="1200" i="1" dirty="0">
                <a:latin typeface="Arial" panose="020B0604020202020204" pitchFamily="34" charset="0"/>
                <a:cs typeface="Arial" panose="020B0604020202020204" pitchFamily="34" charset="0"/>
              </a:rPr>
              <a:t>SPR</a:t>
            </a:r>
          </a:p>
        </p:txBody>
      </p:sp>
      <p:pic>
        <p:nvPicPr>
          <p:cNvPr id="57" name="Image 56" descr="Une image contenant capture d’écran, noir et blanc, noir, monochrome&#10;&#10;Description générée automatiquement">
            <a:extLst>
              <a:ext uri="{FF2B5EF4-FFF2-40B4-BE49-F238E27FC236}">
                <a16:creationId xmlns:a16="http://schemas.microsoft.com/office/drawing/2014/main" id="{FBCE260D-30C3-6004-DF0B-AD1B90AF067A}"/>
              </a:ext>
            </a:extLst>
          </p:cNvPr>
          <p:cNvPicPr>
            <a:picLocks noChangeAspect="1"/>
          </p:cNvPicPr>
          <p:nvPr/>
        </p:nvPicPr>
        <p:blipFill>
          <a:blip r:embed="rId12"/>
          <a:stretch>
            <a:fillRect/>
          </a:stretch>
        </p:blipFill>
        <p:spPr>
          <a:xfrm>
            <a:off x="9945608" y="2136156"/>
            <a:ext cx="1068364" cy="575000"/>
          </a:xfrm>
          <a:prstGeom prst="rect">
            <a:avLst/>
          </a:prstGeom>
        </p:spPr>
      </p:pic>
      <p:sp>
        <p:nvSpPr>
          <p:cNvPr id="58" name="ZoneTexte 57">
            <a:extLst>
              <a:ext uri="{FF2B5EF4-FFF2-40B4-BE49-F238E27FC236}">
                <a16:creationId xmlns:a16="http://schemas.microsoft.com/office/drawing/2014/main" id="{FE443F91-8048-548F-2263-9639A4A1BE38}"/>
              </a:ext>
            </a:extLst>
          </p:cNvPr>
          <p:cNvSpPr txBox="1"/>
          <p:nvPr/>
        </p:nvSpPr>
        <p:spPr>
          <a:xfrm>
            <a:off x="10065865" y="2711156"/>
            <a:ext cx="827850" cy="276999"/>
          </a:xfrm>
          <a:prstGeom prst="rect">
            <a:avLst/>
          </a:prstGeom>
          <a:noFill/>
        </p:spPr>
        <p:txBody>
          <a:bodyPr wrap="square" rtlCol="0">
            <a:spAutoFit/>
          </a:bodyPr>
          <a:lstStyle/>
          <a:p>
            <a:pPr algn="ctr"/>
            <a:r>
              <a:rPr lang="en-US" sz="1200" i="1" dirty="0">
                <a:latin typeface="Arial" panose="020B0604020202020204" pitchFamily="34" charset="0"/>
                <a:cs typeface="Arial" panose="020B0604020202020204" pitchFamily="34" charset="0"/>
              </a:rPr>
              <a:t>Gel Shift</a:t>
            </a:r>
          </a:p>
        </p:txBody>
      </p:sp>
      <p:pic>
        <p:nvPicPr>
          <p:cNvPr id="60" name="Image 59" descr="Une image contenant texte, Police, ligne&#10;&#10;Description générée automatiquement">
            <a:extLst>
              <a:ext uri="{FF2B5EF4-FFF2-40B4-BE49-F238E27FC236}">
                <a16:creationId xmlns:a16="http://schemas.microsoft.com/office/drawing/2014/main" id="{A54623DD-0F2C-81D5-BCF3-6EE9C891AEE6}"/>
              </a:ext>
            </a:extLst>
          </p:cNvPr>
          <p:cNvPicPr>
            <a:picLocks noChangeAspect="1"/>
          </p:cNvPicPr>
          <p:nvPr/>
        </p:nvPicPr>
        <p:blipFill>
          <a:blip r:embed="rId13"/>
          <a:stretch>
            <a:fillRect/>
          </a:stretch>
        </p:blipFill>
        <p:spPr>
          <a:xfrm>
            <a:off x="7209095" y="5638438"/>
            <a:ext cx="2366406" cy="590401"/>
          </a:xfrm>
          <a:prstGeom prst="rect">
            <a:avLst/>
          </a:prstGeom>
        </p:spPr>
      </p:pic>
      <p:pic>
        <p:nvPicPr>
          <p:cNvPr id="62" name="Image 61" descr="Une image contenant rose, violet, Magenta, violette&#10;&#10;Description générée automatiquement">
            <a:extLst>
              <a:ext uri="{FF2B5EF4-FFF2-40B4-BE49-F238E27FC236}">
                <a16:creationId xmlns:a16="http://schemas.microsoft.com/office/drawing/2014/main" id="{BFED8705-C7EB-9B77-FFA1-ACDE695CDE5B}"/>
              </a:ext>
            </a:extLst>
          </p:cNvPr>
          <p:cNvPicPr>
            <a:picLocks noChangeAspect="1"/>
          </p:cNvPicPr>
          <p:nvPr/>
        </p:nvPicPr>
        <p:blipFill>
          <a:blip r:embed="rId14"/>
          <a:stretch>
            <a:fillRect/>
          </a:stretch>
        </p:blipFill>
        <p:spPr>
          <a:xfrm>
            <a:off x="9957654" y="5675203"/>
            <a:ext cx="1202015" cy="664709"/>
          </a:xfrm>
          <a:prstGeom prst="rect">
            <a:avLst/>
          </a:prstGeom>
        </p:spPr>
      </p:pic>
      <p:sp>
        <p:nvSpPr>
          <p:cNvPr id="63" name="ZoneTexte 62">
            <a:extLst>
              <a:ext uri="{FF2B5EF4-FFF2-40B4-BE49-F238E27FC236}">
                <a16:creationId xmlns:a16="http://schemas.microsoft.com/office/drawing/2014/main" id="{FBD0291D-74E4-9406-C4BB-4FD400A377F6}"/>
              </a:ext>
            </a:extLst>
          </p:cNvPr>
          <p:cNvSpPr txBox="1"/>
          <p:nvPr/>
        </p:nvSpPr>
        <p:spPr>
          <a:xfrm>
            <a:off x="9994092" y="6320691"/>
            <a:ext cx="1034728" cy="276999"/>
          </a:xfrm>
          <a:prstGeom prst="rect">
            <a:avLst/>
          </a:prstGeom>
          <a:noFill/>
        </p:spPr>
        <p:txBody>
          <a:bodyPr wrap="square" rtlCol="0">
            <a:spAutoFit/>
          </a:bodyPr>
          <a:lstStyle/>
          <a:p>
            <a:pPr algn="ctr"/>
            <a:r>
              <a:rPr lang="en-US" sz="1200" i="1" dirty="0">
                <a:latin typeface="Arial" panose="020B0604020202020204" pitchFamily="34" charset="0"/>
                <a:cs typeface="Arial" panose="020B0604020202020204" pitchFamily="34" charset="0"/>
              </a:rPr>
              <a:t>Proliferation</a:t>
            </a:r>
          </a:p>
        </p:txBody>
      </p:sp>
      <p:sp>
        <p:nvSpPr>
          <p:cNvPr id="1024" name="ZoneTexte 1023">
            <a:extLst>
              <a:ext uri="{FF2B5EF4-FFF2-40B4-BE49-F238E27FC236}">
                <a16:creationId xmlns:a16="http://schemas.microsoft.com/office/drawing/2014/main" id="{893831D5-727C-A8D3-A3F6-F6B5BB7A3C1B}"/>
              </a:ext>
            </a:extLst>
          </p:cNvPr>
          <p:cNvSpPr txBox="1"/>
          <p:nvPr/>
        </p:nvSpPr>
        <p:spPr>
          <a:xfrm>
            <a:off x="7342745" y="6292956"/>
            <a:ext cx="2099106" cy="276999"/>
          </a:xfrm>
          <a:prstGeom prst="rect">
            <a:avLst/>
          </a:prstGeom>
          <a:noFill/>
        </p:spPr>
        <p:txBody>
          <a:bodyPr wrap="square" rtlCol="0">
            <a:spAutoFit/>
          </a:bodyPr>
          <a:lstStyle/>
          <a:p>
            <a:pPr algn="ctr"/>
            <a:r>
              <a:rPr lang="en-US" sz="1200" i="1" dirty="0">
                <a:latin typeface="Arial" panose="020B0604020202020204" pitchFamily="34" charset="0"/>
                <a:cs typeface="Arial" panose="020B0604020202020204" pitchFamily="34" charset="0"/>
              </a:rPr>
              <a:t>Splicing reporter</a:t>
            </a:r>
          </a:p>
        </p:txBody>
      </p:sp>
      <p:sp>
        <p:nvSpPr>
          <p:cNvPr id="2" name="ZoneTexte 1">
            <a:extLst>
              <a:ext uri="{FF2B5EF4-FFF2-40B4-BE49-F238E27FC236}">
                <a16:creationId xmlns:a16="http://schemas.microsoft.com/office/drawing/2014/main" id="{E69AA43D-3595-EF8D-A19A-B4F4A497230A}"/>
              </a:ext>
            </a:extLst>
          </p:cNvPr>
          <p:cNvSpPr txBox="1"/>
          <p:nvPr/>
        </p:nvSpPr>
        <p:spPr>
          <a:xfrm>
            <a:off x="355058" y="2282824"/>
            <a:ext cx="585418" cy="276999"/>
          </a:xfrm>
          <a:prstGeom prst="rect">
            <a:avLst/>
          </a:prstGeom>
          <a:solidFill>
            <a:schemeClr val="bg1"/>
          </a:solidFill>
        </p:spPr>
        <p:txBody>
          <a:bodyPr wrap="none" rtlCol="0">
            <a:spAutoFit/>
          </a:bodyPr>
          <a:lstStyle/>
          <a:p>
            <a:pPr algn="ctr"/>
            <a:r>
              <a:rPr lang="en-US" sz="1200" i="1" dirty="0">
                <a:latin typeface="Arial" panose="020B0604020202020204" pitchFamily="34" charset="0"/>
                <a:cs typeface="Arial" panose="020B0604020202020204" pitchFamily="34" charset="0"/>
              </a:rPr>
              <a:t>In cell</a:t>
            </a:r>
          </a:p>
        </p:txBody>
      </p:sp>
      <p:sp>
        <p:nvSpPr>
          <p:cNvPr id="17" name="ZoneTexte 16">
            <a:extLst>
              <a:ext uri="{FF2B5EF4-FFF2-40B4-BE49-F238E27FC236}">
                <a16:creationId xmlns:a16="http://schemas.microsoft.com/office/drawing/2014/main" id="{081205BD-921F-6F9A-1731-707BBBE64E0A}"/>
              </a:ext>
            </a:extLst>
          </p:cNvPr>
          <p:cNvSpPr txBox="1"/>
          <p:nvPr/>
        </p:nvSpPr>
        <p:spPr>
          <a:xfrm>
            <a:off x="321602" y="1271789"/>
            <a:ext cx="646332" cy="276999"/>
          </a:xfrm>
          <a:prstGeom prst="rect">
            <a:avLst/>
          </a:prstGeom>
          <a:solidFill>
            <a:schemeClr val="bg1"/>
          </a:solidFill>
        </p:spPr>
        <p:txBody>
          <a:bodyPr wrap="none" rtlCol="0">
            <a:spAutoFit/>
          </a:bodyPr>
          <a:lstStyle/>
          <a:p>
            <a:pPr algn="ctr"/>
            <a:r>
              <a:rPr lang="en-US" sz="1200" i="1" dirty="0">
                <a:latin typeface="Arial" panose="020B0604020202020204" pitchFamily="34" charset="0"/>
                <a:cs typeface="Arial" panose="020B0604020202020204" pitchFamily="34" charset="0"/>
              </a:rPr>
              <a:t>In vitro</a:t>
            </a:r>
          </a:p>
        </p:txBody>
      </p:sp>
      <p:sp>
        <p:nvSpPr>
          <p:cNvPr id="29" name="ZoneTexte 28">
            <a:extLst>
              <a:ext uri="{FF2B5EF4-FFF2-40B4-BE49-F238E27FC236}">
                <a16:creationId xmlns:a16="http://schemas.microsoft.com/office/drawing/2014/main" id="{B8271078-55F7-77C5-125A-D793B54FED08}"/>
              </a:ext>
            </a:extLst>
          </p:cNvPr>
          <p:cNvSpPr txBox="1"/>
          <p:nvPr/>
        </p:nvSpPr>
        <p:spPr>
          <a:xfrm>
            <a:off x="6321461" y="2156139"/>
            <a:ext cx="585418" cy="276999"/>
          </a:xfrm>
          <a:prstGeom prst="rect">
            <a:avLst/>
          </a:prstGeom>
          <a:solidFill>
            <a:schemeClr val="bg1"/>
          </a:solidFill>
        </p:spPr>
        <p:txBody>
          <a:bodyPr wrap="none" rtlCol="0">
            <a:spAutoFit/>
          </a:bodyPr>
          <a:lstStyle/>
          <a:p>
            <a:pPr algn="ctr"/>
            <a:r>
              <a:rPr lang="en-US" sz="1200" i="1" dirty="0">
                <a:latin typeface="Arial" panose="020B0604020202020204" pitchFamily="34" charset="0"/>
                <a:cs typeface="Arial" panose="020B0604020202020204" pitchFamily="34" charset="0"/>
              </a:rPr>
              <a:t>In cell</a:t>
            </a:r>
          </a:p>
        </p:txBody>
      </p:sp>
      <p:sp>
        <p:nvSpPr>
          <p:cNvPr id="30" name="ZoneTexte 29">
            <a:extLst>
              <a:ext uri="{FF2B5EF4-FFF2-40B4-BE49-F238E27FC236}">
                <a16:creationId xmlns:a16="http://schemas.microsoft.com/office/drawing/2014/main" id="{FAF42F6A-249E-230E-FD23-91CDF6EB74A8}"/>
              </a:ext>
            </a:extLst>
          </p:cNvPr>
          <p:cNvSpPr txBox="1"/>
          <p:nvPr/>
        </p:nvSpPr>
        <p:spPr>
          <a:xfrm>
            <a:off x="6377573" y="1308909"/>
            <a:ext cx="646332" cy="276999"/>
          </a:xfrm>
          <a:prstGeom prst="rect">
            <a:avLst/>
          </a:prstGeom>
          <a:solidFill>
            <a:schemeClr val="bg1"/>
          </a:solidFill>
        </p:spPr>
        <p:txBody>
          <a:bodyPr wrap="none" rtlCol="0">
            <a:spAutoFit/>
          </a:bodyPr>
          <a:lstStyle/>
          <a:p>
            <a:pPr algn="ctr"/>
            <a:r>
              <a:rPr lang="en-US" sz="1200" i="1" dirty="0">
                <a:latin typeface="Arial" panose="020B0604020202020204" pitchFamily="34" charset="0"/>
                <a:cs typeface="Arial" panose="020B0604020202020204" pitchFamily="34" charset="0"/>
              </a:rPr>
              <a:t>In vitro</a:t>
            </a:r>
          </a:p>
        </p:txBody>
      </p:sp>
      <p:sp>
        <p:nvSpPr>
          <p:cNvPr id="31" name="ZoneTexte 30">
            <a:extLst>
              <a:ext uri="{FF2B5EF4-FFF2-40B4-BE49-F238E27FC236}">
                <a16:creationId xmlns:a16="http://schemas.microsoft.com/office/drawing/2014/main" id="{B1DFB32C-87B4-C9FD-0B72-0F0EE3F495DF}"/>
              </a:ext>
            </a:extLst>
          </p:cNvPr>
          <p:cNvSpPr txBox="1"/>
          <p:nvPr/>
        </p:nvSpPr>
        <p:spPr>
          <a:xfrm>
            <a:off x="6292793" y="4917288"/>
            <a:ext cx="585418" cy="276999"/>
          </a:xfrm>
          <a:prstGeom prst="rect">
            <a:avLst/>
          </a:prstGeom>
          <a:solidFill>
            <a:schemeClr val="bg1"/>
          </a:solidFill>
        </p:spPr>
        <p:txBody>
          <a:bodyPr wrap="none" rtlCol="0">
            <a:spAutoFit/>
          </a:bodyPr>
          <a:lstStyle/>
          <a:p>
            <a:pPr algn="ctr"/>
            <a:r>
              <a:rPr lang="en-US" sz="1200" i="1" dirty="0">
                <a:latin typeface="Arial" panose="020B0604020202020204" pitchFamily="34" charset="0"/>
                <a:cs typeface="Arial" panose="020B0604020202020204" pitchFamily="34" charset="0"/>
              </a:rPr>
              <a:t>In cell</a:t>
            </a:r>
          </a:p>
        </p:txBody>
      </p:sp>
      <p:grpSp>
        <p:nvGrpSpPr>
          <p:cNvPr id="32" name="Groupe 31">
            <a:extLst>
              <a:ext uri="{FF2B5EF4-FFF2-40B4-BE49-F238E27FC236}">
                <a16:creationId xmlns:a16="http://schemas.microsoft.com/office/drawing/2014/main" id="{DCF298DD-A5A5-9837-E6D5-FD94D66C4344}"/>
              </a:ext>
            </a:extLst>
          </p:cNvPr>
          <p:cNvGrpSpPr/>
          <p:nvPr/>
        </p:nvGrpSpPr>
        <p:grpSpPr>
          <a:xfrm>
            <a:off x="5560294" y="3245546"/>
            <a:ext cx="1330512" cy="685104"/>
            <a:chOff x="7901653" y="3255690"/>
            <a:chExt cx="1330512" cy="685104"/>
          </a:xfrm>
        </p:grpSpPr>
        <p:sp>
          <p:nvSpPr>
            <p:cNvPr id="28" name="Rectangle : coins arrondis 27">
              <a:extLst>
                <a:ext uri="{FF2B5EF4-FFF2-40B4-BE49-F238E27FC236}">
                  <a16:creationId xmlns:a16="http://schemas.microsoft.com/office/drawing/2014/main" id="{C2FD20B5-4F20-94F8-6A3C-DCD4704F3F18}"/>
                </a:ext>
              </a:extLst>
            </p:cNvPr>
            <p:cNvSpPr/>
            <p:nvPr/>
          </p:nvSpPr>
          <p:spPr>
            <a:xfrm>
              <a:off x="7953722" y="3255690"/>
              <a:ext cx="1278443" cy="671737"/>
            </a:xfrm>
            <a:prstGeom prst="roundRect">
              <a:avLst/>
            </a:prstGeom>
            <a:solidFill>
              <a:schemeClr val="bg2"/>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3" name="Groupe 22">
              <a:extLst>
                <a:ext uri="{FF2B5EF4-FFF2-40B4-BE49-F238E27FC236}">
                  <a16:creationId xmlns:a16="http://schemas.microsoft.com/office/drawing/2014/main" id="{F615D342-E902-3DDB-A9BA-AF3FC28CF838}"/>
                </a:ext>
              </a:extLst>
            </p:cNvPr>
            <p:cNvGrpSpPr/>
            <p:nvPr/>
          </p:nvGrpSpPr>
          <p:grpSpPr>
            <a:xfrm>
              <a:off x="7901653" y="3269057"/>
              <a:ext cx="1300356" cy="671737"/>
              <a:chOff x="3533433" y="3150547"/>
              <a:chExt cx="1300356" cy="671737"/>
            </a:xfrm>
          </p:grpSpPr>
          <p:pic>
            <p:nvPicPr>
              <p:cNvPr id="24" name="Image 23" descr="Une image contenant ballon, violet&#10;&#10;Description générée automatiquement">
                <a:extLst>
                  <a:ext uri="{FF2B5EF4-FFF2-40B4-BE49-F238E27FC236}">
                    <a16:creationId xmlns:a16="http://schemas.microsoft.com/office/drawing/2014/main" id="{B7565057-1791-3A6B-B2F0-18568F6D2674}"/>
                  </a:ext>
                </a:extLst>
              </p:cNvPr>
              <p:cNvPicPr>
                <a:picLocks noChangeAspect="1"/>
              </p:cNvPicPr>
              <p:nvPr/>
            </p:nvPicPr>
            <p:blipFill>
              <a:blip r:embed="rId15"/>
              <a:stretch>
                <a:fillRect/>
              </a:stretch>
            </p:blipFill>
            <p:spPr>
              <a:xfrm>
                <a:off x="3685869" y="3150547"/>
                <a:ext cx="986025" cy="476720"/>
              </a:xfrm>
              <a:prstGeom prst="rect">
                <a:avLst/>
              </a:prstGeom>
            </p:spPr>
          </p:pic>
          <p:sp>
            <p:nvSpPr>
              <p:cNvPr id="25" name="ZoneTexte 24">
                <a:extLst>
                  <a:ext uri="{FF2B5EF4-FFF2-40B4-BE49-F238E27FC236}">
                    <a16:creationId xmlns:a16="http://schemas.microsoft.com/office/drawing/2014/main" id="{E2B83A75-9216-CCE5-47F8-6D7A67177622}"/>
                  </a:ext>
                </a:extLst>
              </p:cNvPr>
              <p:cNvSpPr txBox="1"/>
              <p:nvPr/>
            </p:nvSpPr>
            <p:spPr>
              <a:xfrm>
                <a:off x="3533433" y="3545285"/>
                <a:ext cx="1300356" cy="276999"/>
              </a:xfrm>
              <a:prstGeom prst="rect">
                <a:avLst/>
              </a:prstGeom>
              <a:noFill/>
            </p:spPr>
            <p:txBody>
              <a:bodyPr wrap="none" rtlCol="0">
                <a:spAutoFit/>
              </a:bodyPr>
              <a:lstStyle/>
              <a:p>
                <a:pPr algn="ctr"/>
                <a:r>
                  <a:rPr lang="en-US" sz="1200" dirty="0">
                    <a:latin typeface="Arial" panose="020B0604020202020204" pitchFamily="34" charset="0"/>
                    <a:cs typeface="Arial" panose="020B0604020202020204" pitchFamily="34" charset="0"/>
                  </a:rPr>
                  <a:t>Small molecules</a:t>
                </a:r>
              </a:p>
            </p:txBody>
          </p:sp>
        </p:grpSp>
      </p:grpSp>
    </p:spTree>
    <p:extLst>
      <p:ext uri="{BB962C8B-B14F-4D97-AF65-F5344CB8AC3E}">
        <p14:creationId xmlns:p14="http://schemas.microsoft.com/office/powerpoint/2010/main" val="357960578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descr="Icône De Vecteur De Foudre. Icône Flash. Bolt De Vecteur De Foudre. Signe  De La Lumière. Icône Éclair De Boulon Électrique. Élément De Conception  Éclair. Logo Grève Du Tonnerre. Icône De Charge">
            <a:extLst>
              <a:ext uri="{FF2B5EF4-FFF2-40B4-BE49-F238E27FC236}">
                <a16:creationId xmlns:a16="http://schemas.microsoft.com/office/drawing/2014/main" id="{FD1F601F-673E-8E8C-DCBD-7C203882358D}"/>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13806" t="21859" r="55625" b="13169"/>
          <a:stretch/>
        </p:blipFill>
        <p:spPr bwMode="auto">
          <a:xfrm rot="18604367">
            <a:off x="1199467" y="2117673"/>
            <a:ext cx="417634" cy="888270"/>
          </a:xfrm>
          <a:prstGeom prst="rect">
            <a:avLst/>
          </a:prstGeom>
          <a:noFill/>
          <a:extLst>
            <a:ext uri="{909E8E84-426E-40DD-AFC4-6F175D3DCCD1}">
              <a14:hiddenFill xmlns:a14="http://schemas.microsoft.com/office/drawing/2010/main">
                <a:solidFill>
                  <a:srgbClr val="FFFFFF"/>
                </a:solidFill>
              </a14:hiddenFill>
            </a:ext>
          </a:extLst>
        </p:spPr>
      </p:pic>
      <p:sp>
        <p:nvSpPr>
          <p:cNvPr id="4" name="ZoneTexte 3">
            <a:extLst>
              <a:ext uri="{FF2B5EF4-FFF2-40B4-BE49-F238E27FC236}">
                <a16:creationId xmlns:a16="http://schemas.microsoft.com/office/drawing/2014/main" id="{62E49103-83E1-E43E-03D1-84FBE4D166FA}"/>
              </a:ext>
            </a:extLst>
          </p:cNvPr>
          <p:cNvSpPr txBox="1"/>
          <p:nvPr/>
        </p:nvSpPr>
        <p:spPr>
          <a:xfrm>
            <a:off x="0" y="22041"/>
            <a:ext cx="1095172" cy="369332"/>
          </a:xfrm>
          <a:prstGeom prst="rect">
            <a:avLst/>
          </a:prstGeom>
          <a:noFill/>
        </p:spPr>
        <p:txBody>
          <a:bodyPr wrap="none" rtlCol="0">
            <a:spAutoFit/>
          </a:bodyPr>
          <a:lstStyle/>
          <a:p>
            <a:r>
              <a:rPr lang="fr-FR" dirty="0">
                <a:latin typeface="Arial" panose="020B0604020202020204" pitchFamily="34" charset="0"/>
                <a:cs typeface="Arial" panose="020B0604020202020204" pitchFamily="34" charset="0"/>
              </a:rPr>
              <a:t>Figure 4.</a:t>
            </a:r>
            <a:endParaRPr lang="fr-FR" dirty="0">
              <a:highlight>
                <a:srgbClr val="FFFF00"/>
              </a:highlight>
              <a:latin typeface="Arial" panose="020B0604020202020204" pitchFamily="34" charset="0"/>
              <a:cs typeface="Arial" panose="020B0604020202020204" pitchFamily="34" charset="0"/>
            </a:endParaRPr>
          </a:p>
        </p:txBody>
      </p:sp>
      <p:sp>
        <p:nvSpPr>
          <p:cNvPr id="6" name="ZoneTexte 5">
            <a:extLst>
              <a:ext uri="{FF2B5EF4-FFF2-40B4-BE49-F238E27FC236}">
                <a16:creationId xmlns:a16="http://schemas.microsoft.com/office/drawing/2014/main" id="{6213584E-50CE-82F1-15C7-F6DFCB829F82}"/>
              </a:ext>
            </a:extLst>
          </p:cNvPr>
          <p:cNvSpPr txBox="1"/>
          <p:nvPr/>
        </p:nvSpPr>
        <p:spPr>
          <a:xfrm>
            <a:off x="801912" y="421157"/>
            <a:ext cx="3369414" cy="369332"/>
          </a:xfrm>
          <a:prstGeom prst="rect">
            <a:avLst/>
          </a:prstGeom>
          <a:noFill/>
        </p:spPr>
        <p:txBody>
          <a:bodyPr wrap="square">
            <a:spAutoFit/>
          </a:bodyPr>
          <a:lstStyle/>
          <a:p>
            <a:pPr algn="ctr"/>
            <a:r>
              <a:rPr lang="en-US" b="1" dirty="0">
                <a:latin typeface="Arial" panose="020B0604020202020204" pitchFamily="34" charset="0"/>
                <a:cs typeface="Arial" panose="020B0604020202020204" pitchFamily="34" charset="0"/>
              </a:rPr>
              <a:t>Cellular FRET assay</a:t>
            </a:r>
          </a:p>
        </p:txBody>
      </p:sp>
      <p:sp>
        <p:nvSpPr>
          <p:cNvPr id="26" name="Nuage 25">
            <a:extLst>
              <a:ext uri="{FF2B5EF4-FFF2-40B4-BE49-F238E27FC236}">
                <a16:creationId xmlns:a16="http://schemas.microsoft.com/office/drawing/2014/main" id="{69160EC1-DDA0-3B90-95A4-32FC6EE29D09}"/>
              </a:ext>
            </a:extLst>
          </p:cNvPr>
          <p:cNvSpPr/>
          <p:nvPr/>
        </p:nvSpPr>
        <p:spPr>
          <a:xfrm>
            <a:off x="1710126" y="3750693"/>
            <a:ext cx="926124" cy="914400"/>
          </a:xfrm>
          <a:prstGeom prst="cloud">
            <a:avLst/>
          </a:prstGeom>
          <a:solidFill>
            <a:schemeClr val="accent1"/>
          </a:solidFill>
          <a:ln>
            <a:noFill/>
            <a:extLst>
              <a:ext uri="{C807C97D-BFC1-408E-A445-0C87EB9F89A2}">
                <ask:lineSketchStyleProps xmlns:ask="http://schemas.microsoft.com/office/drawing/2018/sketchyshapes" sd="1219033472">
                  <a:custGeom>
                    <a:avLst/>
                    <a:gdLst>
                      <a:gd name="connsiteX0" fmla="*/ 83608 w 926124"/>
                      <a:gd name="connsiteY0" fmla="*/ 304165 h 914400"/>
                      <a:gd name="connsiteX1" fmla="*/ 120546 w 926124"/>
                      <a:gd name="connsiteY1" fmla="*/ 146198 h 914400"/>
                      <a:gd name="connsiteX2" fmla="*/ 300239 w 926124"/>
                      <a:gd name="connsiteY2" fmla="*/ 110109 h 914400"/>
                      <a:gd name="connsiteX3" fmla="*/ 481412 w 926124"/>
                      <a:gd name="connsiteY3" fmla="*/ 72644 h 914400"/>
                      <a:gd name="connsiteX4" fmla="*/ 552008 w 926124"/>
                      <a:gd name="connsiteY4" fmla="*/ 4233 h 914400"/>
                      <a:gd name="connsiteX5" fmla="*/ 639561 w 926124"/>
                      <a:gd name="connsiteY5" fmla="*/ 52514 h 914400"/>
                      <a:gd name="connsiteX6" fmla="*/ 760257 w 926124"/>
                      <a:gd name="connsiteY6" fmla="*/ 14605 h 914400"/>
                      <a:gd name="connsiteX7" fmla="*/ 821463 w 926124"/>
                      <a:gd name="connsiteY7" fmla="*/ 118025 h 914400"/>
                      <a:gd name="connsiteX8" fmla="*/ 900012 w 926124"/>
                      <a:gd name="connsiteY8" fmla="*/ 218397 h 914400"/>
                      <a:gd name="connsiteX9" fmla="*/ 896496 w 926124"/>
                      <a:gd name="connsiteY9" fmla="*/ 327236 h 914400"/>
                      <a:gd name="connsiteX10" fmla="*/ 922179 w 926124"/>
                      <a:gd name="connsiteY10" fmla="*/ 493649 h 914400"/>
                      <a:gd name="connsiteX11" fmla="*/ 801869 w 926124"/>
                      <a:gd name="connsiteY11" fmla="*/ 639318 h 914400"/>
                      <a:gd name="connsiteX12" fmla="*/ 758799 w 926124"/>
                      <a:gd name="connsiteY12" fmla="*/ 764137 h 914400"/>
                      <a:gd name="connsiteX13" fmla="*/ 612163 w 926124"/>
                      <a:gd name="connsiteY13" fmla="*/ 779250 h 914400"/>
                      <a:gd name="connsiteX14" fmla="*/ 507374 w 926124"/>
                      <a:gd name="connsiteY14" fmla="*/ 912410 h 914400"/>
                      <a:gd name="connsiteX15" fmla="*/ 353299 w 926124"/>
                      <a:gd name="connsiteY15" fmla="*/ 831130 h 914400"/>
                      <a:gd name="connsiteX16" fmla="*/ 124426 w 926124"/>
                      <a:gd name="connsiteY16" fmla="*/ 750824 h 914400"/>
                      <a:gd name="connsiteX17" fmla="*/ 23796 w 926124"/>
                      <a:gd name="connsiteY17" fmla="*/ 661458 h 914400"/>
                      <a:gd name="connsiteX18" fmla="*/ 45298 w 926124"/>
                      <a:gd name="connsiteY18" fmla="*/ 540829 h 914400"/>
                      <a:gd name="connsiteX19" fmla="*/ -108 w 926124"/>
                      <a:gd name="connsiteY19" fmla="*/ 417068 h 914400"/>
                      <a:gd name="connsiteX20" fmla="*/ 82815 w 926124"/>
                      <a:gd name="connsiteY20" fmla="*/ 307064 h 914400"/>
                      <a:gd name="connsiteX21" fmla="*/ 83608 w 926124"/>
                      <a:gd name="connsiteY21" fmla="*/ 304165 h 914400"/>
                      <a:gd name="connsiteX0" fmla="*/ 100608 w 926124"/>
                      <a:gd name="connsiteY0" fmla="*/ 554079 h 914400"/>
                      <a:gd name="connsiteX1" fmla="*/ 46306 w 926124"/>
                      <a:gd name="connsiteY1" fmla="*/ 537210 h 914400"/>
                      <a:gd name="connsiteX2" fmla="*/ 148522 w 926124"/>
                      <a:gd name="connsiteY2" fmla="*/ 738695 h 914400"/>
                      <a:gd name="connsiteX3" fmla="*/ 124769 w 926124"/>
                      <a:gd name="connsiteY3" fmla="*/ 746760 h 914400"/>
                      <a:gd name="connsiteX4" fmla="*/ 353256 w 926124"/>
                      <a:gd name="connsiteY4" fmla="*/ 827405 h 914400"/>
                      <a:gd name="connsiteX5" fmla="*/ 338935 w 926124"/>
                      <a:gd name="connsiteY5" fmla="*/ 790575 h 914400"/>
                      <a:gd name="connsiteX6" fmla="*/ 617994 w 926124"/>
                      <a:gd name="connsiteY6" fmla="*/ 735562 h 914400"/>
                      <a:gd name="connsiteX7" fmla="*/ 612270 w 926124"/>
                      <a:gd name="connsiteY7" fmla="*/ 775970 h 914400"/>
                      <a:gd name="connsiteX8" fmla="*/ 731659 w 926124"/>
                      <a:gd name="connsiteY8" fmla="*/ 485859 h 914400"/>
                      <a:gd name="connsiteX9" fmla="*/ 801354 w 926124"/>
                      <a:gd name="connsiteY9" fmla="*/ 636905 h 914400"/>
                      <a:gd name="connsiteX10" fmla="*/ 896067 w 926124"/>
                      <a:gd name="connsiteY10" fmla="*/ 324993 h 914400"/>
                      <a:gd name="connsiteX11" fmla="*/ 865025 w 926124"/>
                      <a:gd name="connsiteY11" fmla="*/ 381635 h 914400"/>
                      <a:gd name="connsiteX12" fmla="*/ 821592 w 926124"/>
                      <a:gd name="connsiteY12" fmla="*/ 114850 h 914400"/>
                      <a:gd name="connsiteX13" fmla="*/ 823221 w 926124"/>
                      <a:gd name="connsiteY13" fmla="*/ 141605 h 914400"/>
                      <a:gd name="connsiteX14" fmla="*/ 623375 w 926124"/>
                      <a:gd name="connsiteY14" fmla="*/ 83650 h 914400"/>
                      <a:gd name="connsiteX15" fmla="*/ 639282 w 926124"/>
                      <a:gd name="connsiteY15" fmla="*/ 49530 h 914400"/>
                      <a:gd name="connsiteX16" fmla="*/ 474659 w 926124"/>
                      <a:gd name="connsiteY16" fmla="*/ 99906 h 914400"/>
                      <a:gd name="connsiteX17" fmla="*/ 482356 w 926124"/>
                      <a:gd name="connsiteY17" fmla="*/ 70485 h 914400"/>
                      <a:gd name="connsiteX18" fmla="*/ 300132 w 926124"/>
                      <a:gd name="connsiteY18" fmla="*/ 109897 h 914400"/>
                      <a:gd name="connsiteX19" fmla="*/ 328002 w 926124"/>
                      <a:gd name="connsiteY19" fmla="*/ 138430 h 914400"/>
                      <a:gd name="connsiteX20" fmla="*/ 88474 w 926124"/>
                      <a:gd name="connsiteY20" fmla="*/ 334200 h 914400"/>
                      <a:gd name="connsiteX21" fmla="*/ 83608 w 926124"/>
                      <a:gd name="connsiteY21" fmla="*/ 304165 h 9144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926124" h="914400" fill="none" extrusionOk="0">
                        <a:moveTo>
                          <a:pt x="83608" y="304165"/>
                        </a:moveTo>
                        <a:cubicBezTo>
                          <a:pt x="71337" y="259709"/>
                          <a:pt x="89078" y="185816"/>
                          <a:pt x="120546" y="146198"/>
                        </a:cubicBezTo>
                        <a:cubicBezTo>
                          <a:pt x="180294" y="83133"/>
                          <a:pt x="240544" y="44472"/>
                          <a:pt x="300239" y="110109"/>
                        </a:cubicBezTo>
                        <a:cubicBezTo>
                          <a:pt x="343738" y="24049"/>
                          <a:pt x="411423" y="3865"/>
                          <a:pt x="481412" y="72644"/>
                        </a:cubicBezTo>
                        <a:cubicBezTo>
                          <a:pt x="494012" y="39184"/>
                          <a:pt x="519547" y="3742"/>
                          <a:pt x="552008" y="4233"/>
                        </a:cubicBezTo>
                        <a:cubicBezTo>
                          <a:pt x="591139" y="-6367"/>
                          <a:pt x="621071" y="12742"/>
                          <a:pt x="639561" y="52514"/>
                        </a:cubicBezTo>
                        <a:cubicBezTo>
                          <a:pt x="661000" y="2512"/>
                          <a:pt x="727085" y="-18478"/>
                          <a:pt x="760257" y="14605"/>
                        </a:cubicBezTo>
                        <a:cubicBezTo>
                          <a:pt x="781805" y="39036"/>
                          <a:pt x="816997" y="76594"/>
                          <a:pt x="821463" y="118025"/>
                        </a:cubicBezTo>
                        <a:cubicBezTo>
                          <a:pt x="862700" y="130782"/>
                          <a:pt x="887054" y="172857"/>
                          <a:pt x="900012" y="218397"/>
                        </a:cubicBezTo>
                        <a:cubicBezTo>
                          <a:pt x="911392" y="254804"/>
                          <a:pt x="905949" y="287720"/>
                          <a:pt x="896496" y="327236"/>
                        </a:cubicBezTo>
                        <a:cubicBezTo>
                          <a:pt x="935652" y="374908"/>
                          <a:pt x="941457" y="444601"/>
                          <a:pt x="922179" y="493649"/>
                        </a:cubicBezTo>
                        <a:cubicBezTo>
                          <a:pt x="917821" y="580107"/>
                          <a:pt x="864011" y="637252"/>
                          <a:pt x="801869" y="639318"/>
                        </a:cubicBezTo>
                        <a:cubicBezTo>
                          <a:pt x="807488" y="693136"/>
                          <a:pt x="780739" y="725942"/>
                          <a:pt x="758799" y="764137"/>
                        </a:cubicBezTo>
                        <a:cubicBezTo>
                          <a:pt x="716295" y="813096"/>
                          <a:pt x="670149" y="820532"/>
                          <a:pt x="612163" y="779250"/>
                        </a:cubicBezTo>
                        <a:cubicBezTo>
                          <a:pt x="603395" y="839019"/>
                          <a:pt x="553129" y="888687"/>
                          <a:pt x="507374" y="912410"/>
                        </a:cubicBezTo>
                        <a:cubicBezTo>
                          <a:pt x="436158" y="937157"/>
                          <a:pt x="387522" y="907165"/>
                          <a:pt x="353299" y="831130"/>
                        </a:cubicBezTo>
                        <a:cubicBezTo>
                          <a:pt x="260389" y="880211"/>
                          <a:pt x="191762" y="836405"/>
                          <a:pt x="124426" y="750824"/>
                        </a:cubicBezTo>
                        <a:cubicBezTo>
                          <a:pt x="88896" y="769993"/>
                          <a:pt x="52190" y="722855"/>
                          <a:pt x="23796" y="661458"/>
                        </a:cubicBezTo>
                        <a:cubicBezTo>
                          <a:pt x="5689" y="622220"/>
                          <a:pt x="22538" y="566743"/>
                          <a:pt x="45298" y="540829"/>
                        </a:cubicBezTo>
                        <a:cubicBezTo>
                          <a:pt x="14203" y="506065"/>
                          <a:pt x="-2065" y="459478"/>
                          <a:pt x="-108" y="417068"/>
                        </a:cubicBezTo>
                        <a:cubicBezTo>
                          <a:pt x="3361" y="358891"/>
                          <a:pt x="45535" y="303762"/>
                          <a:pt x="82815" y="307064"/>
                        </a:cubicBezTo>
                        <a:cubicBezTo>
                          <a:pt x="83174" y="306011"/>
                          <a:pt x="83501" y="305126"/>
                          <a:pt x="83608" y="304165"/>
                        </a:cubicBezTo>
                        <a:close/>
                      </a:path>
                      <a:path w="926124" h="914400" fill="none" extrusionOk="0">
                        <a:moveTo>
                          <a:pt x="100608" y="554079"/>
                        </a:moveTo>
                        <a:cubicBezTo>
                          <a:pt x="82473" y="554508"/>
                          <a:pt x="64241" y="548588"/>
                          <a:pt x="46306" y="537210"/>
                        </a:cubicBezTo>
                        <a:moveTo>
                          <a:pt x="148522" y="738695"/>
                        </a:moveTo>
                        <a:cubicBezTo>
                          <a:pt x="142839" y="741453"/>
                          <a:pt x="134619" y="744048"/>
                          <a:pt x="124769" y="746760"/>
                        </a:cubicBezTo>
                        <a:moveTo>
                          <a:pt x="353256" y="827405"/>
                        </a:moveTo>
                        <a:cubicBezTo>
                          <a:pt x="348060" y="818827"/>
                          <a:pt x="343509" y="802778"/>
                          <a:pt x="338935" y="790575"/>
                        </a:cubicBezTo>
                        <a:moveTo>
                          <a:pt x="617994" y="735562"/>
                        </a:moveTo>
                        <a:cubicBezTo>
                          <a:pt x="620346" y="749453"/>
                          <a:pt x="615005" y="760028"/>
                          <a:pt x="612270" y="775970"/>
                        </a:cubicBezTo>
                        <a:moveTo>
                          <a:pt x="731659" y="485859"/>
                        </a:moveTo>
                        <a:cubicBezTo>
                          <a:pt x="767886" y="514709"/>
                          <a:pt x="810093" y="582907"/>
                          <a:pt x="801354" y="636905"/>
                        </a:cubicBezTo>
                        <a:moveTo>
                          <a:pt x="896067" y="324993"/>
                        </a:moveTo>
                        <a:cubicBezTo>
                          <a:pt x="887796" y="350013"/>
                          <a:pt x="882311" y="364882"/>
                          <a:pt x="865025" y="381635"/>
                        </a:cubicBezTo>
                        <a:moveTo>
                          <a:pt x="821592" y="114850"/>
                        </a:moveTo>
                        <a:cubicBezTo>
                          <a:pt x="822863" y="123456"/>
                          <a:pt x="825677" y="133667"/>
                          <a:pt x="823221" y="141605"/>
                        </a:cubicBezTo>
                        <a:moveTo>
                          <a:pt x="623375" y="83650"/>
                        </a:moveTo>
                        <a:cubicBezTo>
                          <a:pt x="628665" y="69366"/>
                          <a:pt x="635344" y="58957"/>
                          <a:pt x="639282" y="49530"/>
                        </a:cubicBezTo>
                        <a:moveTo>
                          <a:pt x="474659" y="99906"/>
                        </a:moveTo>
                        <a:cubicBezTo>
                          <a:pt x="478201" y="90042"/>
                          <a:pt x="479087" y="82159"/>
                          <a:pt x="482356" y="70485"/>
                        </a:cubicBezTo>
                        <a:moveTo>
                          <a:pt x="300132" y="109897"/>
                        </a:moveTo>
                        <a:cubicBezTo>
                          <a:pt x="309763" y="117673"/>
                          <a:pt x="321642" y="127309"/>
                          <a:pt x="328002" y="138430"/>
                        </a:cubicBezTo>
                        <a:moveTo>
                          <a:pt x="88474" y="334200"/>
                        </a:moveTo>
                        <a:cubicBezTo>
                          <a:pt x="86238" y="323175"/>
                          <a:pt x="85815" y="313492"/>
                          <a:pt x="83608" y="304165"/>
                        </a:cubicBezTo>
                      </a:path>
                      <a:path w="926124" h="914400" stroke="0" extrusionOk="0">
                        <a:moveTo>
                          <a:pt x="83608" y="304165"/>
                        </a:moveTo>
                        <a:cubicBezTo>
                          <a:pt x="66932" y="240037"/>
                          <a:pt x="81174" y="192645"/>
                          <a:pt x="120546" y="146198"/>
                        </a:cubicBezTo>
                        <a:cubicBezTo>
                          <a:pt x="186588" y="83058"/>
                          <a:pt x="232151" y="64156"/>
                          <a:pt x="300239" y="110109"/>
                        </a:cubicBezTo>
                        <a:cubicBezTo>
                          <a:pt x="323746" y="31309"/>
                          <a:pt x="422981" y="22222"/>
                          <a:pt x="481412" y="72644"/>
                        </a:cubicBezTo>
                        <a:cubicBezTo>
                          <a:pt x="490727" y="33201"/>
                          <a:pt x="522797" y="10631"/>
                          <a:pt x="552008" y="4233"/>
                        </a:cubicBezTo>
                        <a:cubicBezTo>
                          <a:pt x="590055" y="-1623"/>
                          <a:pt x="623701" y="6671"/>
                          <a:pt x="639561" y="52514"/>
                        </a:cubicBezTo>
                        <a:cubicBezTo>
                          <a:pt x="667761" y="5433"/>
                          <a:pt x="714039" y="-5823"/>
                          <a:pt x="760257" y="14605"/>
                        </a:cubicBezTo>
                        <a:cubicBezTo>
                          <a:pt x="791039" y="21051"/>
                          <a:pt x="813129" y="74968"/>
                          <a:pt x="821463" y="118025"/>
                        </a:cubicBezTo>
                        <a:cubicBezTo>
                          <a:pt x="860627" y="132800"/>
                          <a:pt x="890405" y="169868"/>
                          <a:pt x="900012" y="218397"/>
                        </a:cubicBezTo>
                        <a:cubicBezTo>
                          <a:pt x="905376" y="253498"/>
                          <a:pt x="914442" y="298438"/>
                          <a:pt x="896496" y="327236"/>
                        </a:cubicBezTo>
                        <a:cubicBezTo>
                          <a:pt x="927721" y="380763"/>
                          <a:pt x="934588" y="452437"/>
                          <a:pt x="922179" y="493649"/>
                        </a:cubicBezTo>
                        <a:cubicBezTo>
                          <a:pt x="911761" y="576604"/>
                          <a:pt x="871426" y="641770"/>
                          <a:pt x="801869" y="639318"/>
                        </a:cubicBezTo>
                        <a:cubicBezTo>
                          <a:pt x="804649" y="684623"/>
                          <a:pt x="788286" y="721477"/>
                          <a:pt x="758799" y="764137"/>
                        </a:cubicBezTo>
                        <a:cubicBezTo>
                          <a:pt x="706752" y="813532"/>
                          <a:pt x="644367" y="808290"/>
                          <a:pt x="612163" y="779250"/>
                        </a:cubicBezTo>
                        <a:cubicBezTo>
                          <a:pt x="595019" y="845407"/>
                          <a:pt x="554883" y="891194"/>
                          <a:pt x="507374" y="912410"/>
                        </a:cubicBezTo>
                        <a:cubicBezTo>
                          <a:pt x="449816" y="913121"/>
                          <a:pt x="380720" y="902665"/>
                          <a:pt x="353299" y="831130"/>
                        </a:cubicBezTo>
                        <a:cubicBezTo>
                          <a:pt x="266890" y="907926"/>
                          <a:pt x="175732" y="863187"/>
                          <a:pt x="124426" y="750824"/>
                        </a:cubicBezTo>
                        <a:cubicBezTo>
                          <a:pt x="78787" y="765544"/>
                          <a:pt x="37828" y="719416"/>
                          <a:pt x="23796" y="661458"/>
                        </a:cubicBezTo>
                        <a:cubicBezTo>
                          <a:pt x="13604" y="620487"/>
                          <a:pt x="18510" y="573354"/>
                          <a:pt x="45298" y="540829"/>
                        </a:cubicBezTo>
                        <a:cubicBezTo>
                          <a:pt x="16289" y="521471"/>
                          <a:pt x="-7050" y="468182"/>
                          <a:pt x="-108" y="417068"/>
                        </a:cubicBezTo>
                        <a:cubicBezTo>
                          <a:pt x="7028" y="347859"/>
                          <a:pt x="33266" y="312720"/>
                          <a:pt x="82815" y="307064"/>
                        </a:cubicBezTo>
                        <a:cubicBezTo>
                          <a:pt x="83208" y="306208"/>
                          <a:pt x="83291" y="305318"/>
                          <a:pt x="83608" y="304165"/>
                        </a:cubicBezTo>
                        <a:close/>
                      </a:path>
                      <a:path w="926124" h="914400" fill="none" stroke="0" extrusionOk="0">
                        <a:moveTo>
                          <a:pt x="100608" y="554079"/>
                        </a:moveTo>
                        <a:cubicBezTo>
                          <a:pt x="82651" y="552223"/>
                          <a:pt x="64096" y="544965"/>
                          <a:pt x="46306" y="537210"/>
                        </a:cubicBezTo>
                        <a:moveTo>
                          <a:pt x="148522" y="738695"/>
                        </a:moveTo>
                        <a:cubicBezTo>
                          <a:pt x="140461" y="745022"/>
                          <a:pt x="132318" y="744850"/>
                          <a:pt x="124769" y="746760"/>
                        </a:cubicBezTo>
                        <a:moveTo>
                          <a:pt x="353256" y="827405"/>
                        </a:moveTo>
                        <a:cubicBezTo>
                          <a:pt x="348714" y="816800"/>
                          <a:pt x="342097" y="803684"/>
                          <a:pt x="338935" y="790575"/>
                        </a:cubicBezTo>
                        <a:moveTo>
                          <a:pt x="617994" y="735562"/>
                        </a:moveTo>
                        <a:cubicBezTo>
                          <a:pt x="615161" y="749958"/>
                          <a:pt x="615206" y="761646"/>
                          <a:pt x="612270" y="775970"/>
                        </a:cubicBezTo>
                        <a:moveTo>
                          <a:pt x="731659" y="485859"/>
                        </a:moveTo>
                        <a:cubicBezTo>
                          <a:pt x="757104" y="520467"/>
                          <a:pt x="800960" y="584526"/>
                          <a:pt x="801354" y="636905"/>
                        </a:cubicBezTo>
                        <a:moveTo>
                          <a:pt x="896067" y="324993"/>
                        </a:moveTo>
                        <a:cubicBezTo>
                          <a:pt x="887389" y="345337"/>
                          <a:pt x="880596" y="366416"/>
                          <a:pt x="865025" y="381635"/>
                        </a:cubicBezTo>
                        <a:moveTo>
                          <a:pt x="821592" y="114850"/>
                        </a:moveTo>
                        <a:cubicBezTo>
                          <a:pt x="820128" y="123423"/>
                          <a:pt x="822589" y="132954"/>
                          <a:pt x="823221" y="141605"/>
                        </a:cubicBezTo>
                        <a:moveTo>
                          <a:pt x="623375" y="83650"/>
                        </a:moveTo>
                        <a:cubicBezTo>
                          <a:pt x="626548" y="70286"/>
                          <a:pt x="632875" y="58419"/>
                          <a:pt x="639282" y="49530"/>
                        </a:cubicBezTo>
                        <a:moveTo>
                          <a:pt x="474659" y="99906"/>
                        </a:moveTo>
                        <a:cubicBezTo>
                          <a:pt x="476015" y="90132"/>
                          <a:pt x="478087" y="81859"/>
                          <a:pt x="482356" y="70485"/>
                        </a:cubicBezTo>
                        <a:moveTo>
                          <a:pt x="300132" y="109897"/>
                        </a:moveTo>
                        <a:cubicBezTo>
                          <a:pt x="308469" y="118284"/>
                          <a:pt x="320059" y="128707"/>
                          <a:pt x="328002" y="138430"/>
                        </a:cubicBezTo>
                        <a:moveTo>
                          <a:pt x="88474" y="334200"/>
                        </a:moveTo>
                        <a:cubicBezTo>
                          <a:pt x="84869" y="324137"/>
                          <a:pt x="84568" y="312557"/>
                          <a:pt x="83608" y="304165"/>
                        </a:cubicBezTo>
                      </a:path>
                    </a:pathLst>
                  </a:custGeom>
                  <ask:type>
                    <ask:lineSketchNone/>
                  </ask:type>
                </ask:lineSketchStyleProps>
              </a:ext>
            </a:extLst>
          </a:ln>
          <a:effectLst/>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latin typeface="Arial" panose="020B0604020202020204" pitchFamily="34" charset="0"/>
                <a:cs typeface="Arial" panose="020B0604020202020204" pitchFamily="34" charset="0"/>
              </a:rPr>
              <a:t>POI</a:t>
            </a:r>
          </a:p>
        </p:txBody>
      </p:sp>
      <p:sp>
        <p:nvSpPr>
          <p:cNvPr id="41" name="Arc 40">
            <a:extLst>
              <a:ext uri="{FF2B5EF4-FFF2-40B4-BE49-F238E27FC236}">
                <a16:creationId xmlns:a16="http://schemas.microsoft.com/office/drawing/2014/main" id="{A6F8844F-A060-389B-B01A-79C26E9C486C}"/>
              </a:ext>
            </a:extLst>
          </p:cNvPr>
          <p:cNvSpPr/>
          <p:nvPr/>
        </p:nvSpPr>
        <p:spPr>
          <a:xfrm rot="12068907">
            <a:off x="2632558" y="3479195"/>
            <a:ext cx="950093" cy="1320944"/>
          </a:xfrm>
          <a:prstGeom prst="arc">
            <a:avLst>
              <a:gd name="adj1" fmla="val 16200000"/>
              <a:gd name="adj2" fmla="val 3448526"/>
            </a:avLst>
          </a:prstGeom>
          <a:ln w="152400">
            <a:solidFill>
              <a:schemeClr val="accent2">
                <a:lumMod val="7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44" name="Nuage 43">
            <a:extLst>
              <a:ext uri="{FF2B5EF4-FFF2-40B4-BE49-F238E27FC236}">
                <a16:creationId xmlns:a16="http://schemas.microsoft.com/office/drawing/2014/main" id="{5C85467D-23FE-E901-0DD8-0296F90EA1C4}"/>
              </a:ext>
            </a:extLst>
          </p:cNvPr>
          <p:cNvSpPr/>
          <p:nvPr/>
        </p:nvSpPr>
        <p:spPr>
          <a:xfrm>
            <a:off x="2926198" y="3233923"/>
            <a:ext cx="492409" cy="444537"/>
          </a:xfrm>
          <a:prstGeom prst="cloud">
            <a:avLst/>
          </a:prstGeom>
          <a:solidFill>
            <a:srgbClr val="FF0000"/>
          </a:solidFill>
          <a:ln>
            <a:noFill/>
            <a:extLst>
              <a:ext uri="{C807C97D-BFC1-408E-A445-0C87EB9F89A2}">
                <ask:lineSketchStyleProps xmlns:ask="http://schemas.microsoft.com/office/drawing/2018/sketchyshapes" sd="1219033472">
                  <a:custGeom>
                    <a:avLst/>
                    <a:gdLst>
                      <a:gd name="connsiteX0" fmla="*/ 83608 w 926124"/>
                      <a:gd name="connsiteY0" fmla="*/ 304165 h 914400"/>
                      <a:gd name="connsiteX1" fmla="*/ 120546 w 926124"/>
                      <a:gd name="connsiteY1" fmla="*/ 146198 h 914400"/>
                      <a:gd name="connsiteX2" fmla="*/ 300239 w 926124"/>
                      <a:gd name="connsiteY2" fmla="*/ 110109 h 914400"/>
                      <a:gd name="connsiteX3" fmla="*/ 481412 w 926124"/>
                      <a:gd name="connsiteY3" fmla="*/ 72644 h 914400"/>
                      <a:gd name="connsiteX4" fmla="*/ 552008 w 926124"/>
                      <a:gd name="connsiteY4" fmla="*/ 4233 h 914400"/>
                      <a:gd name="connsiteX5" fmla="*/ 639561 w 926124"/>
                      <a:gd name="connsiteY5" fmla="*/ 52514 h 914400"/>
                      <a:gd name="connsiteX6" fmla="*/ 760257 w 926124"/>
                      <a:gd name="connsiteY6" fmla="*/ 14605 h 914400"/>
                      <a:gd name="connsiteX7" fmla="*/ 821463 w 926124"/>
                      <a:gd name="connsiteY7" fmla="*/ 118025 h 914400"/>
                      <a:gd name="connsiteX8" fmla="*/ 900012 w 926124"/>
                      <a:gd name="connsiteY8" fmla="*/ 218397 h 914400"/>
                      <a:gd name="connsiteX9" fmla="*/ 896496 w 926124"/>
                      <a:gd name="connsiteY9" fmla="*/ 327236 h 914400"/>
                      <a:gd name="connsiteX10" fmla="*/ 922179 w 926124"/>
                      <a:gd name="connsiteY10" fmla="*/ 493649 h 914400"/>
                      <a:gd name="connsiteX11" fmla="*/ 801869 w 926124"/>
                      <a:gd name="connsiteY11" fmla="*/ 639318 h 914400"/>
                      <a:gd name="connsiteX12" fmla="*/ 758799 w 926124"/>
                      <a:gd name="connsiteY12" fmla="*/ 764137 h 914400"/>
                      <a:gd name="connsiteX13" fmla="*/ 612163 w 926124"/>
                      <a:gd name="connsiteY13" fmla="*/ 779250 h 914400"/>
                      <a:gd name="connsiteX14" fmla="*/ 507374 w 926124"/>
                      <a:gd name="connsiteY14" fmla="*/ 912410 h 914400"/>
                      <a:gd name="connsiteX15" fmla="*/ 353299 w 926124"/>
                      <a:gd name="connsiteY15" fmla="*/ 831130 h 914400"/>
                      <a:gd name="connsiteX16" fmla="*/ 124426 w 926124"/>
                      <a:gd name="connsiteY16" fmla="*/ 750824 h 914400"/>
                      <a:gd name="connsiteX17" fmla="*/ 23796 w 926124"/>
                      <a:gd name="connsiteY17" fmla="*/ 661458 h 914400"/>
                      <a:gd name="connsiteX18" fmla="*/ 45298 w 926124"/>
                      <a:gd name="connsiteY18" fmla="*/ 540829 h 914400"/>
                      <a:gd name="connsiteX19" fmla="*/ -108 w 926124"/>
                      <a:gd name="connsiteY19" fmla="*/ 417068 h 914400"/>
                      <a:gd name="connsiteX20" fmla="*/ 82815 w 926124"/>
                      <a:gd name="connsiteY20" fmla="*/ 307064 h 914400"/>
                      <a:gd name="connsiteX21" fmla="*/ 83608 w 926124"/>
                      <a:gd name="connsiteY21" fmla="*/ 304165 h 914400"/>
                      <a:gd name="connsiteX0" fmla="*/ 100608 w 926124"/>
                      <a:gd name="connsiteY0" fmla="*/ 554079 h 914400"/>
                      <a:gd name="connsiteX1" fmla="*/ 46306 w 926124"/>
                      <a:gd name="connsiteY1" fmla="*/ 537210 h 914400"/>
                      <a:gd name="connsiteX2" fmla="*/ 148522 w 926124"/>
                      <a:gd name="connsiteY2" fmla="*/ 738695 h 914400"/>
                      <a:gd name="connsiteX3" fmla="*/ 124769 w 926124"/>
                      <a:gd name="connsiteY3" fmla="*/ 746760 h 914400"/>
                      <a:gd name="connsiteX4" fmla="*/ 353256 w 926124"/>
                      <a:gd name="connsiteY4" fmla="*/ 827405 h 914400"/>
                      <a:gd name="connsiteX5" fmla="*/ 338935 w 926124"/>
                      <a:gd name="connsiteY5" fmla="*/ 790575 h 914400"/>
                      <a:gd name="connsiteX6" fmla="*/ 617994 w 926124"/>
                      <a:gd name="connsiteY6" fmla="*/ 735562 h 914400"/>
                      <a:gd name="connsiteX7" fmla="*/ 612270 w 926124"/>
                      <a:gd name="connsiteY7" fmla="*/ 775970 h 914400"/>
                      <a:gd name="connsiteX8" fmla="*/ 731659 w 926124"/>
                      <a:gd name="connsiteY8" fmla="*/ 485859 h 914400"/>
                      <a:gd name="connsiteX9" fmla="*/ 801354 w 926124"/>
                      <a:gd name="connsiteY9" fmla="*/ 636905 h 914400"/>
                      <a:gd name="connsiteX10" fmla="*/ 896067 w 926124"/>
                      <a:gd name="connsiteY10" fmla="*/ 324993 h 914400"/>
                      <a:gd name="connsiteX11" fmla="*/ 865025 w 926124"/>
                      <a:gd name="connsiteY11" fmla="*/ 381635 h 914400"/>
                      <a:gd name="connsiteX12" fmla="*/ 821592 w 926124"/>
                      <a:gd name="connsiteY12" fmla="*/ 114850 h 914400"/>
                      <a:gd name="connsiteX13" fmla="*/ 823221 w 926124"/>
                      <a:gd name="connsiteY13" fmla="*/ 141605 h 914400"/>
                      <a:gd name="connsiteX14" fmla="*/ 623375 w 926124"/>
                      <a:gd name="connsiteY14" fmla="*/ 83650 h 914400"/>
                      <a:gd name="connsiteX15" fmla="*/ 639282 w 926124"/>
                      <a:gd name="connsiteY15" fmla="*/ 49530 h 914400"/>
                      <a:gd name="connsiteX16" fmla="*/ 474659 w 926124"/>
                      <a:gd name="connsiteY16" fmla="*/ 99906 h 914400"/>
                      <a:gd name="connsiteX17" fmla="*/ 482356 w 926124"/>
                      <a:gd name="connsiteY17" fmla="*/ 70485 h 914400"/>
                      <a:gd name="connsiteX18" fmla="*/ 300132 w 926124"/>
                      <a:gd name="connsiteY18" fmla="*/ 109897 h 914400"/>
                      <a:gd name="connsiteX19" fmla="*/ 328002 w 926124"/>
                      <a:gd name="connsiteY19" fmla="*/ 138430 h 914400"/>
                      <a:gd name="connsiteX20" fmla="*/ 88474 w 926124"/>
                      <a:gd name="connsiteY20" fmla="*/ 334200 h 914400"/>
                      <a:gd name="connsiteX21" fmla="*/ 83608 w 926124"/>
                      <a:gd name="connsiteY21" fmla="*/ 304165 h 9144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926124" h="914400" fill="none" extrusionOk="0">
                        <a:moveTo>
                          <a:pt x="83608" y="304165"/>
                        </a:moveTo>
                        <a:cubicBezTo>
                          <a:pt x="71337" y="259709"/>
                          <a:pt x="89078" y="185816"/>
                          <a:pt x="120546" y="146198"/>
                        </a:cubicBezTo>
                        <a:cubicBezTo>
                          <a:pt x="180294" y="83133"/>
                          <a:pt x="240544" y="44472"/>
                          <a:pt x="300239" y="110109"/>
                        </a:cubicBezTo>
                        <a:cubicBezTo>
                          <a:pt x="343738" y="24049"/>
                          <a:pt x="411423" y="3865"/>
                          <a:pt x="481412" y="72644"/>
                        </a:cubicBezTo>
                        <a:cubicBezTo>
                          <a:pt x="494012" y="39184"/>
                          <a:pt x="519547" y="3742"/>
                          <a:pt x="552008" y="4233"/>
                        </a:cubicBezTo>
                        <a:cubicBezTo>
                          <a:pt x="591139" y="-6367"/>
                          <a:pt x="621071" y="12742"/>
                          <a:pt x="639561" y="52514"/>
                        </a:cubicBezTo>
                        <a:cubicBezTo>
                          <a:pt x="661000" y="2512"/>
                          <a:pt x="727085" y="-18478"/>
                          <a:pt x="760257" y="14605"/>
                        </a:cubicBezTo>
                        <a:cubicBezTo>
                          <a:pt x="781805" y="39036"/>
                          <a:pt x="816997" y="76594"/>
                          <a:pt x="821463" y="118025"/>
                        </a:cubicBezTo>
                        <a:cubicBezTo>
                          <a:pt x="862700" y="130782"/>
                          <a:pt x="887054" y="172857"/>
                          <a:pt x="900012" y="218397"/>
                        </a:cubicBezTo>
                        <a:cubicBezTo>
                          <a:pt x="911392" y="254804"/>
                          <a:pt x="905949" y="287720"/>
                          <a:pt x="896496" y="327236"/>
                        </a:cubicBezTo>
                        <a:cubicBezTo>
                          <a:pt x="935652" y="374908"/>
                          <a:pt x="941457" y="444601"/>
                          <a:pt x="922179" y="493649"/>
                        </a:cubicBezTo>
                        <a:cubicBezTo>
                          <a:pt x="917821" y="580107"/>
                          <a:pt x="864011" y="637252"/>
                          <a:pt x="801869" y="639318"/>
                        </a:cubicBezTo>
                        <a:cubicBezTo>
                          <a:pt x="807488" y="693136"/>
                          <a:pt x="780739" y="725942"/>
                          <a:pt x="758799" y="764137"/>
                        </a:cubicBezTo>
                        <a:cubicBezTo>
                          <a:pt x="716295" y="813096"/>
                          <a:pt x="670149" y="820532"/>
                          <a:pt x="612163" y="779250"/>
                        </a:cubicBezTo>
                        <a:cubicBezTo>
                          <a:pt x="603395" y="839019"/>
                          <a:pt x="553129" y="888687"/>
                          <a:pt x="507374" y="912410"/>
                        </a:cubicBezTo>
                        <a:cubicBezTo>
                          <a:pt x="436158" y="937157"/>
                          <a:pt x="387522" y="907165"/>
                          <a:pt x="353299" y="831130"/>
                        </a:cubicBezTo>
                        <a:cubicBezTo>
                          <a:pt x="260389" y="880211"/>
                          <a:pt x="191762" y="836405"/>
                          <a:pt x="124426" y="750824"/>
                        </a:cubicBezTo>
                        <a:cubicBezTo>
                          <a:pt x="88896" y="769993"/>
                          <a:pt x="52190" y="722855"/>
                          <a:pt x="23796" y="661458"/>
                        </a:cubicBezTo>
                        <a:cubicBezTo>
                          <a:pt x="5689" y="622220"/>
                          <a:pt x="22538" y="566743"/>
                          <a:pt x="45298" y="540829"/>
                        </a:cubicBezTo>
                        <a:cubicBezTo>
                          <a:pt x="14203" y="506065"/>
                          <a:pt x="-2065" y="459478"/>
                          <a:pt x="-108" y="417068"/>
                        </a:cubicBezTo>
                        <a:cubicBezTo>
                          <a:pt x="3361" y="358891"/>
                          <a:pt x="45535" y="303762"/>
                          <a:pt x="82815" y="307064"/>
                        </a:cubicBezTo>
                        <a:cubicBezTo>
                          <a:pt x="83174" y="306011"/>
                          <a:pt x="83501" y="305126"/>
                          <a:pt x="83608" y="304165"/>
                        </a:cubicBezTo>
                        <a:close/>
                      </a:path>
                      <a:path w="926124" h="914400" fill="none" extrusionOk="0">
                        <a:moveTo>
                          <a:pt x="100608" y="554079"/>
                        </a:moveTo>
                        <a:cubicBezTo>
                          <a:pt x="82473" y="554508"/>
                          <a:pt x="64241" y="548588"/>
                          <a:pt x="46306" y="537210"/>
                        </a:cubicBezTo>
                        <a:moveTo>
                          <a:pt x="148522" y="738695"/>
                        </a:moveTo>
                        <a:cubicBezTo>
                          <a:pt x="142839" y="741453"/>
                          <a:pt x="134619" y="744048"/>
                          <a:pt x="124769" y="746760"/>
                        </a:cubicBezTo>
                        <a:moveTo>
                          <a:pt x="353256" y="827405"/>
                        </a:moveTo>
                        <a:cubicBezTo>
                          <a:pt x="348060" y="818827"/>
                          <a:pt x="343509" y="802778"/>
                          <a:pt x="338935" y="790575"/>
                        </a:cubicBezTo>
                        <a:moveTo>
                          <a:pt x="617994" y="735562"/>
                        </a:moveTo>
                        <a:cubicBezTo>
                          <a:pt x="620346" y="749453"/>
                          <a:pt x="615005" y="760028"/>
                          <a:pt x="612270" y="775970"/>
                        </a:cubicBezTo>
                        <a:moveTo>
                          <a:pt x="731659" y="485859"/>
                        </a:moveTo>
                        <a:cubicBezTo>
                          <a:pt x="767886" y="514709"/>
                          <a:pt x="810093" y="582907"/>
                          <a:pt x="801354" y="636905"/>
                        </a:cubicBezTo>
                        <a:moveTo>
                          <a:pt x="896067" y="324993"/>
                        </a:moveTo>
                        <a:cubicBezTo>
                          <a:pt x="887796" y="350013"/>
                          <a:pt x="882311" y="364882"/>
                          <a:pt x="865025" y="381635"/>
                        </a:cubicBezTo>
                        <a:moveTo>
                          <a:pt x="821592" y="114850"/>
                        </a:moveTo>
                        <a:cubicBezTo>
                          <a:pt x="822863" y="123456"/>
                          <a:pt x="825677" y="133667"/>
                          <a:pt x="823221" y="141605"/>
                        </a:cubicBezTo>
                        <a:moveTo>
                          <a:pt x="623375" y="83650"/>
                        </a:moveTo>
                        <a:cubicBezTo>
                          <a:pt x="628665" y="69366"/>
                          <a:pt x="635344" y="58957"/>
                          <a:pt x="639282" y="49530"/>
                        </a:cubicBezTo>
                        <a:moveTo>
                          <a:pt x="474659" y="99906"/>
                        </a:moveTo>
                        <a:cubicBezTo>
                          <a:pt x="478201" y="90042"/>
                          <a:pt x="479087" y="82159"/>
                          <a:pt x="482356" y="70485"/>
                        </a:cubicBezTo>
                        <a:moveTo>
                          <a:pt x="300132" y="109897"/>
                        </a:moveTo>
                        <a:cubicBezTo>
                          <a:pt x="309763" y="117673"/>
                          <a:pt x="321642" y="127309"/>
                          <a:pt x="328002" y="138430"/>
                        </a:cubicBezTo>
                        <a:moveTo>
                          <a:pt x="88474" y="334200"/>
                        </a:moveTo>
                        <a:cubicBezTo>
                          <a:pt x="86238" y="323175"/>
                          <a:pt x="85815" y="313492"/>
                          <a:pt x="83608" y="304165"/>
                        </a:cubicBezTo>
                      </a:path>
                      <a:path w="926124" h="914400" stroke="0" extrusionOk="0">
                        <a:moveTo>
                          <a:pt x="83608" y="304165"/>
                        </a:moveTo>
                        <a:cubicBezTo>
                          <a:pt x="66932" y="240037"/>
                          <a:pt x="81174" y="192645"/>
                          <a:pt x="120546" y="146198"/>
                        </a:cubicBezTo>
                        <a:cubicBezTo>
                          <a:pt x="186588" y="83058"/>
                          <a:pt x="232151" y="64156"/>
                          <a:pt x="300239" y="110109"/>
                        </a:cubicBezTo>
                        <a:cubicBezTo>
                          <a:pt x="323746" y="31309"/>
                          <a:pt x="422981" y="22222"/>
                          <a:pt x="481412" y="72644"/>
                        </a:cubicBezTo>
                        <a:cubicBezTo>
                          <a:pt x="490727" y="33201"/>
                          <a:pt x="522797" y="10631"/>
                          <a:pt x="552008" y="4233"/>
                        </a:cubicBezTo>
                        <a:cubicBezTo>
                          <a:pt x="590055" y="-1623"/>
                          <a:pt x="623701" y="6671"/>
                          <a:pt x="639561" y="52514"/>
                        </a:cubicBezTo>
                        <a:cubicBezTo>
                          <a:pt x="667761" y="5433"/>
                          <a:pt x="714039" y="-5823"/>
                          <a:pt x="760257" y="14605"/>
                        </a:cubicBezTo>
                        <a:cubicBezTo>
                          <a:pt x="791039" y="21051"/>
                          <a:pt x="813129" y="74968"/>
                          <a:pt x="821463" y="118025"/>
                        </a:cubicBezTo>
                        <a:cubicBezTo>
                          <a:pt x="860627" y="132800"/>
                          <a:pt x="890405" y="169868"/>
                          <a:pt x="900012" y="218397"/>
                        </a:cubicBezTo>
                        <a:cubicBezTo>
                          <a:pt x="905376" y="253498"/>
                          <a:pt x="914442" y="298438"/>
                          <a:pt x="896496" y="327236"/>
                        </a:cubicBezTo>
                        <a:cubicBezTo>
                          <a:pt x="927721" y="380763"/>
                          <a:pt x="934588" y="452437"/>
                          <a:pt x="922179" y="493649"/>
                        </a:cubicBezTo>
                        <a:cubicBezTo>
                          <a:pt x="911761" y="576604"/>
                          <a:pt x="871426" y="641770"/>
                          <a:pt x="801869" y="639318"/>
                        </a:cubicBezTo>
                        <a:cubicBezTo>
                          <a:pt x="804649" y="684623"/>
                          <a:pt x="788286" y="721477"/>
                          <a:pt x="758799" y="764137"/>
                        </a:cubicBezTo>
                        <a:cubicBezTo>
                          <a:pt x="706752" y="813532"/>
                          <a:pt x="644367" y="808290"/>
                          <a:pt x="612163" y="779250"/>
                        </a:cubicBezTo>
                        <a:cubicBezTo>
                          <a:pt x="595019" y="845407"/>
                          <a:pt x="554883" y="891194"/>
                          <a:pt x="507374" y="912410"/>
                        </a:cubicBezTo>
                        <a:cubicBezTo>
                          <a:pt x="449816" y="913121"/>
                          <a:pt x="380720" y="902665"/>
                          <a:pt x="353299" y="831130"/>
                        </a:cubicBezTo>
                        <a:cubicBezTo>
                          <a:pt x="266890" y="907926"/>
                          <a:pt x="175732" y="863187"/>
                          <a:pt x="124426" y="750824"/>
                        </a:cubicBezTo>
                        <a:cubicBezTo>
                          <a:pt x="78787" y="765544"/>
                          <a:pt x="37828" y="719416"/>
                          <a:pt x="23796" y="661458"/>
                        </a:cubicBezTo>
                        <a:cubicBezTo>
                          <a:pt x="13604" y="620487"/>
                          <a:pt x="18510" y="573354"/>
                          <a:pt x="45298" y="540829"/>
                        </a:cubicBezTo>
                        <a:cubicBezTo>
                          <a:pt x="16289" y="521471"/>
                          <a:pt x="-7050" y="468182"/>
                          <a:pt x="-108" y="417068"/>
                        </a:cubicBezTo>
                        <a:cubicBezTo>
                          <a:pt x="7028" y="347859"/>
                          <a:pt x="33266" y="312720"/>
                          <a:pt x="82815" y="307064"/>
                        </a:cubicBezTo>
                        <a:cubicBezTo>
                          <a:pt x="83208" y="306208"/>
                          <a:pt x="83291" y="305318"/>
                          <a:pt x="83608" y="304165"/>
                        </a:cubicBezTo>
                        <a:close/>
                      </a:path>
                      <a:path w="926124" h="914400" fill="none" stroke="0" extrusionOk="0">
                        <a:moveTo>
                          <a:pt x="100608" y="554079"/>
                        </a:moveTo>
                        <a:cubicBezTo>
                          <a:pt x="82651" y="552223"/>
                          <a:pt x="64096" y="544965"/>
                          <a:pt x="46306" y="537210"/>
                        </a:cubicBezTo>
                        <a:moveTo>
                          <a:pt x="148522" y="738695"/>
                        </a:moveTo>
                        <a:cubicBezTo>
                          <a:pt x="140461" y="745022"/>
                          <a:pt x="132318" y="744850"/>
                          <a:pt x="124769" y="746760"/>
                        </a:cubicBezTo>
                        <a:moveTo>
                          <a:pt x="353256" y="827405"/>
                        </a:moveTo>
                        <a:cubicBezTo>
                          <a:pt x="348714" y="816800"/>
                          <a:pt x="342097" y="803684"/>
                          <a:pt x="338935" y="790575"/>
                        </a:cubicBezTo>
                        <a:moveTo>
                          <a:pt x="617994" y="735562"/>
                        </a:moveTo>
                        <a:cubicBezTo>
                          <a:pt x="615161" y="749958"/>
                          <a:pt x="615206" y="761646"/>
                          <a:pt x="612270" y="775970"/>
                        </a:cubicBezTo>
                        <a:moveTo>
                          <a:pt x="731659" y="485859"/>
                        </a:moveTo>
                        <a:cubicBezTo>
                          <a:pt x="757104" y="520467"/>
                          <a:pt x="800960" y="584526"/>
                          <a:pt x="801354" y="636905"/>
                        </a:cubicBezTo>
                        <a:moveTo>
                          <a:pt x="896067" y="324993"/>
                        </a:moveTo>
                        <a:cubicBezTo>
                          <a:pt x="887389" y="345337"/>
                          <a:pt x="880596" y="366416"/>
                          <a:pt x="865025" y="381635"/>
                        </a:cubicBezTo>
                        <a:moveTo>
                          <a:pt x="821592" y="114850"/>
                        </a:moveTo>
                        <a:cubicBezTo>
                          <a:pt x="820128" y="123423"/>
                          <a:pt x="822589" y="132954"/>
                          <a:pt x="823221" y="141605"/>
                        </a:cubicBezTo>
                        <a:moveTo>
                          <a:pt x="623375" y="83650"/>
                        </a:moveTo>
                        <a:cubicBezTo>
                          <a:pt x="626548" y="70286"/>
                          <a:pt x="632875" y="58419"/>
                          <a:pt x="639282" y="49530"/>
                        </a:cubicBezTo>
                        <a:moveTo>
                          <a:pt x="474659" y="99906"/>
                        </a:moveTo>
                        <a:cubicBezTo>
                          <a:pt x="476015" y="90132"/>
                          <a:pt x="478087" y="81859"/>
                          <a:pt x="482356" y="70485"/>
                        </a:cubicBezTo>
                        <a:moveTo>
                          <a:pt x="300132" y="109897"/>
                        </a:moveTo>
                        <a:cubicBezTo>
                          <a:pt x="308469" y="118284"/>
                          <a:pt x="320059" y="128707"/>
                          <a:pt x="328002" y="138430"/>
                        </a:cubicBezTo>
                        <a:moveTo>
                          <a:pt x="88474" y="334200"/>
                        </a:moveTo>
                        <a:cubicBezTo>
                          <a:pt x="84869" y="324137"/>
                          <a:pt x="84568" y="312557"/>
                          <a:pt x="83608" y="304165"/>
                        </a:cubicBezTo>
                      </a:path>
                    </a:pathLst>
                  </a:custGeom>
                  <ask:type>
                    <ask:lineSketchNone/>
                  </ask:type>
                </ask:lineSketchStyleProps>
              </a:ext>
            </a:extLst>
          </a:ln>
          <a:effectLst>
            <a:glow rad="704318">
              <a:srgbClr val="FF0000">
                <a:alpha val="46000"/>
              </a:srgbClr>
            </a:glow>
          </a:effectLst>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 name="Virage 45">
            <a:extLst>
              <a:ext uri="{FF2B5EF4-FFF2-40B4-BE49-F238E27FC236}">
                <a16:creationId xmlns:a16="http://schemas.microsoft.com/office/drawing/2014/main" id="{A74A3969-52D4-C2B8-7B91-7E78B106E652}"/>
              </a:ext>
            </a:extLst>
          </p:cNvPr>
          <p:cNvSpPr/>
          <p:nvPr/>
        </p:nvSpPr>
        <p:spPr>
          <a:xfrm rot="1060915">
            <a:off x="2011471" y="2512746"/>
            <a:ext cx="1027965" cy="762037"/>
          </a:xfrm>
          <a:prstGeom prst="bentArrow">
            <a:avLst>
              <a:gd name="adj1" fmla="val 25000"/>
              <a:gd name="adj2" fmla="val 25000"/>
              <a:gd name="adj3" fmla="val 25000"/>
              <a:gd name="adj4" fmla="val 87500"/>
            </a:avLst>
          </a:prstGeom>
          <a:solidFill>
            <a:schemeClr val="bg1">
              <a:lumMod val="7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47" name="ZoneTexte 46">
            <a:extLst>
              <a:ext uri="{FF2B5EF4-FFF2-40B4-BE49-F238E27FC236}">
                <a16:creationId xmlns:a16="http://schemas.microsoft.com/office/drawing/2014/main" id="{145FFC39-7E70-BEAF-B014-03FA1340314B}"/>
              </a:ext>
            </a:extLst>
          </p:cNvPr>
          <p:cNvSpPr txBox="1"/>
          <p:nvPr/>
        </p:nvSpPr>
        <p:spPr>
          <a:xfrm>
            <a:off x="2002252" y="2293315"/>
            <a:ext cx="718466" cy="338554"/>
          </a:xfrm>
          <a:prstGeom prst="rect">
            <a:avLst/>
          </a:prstGeom>
          <a:noFill/>
        </p:spPr>
        <p:txBody>
          <a:bodyPr wrap="none" rtlCol="0">
            <a:spAutoFit/>
          </a:bodyPr>
          <a:lstStyle/>
          <a:p>
            <a:r>
              <a:rPr lang="en-US" sz="1600" dirty="0">
                <a:solidFill>
                  <a:schemeClr val="bg1">
                    <a:lumMod val="50000"/>
                  </a:schemeClr>
                </a:solidFill>
                <a:latin typeface="Arial" panose="020B0604020202020204" pitchFamily="34" charset="0"/>
                <a:cs typeface="Arial" panose="020B0604020202020204" pitchFamily="34" charset="0"/>
              </a:rPr>
              <a:t>FRET</a:t>
            </a:r>
          </a:p>
        </p:txBody>
      </p:sp>
      <p:sp>
        <p:nvSpPr>
          <p:cNvPr id="49" name="ZoneTexte 48">
            <a:extLst>
              <a:ext uri="{FF2B5EF4-FFF2-40B4-BE49-F238E27FC236}">
                <a16:creationId xmlns:a16="http://schemas.microsoft.com/office/drawing/2014/main" id="{03C53ADE-5D8D-09DD-FE14-BE548F4F4F57}"/>
              </a:ext>
            </a:extLst>
          </p:cNvPr>
          <p:cNvSpPr txBox="1"/>
          <p:nvPr/>
        </p:nvSpPr>
        <p:spPr>
          <a:xfrm>
            <a:off x="8959582" y="421157"/>
            <a:ext cx="3369414" cy="369332"/>
          </a:xfrm>
          <a:prstGeom prst="rect">
            <a:avLst/>
          </a:prstGeom>
          <a:noFill/>
        </p:spPr>
        <p:txBody>
          <a:bodyPr wrap="square">
            <a:spAutoFit/>
          </a:bodyPr>
          <a:lstStyle/>
          <a:p>
            <a:pPr algn="ctr"/>
            <a:r>
              <a:rPr lang="en-US" b="1" dirty="0">
                <a:latin typeface="Arial" panose="020B0604020202020204" pitchFamily="34" charset="0"/>
                <a:cs typeface="Arial" panose="020B0604020202020204" pitchFamily="34" charset="0"/>
              </a:rPr>
              <a:t>Cellular </a:t>
            </a:r>
            <a:r>
              <a:rPr lang="en-US" b="1" dirty="0" err="1">
                <a:latin typeface="Arial" panose="020B0604020202020204" pitchFamily="34" charset="0"/>
                <a:cs typeface="Arial" panose="020B0604020202020204" pitchFamily="34" charset="0"/>
              </a:rPr>
              <a:t>MTBench</a:t>
            </a:r>
            <a:r>
              <a:rPr lang="en-US" b="1" baseline="30000" dirty="0">
                <a:latin typeface="Arial" panose="020B0604020202020204" pitchFamily="34" charset="0"/>
                <a:cs typeface="Arial" panose="020B0604020202020204" pitchFamily="34" charset="0"/>
              </a:rPr>
              <a:t>®</a:t>
            </a:r>
            <a:r>
              <a:rPr lang="en-US" b="1" dirty="0">
                <a:latin typeface="Arial" panose="020B0604020202020204" pitchFamily="34" charset="0"/>
                <a:cs typeface="Arial" panose="020B0604020202020204" pitchFamily="34" charset="0"/>
              </a:rPr>
              <a:t> assay</a:t>
            </a:r>
          </a:p>
        </p:txBody>
      </p:sp>
      <p:sp>
        <p:nvSpPr>
          <p:cNvPr id="50" name="ZoneTexte 49">
            <a:extLst>
              <a:ext uri="{FF2B5EF4-FFF2-40B4-BE49-F238E27FC236}">
                <a16:creationId xmlns:a16="http://schemas.microsoft.com/office/drawing/2014/main" id="{39B0B4E9-AFB2-C1EE-BBAE-FDDDF31578EA}"/>
              </a:ext>
            </a:extLst>
          </p:cNvPr>
          <p:cNvSpPr txBox="1"/>
          <p:nvPr/>
        </p:nvSpPr>
        <p:spPr>
          <a:xfrm>
            <a:off x="4939613" y="421157"/>
            <a:ext cx="3369414" cy="369332"/>
          </a:xfrm>
          <a:prstGeom prst="rect">
            <a:avLst/>
          </a:prstGeom>
          <a:noFill/>
        </p:spPr>
        <p:txBody>
          <a:bodyPr wrap="square">
            <a:spAutoFit/>
          </a:bodyPr>
          <a:lstStyle/>
          <a:p>
            <a:pPr algn="ctr"/>
            <a:r>
              <a:rPr lang="en-US" b="1" dirty="0">
                <a:latin typeface="Arial" panose="020B0604020202020204" pitchFamily="34" charset="0"/>
                <a:cs typeface="Arial" panose="020B0604020202020204" pitchFamily="34" charset="0"/>
              </a:rPr>
              <a:t>Proximity ligation assay</a:t>
            </a:r>
          </a:p>
        </p:txBody>
      </p:sp>
      <p:sp>
        <p:nvSpPr>
          <p:cNvPr id="52" name="Cylindre 51">
            <a:extLst>
              <a:ext uri="{FF2B5EF4-FFF2-40B4-BE49-F238E27FC236}">
                <a16:creationId xmlns:a16="http://schemas.microsoft.com/office/drawing/2014/main" id="{9F9AA4BB-CB20-31B7-A0FA-A4C5D35DA112}"/>
              </a:ext>
            </a:extLst>
          </p:cNvPr>
          <p:cNvSpPr/>
          <p:nvPr/>
        </p:nvSpPr>
        <p:spPr>
          <a:xfrm rot="16200000">
            <a:off x="10355751" y="3907956"/>
            <a:ext cx="369330" cy="2071076"/>
          </a:xfrm>
          <a:prstGeom prst="can">
            <a:avLst/>
          </a:prstGeom>
          <a:solidFill>
            <a:schemeClr val="bg1">
              <a:lumMod val="85000"/>
            </a:schemeClr>
          </a:solidFill>
          <a:ln>
            <a:solidFill>
              <a:schemeClr val="bg1">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8" name="Arc 47">
            <a:extLst>
              <a:ext uri="{FF2B5EF4-FFF2-40B4-BE49-F238E27FC236}">
                <a16:creationId xmlns:a16="http://schemas.microsoft.com/office/drawing/2014/main" id="{D99B903C-5670-4AED-6B60-2E8FC29A9298}"/>
              </a:ext>
            </a:extLst>
          </p:cNvPr>
          <p:cNvSpPr/>
          <p:nvPr/>
        </p:nvSpPr>
        <p:spPr>
          <a:xfrm rot="5400000">
            <a:off x="9772045" y="3623310"/>
            <a:ext cx="950093" cy="1320944"/>
          </a:xfrm>
          <a:prstGeom prst="arc">
            <a:avLst>
              <a:gd name="adj1" fmla="val 16200000"/>
              <a:gd name="adj2" fmla="val 3252204"/>
            </a:avLst>
          </a:prstGeom>
          <a:ln w="152400">
            <a:solidFill>
              <a:schemeClr val="bg1">
                <a:lumMod val="7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53" name="Nuage 52">
            <a:extLst>
              <a:ext uri="{FF2B5EF4-FFF2-40B4-BE49-F238E27FC236}">
                <a16:creationId xmlns:a16="http://schemas.microsoft.com/office/drawing/2014/main" id="{6B0E50E8-D95D-A2D6-D283-A811161BA967}"/>
              </a:ext>
            </a:extLst>
          </p:cNvPr>
          <p:cNvSpPr/>
          <p:nvPr/>
        </p:nvSpPr>
        <p:spPr>
          <a:xfrm>
            <a:off x="10420496" y="2995377"/>
            <a:ext cx="926124" cy="914400"/>
          </a:xfrm>
          <a:prstGeom prst="cloud">
            <a:avLst/>
          </a:prstGeom>
          <a:solidFill>
            <a:schemeClr val="accent1"/>
          </a:solidFill>
          <a:ln>
            <a:noFill/>
            <a:extLst>
              <a:ext uri="{C807C97D-BFC1-408E-A445-0C87EB9F89A2}">
                <ask:lineSketchStyleProps xmlns:ask="http://schemas.microsoft.com/office/drawing/2018/sketchyshapes" sd="1219033472">
                  <a:custGeom>
                    <a:avLst/>
                    <a:gdLst>
                      <a:gd name="connsiteX0" fmla="*/ 83608 w 926124"/>
                      <a:gd name="connsiteY0" fmla="*/ 304165 h 914400"/>
                      <a:gd name="connsiteX1" fmla="*/ 120546 w 926124"/>
                      <a:gd name="connsiteY1" fmla="*/ 146198 h 914400"/>
                      <a:gd name="connsiteX2" fmla="*/ 300239 w 926124"/>
                      <a:gd name="connsiteY2" fmla="*/ 110109 h 914400"/>
                      <a:gd name="connsiteX3" fmla="*/ 481412 w 926124"/>
                      <a:gd name="connsiteY3" fmla="*/ 72644 h 914400"/>
                      <a:gd name="connsiteX4" fmla="*/ 552008 w 926124"/>
                      <a:gd name="connsiteY4" fmla="*/ 4233 h 914400"/>
                      <a:gd name="connsiteX5" fmla="*/ 639561 w 926124"/>
                      <a:gd name="connsiteY5" fmla="*/ 52514 h 914400"/>
                      <a:gd name="connsiteX6" fmla="*/ 760257 w 926124"/>
                      <a:gd name="connsiteY6" fmla="*/ 14605 h 914400"/>
                      <a:gd name="connsiteX7" fmla="*/ 821463 w 926124"/>
                      <a:gd name="connsiteY7" fmla="*/ 118025 h 914400"/>
                      <a:gd name="connsiteX8" fmla="*/ 900012 w 926124"/>
                      <a:gd name="connsiteY8" fmla="*/ 218397 h 914400"/>
                      <a:gd name="connsiteX9" fmla="*/ 896496 w 926124"/>
                      <a:gd name="connsiteY9" fmla="*/ 327236 h 914400"/>
                      <a:gd name="connsiteX10" fmla="*/ 922179 w 926124"/>
                      <a:gd name="connsiteY10" fmla="*/ 493649 h 914400"/>
                      <a:gd name="connsiteX11" fmla="*/ 801869 w 926124"/>
                      <a:gd name="connsiteY11" fmla="*/ 639318 h 914400"/>
                      <a:gd name="connsiteX12" fmla="*/ 758799 w 926124"/>
                      <a:gd name="connsiteY12" fmla="*/ 764137 h 914400"/>
                      <a:gd name="connsiteX13" fmla="*/ 612163 w 926124"/>
                      <a:gd name="connsiteY13" fmla="*/ 779250 h 914400"/>
                      <a:gd name="connsiteX14" fmla="*/ 507374 w 926124"/>
                      <a:gd name="connsiteY14" fmla="*/ 912410 h 914400"/>
                      <a:gd name="connsiteX15" fmla="*/ 353299 w 926124"/>
                      <a:gd name="connsiteY15" fmla="*/ 831130 h 914400"/>
                      <a:gd name="connsiteX16" fmla="*/ 124426 w 926124"/>
                      <a:gd name="connsiteY16" fmla="*/ 750824 h 914400"/>
                      <a:gd name="connsiteX17" fmla="*/ 23796 w 926124"/>
                      <a:gd name="connsiteY17" fmla="*/ 661458 h 914400"/>
                      <a:gd name="connsiteX18" fmla="*/ 45298 w 926124"/>
                      <a:gd name="connsiteY18" fmla="*/ 540829 h 914400"/>
                      <a:gd name="connsiteX19" fmla="*/ -108 w 926124"/>
                      <a:gd name="connsiteY19" fmla="*/ 417068 h 914400"/>
                      <a:gd name="connsiteX20" fmla="*/ 82815 w 926124"/>
                      <a:gd name="connsiteY20" fmla="*/ 307064 h 914400"/>
                      <a:gd name="connsiteX21" fmla="*/ 83608 w 926124"/>
                      <a:gd name="connsiteY21" fmla="*/ 304165 h 914400"/>
                      <a:gd name="connsiteX0" fmla="*/ 100608 w 926124"/>
                      <a:gd name="connsiteY0" fmla="*/ 554079 h 914400"/>
                      <a:gd name="connsiteX1" fmla="*/ 46306 w 926124"/>
                      <a:gd name="connsiteY1" fmla="*/ 537210 h 914400"/>
                      <a:gd name="connsiteX2" fmla="*/ 148522 w 926124"/>
                      <a:gd name="connsiteY2" fmla="*/ 738695 h 914400"/>
                      <a:gd name="connsiteX3" fmla="*/ 124769 w 926124"/>
                      <a:gd name="connsiteY3" fmla="*/ 746760 h 914400"/>
                      <a:gd name="connsiteX4" fmla="*/ 353256 w 926124"/>
                      <a:gd name="connsiteY4" fmla="*/ 827405 h 914400"/>
                      <a:gd name="connsiteX5" fmla="*/ 338935 w 926124"/>
                      <a:gd name="connsiteY5" fmla="*/ 790575 h 914400"/>
                      <a:gd name="connsiteX6" fmla="*/ 617994 w 926124"/>
                      <a:gd name="connsiteY6" fmla="*/ 735562 h 914400"/>
                      <a:gd name="connsiteX7" fmla="*/ 612270 w 926124"/>
                      <a:gd name="connsiteY7" fmla="*/ 775970 h 914400"/>
                      <a:gd name="connsiteX8" fmla="*/ 731659 w 926124"/>
                      <a:gd name="connsiteY8" fmla="*/ 485859 h 914400"/>
                      <a:gd name="connsiteX9" fmla="*/ 801354 w 926124"/>
                      <a:gd name="connsiteY9" fmla="*/ 636905 h 914400"/>
                      <a:gd name="connsiteX10" fmla="*/ 896067 w 926124"/>
                      <a:gd name="connsiteY10" fmla="*/ 324993 h 914400"/>
                      <a:gd name="connsiteX11" fmla="*/ 865025 w 926124"/>
                      <a:gd name="connsiteY11" fmla="*/ 381635 h 914400"/>
                      <a:gd name="connsiteX12" fmla="*/ 821592 w 926124"/>
                      <a:gd name="connsiteY12" fmla="*/ 114850 h 914400"/>
                      <a:gd name="connsiteX13" fmla="*/ 823221 w 926124"/>
                      <a:gd name="connsiteY13" fmla="*/ 141605 h 914400"/>
                      <a:gd name="connsiteX14" fmla="*/ 623375 w 926124"/>
                      <a:gd name="connsiteY14" fmla="*/ 83650 h 914400"/>
                      <a:gd name="connsiteX15" fmla="*/ 639282 w 926124"/>
                      <a:gd name="connsiteY15" fmla="*/ 49530 h 914400"/>
                      <a:gd name="connsiteX16" fmla="*/ 474659 w 926124"/>
                      <a:gd name="connsiteY16" fmla="*/ 99906 h 914400"/>
                      <a:gd name="connsiteX17" fmla="*/ 482356 w 926124"/>
                      <a:gd name="connsiteY17" fmla="*/ 70485 h 914400"/>
                      <a:gd name="connsiteX18" fmla="*/ 300132 w 926124"/>
                      <a:gd name="connsiteY18" fmla="*/ 109897 h 914400"/>
                      <a:gd name="connsiteX19" fmla="*/ 328002 w 926124"/>
                      <a:gd name="connsiteY19" fmla="*/ 138430 h 914400"/>
                      <a:gd name="connsiteX20" fmla="*/ 88474 w 926124"/>
                      <a:gd name="connsiteY20" fmla="*/ 334200 h 914400"/>
                      <a:gd name="connsiteX21" fmla="*/ 83608 w 926124"/>
                      <a:gd name="connsiteY21" fmla="*/ 304165 h 9144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926124" h="914400" fill="none" extrusionOk="0">
                        <a:moveTo>
                          <a:pt x="83608" y="304165"/>
                        </a:moveTo>
                        <a:cubicBezTo>
                          <a:pt x="71337" y="259709"/>
                          <a:pt x="89078" y="185816"/>
                          <a:pt x="120546" y="146198"/>
                        </a:cubicBezTo>
                        <a:cubicBezTo>
                          <a:pt x="180294" y="83133"/>
                          <a:pt x="240544" y="44472"/>
                          <a:pt x="300239" y="110109"/>
                        </a:cubicBezTo>
                        <a:cubicBezTo>
                          <a:pt x="343738" y="24049"/>
                          <a:pt x="411423" y="3865"/>
                          <a:pt x="481412" y="72644"/>
                        </a:cubicBezTo>
                        <a:cubicBezTo>
                          <a:pt x="494012" y="39184"/>
                          <a:pt x="519547" y="3742"/>
                          <a:pt x="552008" y="4233"/>
                        </a:cubicBezTo>
                        <a:cubicBezTo>
                          <a:pt x="591139" y="-6367"/>
                          <a:pt x="621071" y="12742"/>
                          <a:pt x="639561" y="52514"/>
                        </a:cubicBezTo>
                        <a:cubicBezTo>
                          <a:pt x="661000" y="2512"/>
                          <a:pt x="727085" y="-18478"/>
                          <a:pt x="760257" y="14605"/>
                        </a:cubicBezTo>
                        <a:cubicBezTo>
                          <a:pt x="781805" y="39036"/>
                          <a:pt x="816997" y="76594"/>
                          <a:pt x="821463" y="118025"/>
                        </a:cubicBezTo>
                        <a:cubicBezTo>
                          <a:pt x="862700" y="130782"/>
                          <a:pt x="887054" y="172857"/>
                          <a:pt x="900012" y="218397"/>
                        </a:cubicBezTo>
                        <a:cubicBezTo>
                          <a:pt x="911392" y="254804"/>
                          <a:pt x="905949" y="287720"/>
                          <a:pt x="896496" y="327236"/>
                        </a:cubicBezTo>
                        <a:cubicBezTo>
                          <a:pt x="935652" y="374908"/>
                          <a:pt x="941457" y="444601"/>
                          <a:pt x="922179" y="493649"/>
                        </a:cubicBezTo>
                        <a:cubicBezTo>
                          <a:pt x="917821" y="580107"/>
                          <a:pt x="864011" y="637252"/>
                          <a:pt x="801869" y="639318"/>
                        </a:cubicBezTo>
                        <a:cubicBezTo>
                          <a:pt x="807488" y="693136"/>
                          <a:pt x="780739" y="725942"/>
                          <a:pt x="758799" y="764137"/>
                        </a:cubicBezTo>
                        <a:cubicBezTo>
                          <a:pt x="716295" y="813096"/>
                          <a:pt x="670149" y="820532"/>
                          <a:pt x="612163" y="779250"/>
                        </a:cubicBezTo>
                        <a:cubicBezTo>
                          <a:pt x="603395" y="839019"/>
                          <a:pt x="553129" y="888687"/>
                          <a:pt x="507374" y="912410"/>
                        </a:cubicBezTo>
                        <a:cubicBezTo>
                          <a:pt x="436158" y="937157"/>
                          <a:pt x="387522" y="907165"/>
                          <a:pt x="353299" y="831130"/>
                        </a:cubicBezTo>
                        <a:cubicBezTo>
                          <a:pt x="260389" y="880211"/>
                          <a:pt x="191762" y="836405"/>
                          <a:pt x="124426" y="750824"/>
                        </a:cubicBezTo>
                        <a:cubicBezTo>
                          <a:pt x="88896" y="769993"/>
                          <a:pt x="52190" y="722855"/>
                          <a:pt x="23796" y="661458"/>
                        </a:cubicBezTo>
                        <a:cubicBezTo>
                          <a:pt x="5689" y="622220"/>
                          <a:pt x="22538" y="566743"/>
                          <a:pt x="45298" y="540829"/>
                        </a:cubicBezTo>
                        <a:cubicBezTo>
                          <a:pt x="14203" y="506065"/>
                          <a:pt x="-2065" y="459478"/>
                          <a:pt x="-108" y="417068"/>
                        </a:cubicBezTo>
                        <a:cubicBezTo>
                          <a:pt x="3361" y="358891"/>
                          <a:pt x="45535" y="303762"/>
                          <a:pt x="82815" y="307064"/>
                        </a:cubicBezTo>
                        <a:cubicBezTo>
                          <a:pt x="83174" y="306011"/>
                          <a:pt x="83501" y="305126"/>
                          <a:pt x="83608" y="304165"/>
                        </a:cubicBezTo>
                        <a:close/>
                      </a:path>
                      <a:path w="926124" h="914400" fill="none" extrusionOk="0">
                        <a:moveTo>
                          <a:pt x="100608" y="554079"/>
                        </a:moveTo>
                        <a:cubicBezTo>
                          <a:pt x="82473" y="554508"/>
                          <a:pt x="64241" y="548588"/>
                          <a:pt x="46306" y="537210"/>
                        </a:cubicBezTo>
                        <a:moveTo>
                          <a:pt x="148522" y="738695"/>
                        </a:moveTo>
                        <a:cubicBezTo>
                          <a:pt x="142839" y="741453"/>
                          <a:pt x="134619" y="744048"/>
                          <a:pt x="124769" y="746760"/>
                        </a:cubicBezTo>
                        <a:moveTo>
                          <a:pt x="353256" y="827405"/>
                        </a:moveTo>
                        <a:cubicBezTo>
                          <a:pt x="348060" y="818827"/>
                          <a:pt x="343509" y="802778"/>
                          <a:pt x="338935" y="790575"/>
                        </a:cubicBezTo>
                        <a:moveTo>
                          <a:pt x="617994" y="735562"/>
                        </a:moveTo>
                        <a:cubicBezTo>
                          <a:pt x="620346" y="749453"/>
                          <a:pt x="615005" y="760028"/>
                          <a:pt x="612270" y="775970"/>
                        </a:cubicBezTo>
                        <a:moveTo>
                          <a:pt x="731659" y="485859"/>
                        </a:moveTo>
                        <a:cubicBezTo>
                          <a:pt x="767886" y="514709"/>
                          <a:pt x="810093" y="582907"/>
                          <a:pt x="801354" y="636905"/>
                        </a:cubicBezTo>
                        <a:moveTo>
                          <a:pt x="896067" y="324993"/>
                        </a:moveTo>
                        <a:cubicBezTo>
                          <a:pt x="887796" y="350013"/>
                          <a:pt x="882311" y="364882"/>
                          <a:pt x="865025" y="381635"/>
                        </a:cubicBezTo>
                        <a:moveTo>
                          <a:pt x="821592" y="114850"/>
                        </a:moveTo>
                        <a:cubicBezTo>
                          <a:pt x="822863" y="123456"/>
                          <a:pt x="825677" y="133667"/>
                          <a:pt x="823221" y="141605"/>
                        </a:cubicBezTo>
                        <a:moveTo>
                          <a:pt x="623375" y="83650"/>
                        </a:moveTo>
                        <a:cubicBezTo>
                          <a:pt x="628665" y="69366"/>
                          <a:pt x="635344" y="58957"/>
                          <a:pt x="639282" y="49530"/>
                        </a:cubicBezTo>
                        <a:moveTo>
                          <a:pt x="474659" y="99906"/>
                        </a:moveTo>
                        <a:cubicBezTo>
                          <a:pt x="478201" y="90042"/>
                          <a:pt x="479087" y="82159"/>
                          <a:pt x="482356" y="70485"/>
                        </a:cubicBezTo>
                        <a:moveTo>
                          <a:pt x="300132" y="109897"/>
                        </a:moveTo>
                        <a:cubicBezTo>
                          <a:pt x="309763" y="117673"/>
                          <a:pt x="321642" y="127309"/>
                          <a:pt x="328002" y="138430"/>
                        </a:cubicBezTo>
                        <a:moveTo>
                          <a:pt x="88474" y="334200"/>
                        </a:moveTo>
                        <a:cubicBezTo>
                          <a:pt x="86238" y="323175"/>
                          <a:pt x="85815" y="313492"/>
                          <a:pt x="83608" y="304165"/>
                        </a:cubicBezTo>
                      </a:path>
                      <a:path w="926124" h="914400" stroke="0" extrusionOk="0">
                        <a:moveTo>
                          <a:pt x="83608" y="304165"/>
                        </a:moveTo>
                        <a:cubicBezTo>
                          <a:pt x="66932" y="240037"/>
                          <a:pt x="81174" y="192645"/>
                          <a:pt x="120546" y="146198"/>
                        </a:cubicBezTo>
                        <a:cubicBezTo>
                          <a:pt x="186588" y="83058"/>
                          <a:pt x="232151" y="64156"/>
                          <a:pt x="300239" y="110109"/>
                        </a:cubicBezTo>
                        <a:cubicBezTo>
                          <a:pt x="323746" y="31309"/>
                          <a:pt x="422981" y="22222"/>
                          <a:pt x="481412" y="72644"/>
                        </a:cubicBezTo>
                        <a:cubicBezTo>
                          <a:pt x="490727" y="33201"/>
                          <a:pt x="522797" y="10631"/>
                          <a:pt x="552008" y="4233"/>
                        </a:cubicBezTo>
                        <a:cubicBezTo>
                          <a:pt x="590055" y="-1623"/>
                          <a:pt x="623701" y="6671"/>
                          <a:pt x="639561" y="52514"/>
                        </a:cubicBezTo>
                        <a:cubicBezTo>
                          <a:pt x="667761" y="5433"/>
                          <a:pt x="714039" y="-5823"/>
                          <a:pt x="760257" y="14605"/>
                        </a:cubicBezTo>
                        <a:cubicBezTo>
                          <a:pt x="791039" y="21051"/>
                          <a:pt x="813129" y="74968"/>
                          <a:pt x="821463" y="118025"/>
                        </a:cubicBezTo>
                        <a:cubicBezTo>
                          <a:pt x="860627" y="132800"/>
                          <a:pt x="890405" y="169868"/>
                          <a:pt x="900012" y="218397"/>
                        </a:cubicBezTo>
                        <a:cubicBezTo>
                          <a:pt x="905376" y="253498"/>
                          <a:pt x="914442" y="298438"/>
                          <a:pt x="896496" y="327236"/>
                        </a:cubicBezTo>
                        <a:cubicBezTo>
                          <a:pt x="927721" y="380763"/>
                          <a:pt x="934588" y="452437"/>
                          <a:pt x="922179" y="493649"/>
                        </a:cubicBezTo>
                        <a:cubicBezTo>
                          <a:pt x="911761" y="576604"/>
                          <a:pt x="871426" y="641770"/>
                          <a:pt x="801869" y="639318"/>
                        </a:cubicBezTo>
                        <a:cubicBezTo>
                          <a:pt x="804649" y="684623"/>
                          <a:pt x="788286" y="721477"/>
                          <a:pt x="758799" y="764137"/>
                        </a:cubicBezTo>
                        <a:cubicBezTo>
                          <a:pt x="706752" y="813532"/>
                          <a:pt x="644367" y="808290"/>
                          <a:pt x="612163" y="779250"/>
                        </a:cubicBezTo>
                        <a:cubicBezTo>
                          <a:pt x="595019" y="845407"/>
                          <a:pt x="554883" y="891194"/>
                          <a:pt x="507374" y="912410"/>
                        </a:cubicBezTo>
                        <a:cubicBezTo>
                          <a:pt x="449816" y="913121"/>
                          <a:pt x="380720" y="902665"/>
                          <a:pt x="353299" y="831130"/>
                        </a:cubicBezTo>
                        <a:cubicBezTo>
                          <a:pt x="266890" y="907926"/>
                          <a:pt x="175732" y="863187"/>
                          <a:pt x="124426" y="750824"/>
                        </a:cubicBezTo>
                        <a:cubicBezTo>
                          <a:pt x="78787" y="765544"/>
                          <a:pt x="37828" y="719416"/>
                          <a:pt x="23796" y="661458"/>
                        </a:cubicBezTo>
                        <a:cubicBezTo>
                          <a:pt x="13604" y="620487"/>
                          <a:pt x="18510" y="573354"/>
                          <a:pt x="45298" y="540829"/>
                        </a:cubicBezTo>
                        <a:cubicBezTo>
                          <a:pt x="16289" y="521471"/>
                          <a:pt x="-7050" y="468182"/>
                          <a:pt x="-108" y="417068"/>
                        </a:cubicBezTo>
                        <a:cubicBezTo>
                          <a:pt x="7028" y="347859"/>
                          <a:pt x="33266" y="312720"/>
                          <a:pt x="82815" y="307064"/>
                        </a:cubicBezTo>
                        <a:cubicBezTo>
                          <a:pt x="83208" y="306208"/>
                          <a:pt x="83291" y="305318"/>
                          <a:pt x="83608" y="304165"/>
                        </a:cubicBezTo>
                        <a:close/>
                      </a:path>
                      <a:path w="926124" h="914400" fill="none" stroke="0" extrusionOk="0">
                        <a:moveTo>
                          <a:pt x="100608" y="554079"/>
                        </a:moveTo>
                        <a:cubicBezTo>
                          <a:pt x="82651" y="552223"/>
                          <a:pt x="64096" y="544965"/>
                          <a:pt x="46306" y="537210"/>
                        </a:cubicBezTo>
                        <a:moveTo>
                          <a:pt x="148522" y="738695"/>
                        </a:moveTo>
                        <a:cubicBezTo>
                          <a:pt x="140461" y="745022"/>
                          <a:pt x="132318" y="744850"/>
                          <a:pt x="124769" y="746760"/>
                        </a:cubicBezTo>
                        <a:moveTo>
                          <a:pt x="353256" y="827405"/>
                        </a:moveTo>
                        <a:cubicBezTo>
                          <a:pt x="348714" y="816800"/>
                          <a:pt x="342097" y="803684"/>
                          <a:pt x="338935" y="790575"/>
                        </a:cubicBezTo>
                        <a:moveTo>
                          <a:pt x="617994" y="735562"/>
                        </a:moveTo>
                        <a:cubicBezTo>
                          <a:pt x="615161" y="749958"/>
                          <a:pt x="615206" y="761646"/>
                          <a:pt x="612270" y="775970"/>
                        </a:cubicBezTo>
                        <a:moveTo>
                          <a:pt x="731659" y="485859"/>
                        </a:moveTo>
                        <a:cubicBezTo>
                          <a:pt x="757104" y="520467"/>
                          <a:pt x="800960" y="584526"/>
                          <a:pt x="801354" y="636905"/>
                        </a:cubicBezTo>
                        <a:moveTo>
                          <a:pt x="896067" y="324993"/>
                        </a:moveTo>
                        <a:cubicBezTo>
                          <a:pt x="887389" y="345337"/>
                          <a:pt x="880596" y="366416"/>
                          <a:pt x="865025" y="381635"/>
                        </a:cubicBezTo>
                        <a:moveTo>
                          <a:pt x="821592" y="114850"/>
                        </a:moveTo>
                        <a:cubicBezTo>
                          <a:pt x="820128" y="123423"/>
                          <a:pt x="822589" y="132954"/>
                          <a:pt x="823221" y="141605"/>
                        </a:cubicBezTo>
                        <a:moveTo>
                          <a:pt x="623375" y="83650"/>
                        </a:moveTo>
                        <a:cubicBezTo>
                          <a:pt x="626548" y="70286"/>
                          <a:pt x="632875" y="58419"/>
                          <a:pt x="639282" y="49530"/>
                        </a:cubicBezTo>
                        <a:moveTo>
                          <a:pt x="474659" y="99906"/>
                        </a:moveTo>
                        <a:cubicBezTo>
                          <a:pt x="476015" y="90132"/>
                          <a:pt x="478087" y="81859"/>
                          <a:pt x="482356" y="70485"/>
                        </a:cubicBezTo>
                        <a:moveTo>
                          <a:pt x="300132" y="109897"/>
                        </a:moveTo>
                        <a:cubicBezTo>
                          <a:pt x="308469" y="118284"/>
                          <a:pt x="320059" y="128707"/>
                          <a:pt x="328002" y="138430"/>
                        </a:cubicBezTo>
                        <a:moveTo>
                          <a:pt x="88474" y="334200"/>
                        </a:moveTo>
                        <a:cubicBezTo>
                          <a:pt x="84869" y="324137"/>
                          <a:pt x="84568" y="312557"/>
                          <a:pt x="83608" y="304165"/>
                        </a:cubicBezTo>
                      </a:path>
                    </a:pathLst>
                  </a:custGeom>
                  <ask:type>
                    <ask:lineSketchNone/>
                  </ask:type>
                </ask:lineSketchStyleProps>
              </a:ext>
            </a:extLst>
          </a:ln>
          <a:effectLst/>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latin typeface="Arial" panose="020B0604020202020204" pitchFamily="34" charset="0"/>
                <a:cs typeface="Arial" panose="020B0604020202020204" pitchFamily="34" charset="0"/>
              </a:rPr>
              <a:t>POI</a:t>
            </a:r>
          </a:p>
        </p:txBody>
      </p:sp>
      <p:sp>
        <p:nvSpPr>
          <p:cNvPr id="54" name="Nuage 53">
            <a:extLst>
              <a:ext uri="{FF2B5EF4-FFF2-40B4-BE49-F238E27FC236}">
                <a16:creationId xmlns:a16="http://schemas.microsoft.com/office/drawing/2014/main" id="{56FDA38D-8461-33D3-FBA1-FADAE361B638}"/>
              </a:ext>
            </a:extLst>
          </p:cNvPr>
          <p:cNvSpPr/>
          <p:nvPr/>
        </p:nvSpPr>
        <p:spPr>
          <a:xfrm>
            <a:off x="10609202" y="3861623"/>
            <a:ext cx="596724" cy="527875"/>
          </a:xfrm>
          <a:prstGeom prst="cloud">
            <a:avLst/>
          </a:prstGeom>
          <a:solidFill>
            <a:srgbClr val="00B050"/>
          </a:solidFill>
          <a:ln>
            <a:noFill/>
            <a:extLst>
              <a:ext uri="{C807C97D-BFC1-408E-A445-0C87EB9F89A2}">
                <ask:lineSketchStyleProps xmlns:ask="http://schemas.microsoft.com/office/drawing/2018/sketchyshapes" sd="1219033472">
                  <a:custGeom>
                    <a:avLst/>
                    <a:gdLst>
                      <a:gd name="connsiteX0" fmla="*/ 83608 w 926124"/>
                      <a:gd name="connsiteY0" fmla="*/ 304165 h 914400"/>
                      <a:gd name="connsiteX1" fmla="*/ 120546 w 926124"/>
                      <a:gd name="connsiteY1" fmla="*/ 146198 h 914400"/>
                      <a:gd name="connsiteX2" fmla="*/ 300239 w 926124"/>
                      <a:gd name="connsiteY2" fmla="*/ 110109 h 914400"/>
                      <a:gd name="connsiteX3" fmla="*/ 481412 w 926124"/>
                      <a:gd name="connsiteY3" fmla="*/ 72644 h 914400"/>
                      <a:gd name="connsiteX4" fmla="*/ 552008 w 926124"/>
                      <a:gd name="connsiteY4" fmla="*/ 4233 h 914400"/>
                      <a:gd name="connsiteX5" fmla="*/ 639561 w 926124"/>
                      <a:gd name="connsiteY5" fmla="*/ 52514 h 914400"/>
                      <a:gd name="connsiteX6" fmla="*/ 760257 w 926124"/>
                      <a:gd name="connsiteY6" fmla="*/ 14605 h 914400"/>
                      <a:gd name="connsiteX7" fmla="*/ 821463 w 926124"/>
                      <a:gd name="connsiteY7" fmla="*/ 118025 h 914400"/>
                      <a:gd name="connsiteX8" fmla="*/ 900012 w 926124"/>
                      <a:gd name="connsiteY8" fmla="*/ 218397 h 914400"/>
                      <a:gd name="connsiteX9" fmla="*/ 896496 w 926124"/>
                      <a:gd name="connsiteY9" fmla="*/ 327236 h 914400"/>
                      <a:gd name="connsiteX10" fmla="*/ 922179 w 926124"/>
                      <a:gd name="connsiteY10" fmla="*/ 493649 h 914400"/>
                      <a:gd name="connsiteX11" fmla="*/ 801869 w 926124"/>
                      <a:gd name="connsiteY11" fmla="*/ 639318 h 914400"/>
                      <a:gd name="connsiteX12" fmla="*/ 758799 w 926124"/>
                      <a:gd name="connsiteY12" fmla="*/ 764137 h 914400"/>
                      <a:gd name="connsiteX13" fmla="*/ 612163 w 926124"/>
                      <a:gd name="connsiteY13" fmla="*/ 779250 h 914400"/>
                      <a:gd name="connsiteX14" fmla="*/ 507374 w 926124"/>
                      <a:gd name="connsiteY14" fmla="*/ 912410 h 914400"/>
                      <a:gd name="connsiteX15" fmla="*/ 353299 w 926124"/>
                      <a:gd name="connsiteY15" fmla="*/ 831130 h 914400"/>
                      <a:gd name="connsiteX16" fmla="*/ 124426 w 926124"/>
                      <a:gd name="connsiteY16" fmla="*/ 750824 h 914400"/>
                      <a:gd name="connsiteX17" fmla="*/ 23796 w 926124"/>
                      <a:gd name="connsiteY17" fmla="*/ 661458 h 914400"/>
                      <a:gd name="connsiteX18" fmla="*/ 45298 w 926124"/>
                      <a:gd name="connsiteY18" fmla="*/ 540829 h 914400"/>
                      <a:gd name="connsiteX19" fmla="*/ -108 w 926124"/>
                      <a:gd name="connsiteY19" fmla="*/ 417068 h 914400"/>
                      <a:gd name="connsiteX20" fmla="*/ 82815 w 926124"/>
                      <a:gd name="connsiteY20" fmla="*/ 307064 h 914400"/>
                      <a:gd name="connsiteX21" fmla="*/ 83608 w 926124"/>
                      <a:gd name="connsiteY21" fmla="*/ 304165 h 914400"/>
                      <a:gd name="connsiteX0" fmla="*/ 100608 w 926124"/>
                      <a:gd name="connsiteY0" fmla="*/ 554079 h 914400"/>
                      <a:gd name="connsiteX1" fmla="*/ 46306 w 926124"/>
                      <a:gd name="connsiteY1" fmla="*/ 537210 h 914400"/>
                      <a:gd name="connsiteX2" fmla="*/ 148522 w 926124"/>
                      <a:gd name="connsiteY2" fmla="*/ 738695 h 914400"/>
                      <a:gd name="connsiteX3" fmla="*/ 124769 w 926124"/>
                      <a:gd name="connsiteY3" fmla="*/ 746760 h 914400"/>
                      <a:gd name="connsiteX4" fmla="*/ 353256 w 926124"/>
                      <a:gd name="connsiteY4" fmla="*/ 827405 h 914400"/>
                      <a:gd name="connsiteX5" fmla="*/ 338935 w 926124"/>
                      <a:gd name="connsiteY5" fmla="*/ 790575 h 914400"/>
                      <a:gd name="connsiteX6" fmla="*/ 617994 w 926124"/>
                      <a:gd name="connsiteY6" fmla="*/ 735562 h 914400"/>
                      <a:gd name="connsiteX7" fmla="*/ 612270 w 926124"/>
                      <a:gd name="connsiteY7" fmla="*/ 775970 h 914400"/>
                      <a:gd name="connsiteX8" fmla="*/ 731659 w 926124"/>
                      <a:gd name="connsiteY8" fmla="*/ 485859 h 914400"/>
                      <a:gd name="connsiteX9" fmla="*/ 801354 w 926124"/>
                      <a:gd name="connsiteY9" fmla="*/ 636905 h 914400"/>
                      <a:gd name="connsiteX10" fmla="*/ 896067 w 926124"/>
                      <a:gd name="connsiteY10" fmla="*/ 324993 h 914400"/>
                      <a:gd name="connsiteX11" fmla="*/ 865025 w 926124"/>
                      <a:gd name="connsiteY11" fmla="*/ 381635 h 914400"/>
                      <a:gd name="connsiteX12" fmla="*/ 821592 w 926124"/>
                      <a:gd name="connsiteY12" fmla="*/ 114850 h 914400"/>
                      <a:gd name="connsiteX13" fmla="*/ 823221 w 926124"/>
                      <a:gd name="connsiteY13" fmla="*/ 141605 h 914400"/>
                      <a:gd name="connsiteX14" fmla="*/ 623375 w 926124"/>
                      <a:gd name="connsiteY14" fmla="*/ 83650 h 914400"/>
                      <a:gd name="connsiteX15" fmla="*/ 639282 w 926124"/>
                      <a:gd name="connsiteY15" fmla="*/ 49530 h 914400"/>
                      <a:gd name="connsiteX16" fmla="*/ 474659 w 926124"/>
                      <a:gd name="connsiteY16" fmla="*/ 99906 h 914400"/>
                      <a:gd name="connsiteX17" fmla="*/ 482356 w 926124"/>
                      <a:gd name="connsiteY17" fmla="*/ 70485 h 914400"/>
                      <a:gd name="connsiteX18" fmla="*/ 300132 w 926124"/>
                      <a:gd name="connsiteY18" fmla="*/ 109897 h 914400"/>
                      <a:gd name="connsiteX19" fmla="*/ 328002 w 926124"/>
                      <a:gd name="connsiteY19" fmla="*/ 138430 h 914400"/>
                      <a:gd name="connsiteX20" fmla="*/ 88474 w 926124"/>
                      <a:gd name="connsiteY20" fmla="*/ 334200 h 914400"/>
                      <a:gd name="connsiteX21" fmla="*/ 83608 w 926124"/>
                      <a:gd name="connsiteY21" fmla="*/ 304165 h 9144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926124" h="914400" fill="none" extrusionOk="0">
                        <a:moveTo>
                          <a:pt x="83608" y="304165"/>
                        </a:moveTo>
                        <a:cubicBezTo>
                          <a:pt x="71337" y="259709"/>
                          <a:pt x="89078" y="185816"/>
                          <a:pt x="120546" y="146198"/>
                        </a:cubicBezTo>
                        <a:cubicBezTo>
                          <a:pt x="180294" y="83133"/>
                          <a:pt x="240544" y="44472"/>
                          <a:pt x="300239" y="110109"/>
                        </a:cubicBezTo>
                        <a:cubicBezTo>
                          <a:pt x="343738" y="24049"/>
                          <a:pt x="411423" y="3865"/>
                          <a:pt x="481412" y="72644"/>
                        </a:cubicBezTo>
                        <a:cubicBezTo>
                          <a:pt x="494012" y="39184"/>
                          <a:pt x="519547" y="3742"/>
                          <a:pt x="552008" y="4233"/>
                        </a:cubicBezTo>
                        <a:cubicBezTo>
                          <a:pt x="591139" y="-6367"/>
                          <a:pt x="621071" y="12742"/>
                          <a:pt x="639561" y="52514"/>
                        </a:cubicBezTo>
                        <a:cubicBezTo>
                          <a:pt x="661000" y="2512"/>
                          <a:pt x="727085" y="-18478"/>
                          <a:pt x="760257" y="14605"/>
                        </a:cubicBezTo>
                        <a:cubicBezTo>
                          <a:pt x="781805" y="39036"/>
                          <a:pt x="816997" y="76594"/>
                          <a:pt x="821463" y="118025"/>
                        </a:cubicBezTo>
                        <a:cubicBezTo>
                          <a:pt x="862700" y="130782"/>
                          <a:pt x="887054" y="172857"/>
                          <a:pt x="900012" y="218397"/>
                        </a:cubicBezTo>
                        <a:cubicBezTo>
                          <a:pt x="911392" y="254804"/>
                          <a:pt x="905949" y="287720"/>
                          <a:pt x="896496" y="327236"/>
                        </a:cubicBezTo>
                        <a:cubicBezTo>
                          <a:pt x="935652" y="374908"/>
                          <a:pt x="941457" y="444601"/>
                          <a:pt x="922179" y="493649"/>
                        </a:cubicBezTo>
                        <a:cubicBezTo>
                          <a:pt x="917821" y="580107"/>
                          <a:pt x="864011" y="637252"/>
                          <a:pt x="801869" y="639318"/>
                        </a:cubicBezTo>
                        <a:cubicBezTo>
                          <a:pt x="807488" y="693136"/>
                          <a:pt x="780739" y="725942"/>
                          <a:pt x="758799" y="764137"/>
                        </a:cubicBezTo>
                        <a:cubicBezTo>
                          <a:pt x="716295" y="813096"/>
                          <a:pt x="670149" y="820532"/>
                          <a:pt x="612163" y="779250"/>
                        </a:cubicBezTo>
                        <a:cubicBezTo>
                          <a:pt x="603395" y="839019"/>
                          <a:pt x="553129" y="888687"/>
                          <a:pt x="507374" y="912410"/>
                        </a:cubicBezTo>
                        <a:cubicBezTo>
                          <a:pt x="436158" y="937157"/>
                          <a:pt x="387522" y="907165"/>
                          <a:pt x="353299" y="831130"/>
                        </a:cubicBezTo>
                        <a:cubicBezTo>
                          <a:pt x="260389" y="880211"/>
                          <a:pt x="191762" y="836405"/>
                          <a:pt x="124426" y="750824"/>
                        </a:cubicBezTo>
                        <a:cubicBezTo>
                          <a:pt x="88896" y="769993"/>
                          <a:pt x="52190" y="722855"/>
                          <a:pt x="23796" y="661458"/>
                        </a:cubicBezTo>
                        <a:cubicBezTo>
                          <a:pt x="5689" y="622220"/>
                          <a:pt x="22538" y="566743"/>
                          <a:pt x="45298" y="540829"/>
                        </a:cubicBezTo>
                        <a:cubicBezTo>
                          <a:pt x="14203" y="506065"/>
                          <a:pt x="-2065" y="459478"/>
                          <a:pt x="-108" y="417068"/>
                        </a:cubicBezTo>
                        <a:cubicBezTo>
                          <a:pt x="3361" y="358891"/>
                          <a:pt x="45535" y="303762"/>
                          <a:pt x="82815" y="307064"/>
                        </a:cubicBezTo>
                        <a:cubicBezTo>
                          <a:pt x="83174" y="306011"/>
                          <a:pt x="83501" y="305126"/>
                          <a:pt x="83608" y="304165"/>
                        </a:cubicBezTo>
                        <a:close/>
                      </a:path>
                      <a:path w="926124" h="914400" fill="none" extrusionOk="0">
                        <a:moveTo>
                          <a:pt x="100608" y="554079"/>
                        </a:moveTo>
                        <a:cubicBezTo>
                          <a:pt x="82473" y="554508"/>
                          <a:pt x="64241" y="548588"/>
                          <a:pt x="46306" y="537210"/>
                        </a:cubicBezTo>
                        <a:moveTo>
                          <a:pt x="148522" y="738695"/>
                        </a:moveTo>
                        <a:cubicBezTo>
                          <a:pt x="142839" y="741453"/>
                          <a:pt x="134619" y="744048"/>
                          <a:pt x="124769" y="746760"/>
                        </a:cubicBezTo>
                        <a:moveTo>
                          <a:pt x="353256" y="827405"/>
                        </a:moveTo>
                        <a:cubicBezTo>
                          <a:pt x="348060" y="818827"/>
                          <a:pt x="343509" y="802778"/>
                          <a:pt x="338935" y="790575"/>
                        </a:cubicBezTo>
                        <a:moveTo>
                          <a:pt x="617994" y="735562"/>
                        </a:moveTo>
                        <a:cubicBezTo>
                          <a:pt x="620346" y="749453"/>
                          <a:pt x="615005" y="760028"/>
                          <a:pt x="612270" y="775970"/>
                        </a:cubicBezTo>
                        <a:moveTo>
                          <a:pt x="731659" y="485859"/>
                        </a:moveTo>
                        <a:cubicBezTo>
                          <a:pt x="767886" y="514709"/>
                          <a:pt x="810093" y="582907"/>
                          <a:pt x="801354" y="636905"/>
                        </a:cubicBezTo>
                        <a:moveTo>
                          <a:pt x="896067" y="324993"/>
                        </a:moveTo>
                        <a:cubicBezTo>
                          <a:pt x="887796" y="350013"/>
                          <a:pt x="882311" y="364882"/>
                          <a:pt x="865025" y="381635"/>
                        </a:cubicBezTo>
                        <a:moveTo>
                          <a:pt x="821592" y="114850"/>
                        </a:moveTo>
                        <a:cubicBezTo>
                          <a:pt x="822863" y="123456"/>
                          <a:pt x="825677" y="133667"/>
                          <a:pt x="823221" y="141605"/>
                        </a:cubicBezTo>
                        <a:moveTo>
                          <a:pt x="623375" y="83650"/>
                        </a:moveTo>
                        <a:cubicBezTo>
                          <a:pt x="628665" y="69366"/>
                          <a:pt x="635344" y="58957"/>
                          <a:pt x="639282" y="49530"/>
                        </a:cubicBezTo>
                        <a:moveTo>
                          <a:pt x="474659" y="99906"/>
                        </a:moveTo>
                        <a:cubicBezTo>
                          <a:pt x="478201" y="90042"/>
                          <a:pt x="479087" y="82159"/>
                          <a:pt x="482356" y="70485"/>
                        </a:cubicBezTo>
                        <a:moveTo>
                          <a:pt x="300132" y="109897"/>
                        </a:moveTo>
                        <a:cubicBezTo>
                          <a:pt x="309763" y="117673"/>
                          <a:pt x="321642" y="127309"/>
                          <a:pt x="328002" y="138430"/>
                        </a:cubicBezTo>
                        <a:moveTo>
                          <a:pt x="88474" y="334200"/>
                        </a:moveTo>
                        <a:cubicBezTo>
                          <a:pt x="86238" y="323175"/>
                          <a:pt x="85815" y="313492"/>
                          <a:pt x="83608" y="304165"/>
                        </a:cubicBezTo>
                      </a:path>
                      <a:path w="926124" h="914400" stroke="0" extrusionOk="0">
                        <a:moveTo>
                          <a:pt x="83608" y="304165"/>
                        </a:moveTo>
                        <a:cubicBezTo>
                          <a:pt x="66932" y="240037"/>
                          <a:pt x="81174" y="192645"/>
                          <a:pt x="120546" y="146198"/>
                        </a:cubicBezTo>
                        <a:cubicBezTo>
                          <a:pt x="186588" y="83058"/>
                          <a:pt x="232151" y="64156"/>
                          <a:pt x="300239" y="110109"/>
                        </a:cubicBezTo>
                        <a:cubicBezTo>
                          <a:pt x="323746" y="31309"/>
                          <a:pt x="422981" y="22222"/>
                          <a:pt x="481412" y="72644"/>
                        </a:cubicBezTo>
                        <a:cubicBezTo>
                          <a:pt x="490727" y="33201"/>
                          <a:pt x="522797" y="10631"/>
                          <a:pt x="552008" y="4233"/>
                        </a:cubicBezTo>
                        <a:cubicBezTo>
                          <a:pt x="590055" y="-1623"/>
                          <a:pt x="623701" y="6671"/>
                          <a:pt x="639561" y="52514"/>
                        </a:cubicBezTo>
                        <a:cubicBezTo>
                          <a:pt x="667761" y="5433"/>
                          <a:pt x="714039" y="-5823"/>
                          <a:pt x="760257" y="14605"/>
                        </a:cubicBezTo>
                        <a:cubicBezTo>
                          <a:pt x="791039" y="21051"/>
                          <a:pt x="813129" y="74968"/>
                          <a:pt x="821463" y="118025"/>
                        </a:cubicBezTo>
                        <a:cubicBezTo>
                          <a:pt x="860627" y="132800"/>
                          <a:pt x="890405" y="169868"/>
                          <a:pt x="900012" y="218397"/>
                        </a:cubicBezTo>
                        <a:cubicBezTo>
                          <a:pt x="905376" y="253498"/>
                          <a:pt x="914442" y="298438"/>
                          <a:pt x="896496" y="327236"/>
                        </a:cubicBezTo>
                        <a:cubicBezTo>
                          <a:pt x="927721" y="380763"/>
                          <a:pt x="934588" y="452437"/>
                          <a:pt x="922179" y="493649"/>
                        </a:cubicBezTo>
                        <a:cubicBezTo>
                          <a:pt x="911761" y="576604"/>
                          <a:pt x="871426" y="641770"/>
                          <a:pt x="801869" y="639318"/>
                        </a:cubicBezTo>
                        <a:cubicBezTo>
                          <a:pt x="804649" y="684623"/>
                          <a:pt x="788286" y="721477"/>
                          <a:pt x="758799" y="764137"/>
                        </a:cubicBezTo>
                        <a:cubicBezTo>
                          <a:pt x="706752" y="813532"/>
                          <a:pt x="644367" y="808290"/>
                          <a:pt x="612163" y="779250"/>
                        </a:cubicBezTo>
                        <a:cubicBezTo>
                          <a:pt x="595019" y="845407"/>
                          <a:pt x="554883" y="891194"/>
                          <a:pt x="507374" y="912410"/>
                        </a:cubicBezTo>
                        <a:cubicBezTo>
                          <a:pt x="449816" y="913121"/>
                          <a:pt x="380720" y="902665"/>
                          <a:pt x="353299" y="831130"/>
                        </a:cubicBezTo>
                        <a:cubicBezTo>
                          <a:pt x="266890" y="907926"/>
                          <a:pt x="175732" y="863187"/>
                          <a:pt x="124426" y="750824"/>
                        </a:cubicBezTo>
                        <a:cubicBezTo>
                          <a:pt x="78787" y="765544"/>
                          <a:pt x="37828" y="719416"/>
                          <a:pt x="23796" y="661458"/>
                        </a:cubicBezTo>
                        <a:cubicBezTo>
                          <a:pt x="13604" y="620487"/>
                          <a:pt x="18510" y="573354"/>
                          <a:pt x="45298" y="540829"/>
                        </a:cubicBezTo>
                        <a:cubicBezTo>
                          <a:pt x="16289" y="521471"/>
                          <a:pt x="-7050" y="468182"/>
                          <a:pt x="-108" y="417068"/>
                        </a:cubicBezTo>
                        <a:cubicBezTo>
                          <a:pt x="7028" y="347859"/>
                          <a:pt x="33266" y="312720"/>
                          <a:pt x="82815" y="307064"/>
                        </a:cubicBezTo>
                        <a:cubicBezTo>
                          <a:pt x="83208" y="306208"/>
                          <a:pt x="83291" y="305318"/>
                          <a:pt x="83608" y="304165"/>
                        </a:cubicBezTo>
                        <a:close/>
                      </a:path>
                      <a:path w="926124" h="914400" fill="none" stroke="0" extrusionOk="0">
                        <a:moveTo>
                          <a:pt x="100608" y="554079"/>
                        </a:moveTo>
                        <a:cubicBezTo>
                          <a:pt x="82651" y="552223"/>
                          <a:pt x="64096" y="544965"/>
                          <a:pt x="46306" y="537210"/>
                        </a:cubicBezTo>
                        <a:moveTo>
                          <a:pt x="148522" y="738695"/>
                        </a:moveTo>
                        <a:cubicBezTo>
                          <a:pt x="140461" y="745022"/>
                          <a:pt x="132318" y="744850"/>
                          <a:pt x="124769" y="746760"/>
                        </a:cubicBezTo>
                        <a:moveTo>
                          <a:pt x="353256" y="827405"/>
                        </a:moveTo>
                        <a:cubicBezTo>
                          <a:pt x="348714" y="816800"/>
                          <a:pt x="342097" y="803684"/>
                          <a:pt x="338935" y="790575"/>
                        </a:cubicBezTo>
                        <a:moveTo>
                          <a:pt x="617994" y="735562"/>
                        </a:moveTo>
                        <a:cubicBezTo>
                          <a:pt x="615161" y="749958"/>
                          <a:pt x="615206" y="761646"/>
                          <a:pt x="612270" y="775970"/>
                        </a:cubicBezTo>
                        <a:moveTo>
                          <a:pt x="731659" y="485859"/>
                        </a:moveTo>
                        <a:cubicBezTo>
                          <a:pt x="757104" y="520467"/>
                          <a:pt x="800960" y="584526"/>
                          <a:pt x="801354" y="636905"/>
                        </a:cubicBezTo>
                        <a:moveTo>
                          <a:pt x="896067" y="324993"/>
                        </a:moveTo>
                        <a:cubicBezTo>
                          <a:pt x="887389" y="345337"/>
                          <a:pt x="880596" y="366416"/>
                          <a:pt x="865025" y="381635"/>
                        </a:cubicBezTo>
                        <a:moveTo>
                          <a:pt x="821592" y="114850"/>
                        </a:moveTo>
                        <a:cubicBezTo>
                          <a:pt x="820128" y="123423"/>
                          <a:pt x="822589" y="132954"/>
                          <a:pt x="823221" y="141605"/>
                        </a:cubicBezTo>
                        <a:moveTo>
                          <a:pt x="623375" y="83650"/>
                        </a:moveTo>
                        <a:cubicBezTo>
                          <a:pt x="626548" y="70286"/>
                          <a:pt x="632875" y="58419"/>
                          <a:pt x="639282" y="49530"/>
                        </a:cubicBezTo>
                        <a:moveTo>
                          <a:pt x="474659" y="99906"/>
                        </a:moveTo>
                        <a:cubicBezTo>
                          <a:pt x="476015" y="90132"/>
                          <a:pt x="478087" y="81859"/>
                          <a:pt x="482356" y="70485"/>
                        </a:cubicBezTo>
                        <a:moveTo>
                          <a:pt x="300132" y="109897"/>
                        </a:moveTo>
                        <a:cubicBezTo>
                          <a:pt x="308469" y="118284"/>
                          <a:pt x="320059" y="128707"/>
                          <a:pt x="328002" y="138430"/>
                        </a:cubicBezTo>
                        <a:moveTo>
                          <a:pt x="88474" y="334200"/>
                        </a:moveTo>
                        <a:cubicBezTo>
                          <a:pt x="84869" y="324137"/>
                          <a:pt x="84568" y="312557"/>
                          <a:pt x="83608" y="304165"/>
                        </a:cubicBezTo>
                      </a:path>
                    </a:pathLst>
                  </a:custGeom>
                  <ask:type>
                    <ask:lineSketchNone/>
                  </ask:type>
                </ask:lineSketchStyleProps>
              </a:ext>
            </a:extLst>
          </a:ln>
          <a:effectLst>
            <a:glow rad="704318">
              <a:srgbClr val="00B050">
                <a:alpha val="45846"/>
              </a:srgbClr>
            </a:glow>
          </a:effectLst>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5" name="Arc 54">
            <a:extLst>
              <a:ext uri="{FF2B5EF4-FFF2-40B4-BE49-F238E27FC236}">
                <a16:creationId xmlns:a16="http://schemas.microsoft.com/office/drawing/2014/main" id="{AC6A2E89-26C6-09EC-4073-CC81DF90788D}"/>
              </a:ext>
            </a:extLst>
          </p:cNvPr>
          <p:cNvSpPr/>
          <p:nvPr/>
        </p:nvSpPr>
        <p:spPr>
          <a:xfrm rot="8998612">
            <a:off x="11015341" y="2477550"/>
            <a:ext cx="582065" cy="932225"/>
          </a:xfrm>
          <a:prstGeom prst="arc">
            <a:avLst>
              <a:gd name="adj1" fmla="val 16200000"/>
              <a:gd name="adj2" fmla="val 3448526"/>
            </a:avLst>
          </a:prstGeom>
          <a:ln w="152400">
            <a:solidFill>
              <a:schemeClr val="accent2">
                <a:lumMod val="7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57" name="Nuage 56">
            <a:extLst>
              <a:ext uri="{FF2B5EF4-FFF2-40B4-BE49-F238E27FC236}">
                <a16:creationId xmlns:a16="http://schemas.microsoft.com/office/drawing/2014/main" id="{394A524F-67F8-A8C4-719A-F1227A99AF95}"/>
              </a:ext>
            </a:extLst>
          </p:cNvPr>
          <p:cNvSpPr/>
          <p:nvPr/>
        </p:nvSpPr>
        <p:spPr>
          <a:xfrm>
            <a:off x="10703534" y="2358603"/>
            <a:ext cx="524563" cy="453616"/>
          </a:xfrm>
          <a:prstGeom prst="cloud">
            <a:avLst/>
          </a:prstGeom>
          <a:solidFill>
            <a:srgbClr val="FF0000"/>
          </a:solidFill>
          <a:ln>
            <a:noFill/>
            <a:extLst>
              <a:ext uri="{C807C97D-BFC1-408E-A445-0C87EB9F89A2}">
                <ask:lineSketchStyleProps xmlns:ask="http://schemas.microsoft.com/office/drawing/2018/sketchyshapes" sd="1219033472">
                  <a:custGeom>
                    <a:avLst/>
                    <a:gdLst>
                      <a:gd name="connsiteX0" fmla="*/ 83608 w 926124"/>
                      <a:gd name="connsiteY0" fmla="*/ 304165 h 914400"/>
                      <a:gd name="connsiteX1" fmla="*/ 120546 w 926124"/>
                      <a:gd name="connsiteY1" fmla="*/ 146198 h 914400"/>
                      <a:gd name="connsiteX2" fmla="*/ 300239 w 926124"/>
                      <a:gd name="connsiteY2" fmla="*/ 110109 h 914400"/>
                      <a:gd name="connsiteX3" fmla="*/ 481412 w 926124"/>
                      <a:gd name="connsiteY3" fmla="*/ 72644 h 914400"/>
                      <a:gd name="connsiteX4" fmla="*/ 552008 w 926124"/>
                      <a:gd name="connsiteY4" fmla="*/ 4233 h 914400"/>
                      <a:gd name="connsiteX5" fmla="*/ 639561 w 926124"/>
                      <a:gd name="connsiteY5" fmla="*/ 52514 h 914400"/>
                      <a:gd name="connsiteX6" fmla="*/ 760257 w 926124"/>
                      <a:gd name="connsiteY6" fmla="*/ 14605 h 914400"/>
                      <a:gd name="connsiteX7" fmla="*/ 821463 w 926124"/>
                      <a:gd name="connsiteY7" fmla="*/ 118025 h 914400"/>
                      <a:gd name="connsiteX8" fmla="*/ 900012 w 926124"/>
                      <a:gd name="connsiteY8" fmla="*/ 218397 h 914400"/>
                      <a:gd name="connsiteX9" fmla="*/ 896496 w 926124"/>
                      <a:gd name="connsiteY9" fmla="*/ 327236 h 914400"/>
                      <a:gd name="connsiteX10" fmla="*/ 922179 w 926124"/>
                      <a:gd name="connsiteY10" fmla="*/ 493649 h 914400"/>
                      <a:gd name="connsiteX11" fmla="*/ 801869 w 926124"/>
                      <a:gd name="connsiteY11" fmla="*/ 639318 h 914400"/>
                      <a:gd name="connsiteX12" fmla="*/ 758799 w 926124"/>
                      <a:gd name="connsiteY12" fmla="*/ 764137 h 914400"/>
                      <a:gd name="connsiteX13" fmla="*/ 612163 w 926124"/>
                      <a:gd name="connsiteY13" fmla="*/ 779250 h 914400"/>
                      <a:gd name="connsiteX14" fmla="*/ 507374 w 926124"/>
                      <a:gd name="connsiteY14" fmla="*/ 912410 h 914400"/>
                      <a:gd name="connsiteX15" fmla="*/ 353299 w 926124"/>
                      <a:gd name="connsiteY15" fmla="*/ 831130 h 914400"/>
                      <a:gd name="connsiteX16" fmla="*/ 124426 w 926124"/>
                      <a:gd name="connsiteY16" fmla="*/ 750824 h 914400"/>
                      <a:gd name="connsiteX17" fmla="*/ 23796 w 926124"/>
                      <a:gd name="connsiteY17" fmla="*/ 661458 h 914400"/>
                      <a:gd name="connsiteX18" fmla="*/ 45298 w 926124"/>
                      <a:gd name="connsiteY18" fmla="*/ 540829 h 914400"/>
                      <a:gd name="connsiteX19" fmla="*/ -108 w 926124"/>
                      <a:gd name="connsiteY19" fmla="*/ 417068 h 914400"/>
                      <a:gd name="connsiteX20" fmla="*/ 82815 w 926124"/>
                      <a:gd name="connsiteY20" fmla="*/ 307064 h 914400"/>
                      <a:gd name="connsiteX21" fmla="*/ 83608 w 926124"/>
                      <a:gd name="connsiteY21" fmla="*/ 304165 h 914400"/>
                      <a:gd name="connsiteX0" fmla="*/ 100608 w 926124"/>
                      <a:gd name="connsiteY0" fmla="*/ 554079 h 914400"/>
                      <a:gd name="connsiteX1" fmla="*/ 46306 w 926124"/>
                      <a:gd name="connsiteY1" fmla="*/ 537210 h 914400"/>
                      <a:gd name="connsiteX2" fmla="*/ 148522 w 926124"/>
                      <a:gd name="connsiteY2" fmla="*/ 738695 h 914400"/>
                      <a:gd name="connsiteX3" fmla="*/ 124769 w 926124"/>
                      <a:gd name="connsiteY3" fmla="*/ 746760 h 914400"/>
                      <a:gd name="connsiteX4" fmla="*/ 353256 w 926124"/>
                      <a:gd name="connsiteY4" fmla="*/ 827405 h 914400"/>
                      <a:gd name="connsiteX5" fmla="*/ 338935 w 926124"/>
                      <a:gd name="connsiteY5" fmla="*/ 790575 h 914400"/>
                      <a:gd name="connsiteX6" fmla="*/ 617994 w 926124"/>
                      <a:gd name="connsiteY6" fmla="*/ 735562 h 914400"/>
                      <a:gd name="connsiteX7" fmla="*/ 612270 w 926124"/>
                      <a:gd name="connsiteY7" fmla="*/ 775970 h 914400"/>
                      <a:gd name="connsiteX8" fmla="*/ 731659 w 926124"/>
                      <a:gd name="connsiteY8" fmla="*/ 485859 h 914400"/>
                      <a:gd name="connsiteX9" fmla="*/ 801354 w 926124"/>
                      <a:gd name="connsiteY9" fmla="*/ 636905 h 914400"/>
                      <a:gd name="connsiteX10" fmla="*/ 896067 w 926124"/>
                      <a:gd name="connsiteY10" fmla="*/ 324993 h 914400"/>
                      <a:gd name="connsiteX11" fmla="*/ 865025 w 926124"/>
                      <a:gd name="connsiteY11" fmla="*/ 381635 h 914400"/>
                      <a:gd name="connsiteX12" fmla="*/ 821592 w 926124"/>
                      <a:gd name="connsiteY12" fmla="*/ 114850 h 914400"/>
                      <a:gd name="connsiteX13" fmla="*/ 823221 w 926124"/>
                      <a:gd name="connsiteY13" fmla="*/ 141605 h 914400"/>
                      <a:gd name="connsiteX14" fmla="*/ 623375 w 926124"/>
                      <a:gd name="connsiteY14" fmla="*/ 83650 h 914400"/>
                      <a:gd name="connsiteX15" fmla="*/ 639282 w 926124"/>
                      <a:gd name="connsiteY15" fmla="*/ 49530 h 914400"/>
                      <a:gd name="connsiteX16" fmla="*/ 474659 w 926124"/>
                      <a:gd name="connsiteY16" fmla="*/ 99906 h 914400"/>
                      <a:gd name="connsiteX17" fmla="*/ 482356 w 926124"/>
                      <a:gd name="connsiteY17" fmla="*/ 70485 h 914400"/>
                      <a:gd name="connsiteX18" fmla="*/ 300132 w 926124"/>
                      <a:gd name="connsiteY18" fmla="*/ 109897 h 914400"/>
                      <a:gd name="connsiteX19" fmla="*/ 328002 w 926124"/>
                      <a:gd name="connsiteY19" fmla="*/ 138430 h 914400"/>
                      <a:gd name="connsiteX20" fmla="*/ 88474 w 926124"/>
                      <a:gd name="connsiteY20" fmla="*/ 334200 h 914400"/>
                      <a:gd name="connsiteX21" fmla="*/ 83608 w 926124"/>
                      <a:gd name="connsiteY21" fmla="*/ 304165 h 9144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926124" h="914400" fill="none" extrusionOk="0">
                        <a:moveTo>
                          <a:pt x="83608" y="304165"/>
                        </a:moveTo>
                        <a:cubicBezTo>
                          <a:pt x="71337" y="259709"/>
                          <a:pt x="89078" y="185816"/>
                          <a:pt x="120546" y="146198"/>
                        </a:cubicBezTo>
                        <a:cubicBezTo>
                          <a:pt x="180294" y="83133"/>
                          <a:pt x="240544" y="44472"/>
                          <a:pt x="300239" y="110109"/>
                        </a:cubicBezTo>
                        <a:cubicBezTo>
                          <a:pt x="343738" y="24049"/>
                          <a:pt x="411423" y="3865"/>
                          <a:pt x="481412" y="72644"/>
                        </a:cubicBezTo>
                        <a:cubicBezTo>
                          <a:pt x="494012" y="39184"/>
                          <a:pt x="519547" y="3742"/>
                          <a:pt x="552008" y="4233"/>
                        </a:cubicBezTo>
                        <a:cubicBezTo>
                          <a:pt x="591139" y="-6367"/>
                          <a:pt x="621071" y="12742"/>
                          <a:pt x="639561" y="52514"/>
                        </a:cubicBezTo>
                        <a:cubicBezTo>
                          <a:pt x="661000" y="2512"/>
                          <a:pt x="727085" y="-18478"/>
                          <a:pt x="760257" y="14605"/>
                        </a:cubicBezTo>
                        <a:cubicBezTo>
                          <a:pt x="781805" y="39036"/>
                          <a:pt x="816997" y="76594"/>
                          <a:pt x="821463" y="118025"/>
                        </a:cubicBezTo>
                        <a:cubicBezTo>
                          <a:pt x="862700" y="130782"/>
                          <a:pt x="887054" y="172857"/>
                          <a:pt x="900012" y="218397"/>
                        </a:cubicBezTo>
                        <a:cubicBezTo>
                          <a:pt x="911392" y="254804"/>
                          <a:pt x="905949" y="287720"/>
                          <a:pt x="896496" y="327236"/>
                        </a:cubicBezTo>
                        <a:cubicBezTo>
                          <a:pt x="935652" y="374908"/>
                          <a:pt x="941457" y="444601"/>
                          <a:pt x="922179" y="493649"/>
                        </a:cubicBezTo>
                        <a:cubicBezTo>
                          <a:pt x="917821" y="580107"/>
                          <a:pt x="864011" y="637252"/>
                          <a:pt x="801869" y="639318"/>
                        </a:cubicBezTo>
                        <a:cubicBezTo>
                          <a:pt x="807488" y="693136"/>
                          <a:pt x="780739" y="725942"/>
                          <a:pt x="758799" y="764137"/>
                        </a:cubicBezTo>
                        <a:cubicBezTo>
                          <a:pt x="716295" y="813096"/>
                          <a:pt x="670149" y="820532"/>
                          <a:pt x="612163" y="779250"/>
                        </a:cubicBezTo>
                        <a:cubicBezTo>
                          <a:pt x="603395" y="839019"/>
                          <a:pt x="553129" y="888687"/>
                          <a:pt x="507374" y="912410"/>
                        </a:cubicBezTo>
                        <a:cubicBezTo>
                          <a:pt x="436158" y="937157"/>
                          <a:pt x="387522" y="907165"/>
                          <a:pt x="353299" y="831130"/>
                        </a:cubicBezTo>
                        <a:cubicBezTo>
                          <a:pt x="260389" y="880211"/>
                          <a:pt x="191762" y="836405"/>
                          <a:pt x="124426" y="750824"/>
                        </a:cubicBezTo>
                        <a:cubicBezTo>
                          <a:pt x="88896" y="769993"/>
                          <a:pt x="52190" y="722855"/>
                          <a:pt x="23796" y="661458"/>
                        </a:cubicBezTo>
                        <a:cubicBezTo>
                          <a:pt x="5689" y="622220"/>
                          <a:pt x="22538" y="566743"/>
                          <a:pt x="45298" y="540829"/>
                        </a:cubicBezTo>
                        <a:cubicBezTo>
                          <a:pt x="14203" y="506065"/>
                          <a:pt x="-2065" y="459478"/>
                          <a:pt x="-108" y="417068"/>
                        </a:cubicBezTo>
                        <a:cubicBezTo>
                          <a:pt x="3361" y="358891"/>
                          <a:pt x="45535" y="303762"/>
                          <a:pt x="82815" y="307064"/>
                        </a:cubicBezTo>
                        <a:cubicBezTo>
                          <a:pt x="83174" y="306011"/>
                          <a:pt x="83501" y="305126"/>
                          <a:pt x="83608" y="304165"/>
                        </a:cubicBezTo>
                        <a:close/>
                      </a:path>
                      <a:path w="926124" h="914400" fill="none" extrusionOk="0">
                        <a:moveTo>
                          <a:pt x="100608" y="554079"/>
                        </a:moveTo>
                        <a:cubicBezTo>
                          <a:pt x="82473" y="554508"/>
                          <a:pt x="64241" y="548588"/>
                          <a:pt x="46306" y="537210"/>
                        </a:cubicBezTo>
                        <a:moveTo>
                          <a:pt x="148522" y="738695"/>
                        </a:moveTo>
                        <a:cubicBezTo>
                          <a:pt x="142839" y="741453"/>
                          <a:pt x="134619" y="744048"/>
                          <a:pt x="124769" y="746760"/>
                        </a:cubicBezTo>
                        <a:moveTo>
                          <a:pt x="353256" y="827405"/>
                        </a:moveTo>
                        <a:cubicBezTo>
                          <a:pt x="348060" y="818827"/>
                          <a:pt x="343509" y="802778"/>
                          <a:pt x="338935" y="790575"/>
                        </a:cubicBezTo>
                        <a:moveTo>
                          <a:pt x="617994" y="735562"/>
                        </a:moveTo>
                        <a:cubicBezTo>
                          <a:pt x="620346" y="749453"/>
                          <a:pt x="615005" y="760028"/>
                          <a:pt x="612270" y="775970"/>
                        </a:cubicBezTo>
                        <a:moveTo>
                          <a:pt x="731659" y="485859"/>
                        </a:moveTo>
                        <a:cubicBezTo>
                          <a:pt x="767886" y="514709"/>
                          <a:pt x="810093" y="582907"/>
                          <a:pt x="801354" y="636905"/>
                        </a:cubicBezTo>
                        <a:moveTo>
                          <a:pt x="896067" y="324993"/>
                        </a:moveTo>
                        <a:cubicBezTo>
                          <a:pt x="887796" y="350013"/>
                          <a:pt x="882311" y="364882"/>
                          <a:pt x="865025" y="381635"/>
                        </a:cubicBezTo>
                        <a:moveTo>
                          <a:pt x="821592" y="114850"/>
                        </a:moveTo>
                        <a:cubicBezTo>
                          <a:pt x="822863" y="123456"/>
                          <a:pt x="825677" y="133667"/>
                          <a:pt x="823221" y="141605"/>
                        </a:cubicBezTo>
                        <a:moveTo>
                          <a:pt x="623375" y="83650"/>
                        </a:moveTo>
                        <a:cubicBezTo>
                          <a:pt x="628665" y="69366"/>
                          <a:pt x="635344" y="58957"/>
                          <a:pt x="639282" y="49530"/>
                        </a:cubicBezTo>
                        <a:moveTo>
                          <a:pt x="474659" y="99906"/>
                        </a:moveTo>
                        <a:cubicBezTo>
                          <a:pt x="478201" y="90042"/>
                          <a:pt x="479087" y="82159"/>
                          <a:pt x="482356" y="70485"/>
                        </a:cubicBezTo>
                        <a:moveTo>
                          <a:pt x="300132" y="109897"/>
                        </a:moveTo>
                        <a:cubicBezTo>
                          <a:pt x="309763" y="117673"/>
                          <a:pt x="321642" y="127309"/>
                          <a:pt x="328002" y="138430"/>
                        </a:cubicBezTo>
                        <a:moveTo>
                          <a:pt x="88474" y="334200"/>
                        </a:moveTo>
                        <a:cubicBezTo>
                          <a:pt x="86238" y="323175"/>
                          <a:pt x="85815" y="313492"/>
                          <a:pt x="83608" y="304165"/>
                        </a:cubicBezTo>
                      </a:path>
                      <a:path w="926124" h="914400" stroke="0" extrusionOk="0">
                        <a:moveTo>
                          <a:pt x="83608" y="304165"/>
                        </a:moveTo>
                        <a:cubicBezTo>
                          <a:pt x="66932" y="240037"/>
                          <a:pt x="81174" y="192645"/>
                          <a:pt x="120546" y="146198"/>
                        </a:cubicBezTo>
                        <a:cubicBezTo>
                          <a:pt x="186588" y="83058"/>
                          <a:pt x="232151" y="64156"/>
                          <a:pt x="300239" y="110109"/>
                        </a:cubicBezTo>
                        <a:cubicBezTo>
                          <a:pt x="323746" y="31309"/>
                          <a:pt x="422981" y="22222"/>
                          <a:pt x="481412" y="72644"/>
                        </a:cubicBezTo>
                        <a:cubicBezTo>
                          <a:pt x="490727" y="33201"/>
                          <a:pt x="522797" y="10631"/>
                          <a:pt x="552008" y="4233"/>
                        </a:cubicBezTo>
                        <a:cubicBezTo>
                          <a:pt x="590055" y="-1623"/>
                          <a:pt x="623701" y="6671"/>
                          <a:pt x="639561" y="52514"/>
                        </a:cubicBezTo>
                        <a:cubicBezTo>
                          <a:pt x="667761" y="5433"/>
                          <a:pt x="714039" y="-5823"/>
                          <a:pt x="760257" y="14605"/>
                        </a:cubicBezTo>
                        <a:cubicBezTo>
                          <a:pt x="791039" y="21051"/>
                          <a:pt x="813129" y="74968"/>
                          <a:pt x="821463" y="118025"/>
                        </a:cubicBezTo>
                        <a:cubicBezTo>
                          <a:pt x="860627" y="132800"/>
                          <a:pt x="890405" y="169868"/>
                          <a:pt x="900012" y="218397"/>
                        </a:cubicBezTo>
                        <a:cubicBezTo>
                          <a:pt x="905376" y="253498"/>
                          <a:pt x="914442" y="298438"/>
                          <a:pt x="896496" y="327236"/>
                        </a:cubicBezTo>
                        <a:cubicBezTo>
                          <a:pt x="927721" y="380763"/>
                          <a:pt x="934588" y="452437"/>
                          <a:pt x="922179" y="493649"/>
                        </a:cubicBezTo>
                        <a:cubicBezTo>
                          <a:pt x="911761" y="576604"/>
                          <a:pt x="871426" y="641770"/>
                          <a:pt x="801869" y="639318"/>
                        </a:cubicBezTo>
                        <a:cubicBezTo>
                          <a:pt x="804649" y="684623"/>
                          <a:pt x="788286" y="721477"/>
                          <a:pt x="758799" y="764137"/>
                        </a:cubicBezTo>
                        <a:cubicBezTo>
                          <a:pt x="706752" y="813532"/>
                          <a:pt x="644367" y="808290"/>
                          <a:pt x="612163" y="779250"/>
                        </a:cubicBezTo>
                        <a:cubicBezTo>
                          <a:pt x="595019" y="845407"/>
                          <a:pt x="554883" y="891194"/>
                          <a:pt x="507374" y="912410"/>
                        </a:cubicBezTo>
                        <a:cubicBezTo>
                          <a:pt x="449816" y="913121"/>
                          <a:pt x="380720" y="902665"/>
                          <a:pt x="353299" y="831130"/>
                        </a:cubicBezTo>
                        <a:cubicBezTo>
                          <a:pt x="266890" y="907926"/>
                          <a:pt x="175732" y="863187"/>
                          <a:pt x="124426" y="750824"/>
                        </a:cubicBezTo>
                        <a:cubicBezTo>
                          <a:pt x="78787" y="765544"/>
                          <a:pt x="37828" y="719416"/>
                          <a:pt x="23796" y="661458"/>
                        </a:cubicBezTo>
                        <a:cubicBezTo>
                          <a:pt x="13604" y="620487"/>
                          <a:pt x="18510" y="573354"/>
                          <a:pt x="45298" y="540829"/>
                        </a:cubicBezTo>
                        <a:cubicBezTo>
                          <a:pt x="16289" y="521471"/>
                          <a:pt x="-7050" y="468182"/>
                          <a:pt x="-108" y="417068"/>
                        </a:cubicBezTo>
                        <a:cubicBezTo>
                          <a:pt x="7028" y="347859"/>
                          <a:pt x="33266" y="312720"/>
                          <a:pt x="82815" y="307064"/>
                        </a:cubicBezTo>
                        <a:cubicBezTo>
                          <a:pt x="83208" y="306208"/>
                          <a:pt x="83291" y="305318"/>
                          <a:pt x="83608" y="304165"/>
                        </a:cubicBezTo>
                        <a:close/>
                      </a:path>
                      <a:path w="926124" h="914400" fill="none" stroke="0" extrusionOk="0">
                        <a:moveTo>
                          <a:pt x="100608" y="554079"/>
                        </a:moveTo>
                        <a:cubicBezTo>
                          <a:pt x="82651" y="552223"/>
                          <a:pt x="64096" y="544965"/>
                          <a:pt x="46306" y="537210"/>
                        </a:cubicBezTo>
                        <a:moveTo>
                          <a:pt x="148522" y="738695"/>
                        </a:moveTo>
                        <a:cubicBezTo>
                          <a:pt x="140461" y="745022"/>
                          <a:pt x="132318" y="744850"/>
                          <a:pt x="124769" y="746760"/>
                        </a:cubicBezTo>
                        <a:moveTo>
                          <a:pt x="353256" y="827405"/>
                        </a:moveTo>
                        <a:cubicBezTo>
                          <a:pt x="348714" y="816800"/>
                          <a:pt x="342097" y="803684"/>
                          <a:pt x="338935" y="790575"/>
                        </a:cubicBezTo>
                        <a:moveTo>
                          <a:pt x="617994" y="735562"/>
                        </a:moveTo>
                        <a:cubicBezTo>
                          <a:pt x="615161" y="749958"/>
                          <a:pt x="615206" y="761646"/>
                          <a:pt x="612270" y="775970"/>
                        </a:cubicBezTo>
                        <a:moveTo>
                          <a:pt x="731659" y="485859"/>
                        </a:moveTo>
                        <a:cubicBezTo>
                          <a:pt x="757104" y="520467"/>
                          <a:pt x="800960" y="584526"/>
                          <a:pt x="801354" y="636905"/>
                        </a:cubicBezTo>
                        <a:moveTo>
                          <a:pt x="896067" y="324993"/>
                        </a:moveTo>
                        <a:cubicBezTo>
                          <a:pt x="887389" y="345337"/>
                          <a:pt x="880596" y="366416"/>
                          <a:pt x="865025" y="381635"/>
                        </a:cubicBezTo>
                        <a:moveTo>
                          <a:pt x="821592" y="114850"/>
                        </a:moveTo>
                        <a:cubicBezTo>
                          <a:pt x="820128" y="123423"/>
                          <a:pt x="822589" y="132954"/>
                          <a:pt x="823221" y="141605"/>
                        </a:cubicBezTo>
                        <a:moveTo>
                          <a:pt x="623375" y="83650"/>
                        </a:moveTo>
                        <a:cubicBezTo>
                          <a:pt x="626548" y="70286"/>
                          <a:pt x="632875" y="58419"/>
                          <a:pt x="639282" y="49530"/>
                        </a:cubicBezTo>
                        <a:moveTo>
                          <a:pt x="474659" y="99906"/>
                        </a:moveTo>
                        <a:cubicBezTo>
                          <a:pt x="476015" y="90132"/>
                          <a:pt x="478087" y="81859"/>
                          <a:pt x="482356" y="70485"/>
                        </a:cubicBezTo>
                        <a:moveTo>
                          <a:pt x="300132" y="109897"/>
                        </a:moveTo>
                        <a:cubicBezTo>
                          <a:pt x="308469" y="118284"/>
                          <a:pt x="320059" y="128707"/>
                          <a:pt x="328002" y="138430"/>
                        </a:cubicBezTo>
                        <a:moveTo>
                          <a:pt x="88474" y="334200"/>
                        </a:moveTo>
                        <a:cubicBezTo>
                          <a:pt x="84869" y="324137"/>
                          <a:pt x="84568" y="312557"/>
                          <a:pt x="83608" y="304165"/>
                        </a:cubicBezTo>
                      </a:path>
                    </a:pathLst>
                  </a:custGeom>
                  <ask:type>
                    <ask:lineSketchNone/>
                  </ask:type>
                </ask:lineSketchStyleProps>
              </a:ext>
            </a:extLst>
          </a:ln>
          <a:effectLst>
            <a:glow rad="704318">
              <a:srgbClr val="FF0000">
                <a:alpha val="46000"/>
              </a:srgbClr>
            </a:glow>
          </a:effectLst>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3" name="Forme en L 62">
            <a:extLst>
              <a:ext uri="{FF2B5EF4-FFF2-40B4-BE49-F238E27FC236}">
                <a16:creationId xmlns:a16="http://schemas.microsoft.com/office/drawing/2014/main" id="{7357FDE2-75BD-D30B-2938-49F1AAD9CE46}"/>
              </a:ext>
            </a:extLst>
          </p:cNvPr>
          <p:cNvSpPr>
            <a:spLocks noChangeAspect="1"/>
          </p:cNvSpPr>
          <p:nvPr/>
        </p:nvSpPr>
        <p:spPr>
          <a:xfrm rot="8107852">
            <a:off x="3929496" y="5624536"/>
            <a:ext cx="474973" cy="474973"/>
          </a:xfrm>
          <a:prstGeom prst="corner">
            <a:avLst>
              <a:gd name="adj1" fmla="val 35264"/>
              <a:gd name="adj2" fmla="val 37106"/>
            </a:avLst>
          </a:prstGeom>
          <a:solidFill>
            <a:schemeClr val="bg1">
              <a:lumMod val="65000"/>
            </a:schemeClr>
          </a:solidFill>
          <a:ln>
            <a:noFill/>
          </a:ln>
          <a:effectLst/>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24" name="ZoneTexte 1023">
            <a:extLst>
              <a:ext uri="{FF2B5EF4-FFF2-40B4-BE49-F238E27FC236}">
                <a16:creationId xmlns:a16="http://schemas.microsoft.com/office/drawing/2014/main" id="{735CEA03-7780-2D2D-4061-FE0C740C7A15}"/>
              </a:ext>
            </a:extLst>
          </p:cNvPr>
          <p:cNvSpPr txBox="1"/>
          <p:nvPr/>
        </p:nvSpPr>
        <p:spPr>
          <a:xfrm>
            <a:off x="4529544" y="5629433"/>
            <a:ext cx="1082349"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ntibody</a:t>
            </a:r>
          </a:p>
        </p:txBody>
      </p:sp>
      <p:sp>
        <p:nvSpPr>
          <p:cNvPr id="1025" name="Nuage 1024">
            <a:extLst>
              <a:ext uri="{FF2B5EF4-FFF2-40B4-BE49-F238E27FC236}">
                <a16:creationId xmlns:a16="http://schemas.microsoft.com/office/drawing/2014/main" id="{FE4ABF3E-24D2-BAA9-6DC3-8A5D9071D89F}"/>
              </a:ext>
            </a:extLst>
          </p:cNvPr>
          <p:cNvSpPr/>
          <p:nvPr/>
        </p:nvSpPr>
        <p:spPr>
          <a:xfrm>
            <a:off x="5828923" y="5636052"/>
            <a:ext cx="390669" cy="289245"/>
          </a:xfrm>
          <a:prstGeom prst="cloud">
            <a:avLst/>
          </a:prstGeom>
          <a:solidFill>
            <a:schemeClr val="bg1">
              <a:lumMod val="50000"/>
            </a:schemeClr>
          </a:solidFill>
          <a:ln>
            <a:noFill/>
            <a:extLst>
              <a:ext uri="{C807C97D-BFC1-408E-A445-0C87EB9F89A2}">
                <ask:lineSketchStyleProps xmlns:ask="http://schemas.microsoft.com/office/drawing/2018/sketchyshapes" sd="1219033472">
                  <a:custGeom>
                    <a:avLst/>
                    <a:gdLst>
                      <a:gd name="connsiteX0" fmla="*/ 83608 w 926124"/>
                      <a:gd name="connsiteY0" fmla="*/ 304165 h 914400"/>
                      <a:gd name="connsiteX1" fmla="*/ 120546 w 926124"/>
                      <a:gd name="connsiteY1" fmla="*/ 146198 h 914400"/>
                      <a:gd name="connsiteX2" fmla="*/ 300239 w 926124"/>
                      <a:gd name="connsiteY2" fmla="*/ 110109 h 914400"/>
                      <a:gd name="connsiteX3" fmla="*/ 481412 w 926124"/>
                      <a:gd name="connsiteY3" fmla="*/ 72644 h 914400"/>
                      <a:gd name="connsiteX4" fmla="*/ 552008 w 926124"/>
                      <a:gd name="connsiteY4" fmla="*/ 4233 h 914400"/>
                      <a:gd name="connsiteX5" fmla="*/ 639561 w 926124"/>
                      <a:gd name="connsiteY5" fmla="*/ 52514 h 914400"/>
                      <a:gd name="connsiteX6" fmla="*/ 760257 w 926124"/>
                      <a:gd name="connsiteY6" fmla="*/ 14605 h 914400"/>
                      <a:gd name="connsiteX7" fmla="*/ 821463 w 926124"/>
                      <a:gd name="connsiteY7" fmla="*/ 118025 h 914400"/>
                      <a:gd name="connsiteX8" fmla="*/ 900012 w 926124"/>
                      <a:gd name="connsiteY8" fmla="*/ 218397 h 914400"/>
                      <a:gd name="connsiteX9" fmla="*/ 896496 w 926124"/>
                      <a:gd name="connsiteY9" fmla="*/ 327236 h 914400"/>
                      <a:gd name="connsiteX10" fmla="*/ 922179 w 926124"/>
                      <a:gd name="connsiteY10" fmla="*/ 493649 h 914400"/>
                      <a:gd name="connsiteX11" fmla="*/ 801869 w 926124"/>
                      <a:gd name="connsiteY11" fmla="*/ 639318 h 914400"/>
                      <a:gd name="connsiteX12" fmla="*/ 758799 w 926124"/>
                      <a:gd name="connsiteY12" fmla="*/ 764137 h 914400"/>
                      <a:gd name="connsiteX13" fmla="*/ 612163 w 926124"/>
                      <a:gd name="connsiteY13" fmla="*/ 779250 h 914400"/>
                      <a:gd name="connsiteX14" fmla="*/ 507374 w 926124"/>
                      <a:gd name="connsiteY14" fmla="*/ 912410 h 914400"/>
                      <a:gd name="connsiteX15" fmla="*/ 353299 w 926124"/>
                      <a:gd name="connsiteY15" fmla="*/ 831130 h 914400"/>
                      <a:gd name="connsiteX16" fmla="*/ 124426 w 926124"/>
                      <a:gd name="connsiteY16" fmla="*/ 750824 h 914400"/>
                      <a:gd name="connsiteX17" fmla="*/ 23796 w 926124"/>
                      <a:gd name="connsiteY17" fmla="*/ 661458 h 914400"/>
                      <a:gd name="connsiteX18" fmla="*/ 45298 w 926124"/>
                      <a:gd name="connsiteY18" fmla="*/ 540829 h 914400"/>
                      <a:gd name="connsiteX19" fmla="*/ -108 w 926124"/>
                      <a:gd name="connsiteY19" fmla="*/ 417068 h 914400"/>
                      <a:gd name="connsiteX20" fmla="*/ 82815 w 926124"/>
                      <a:gd name="connsiteY20" fmla="*/ 307064 h 914400"/>
                      <a:gd name="connsiteX21" fmla="*/ 83608 w 926124"/>
                      <a:gd name="connsiteY21" fmla="*/ 304165 h 914400"/>
                      <a:gd name="connsiteX0" fmla="*/ 100608 w 926124"/>
                      <a:gd name="connsiteY0" fmla="*/ 554079 h 914400"/>
                      <a:gd name="connsiteX1" fmla="*/ 46306 w 926124"/>
                      <a:gd name="connsiteY1" fmla="*/ 537210 h 914400"/>
                      <a:gd name="connsiteX2" fmla="*/ 148522 w 926124"/>
                      <a:gd name="connsiteY2" fmla="*/ 738695 h 914400"/>
                      <a:gd name="connsiteX3" fmla="*/ 124769 w 926124"/>
                      <a:gd name="connsiteY3" fmla="*/ 746760 h 914400"/>
                      <a:gd name="connsiteX4" fmla="*/ 353256 w 926124"/>
                      <a:gd name="connsiteY4" fmla="*/ 827405 h 914400"/>
                      <a:gd name="connsiteX5" fmla="*/ 338935 w 926124"/>
                      <a:gd name="connsiteY5" fmla="*/ 790575 h 914400"/>
                      <a:gd name="connsiteX6" fmla="*/ 617994 w 926124"/>
                      <a:gd name="connsiteY6" fmla="*/ 735562 h 914400"/>
                      <a:gd name="connsiteX7" fmla="*/ 612270 w 926124"/>
                      <a:gd name="connsiteY7" fmla="*/ 775970 h 914400"/>
                      <a:gd name="connsiteX8" fmla="*/ 731659 w 926124"/>
                      <a:gd name="connsiteY8" fmla="*/ 485859 h 914400"/>
                      <a:gd name="connsiteX9" fmla="*/ 801354 w 926124"/>
                      <a:gd name="connsiteY9" fmla="*/ 636905 h 914400"/>
                      <a:gd name="connsiteX10" fmla="*/ 896067 w 926124"/>
                      <a:gd name="connsiteY10" fmla="*/ 324993 h 914400"/>
                      <a:gd name="connsiteX11" fmla="*/ 865025 w 926124"/>
                      <a:gd name="connsiteY11" fmla="*/ 381635 h 914400"/>
                      <a:gd name="connsiteX12" fmla="*/ 821592 w 926124"/>
                      <a:gd name="connsiteY12" fmla="*/ 114850 h 914400"/>
                      <a:gd name="connsiteX13" fmla="*/ 823221 w 926124"/>
                      <a:gd name="connsiteY13" fmla="*/ 141605 h 914400"/>
                      <a:gd name="connsiteX14" fmla="*/ 623375 w 926124"/>
                      <a:gd name="connsiteY14" fmla="*/ 83650 h 914400"/>
                      <a:gd name="connsiteX15" fmla="*/ 639282 w 926124"/>
                      <a:gd name="connsiteY15" fmla="*/ 49530 h 914400"/>
                      <a:gd name="connsiteX16" fmla="*/ 474659 w 926124"/>
                      <a:gd name="connsiteY16" fmla="*/ 99906 h 914400"/>
                      <a:gd name="connsiteX17" fmla="*/ 482356 w 926124"/>
                      <a:gd name="connsiteY17" fmla="*/ 70485 h 914400"/>
                      <a:gd name="connsiteX18" fmla="*/ 300132 w 926124"/>
                      <a:gd name="connsiteY18" fmla="*/ 109897 h 914400"/>
                      <a:gd name="connsiteX19" fmla="*/ 328002 w 926124"/>
                      <a:gd name="connsiteY19" fmla="*/ 138430 h 914400"/>
                      <a:gd name="connsiteX20" fmla="*/ 88474 w 926124"/>
                      <a:gd name="connsiteY20" fmla="*/ 334200 h 914400"/>
                      <a:gd name="connsiteX21" fmla="*/ 83608 w 926124"/>
                      <a:gd name="connsiteY21" fmla="*/ 304165 h 9144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926124" h="914400" fill="none" extrusionOk="0">
                        <a:moveTo>
                          <a:pt x="83608" y="304165"/>
                        </a:moveTo>
                        <a:cubicBezTo>
                          <a:pt x="71337" y="259709"/>
                          <a:pt x="89078" y="185816"/>
                          <a:pt x="120546" y="146198"/>
                        </a:cubicBezTo>
                        <a:cubicBezTo>
                          <a:pt x="180294" y="83133"/>
                          <a:pt x="240544" y="44472"/>
                          <a:pt x="300239" y="110109"/>
                        </a:cubicBezTo>
                        <a:cubicBezTo>
                          <a:pt x="343738" y="24049"/>
                          <a:pt x="411423" y="3865"/>
                          <a:pt x="481412" y="72644"/>
                        </a:cubicBezTo>
                        <a:cubicBezTo>
                          <a:pt x="494012" y="39184"/>
                          <a:pt x="519547" y="3742"/>
                          <a:pt x="552008" y="4233"/>
                        </a:cubicBezTo>
                        <a:cubicBezTo>
                          <a:pt x="591139" y="-6367"/>
                          <a:pt x="621071" y="12742"/>
                          <a:pt x="639561" y="52514"/>
                        </a:cubicBezTo>
                        <a:cubicBezTo>
                          <a:pt x="661000" y="2512"/>
                          <a:pt x="727085" y="-18478"/>
                          <a:pt x="760257" y="14605"/>
                        </a:cubicBezTo>
                        <a:cubicBezTo>
                          <a:pt x="781805" y="39036"/>
                          <a:pt x="816997" y="76594"/>
                          <a:pt x="821463" y="118025"/>
                        </a:cubicBezTo>
                        <a:cubicBezTo>
                          <a:pt x="862700" y="130782"/>
                          <a:pt x="887054" y="172857"/>
                          <a:pt x="900012" y="218397"/>
                        </a:cubicBezTo>
                        <a:cubicBezTo>
                          <a:pt x="911392" y="254804"/>
                          <a:pt x="905949" y="287720"/>
                          <a:pt x="896496" y="327236"/>
                        </a:cubicBezTo>
                        <a:cubicBezTo>
                          <a:pt x="935652" y="374908"/>
                          <a:pt x="941457" y="444601"/>
                          <a:pt x="922179" y="493649"/>
                        </a:cubicBezTo>
                        <a:cubicBezTo>
                          <a:pt x="917821" y="580107"/>
                          <a:pt x="864011" y="637252"/>
                          <a:pt x="801869" y="639318"/>
                        </a:cubicBezTo>
                        <a:cubicBezTo>
                          <a:pt x="807488" y="693136"/>
                          <a:pt x="780739" y="725942"/>
                          <a:pt x="758799" y="764137"/>
                        </a:cubicBezTo>
                        <a:cubicBezTo>
                          <a:pt x="716295" y="813096"/>
                          <a:pt x="670149" y="820532"/>
                          <a:pt x="612163" y="779250"/>
                        </a:cubicBezTo>
                        <a:cubicBezTo>
                          <a:pt x="603395" y="839019"/>
                          <a:pt x="553129" y="888687"/>
                          <a:pt x="507374" y="912410"/>
                        </a:cubicBezTo>
                        <a:cubicBezTo>
                          <a:pt x="436158" y="937157"/>
                          <a:pt x="387522" y="907165"/>
                          <a:pt x="353299" y="831130"/>
                        </a:cubicBezTo>
                        <a:cubicBezTo>
                          <a:pt x="260389" y="880211"/>
                          <a:pt x="191762" y="836405"/>
                          <a:pt x="124426" y="750824"/>
                        </a:cubicBezTo>
                        <a:cubicBezTo>
                          <a:pt x="88896" y="769993"/>
                          <a:pt x="52190" y="722855"/>
                          <a:pt x="23796" y="661458"/>
                        </a:cubicBezTo>
                        <a:cubicBezTo>
                          <a:pt x="5689" y="622220"/>
                          <a:pt x="22538" y="566743"/>
                          <a:pt x="45298" y="540829"/>
                        </a:cubicBezTo>
                        <a:cubicBezTo>
                          <a:pt x="14203" y="506065"/>
                          <a:pt x="-2065" y="459478"/>
                          <a:pt x="-108" y="417068"/>
                        </a:cubicBezTo>
                        <a:cubicBezTo>
                          <a:pt x="3361" y="358891"/>
                          <a:pt x="45535" y="303762"/>
                          <a:pt x="82815" y="307064"/>
                        </a:cubicBezTo>
                        <a:cubicBezTo>
                          <a:pt x="83174" y="306011"/>
                          <a:pt x="83501" y="305126"/>
                          <a:pt x="83608" y="304165"/>
                        </a:cubicBezTo>
                        <a:close/>
                      </a:path>
                      <a:path w="926124" h="914400" fill="none" extrusionOk="0">
                        <a:moveTo>
                          <a:pt x="100608" y="554079"/>
                        </a:moveTo>
                        <a:cubicBezTo>
                          <a:pt x="82473" y="554508"/>
                          <a:pt x="64241" y="548588"/>
                          <a:pt x="46306" y="537210"/>
                        </a:cubicBezTo>
                        <a:moveTo>
                          <a:pt x="148522" y="738695"/>
                        </a:moveTo>
                        <a:cubicBezTo>
                          <a:pt x="142839" y="741453"/>
                          <a:pt x="134619" y="744048"/>
                          <a:pt x="124769" y="746760"/>
                        </a:cubicBezTo>
                        <a:moveTo>
                          <a:pt x="353256" y="827405"/>
                        </a:moveTo>
                        <a:cubicBezTo>
                          <a:pt x="348060" y="818827"/>
                          <a:pt x="343509" y="802778"/>
                          <a:pt x="338935" y="790575"/>
                        </a:cubicBezTo>
                        <a:moveTo>
                          <a:pt x="617994" y="735562"/>
                        </a:moveTo>
                        <a:cubicBezTo>
                          <a:pt x="620346" y="749453"/>
                          <a:pt x="615005" y="760028"/>
                          <a:pt x="612270" y="775970"/>
                        </a:cubicBezTo>
                        <a:moveTo>
                          <a:pt x="731659" y="485859"/>
                        </a:moveTo>
                        <a:cubicBezTo>
                          <a:pt x="767886" y="514709"/>
                          <a:pt x="810093" y="582907"/>
                          <a:pt x="801354" y="636905"/>
                        </a:cubicBezTo>
                        <a:moveTo>
                          <a:pt x="896067" y="324993"/>
                        </a:moveTo>
                        <a:cubicBezTo>
                          <a:pt x="887796" y="350013"/>
                          <a:pt x="882311" y="364882"/>
                          <a:pt x="865025" y="381635"/>
                        </a:cubicBezTo>
                        <a:moveTo>
                          <a:pt x="821592" y="114850"/>
                        </a:moveTo>
                        <a:cubicBezTo>
                          <a:pt x="822863" y="123456"/>
                          <a:pt x="825677" y="133667"/>
                          <a:pt x="823221" y="141605"/>
                        </a:cubicBezTo>
                        <a:moveTo>
                          <a:pt x="623375" y="83650"/>
                        </a:moveTo>
                        <a:cubicBezTo>
                          <a:pt x="628665" y="69366"/>
                          <a:pt x="635344" y="58957"/>
                          <a:pt x="639282" y="49530"/>
                        </a:cubicBezTo>
                        <a:moveTo>
                          <a:pt x="474659" y="99906"/>
                        </a:moveTo>
                        <a:cubicBezTo>
                          <a:pt x="478201" y="90042"/>
                          <a:pt x="479087" y="82159"/>
                          <a:pt x="482356" y="70485"/>
                        </a:cubicBezTo>
                        <a:moveTo>
                          <a:pt x="300132" y="109897"/>
                        </a:moveTo>
                        <a:cubicBezTo>
                          <a:pt x="309763" y="117673"/>
                          <a:pt x="321642" y="127309"/>
                          <a:pt x="328002" y="138430"/>
                        </a:cubicBezTo>
                        <a:moveTo>
                          <a:pt x="88474" y="334200"/>
                        </a:moveTo>
                        <a:cubicBezTo>
                          <a:pt x="86238" y="323175"/>
                          <a:pt x="85815" y="313492"/>
                          <a:pt x="83608" y="304165"/>
                        </a:cubicBezTo>
                      </a:path>
                      <a:path w="926124" h="914400" stroke="0" extrusionOk="0">
                        <a:moveTo>
                          <a:pt x="83608" y="304165"/>
                        </a:moveTo>
                        <a:cubicBezTo>
                          <a:pt x="66932" y="240037"/>
                          <a:pt x="81174" y="192645"/>
                          <a:pt x="120546" y="146198"/>
                        </a:cubicBezTo>
                        <a:cubicBezTo>
                          <a:pt x="186588" y="83058"/>
                          <a:pt x="232151" y="64156"/>
                          <a:pt x="300239" y="110109"/>
                        </a:cubicBezTo>
                        <a:cubicBezTo>
                          <a:pt x="323746" y="31309"/>
                          <a:pt x="422981" y="22222"/>
                          <a:pt x="481412" y="72644"/>
                        </a:cubicBezTo>
                        <a:cubicBezTo>
                          <a:pt x="490727" y="33201"/>
                          <a:pt x="522797" y="10631"/>
                          <a:pt x="552008" y="4233"/>
                        </a:cubicBezTo>
                        <a:cubicBezTo>
                          <a:pt x="590055" y="-1623"/>
                          <a:pt x="623701" y="6671"/>
                          <a:pt x="639561" y="52514"/>
                        </a:cubicBezTo>
                        <a:cubicBezTo>
                          <a:pt x="667761" y="5433"/>
                          <a:pt x="714039" y="-5823"/>
                          <a:pt x="760257" y="14605"/>
                        </a:cubicBezTo>
                        <a:cubicBezTo>
                          <a:pt x="791039" y="21051"/>
                          <a:pt x="813129" y="74968"/>
                          <a:pt x="821463" y="118025"/>
                        </a:cubicBezTo>
                        <a:cubicBezTo>
                          <a:pt x="860627" y="132800"/>
                          <a:pt x="890405" y="169868"/>
                          <a:pt x="900012" y="218397"/>
                        </a:cubicBezTo>
                        <a:cubicBezTo>
                          <a:pt x="905376" y="253498"/>
                          <a:pt x="914442" y="298438"/>
                          <a:pt x="896496" y="327236"/>
                        </a:cubicBezTo>
                        <a:cubicBezTo>
                          <a:pt x="927721" y="380763"/>
                          <a:pt x="934588" y="452437"/>
                          <a:pt x="922179" y="493649"/>
                        </a:cubicBezTo>
                        <a:cubicBezTo>
                          <a:pt x="911761" y="576604"/>
                          <a:pt x="871426" y="641770"/>
                          <a:pt x="801869" y="639318"/>
                        </a:cubicBezTo>
                        <a:cubicBezTo>
                          <a:pt x="804649" y="684623"/>
                          <a:pt x="788286" y="721477"/>
                          <a:pt x="758799" y="764137"/>
                        </a:cubicBezTo>
                        <a:cubicBezTo>
                          <a:pt x="706752" y="813532"/>
                          <a:pt x="644367" y="808290"/>
                          <a:pt x="612163" y="779250"/>
                        </a:cubicBezTo>
                        <a:cubicBezTo>
                          <a:pt x="595019" y="845407"/>
                          <a:pt x="554883" y="891194"/>
                          <a:pt x="507374" y="912410"/>
                        </a:cubicBezTo>
                        <a:cubicBezTo>
                          <a:pt x="449816" y="913121"/>
                          <a:pt x="380720" y="902665"/>
                          <a:pt x="353299" y="831130"/>
                        </a:cubicBezTo>
                        <a:cubicBezTo>
                          <a:pt x="266890" y="907926"/>
                          <a:pt x="175732" y="863187"/>
                          <a:pt x="124426" y="750824"/>
                        </a:cubicBezTo>
                        <a:cubicBezTo>
                          <a:pt x="78787" y="765544"/>
                          <a:pt x="37828" y="719416"/>
                          <a:pt x="23796" y="661458"/>
                        </a:cubicBezTo>
                        <a:cubicBezTo>
                          <a:pt x="13604" y="620487"/>
                          <a:pt x="18510" y="573354"/>
                          <a:pt x="45298" y="540829"/>
                        </a:cubicBezTo>
                        <a:cubicBezTo>
                          <a:pt x="16289" y="521471"/>
                          <a:pt x="-7050" y="468182"/>
                          <a:pt x="-108" y="417068"/>
                        </a:cubicBezTo>
                        <a:cubicBezTo>
                          <a:pt x="7028" y="347859"/>
                          <a:pt x="33266" y="312720"/>
                          <a:pt x="82815" y="307064"/>
                        </a:cubicBezTo>
                        <a:cubicBezTo>
                          <a:pt x="83208" y="306208"/>
                          <a:pt x="83291" y="305318"/>
                          <a:pt x="83608" y="304165"/>
                        </a:cubicBezTo>
                        <a:close/>
                      </a:path>
                      <a:path w="926124" h="914400" fill="none" stroke="0" extrusionOk="0">
                        <a:moveTo>
                          <a:pt x="100608" y="554079"/>
                        </a:moveTo>
                        <a:cubicBezTo>
                          <a:pt x="82651" y="552223"/>
                          <a:pt x="64096" y="544965"/>
                          <a:pt x="46306" y="537210"/>
                        </a:cubicBezTo>
                        <a:moveTo>
                          <a:pt x="148522" y="738695"/>
                        </a:moveTo>
                        <a:cubicBezTo>
                          <a:pt x="140461" y="745022"/>
                          <a:pt x="132318" y="744850"/>
                          <a:pt x="124769" y="746760"/>
                        </a:cubicBezTo>
                        <a:moveTo>
                          <a:pt x="353256" y="827405"/>
                        </a:moveTo>
                        <a:cubicBezTo>
                          <a:pt x="348714" y="816800"/>
                          <a:pt x="342097" y="803684"/>
                          <a:pt x="338935" y="790575"/>
                        </a:cubicBezTo>
                        <a:moveTo>
                          <a:pt x="617994" y="735562"/>
                        </a:moveTo>
                        <a:cubicBezTo>
                          <a:pt x="615161" y="749958"/>
                          <a:pt x="615206" y="761646"/>
                          <a:pt x="612270" y="775970"/>
                        </a:cubicBezTo>
                        <a:moveTo>
                          <a:pt x="731659" y="485859"/>
                        </a:moveTo>
                        <a:cubicBezTo>
                          <a:pt x="757104" y="520467"/>
                          <a:pt x="800960" y="584526"/>
                          <a:pt x="801354" y="636905"/>
                        </a:cubicBezTo>
                        <a:moveTo>
                          <a:pt x="896067" y="324993"/>
                        </a:moveTo>
                        <a:cubicBezTo>
                          <a:pt x="887389" y="345337"/>
                          <a:pt x="880596" y="366416"/>
                          <a:pt x="865025" y="381635"/>
                        </a:cubicBezTo>
                        <a:moveTo>
                          <a:pt x="821592" y="114850"/>
                        </a:moveTo>
                        <a:cubicBezTo>
                          <a:pt x="820128" y="123423"/>
                          <a:pt x="822589" y="132954"/>
                          <a:pt x="823221" y="141605"/>
                        </a:cubicBezTo>
                        <a:moveTo>
                          <a:pt x="623375" y="83650"/>
                        </a:moveTo>
                        <a:cubicBezTo>
                          <a:pt x="626548" y="70286"/>
                          <a:pt x="632875" y="58419"/>
                          <a:pt x="639282" y="49530"/>
                        </a:cubicBezTo>
                        <a:moveTo>
                          <a:pt x="474659" y="99906"/>
                        </a:moveTo>
                        <a:cubicBezTo>
                          <a:pt x="476015" y="90132"/>
                          <a:pt x="478087" y="81859"/>
                          <a:pt x="482356" y="70485"/>
                        </a:cubicBezTo>
                        <a:moveTo>
                          <a:pt x="300132" y="109897"/>
                        </a:moveTo>
                        <a:cubicBezTo>
                          <a:pt x="308469" y="118284"/>
                          <a:pt x="320059" y="128707"/>
                          <a:pt x="328002" y="138430"/>
                        </a:cubicBezTo>
                        <a:moveTo>
                          <a:pt x="88474" y="334200"/>
                        </a:moveTo>
                        <a:cubicBezTo>
                          <a:pt x="84869" y="324137"/>
                          <a:pt x="84568" y="312557"/>
                          <a:pt x="83608" y="304165"/>
                        </a:cubicBezTo>
                      </a:path>
                    </a:pathLst>
                  </a:custGeom>
                  <ask:type>
                    <ask:lineSketchNone/>
                  </ask:type>
                </ask:lineSketchStyleProps>
              </a:ext>
            </a:extLst>
          </a:ln>
          <a:effectLst>
            <a:glow rad="318456">
              <a:schemeClr val="bg1">
                <a:lumMod val="50000"/>
                <a:alpha val="46000"/>
              </a:schemeClr>
            </a:glow>
          </a:effectLst>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27" name="ZoneTexte 1026">
            <a:extLst>
              <a:ext uri="{FF2B5EF4-FFF2-40B4-BE49-F238E27FC236}">
                <a16:creationId xmlns:a16="http://schemas.microsoft.com/office/drawing/2014/main" id="{B90B31C7-0262-458E-4B39-92DDFAE364BA}"/>
              </a:ext>
            </a:extLst>
          </p:cNvPr>
          <p:cNvSpPr txBox="1"/>
          <p:nvPr/>
        </p:nvSpPr>
        <p:spPr>
          <a:xfrm>
            <a:off x="6386818" y="5629433"/>
            <a:ext cx="1428596"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Fluorophore</a:t>
            </a:r>
          </a:p>
        </p:txBody>
      </p:sp>
      <p:sp>
        <p:nvSpPr>
          <p:cNvPr id="1028" name="Nuage 1027">
            <a:extLst>
              <a:ext uri="{FF2B5EF4-FFF2-40B4-BE49-F238E27FC236}">
                <a16:creationId xmlns:a16="http://schemas.microsoft.com/office/drawing/2014/main" id="{6758A3EB-8E32-4663-5462-B5026673CEAC}"/>
              </a:ext>
            </a:extLst>
          </p:cNvPr>
          <p:cNvSpPr/>
          <p:nvPr/>
        </p:nvSpPr>
        <p:spPr>
          <a:xfrm>
            <a:off x="7865340" y="5556639"/>
            <a:ext cx="463062" cy="493174"/>
          </a:xfrm>
          <a:prstGeom prst="cloud">
            <a:avLst/>
          </a:prstGeom>
          <a:solidFill>
            <a:schemeClr val="accent1"/>
          </a:solidFill>
          <a:ln>
            <a:noFill/>
            <a:extLst>
              <a:ext uri="{C807C97D-BFC1-408E-A445-0C87EB9F89A2}">
                <ask:lineSketchStyleProps xmlns:ask="http://schemas.microsoft.com/office/drawing/2018/sketchyshapes" sd="1219033472">
                  <a:custGeom>
                    <a:avLst/>
                    <a:gdLst>
                      <a:gd name="connsiteX0" fmla="*/ 83608 w 926124"/>
                      <a:gd name="connsiteY0" fmla="*/ 304165 h 914400"/>
                      <a:gd name="connsiteX1" fmla="*/ 120546 w 926124"/>
                      <a:gd name="connsiteY1" fmla="*/ 146198 h 914400"/>
                      <a:gd name="connsiteX2" fmla="*/ 300239 w 926124"/>
                      <a:gd name="connsiteY2" fmla="*/ 110109 h 914400"/>
                      <a:gd name="connsiteX3" fmla="*/ 481412 w 926124"/>
                      <a:gd name="connsiteY3" fmla="*/ 72644 h 914400"/>
                      <a:gd name="connsiteX4" fmla="*/ 552008 w 926124"/>
                      <a:gd name="connsiteY4" fmla="*/ 4233 h 914400"/>
                      <a:gd name="connsiteX5" fmla="*/ 639561 w 926124"/>
                      <a:gd name="connsiteY5" fmla="*/ 52514 h 914400"/>
                      <a:gd name="connsiteX6" fmla="*/ 760257 w 926124"/>
                      <a:gd name="connsiteY6" fmla="*/ 14605 h 914400"/>
                      <a:gd name="connsiteX7" fmla="*/ 821463 w 926124"/>
                      <a:gd name="connsiteY7" fmla="*/ 118025 h 914400"/>
                      <a:gd name="connsiteX8" fmla="*/ 900012 w 926124"/>
                      <a:gd name="connsiteY8" fmla="*/ 218397 h 914400"/>
                      <a:gd name="connsiteX9" fmla="*/ 896496 w 926124"/>
                      <a:gd name="connsiteY9" fmla="*/ 327236 h 914400"/>
                      <a:gd name="connsiteX10" fmla="*/ 922179 w 926124"/>
                      <a:gd name="connsiteY10" fmla="*/ 493649 h 914400"/>
                      <a:gd name="connsiteX11" fmla="*/ 801869 w 926124"/>
                      <a:gd name="connsiteY11" fmla="*/ 639318 h 914400"/>
                      <a:gd name="connsiteX12" fmla="*/ 758799 w 926124"/>
                      <a:gd name="connsiteY12" fmla="*/ 764137 h 914400"/>
                      <a:gd name="connsiteX13" fmla="*/ 612163 w 926124"/>
                      <a:gd name="connsiteY13" fmla="*/ 779250 h 914400"/>
                      <a:gd name="connsiteX14" fmla="*/ 507374 w 926124"/>
                      <a:gd name="connsiteY14" fmla="*/ 912410 h 914400"/>
                      <a:gd name="connsiteX15" fmla="*/ 353299 w 926124"/>
                      <a:gd name="connsiteY15" fmla="*/ 831130 h 914400"/>
                      <a:gd name="connsiteX16" fmla="*/ 124426 w 926124"/>
                      <a:gd name="connsiteY16" fmla="*/ 750824 h 914400"/>
                      <a:gd name="connsiteX17" fmla="*/ 23796 w 926124"/>
                      <a:gd name="connsiteY17" fmla="*/ 661458 h 914400"/>
                      <a:gd name="connsiteX18" fmla="*/ 45298 w 926124"/>
                      <a:gd name="connsiteY18" fmla="*/ 540829 h 914400"/>
                      <a:gd name="connsiteX19" fmla="*/ -108 w 926124"/>
                      <a:gd name="connsiteY19" fmla="*/ 417068 h 914400"/>
                      <a:gd name="connsiteX20" fmla="*/ 82815 w 926124"/>
                      <a:gd name="connsiteY20" fmla="*/ 307064 h 914400"/>
                      <a:gd name="connsiteX21" fmla="*/ 83608 w 926124"/>
                      <a:gd name="connsiteY21" fmla="*/ 304165 h 914400"/>
                      <a:gd name="connsiteX0" fmla="*/ 100608 w 926124"/>
                      <a:gd name="connsiteY0" fmla="*/ 554079 h 914400"/>
                      <a:gd name="connsiteX1" fmla="*/ 46306 w 926124"/>
                      <a:gd name="connsiteY1" fmla="*/ 537210 h 914400"/>
                      <a:gd name="connsiteX2" fmla="*/ 148522 w 926124"/>
                      <a:gd name="connsiteY2" fmla="*/ 738695 h 914400"/>
                      <a:gd name="connsiteX3" fmla="*/ 124769 w 926124"/>
                      <a:gd name="connsiteY3" fmla="*/ 746760 h 914400"/>
                      <a:gd name="connsiteX4" fmla="*/ 353256 w 926124"/>
                      <a:gd name="connsiteY4" fmla="*/ 827405 h 914400"/>
                      <a:gd name="connsiteX5" fmla="*/ 338935 w 926124"/>
                      <a:gd name="connsiteY5" fmla="*/ 790575 h 914400"/>
                      <a:gd name="connsiteX6" fmla="*/ 617994 w 926124"/>
                      <a:gd name="connsiteY6" fmla="*/ 735562 h 914400"/>
                      <a:gd name="connsiteX7" fmla="*/ 612270 w 926124"/>
                      <a:gd name="connsiteY7" fmla="*/ 775970 h 914400"/>
                      <a:gd name="connsiteX8" fmla="*/ 731659 w 926124"/>
                      <a:gd name="connsiteY8" fmla="*/ 485859 h 914400"/>
                      <a:gd name="connsiteX9" fmla="*/ 801354 w 926124"/>
                      <a:gd name="connsiteY9" fmla="*/ 636905 h 914400"/>
                      <a:gd name="connsiteX10" fmla="*/ 896067 w 926124"/>
                      <a:gd name="connsiteY10" fmla="*/ 324993 h 914400"/>
                      <a:gd name="connsiteX11" fmla="*/ 865025 w 926124"/>
                      <a:gd name="connsiteY11" fmla="*/ 381635 h 914400"/>
                      <a:gd name="connsiteX12" fmla="*/ 821592 w 926124"/>
                      <a:gd name="connsiteY12" fmla="*/ 114850 h 914400"/>
                      <a:gd name="connsiteX13" fmla="*/ 823221 w 926124"/>
                      <a:gd name="connsiteY13" fmla="*/ 141605 h 914400"/>
                      <a:gd name="connsiteX14" fmla="*/ 623375 w 926124"/>
                      <a:gd name="connsiteY14" fmla="*/ 83650 h 914400"/>
                      <a:gd name="connsiteX15" fmla="*/ 639282 w 926124"/>
                      <a:gd name="connsiteY15" fmla="*/ 49530 h 914400"/>
                      <a:gd name="connsiteX16" fmla="*/ 474659 w 926124"/>
                      <a:gd name="connsiteY16" fmla="*/ 99906 h 914400"/>
                      <a:gd name="connsiteX17" fmla="*/ 482356 w 926124"/>
                      <a:gd name="connsiteY17" fmla="*/ 70485 h 914400"/>
                      <a:gd name="connsiteX18" fmla="*/ 300132 w 926124"/>
                      <a:gd name="connsiteY18" fmla="*/ 109897 h 914400"/>
                      <a:gd name="connsiteX19" fmla="*/ 328002 w 926124"/>
                      <a:gd name="connsiteY19" fmla="*/ 138430 h 914400"/>
                      <a:gd name="connsiteX20" fmla="*/ 88474 w 926124"/>
                      <a:gd name="connsiteY20" fmla="*/ 334200 h 914400"/>
                      <a:gd name="connsiteX21" fmla="*/ 83608 w 926124"/>
                      <a:gd name="connsiteY21" fmla="*/ 304165 h 9144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926124" h="914400" fill="none" extrusionOk="0">
                        <a:moveTo>
                          <a:pt x="83608" y="304165"/>
                        </a:moveTo>
                        <a:cubicBezTo>
                          <a:pt x="71337" y="259709"/>
                          <a:pt x="89078" y="185816"/>
                          <a:pt x="120546" y="146198"/>
                        </a:cubicBezTo>
                        <a:cubicBezTo>
                          <a:pt x="180294" y="83133"/>
                          <a:pt x="240544" y="44472"/>
                          <a:pt x="300239" y="110109"/>
                        </a:cubicBezTo>
                        <a:cubicBezTo>
                          <a:pt x="343738" y="24049"/>
                          <a:pt x="411423" y="3865"/>
                          <a:pt x="481412" y="72644"/>
                        </a:cubicBezTo>
                        <a:cubicBezTo>
                          <a:pt x="494012" y="39184"/>
                          <a:pt x="519547" y="3742"/>
                          <a:pt x="552008" y="4233"/>
                        </a:cubicBezTo>
                        <a:cubicBezTo>
                          <a:pt x="591139" y="-6367"/>
                          <a:pt x="621071" y="12742"/>
                          <a:pt x="639561" y="52514"/>
                        </a:cubicBezTo>
                        <a:cubicBezTo>
                          <a:pt x="661000" y="2512"/>
                          <a:pt x="727085" y="-18478"/>
                          <a:pt x="760257" y="14605"/>
                        </a:cubicBezTo>
                        <a:cubicBezTo>
                          <a:pt x="781805" y="39036"/>
                          <a:pt x="816997" y="76594"/>
                          <a:pt x="821463" y="118025"/>
                        </a:cubicBezTo>
                        <a:cubicBezTo>
                          <a:pt x="862700" y="130782"/>
                          <a:pt x="887054" y="172857"/>
                          <a:pt x="900012" y="218397"/>
                        </a:cubicBezTo>
                        <a:cubicBezTo>
                          <a:pt x="911392" y="254804"/>
                          <a:pt x="905949" y="287720"/>
                          <a:pt x="896496" y="327236"/>
                        </a:cubicBezTo>
                        <a:cubicBezTo>
                          <a:pt x="935652" y="374908"/>
                          <a:pt x="941457" y="444601"/>
                          <a:pt x="922179" y="493649"/>
                        </a:cubicBezTo>
                        <a:cubicBezTo>
                          <a:pt x="917821" y="580107"/>
                          <a:pt x="864011" y="637252"/>
                          <a:pt x="801869" y="639318"/>
                        </a:cubicBezTo>
                        <a:cubicBezTo>
                          <a:pt x="807488" y="693136"/>
                          <a:pt x="780739" y="725942"/>
                          <a:pt x="758799" y="764137"/>
                        </a:cubicBezTo>
                        <a:cubicBezTo>
                          <a:pt x="716295" y="813096"/>
                          <a:pt x="670149" y="820532"/>
                          <a:pt x="612163" y="779250"/>
                        </a:cubicBezTo>
                        <a:cubicBezTo>
                          <a:pt x="603395" y="839019"/>
                          <a:pt x="553129" y="888687"/>
                          <a:pt x="507374" y="912410"/>
                        </a:cubicBezTo>
                        <a:cubicBezTo>
                          <a:pt x="436158" y="937157"/>
                          <a:pt x="387522" y="907165"/>
                          <a:pt x="353299" y="831130"/>
                        </a:cubicBezTo>
                        <a:cubicBezTo>
                          <a:pt x="260389" y="880211"/>
                          <a:pt x="191762" y="836405"/>
                          <a:pt x="124426" y="750824"/>
                        </a:cubicBezTo>
                        <a:cubicBezTo>
                          <a:pt x="88896" y="769993"/>
                          <a:pt x="52190" y="722855"/>
                          <a:pt x="23796" y="661458"/>
                        </a:cubicBezTo>
                        <a:cubicBezTo>
                          <a:pt x="5689" y="622220"/>
                          <a:pt x="22538" y="566743"/>
                          <a:pt x="45298" y="540829"/>
                        </a:cubicBezTo>
                        <a:cubicBezTo>
                          <a:pt x="14203" y="506065"/>
                          <a:pt x="-2065" y="459478"/>
                          <a:pt x="-108" y="417068"/>
                        </a:cubicBezTo>
                        <a:cubicBezTo>
                          <a:pt x="3361" y="358891"/>
                          <a:pt x="45535" y="303762"/>
                          <a:pt x="82815" y="307064"/>
                        </a:cubicBezTo>
                        <a:cubicBezTo>
                          <a:pt x="83174" y="306011"/>
                          <a:pt x="83501" y="305126"/>
                          <a:pt x="83608" y="304165"/>
                        </a:cubicBezTo>
                        <a:close/>
                      </a:path>
                      <a:path w="926124" h="914400" fill="none" extrusionOk="0">
                        <a:moveTo>
                          <a:pt x="100608" y="554079"/>
                        </a:moveTo>
                        <a:cubicBezTo>
                          <a:pt x="82473" y="554508"/>
                          <a:pt x="64241" y="548588"/>
                          <a:pt x="46306" y="537210"/>
                        </a:cubicBezTo>
                        <a:moveTo>
                          <a:pt x="148522" y="738695"/>
                        </a:moveTo>
                        <a:cubicBezTo>
                          <a:pt x="142839" y="741453"/>
                          <a:pt x="134619" y="744048"/>
                          <a:pt x="124769" y="746760"/>
                        </a:cubicBezTo>
                        <a:moveTo>
                          <a:pt x="353256" y="827405"/>
                        </a:moveTo>
                        <a:cubicBezTo>
                          <a:pt x="348060" y="818827"/>
                          <a:pt x="343509" y="802778"/>
                          <a:pt x="338935" y="790575"/>
                        </a:cubicBezTo>
                        <a:moveTo>
                          <a:pt x="617994" y="735562"/>
                        </a:moveTo>
                        <a:cubicBezTo>
                          <a:pt x="620346" y="749453"/>
                          <a:pt x="615005" y="760028"/>
                          <a:pt x="612270" y="775970"/>
                        </a:cubicBezTo>
                        <a:moveTo>
                          <a:pt x="731659" y="485859"/>
                        </a:moveTo>
                        <a:cubicBezTo>
                          <a:pt x="767886" y="514709"/>
                          <a:pt x="810093" y="582907"/>
                          <a:pt x="801354" y="636905"/>
                        </a:cubicBezTo>
                        <a:moveTo>
                          <a:pt x="896067" y="324993"/>
                        </a:moveTo>
                        <a:cubicBezTo>
                          <a:pt x="887796" y="350013"/>
                          <a:pt x="882311" y="364882"/>
                          <a:pt x="865025" y="381635"/>
                        </a:cubicBezTo>
                        <a:moveTo>
                          <a:pt x="821592" y="114850"/>
                        </a:moveTo>
                        <a:cubicBezTo>
                          <a:pt x="822863" y="123456"/>
                          <a:pt x="825677" y="133667"/>
                          <a:pt x="823221" y="141605"/>
                        </a:cubicBezTo>
                        <a:moveTo>
                          <a:pt x="623375" y="83650"/>
                        </a:moveTo>
                        <a:cubicBezTo>
                          <a:pt x="628665" y="69366"/>
                          <a:pt x="635344" y="58957"/>
                          <a:pt x="639282" y="49530"/>
                        </a:cubicBezTo>
                        <a:moveTo>
                          <a:pt x="474659" y="99906"/>
                        </a:moveTo>
                        <a:cubicBezTo>
                          <a:pt x="478201" y="90042"/>
                          <a:pt x="479087" y="82159"/>
                          <a:pt x="482356" y="70485"/>
                        </a:cubicBezTo>
                        <a:moveTo>
                          <a:pt x="300132" y="109897"/>
                        </a:moveTo>
                        <a:cubicBezTo>
                          <a:pt x="309763" y="117673"/>
                          <a:pt x="321642" y="127309"/>
                          <a:pt x="328002" y="138430"/>
                        </a:cubicBezTo>
                        <a:moveTo>
                          <a:pt x="88474" y="334200"/>
                        </a:moveTo>
                        <a:cubicBezTo>
                          <a:pt x="86238" y="323175"/>
                          <a:pt x="85815" y="313492"/>
                          <a:pt x="83608" y="304165"/>
                        </a:cubicBezTo>
                      </a:path>
                      <a:path w="926124" h="914400" stroke="0" extrusionOk="0">
                        <a:moveTo>
                          <a:pt x="83608" y="304165"/>
                        </a:moveTo>
                        <a:cubicBezTo>
                          <a:pt x="66932" y="240037"/>
                          <a:pt x="81174" y="192645"/>
                          <a:pt x="120546" y="146198"/>
                        </a:cubicBezTo>
                        <a:cubicBezTo>
                          <a:pt x="186588" y="83058"/>
                          <a:pt x="232151" y="64156"/>
                          <a:pt x="300239" y="110109"/>
                        </a:cubicBezTo>
                        <a:cubicBezTo>
                          <a:pt x="323746" y="31309"/>
                          <a:pt x="422981" y="22222"/>
                          <a:pt x="481412" y="72644"/>
                        </a:cubicBezTo>
                        <a:cubicBezTo>
                          <a:pt x="490727" y="33201"/>
                          <a:pt x="522797" y="10631"/>
                          <a:pt x="552008" y="4233"/>
                        </a:cubicBezTo>
                        <a:cubicBezTo>
                          <a:pt x="590055" y="-1623"/>
                          <a:pt x="623701" y="6671"/>
                          <a:pt x="639561" y="52514"/>
                        </a:cubicBezTo>
                        <a:cubicBezTo>
                          <a:pt x="667761" y="5433"/>
                          <a:pt x="714039" y="-5823"/>
                          <a:pt x="760257" y="14605"/>
                        </a:cubicBezTo>
                        <a:cubicBezTo>
                          <a:pt x="791039" y="21051"/>
                          <a:pt x="813129" y="74968"/>
                          <a:pt x="821463" y="118025"/>
                        </a:cubicBezTo>
                        <a:cubicBezTo>
                          <a:pt x="860627" y="132800"/>
                          <a:pt x="890405" y="169868"/>
                          <a:pt x="900012" y="218397"/>
                        </a:cubicBezTo>
                        <a:cubicBezTo>
                          <a:pt x="905376" y="253498"/>
                          <a:pt x="914442" y="298438"/>
                          <a:pt x="896496" y="327236"/>
                        </a:cubicBezTo>
                        <a:cubicBezTo>
                          <a:pt x="927721" y="380763"/>
                          <a:pt x="934588" y="452437"/>
                          <a:pt x="922179" y="493649"/>
                        </a:cubicBezTo>
                        <a:cubicBezTo>
                          <a:pt x="911761" y="576604"/>
                          <a:pt x="871426" y="641770"/>
                          <a:pt x="801869" y="639318"/>
                        </a:cubicBezTo>
                        <a:cubicBezTo>
                          <a:pt x="804649" y="684623"/>
                          <a:pt x="788286" y="721477"/>
                          <a:pt x="758799" y="764137"/>
                        </a:cubicBezTo>
                        <a:cubicBezTo>
                          <a:pt x="706752" y="813532"/>
                          <a:pt x="644367" y="808290"/>
                          <a:pt x="612163" y="779250"/>
                        </a:cubicBezTo>
                        <a:cubicBezTo>
                          <a:pt x="595019" y="845407"/>
                          <a:pt x="554883" y="891194"/>
                          <a:pt x="507374" y="912410"/>
                        </a:cubicBezTo>
                        <a:cubicBezTo>
                          <a:pt x="449816" y="913121"/>
                          <a:pt x="380720" y="902665"/>
                          <a:pt x="353299" y="831130"/>
                        </a:cubicBezTo>
                        <a:cubicBezTo>
                          <a:pt x="266890" y="907926"/>
                          <a:pt x="175732" y="863187"/>
                          <a:pt x="124426" y="750824"/>
                        </a:cubicBezTo>
                        <a:cubicBezTo>
                          <a:pt x="78787" y="765544"/>
                          <a:pt x="37828" y="719416"/>
                          <a:pt x="23796" y="661458"/>
                        </a:cubicBezTo>
                        <a:cubicBezTo>
                          <a:pt x="13604" y="620487"/>
                          <a:pt x="18510" y="573354"/>
                          <a:pt x="45298" y="540829"/>
                        </a:cubicBezTo>
                        <a:cubicBezTo>
                          <a:pt x="16289" y="521471"/>
                          <a:pt x="-7050" y="468182"/>
                          <a:pt x="-108" y="417068"/>
                        </a:cubicBezTo>
                        <a:cubicBezTo>
                          <a:pt x="7028" y="347859"/>
                          <a:pt x="33266" y="312720"/>
                          <a:pt x="82815" y="307064"/>
                        </a:cubicBezTo>
                        <a:cubicBezTo>
                          <a:pt x="83208" y="306208"/>
                          <a:pt x="83291" y="305318"/>
                          <a:pt x="83608" y="304165"/>
                        </a:cubicBezTo>
                        <a:close/>
                      </a:path>
                      <a:path w="926124" h="914400" fill="none" stroke="0" extrusionOk="0">
                        <a:moveTo>
                          <a:pt x="100608" y="554079"/>
                        </a:moveTo>
                        <a:cubicBezTo>
                          <a:pt x="82651" y="552223"/>
                          <a:pt x="64096" y="544965"/>
                          <a:pt x="46306" y="537210"/>
                        </a:cubicBezTo>
                        <a:moveTo>
                          <a:pt x="148522" y="738695"/>
                        </a:moveTo>
                        <a:cubicBezTo>
                          <a:pt x="140461" y="745022"/>
                          <a:pt x="132318" y="744850"/>
                          <a:pt x="124769" y="746760"/>
                        </a:cubicBezTo>
                        <a:moveTo>
                          <a:pt x="353256" y="827405"/>
                        </a:moveTo>
                        <a:cubicBezTo>
                          <a:pt x="348714" y="816800"/>
                          <a:pt x="342097" y="803684"/>
                          <a:pt x="338935" y="790575"/>
                        </a:cubicBezTo>
                        <a:moveTo>
                          <a:pt x="617994" y="735562"/>
                        </a:moveTo>
                        <a:cubicBezTo>
                          <a:pt x="615161" y="749958"/>
                          <a:pt x="615206" y="761646"/>
                          <a:pt x="612270" y="775970"/>
                        </a:cubicBezTo>
                        <a:moveTo>
                          <a:pt x="731659" y="485859"/>
                        </a:moveTo>
                        <a:cubicBezTo>
                          <a:pt x="757104" y="520467"/>
                          <a:pt x="800960" y="584526"/>
                          <a:pt x="801354" y="636905"/>
                        </a:cubicBezTo>
                        <a:moveTo>
                          <a:pt x="896067" y="324993"/>
                        </a:moveTo>
                        <a:cubicBezTo>
                          <a:pt x="887389" y="345337"/>
                          <a:pt x="880596" y="366416"/>
                          <a:pt x="865025" y="381635"/>
                        </a:cubicBezTo>
                        <a:moveTo>
                          <a:pt x="821592" y="114850"/>
                        </a:moveTo>
                        <a:cubicBezTo>
                          <a:pt x="820128" y="123423"/>
                          <a:pt x="822589" y="132954"/>
                          <a:pt x="823221" y="141605"/>
                        </a:cubicBezTo>
                        <a:moveTo>
                          <a:pt x="623375" y="83650"/>
                        </a:moveTo>
                        <a:cubicBezTo>
                          <a:pt x="626548" y="70286"/>
                          <a:pt x="632875" y="58419"/>
                          <a:pt x="639282" y="49530"/>
                        </a:cubicBezTo>
                        <a:moveTo>
                          <a:pt x="474659" y="99906"/>
                        </a:moveTo>
                        <a:cubicBezTo>
                          <a:pt x="476015" y="90132"/>
                          <a:pt x="478087" y="81859"/>
                          <a:pt x="482356" y="70485"/>
                        </a:cubicBezTo>
                        <a:moveTo>
                          <a:pt x="300132" y="109897"/>
                        </a:moveTo>
                        <a:cubicBezTo>
                          <a:pt x="308469" y="118284"/>
                          <a:pt x="320059" y="128707"/>
                          <a:pt x="328002" y="138430"/>
                        </a:cubicBezTo>
                        <a:moveTo>
                          <a:pt x="88474" y="334200"/>
                        </a:moveTo>
                        <a:cubicBezTo>
                          <a:pt x="84869" y="324137"/>
                          <a:pt x="84568" y="312557"/>
                          <a:pt x="83608" y="304165"/>
                        </a:cubicBezTo>
                      </a:path>
                    </a:pathLst>
                  </a:custGeom>
                  <ask:type>
                    <ask:lineSketchNone/>
                  </ask:type>
                </ask:lineSketchStyleProps>
              </a:ext>
            </a:extLst>
          </a:ln>
          <a:effectLst/>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latin typeface="Arial" panose="020B0604020202020204" pitchFamily="34" charset="0"/>
              <a:cs typeface="Arial" panose="020B0604020202020204" pitchFamily="34" charset="0"/>
            </a:endParaRPr>
          </a:p>
        </p:txBody>
      </p:sp>
      <p:sp>
        <p:nvSpPr>
          <p:cNvPr id="1029" name="ZoneTexte 1028">
            <a:extLst>
              <a:ext uri="{FF2B5EF4-FFF2-40B4-BE49-F238E27FC236}">
                <a16:creationId xmlns:a16="http://schemas.microsoft.com/office/drawing/2014/main" id="{8F8AE657-B79A-EE14-D0DB-7864CE5B3FCD}"/>
              </a:ext>
            </a:extLst>
          </p:cNvPr>
          <p:cNvSpPr txBox="1"/>
          <p:nvPr/>
        </p:nvSpPr>
        <p:spPr>
          <a:xfrm>
            <a:off x="8459431" y="5629433"/>
            <a:ext cx="2608406"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Protein of interest (POI)</a:t>
            </a:r>
          </a:p>
        </p:txBody>
      </p:sp>
      <p:sp>
        <p:nvSpPr>
          <p:cNvPr id="1030" name="Arc 1029">
            <a:extLst>
              <a:ext uri="{FF2B5EF4-FFF2-40B4-BE49-F238E27FC236}">
                <a16:creationId xmlns:a16="http://schemas.microsoft.com/office/drawing/2014/main" id="{E7E717E6-AF88-3E70-13D9-041DB85951B3}"/>
              </a:ext>
            </a:extLst>
          </p:cNvPr>
          <p:cNvSpPr/>
          <p:nvPr/>
        </p:nvSpPr>
        <p:spPr>
          <a:xfrm rot="17195374">
            <a:off x="2378106" y="5701085"/>
            <a:ext cx="554812" cy="543629"/>
          </a:xfrm>
          <a:prstGeom prst="arc">
            <a:avLst>
              <a:gd name="adj1" fmla="val 16200000"/>
              <a:gd name="adj2" fmla="val 3448526"/>
            </a:avLst>
          </a:prstGeom>
          <a:ln w="152400">
            <a:solidFill>
              <a:schemeClr val="accent2">
                <a:lumMod val="7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031" name="ZoneTexte 1030">
            <a:extLst>
              <a:ext uri="{FF2B5EF4-FFF2-40B4-BE49-F238E27FC236}">
                <a16:creationId xmlns:a16="http://schemas.microsoft.com/office/drawing/2014/main" id="{511DB28E-B40E-F9AA-AEA2-96901EFB40B5}"/>
              </a:ext>
            </a:extLst>
          </p:cNvPr>
          <p:cNvSpPr txBox="1"/>
          <p:nvPr/>
        </p:nvSpPr>
        <p:spPr>
          <a:xfrm>
            <a:off x="3056171" y="5629433"/>
            <a:ext cx="671979"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RNA</a:t>
            </a:r>
          </a:p>
        </p:txBody>
      </p:sp>
      <p:sp>
        <p:nvSpPr>
          <p:cNvPr id="1032" name="ZoneTexte 1031">
            <a:extLst>
              <a:ext uri="{FF2B5EF4-FFF2-40B4-BE49-F238E27FC236}">
                <a16:creationId xmlns:a16="http://schemas.microsoft.com/office/drawing/2014/main" id="{2CF170C0-DAC5-CB7A-83D8-0093D70FA4EA}"/>
              </a:ext>
            </a:extLst>
          </p:cNvPr>
          <p:cNvSpPr txBox="1"/>
          <p:nvPr/>
        </p:nvSpPr>
        <p:spPr>
          <a:xfrm>
            <a:off x="9985617" y="4808864"/>
            <a:ext cx="1109598" cy="307777"/>
          </a:xfrm>
          <a:prstGeom prst="rect">
            <a:avLst/>
          </a:prstGeom>
          <a:noFill/>
        </p:spPr>
        <p:txBody>
          <a:bodyPr wrap="none" rtlCol="0">
            <a:spAutoFit/>
          </a:bodyPr>
          <a:lstStyle/>
          <a:p>
            <a:pPr algn="ctr"/>
            <a:r>
              <a:rPr lang="en-US" sz="1400" dirty="0">
                <a:latin typeface="Arial" panose="020B0604020202020204" pitchFamily="34" charset="0"/>
                <a:cs typeface="Arial" panose="020B0604020202020204" pitchFamily="34" charset="0"/>
              </a:rPr>
              <a:t>microtubule</a:t>
            </a:r>
          </a:p>
        </p:txBody>
      </p:sp>
      <p:sp>
        <p:nvSpPr>
          <p:cNvPr id="1033" name="ZoneTexte 1032">
            <a:extLst>
              <a:ext uri="{FF2B5EF4-FFF2-40B4-BE49-F238E27FC236}">
                <a16:creationId xmlns:a16="http://schemas.microsoft.com/office/drawing/2014/main" id="{A08E2D80-6A9D-1DE8-A8FB-08B34D0AD12E}"/>
              </a:ext>
            </a:extLst>
          </p:cNvPr>
          <p:cNvSpPr txBox="1"/>
          <p:nvPr/>
        </p:nvSpPr>
        <p:spPr>
          <a:xfrm>
            <a:off x="724118" y="1967692"/>
            <a:ext cx="1050288" cy="338554"/>
          </a:xfrm>
          <a:prstGeom prst="rect">
            <a:avLst/>
          </a:prstGeom>
          <a:noFill/>
        </p:spPr>
        <p:txBody>
          <a:bodyPr wrap="none" rtlCol="0">
            <a:spAutoFit/>
          </a:bodyPr>
          <a:lstStyle/>
          <a:p>
            <a:pPr algn="ctr"/>
            <a:r>
              <a:rPr lang="en-US" sz="1600" dirty="0">
                <a:latin typeface="Arial" panose="020B0604020202020204" pitchFamily="34" charset="0"/>
                <a:cs typeface="Arial" panose="020B0604020202020204" pitchFamily="34" charset="0"/>
              </a:rPr>
              <a:t>excitation</a:t>
            </a:r>
          </a:p>
        </p:txBody>
      </p:sp>
      <p:sp>
        <p:nvSpPr>
          <p:cNvPr id="1034" name="ZoneTexte 1033">
            <a:extLst>
              <a:ext uri="{FF2B5EF4-FFF2-40B4-BE49-F238E27FC236}">
                <a16:creationId xmlns:a16="http://schemas.microsoft.com/office/drawing/2014/main" id="{C3E8ECA1-9B72-22DC-31AA-B0FB807D266F}"/>
              </a:ext>
            </a:extLst>
          </p:cNvPr>
          <p:cNvSpPr txBox="1"/>
          <p:nvPr/>
        </p:nvSpPr>
        <p:spPr>
          <a:xfrm>
            <a:off x="91927" y="3123088"/>
            <a:ext cx="1669047" cy="584775"/>
          </a:xfrm>
          <a:prstGeom prst="rect">
            <a:avLst/>
          </a:prstGeom>
          <a:noFill/>
        </p:spPr>
        <p:txBody>
          <a:bodyPr wrap="none" rtlCol="0">
            <a:spAutoFit/>
          </a:bodyPr>
          <a:lstStyle/>
          <a:p>
            <a:pPr algn="r"/>
            <a:r>
              <a:rPr lang="en-US" sz="1600" dirty="0">
                <a:solidFill>
                  <a:srgbClr val="00B050"/>
                </a:solidFill>
                <a:latin typeface="Arial" panose="020B0604020202020204" pitchFamily="34" charset="0"/>
                <a:cs typeface="Arial" panose="020B0604020202020204" pitchFamily="34" charset="0"/>
              </a:rPr>
              <a:t>donor</a:t>
            </a:r>
          </a:p>
          <a:p>
            <a:pPr algn="r"/>
            <a:r>
              <a:rPr lang="en-US" sz="1600" dirty="0">
                <a:solidFill>
                  <a:srgbClr val="00B050"/>
                </a:solidFill>
                <a:latin typeface="Arial" panose="020B0604020202020204" pitchFamily="34" charset="0"/>
                <a:cs typeface="Arial" panose="020B0604020202020204" pitchFamily="34" charset="0"/>
              </a:rPr>
              <a:t>(fluorescent tag)</a:t>
            </a:r>
          </a:p>
        </p:txBody>
      </p:sp>
      <p:sp>
        <p:nvSpPr>
          <p:cNvPr id="1035" name="ZoneTexte 1034">
            <a:extLst>
              <a:ext uri="{FF2B5EF4-FFF2-40B4-BE49-F238E27FC236}">
                <a16:creationId xmlns:a16="http://schemas.microsoft.com/office/drawing/2014/main" id="{386F441C-6AC8-4D67-6807-5FA32BA6DF52}"/>
              </a:ext>
            </a:extLst>
          </p:cNvPr>
          <p:cNvSpPr txBox="1"/>
          <p:nvPr/>
        </p:nvSpPr>
        <p:spPr>
          <a:xfrm>
            <a:off x="2773642" y="1964541"/>
            <a:ext cx="1518923" cy="830997"/>
          </a:xfrm>
          <a:prstGeom prst="rect">
            <a:avLst/>
          </a:prstGeom>
          <a:noFill/>
        </p:spPr>
        <p:txBody>
          <a:bodyPr wrap="square" rtlCol="0">
            <a:spAutoFit/>
          </a:bodyPr>
          <a:lstStyle/>
          <a:p>
            <a:pPr algn="ctr"/>
            <a:r>
              <a:rPr lang="en-US" sz="1600" dirty="0">
                <a:solidFill>
                  <a:srgbClr val="FF0000"/>
                </a:solidFill>
                <a:latin typeface="Arial" panose="020B0604020202020204" pitchFamily="34" charset="0"/>
                <a:cs typeface="Arial" panose="020B0604020202020204" pitchFamily="34" charset="0"/>
              </a:rPr>
              <a:t>acceptor</a:t>
            </a:r>
          </a:p>
          <a:p>
            <a:pPr algn="ctr"/>
            <a:r>
              <a:rPr lang="en-US" sz="1600" dirty="0">
                <a:solidFill>
                  <a:srgbClr val="FF0000"/>
                </a:solidFill>
                <a:latin typeface="Arial" panose="020B0604020202020204" pitchFamily="34" charset="0"/>
                <a:cs typeface="Arial" panose="020B0604020202020204" pitchFamily="34" charset="0"/>
              </a:rPr>
              <a:t>(RNA probe, MS2 tag?)</a:t>
            </a:r>
          </a:p>
        </p:txBody>
      </p:sp>
      <p:sp>
        <p:nvSpPr>
          <p:cNvPr id="1036" name="ZoneTexte 1035">
            <a:extLst>
              <a:ext uri="{FF2B5EF4-FFF2-40B4-BE49-F238E27FC236}">
                <a16:creationId xmlns:a16="http://schemas.microsoft.com/office/drawing/2014/main" id="{BBD70769-6576-F610-DE9E-2ABF65EA1BAF}"/>
              </a:ext>
            </a:extLst>
          </p:cNvPr>
          <p:cNvSpPr txBox="1"/>
          <p:nvPr/>
        </p:nvSpPr>
        <p:spPr>
          <a:xfrm>
            <a:off x="9836537" y="3935880"/>
            <a:ext cx="606256" cy="338554"/>
          </a:xfrm>
          <a:prstGeom prst="rect">
            <a:avLst/>
          </a:prstGeom>
          <a:noFill/>
        </p:spPr>
        <p:txBody>
          <a:bodyPr wrap="none" rtlCol="0">
            <a:spAutoFit/>
          </a:bodyPr>
          <a:lstStyle/>
          <a:p>
            <a:pPr algn="ctr"/>
            <a:r>
              <a:rPr lang="en-US" sz="1600" dirty="0">
                <a:solidFill>
                  <a:srgbClr val="00B050"/>
                </a:solidFill>
                <a:latin typeface="Arial" panose="020B0604020202020204" pitchFamily="34" charset="0"/>
                <a:cs typeface="Arial" panose="020B0604020202020204" pitchFamily="34" charset="0"/>
              </a:rPr>
              <a:t>GFP</a:t>
            </a:r>
          </a:p>
        </p:txBody>
      </p:sp>
      <p:sp>
        <p:nvSpPr>
          <p:cNvPr id="1037" name="ZoneTexte 1036">
            <a:extLst>
              <a:ext uri="{FF2B5EF4-FFF2-40B4-BE49-F238E27FC236}">
                <a16:creationId xmlns:a16="http://schemas.microsoft.com/office/drawing/2014/main" id="{6B97A3D9-CE08-8FA2-8236-41B344DD925A}"/>
              </a:ext>
            </a:extLst>
          </p:cNvPr>
          <p:cNvSpPr txBox="1"/>
          <p:nvPr/>
        </p:nvSpPr>
        <p:spPr>
          <a:xfrm>
            <a:off x="9356998" y="4322181"/>
            <a:ext cx="583814" cy="307777"/>
          </a:xfrm>
          <a:prstGeom prst="rect">
            <a:avLst/>
          </a:prstGeom>
          <a:noFill/>
        </p:spPr>
        <p:txBody>
          <a:bodyPr wrap="none" rtlCol="0">
            <a:spAutoFit/>
          </a:bodyPr>
          <a:lstStyle/>
          <a:p>
            <a:pPr algn="ctr"/>
            <a:r>
              <a:rPr lang="en-US" sz="1400" dirty="0">
                <a:solidFill>
                  <a:schemeClr val="bg1">
                    <a:lumMod val="65000"/>
                  </a:schemeClr>
                </a:solidFill>
                <a:latin typeface="Arial" panose="020B0604020202020204" pitchFamily="34" charset="0"/>
                <a:cs typeface="Arial" panose="020B0604020202020204" pitchFamily="34" charset="0"/>
              </a:rPr>
              <a:t>MBD</a:t>
            </a:r>
          </a:p>
        </p:txBody>
      </p:sp>
      <p:sp>
        <p:nvSpPr>
          <p:cNvPr id="42" name="Nuage 41">
            <a:extLst>
              <a:ext uri="{FF2B5EF4-FFF2-40B4-BE49-F238E27FC236}">
                <a16:creationId xmlns:a16="http://schemas.microsoft.com/office/drawing/2014/main" id="{533EEF00-70C6-069B-7145-19580A82374C}"/>
              </a:ext>
            </a:extLst>
          </p:cNvPr>
          <p:cNvSpPr/>
          <p:nvPr/>
        </p:nvSpPr>
        <p:spPr>
          <a:xfrm>
            <a:off x="1909947" y="3426932"/>
            <a:ext cx="487336" cy="381803"/>
          </a:xfrm>
          <a:prstGeom prst="cloud">
            <a:avLst/>
          </a:prstGeom>
          <a:solidFill>
            <a:srgbClr val="00B050"/>
          </a:solidFill>
          <a:ln>
            <a:noFill/>
            <a:extLst>
              <a:ext uri="{C807C97D-BFC1-408E-A445-0C87EB9F89A2}">
                <ask:lineSketchStyleProps xmlns:ask="http://schemas.microsoft.com/office/drawing/2018/sketchyshapes" sd="1219033472">
                  <a:custGeom>
                    <a:avLst/>
                    <a:gdLst>
                      <a:gd name="connsiteX0" fmla="*/ 83608 w 926124"/>
                      <a:gd name="connsiteY0" fmla="*/ 304165 h 914400"/>
                      <a:gd name="connsiteX1" fmla="*/ 120546 w 926124"/>
                      <a:gd name="connsiteY1" fmla="*/ 146198 h 914400"/>
                      <a:gd name="connsiteX2" fmla="*/ 300239 w 926124"/>
                      <a:gd name="connsiteY2" fmla="*/ 110109 h 914400"/>
                      <a:gd name="connsiteX3" fmla="*/ 481412 w 926124"/>
                      <a:gd name="connsiteY3" fmla="*/ 72644 h 914400"/>
                      <a:gd name="connsiteX4" fmla="*/ 552008 w 926124"/>
                      <a:gd name="connsiteY4" fmla="*/ 4233 h 914400"/>
                      <a:gd name="connsiteX5" fmla="*/ 639561 w 926124"/>
                      <a:gd name="connsiteY5" fmla="*/ 52514 h 914400"/>
                      <a:gd name="connsiteX6" fmla="*/ 760257 w 926124"/>
                      <a:gd name="connsiteY6" fmla="*/ 14605 h 914400"/>
                      <a:gd name="connsiteX7" fmla="*/ 821463 w 926124"/>
                      <a:gd name="connsiteY7" fmla="*/ 118025 h 914400"/>
                      <a:gd name="connsiteX8" fmla="*/ 900012 w 926124"/>
                      <a:gd name="connsiteY8" fmla="*/ 218397 h 914400"/>
                      <a:gd name="connsiteX9" fmla="*/ 896496 w 926124"/>
                      <a:gd name="connsiteY9" fmla="*/ 327236 h 914400"/>
                      <a:gd name="connsiteX10" fmla="*/ 922179 w 926124"/>
                      <a:gd name="connsiteY10" fmla="*/ 493649 h 914400"/>
                      <a:gd name="connsiteX11" fmla="*/ 801869 w 926124"/>
                      <a:gd name="connsiteY11" fmla="*/ 639318 h 914400"/>
                      <a:gd name="connsiteX12" fmla="*/ 758799 w 926124"/>
                      <a:gd name="connsiteY12" fmla="*/ 764137 h 914400"/>
                      <a:gd name="connsiteX13" fmla="*/ 612163 w 926124"/>
                      <a:gd name="connsiteY13" fmla="*/ 779250 h 914400"/>
                      <a:gd name="connsiteX14" fmla="*/ 507374 w 926124"/>
                      <a:gd name="connsiteY14" fmla="*/ 912410 h 914400"/>
                      <a:gd name="connsiteX15" fmla="*/ 353299 w 926124"/>
                      <a:gd name="connsiteY15" fmla="*/ 831130 h 914400"/>
                      <a:gd name="connsiteX16" fmla="*/ 124426 w 926124"/>
                      <a:gd name="connsiteY16" fmla="*/ 750824 h 914400"/>
                      <a:gd name="connsiteX17" fmla="*/ 23796 w 926124"/>
                      <a:gd name="connsiteY17" fmla="*/ 661458 h 914400"/>
                      <a:gd name="connsiteX18" fmla="*/ 45298 w 926124"/>
                      <a:gd name="connsiteY18" fmla="*/ 540829 h 914400"/>
                      <a:gd name="connsiteX19" fmla="*/ -108 w 926124"/>
                      <a:gd name="connsiteY19" fmla="*/ 417068 h 914400"/>
                      <a:gd name="connsiteX20" fmla="*/ 82815 w 926124"/>
                      <a:gd name="connsiteY20" fmla="*/ 307064 h 914400"/>
                      <a:gd name="connsiteX21" fmla="*/ 83608 w 926124"/>
                      <a:gd name="connsiteY21" fmla="*/ 304165 h 914400"/>
                      <a:gd name="connsiteX0" fmla="*/ 100608 w 926124"/>
                      <a:gd name="connsiteY0" fmla="*/ 554079 h 914400"/>
                      <a:gd name="connsiteX1" fmla="*/ 46306 w 926124"/>
                      <a:gd name="connsiteY1" fmla="*/ 537210 h 914400"/>
                      <a:gd name="connsiteX2" fmla="*/ 148522 w 926124"/>
                      <a:gd name="connsiteY2" fmla="*/ 738695 h 914400"/>
                      <a:gd name="connsiteX3" fmla="*/ 124769 w 926124"/>
                      <a:gd name="connsiteY3" fmla="*/ 746760 h 914400"/>
                      <a:gd name="connsiteX4" fmla="*/ 353256 w 926124"/>
                      <a:gd name="connsiteY4" fmla="*/ 827405 h 914400"/>
                      <a:gd name="connsiteX5" fmla="*/ 338935 w 926124"/>
                      <a:gd name="connsiteY5" fmla="*/ 790575 h 914400"/>
                      <a:gd name="connsiteX6" fmla="*/ 617994 w 926124"/>
                      <a:gd name="connsiteY6" fmla="*/ 735562 h 914400"/>
                      <a:gd name="connsiteX7" fmla="*/ 612270 w 926124"/>
                      <a:gd name="connsiteY7" fmla="*/ 775970 h 914400"/>
                      <a:gd name="connsiteX8" fmla="*/ 731659 w 926124"/>
                      <a:gd name="connsiteY8" fmla="*/ 485859 h 914400"/>
                      <a:gd name="connsiteX9" fmla="*/ 801354 w 926124"/>
                      <a:gd name="connsiteY9" fmla="*/ 636905 h 914400"/>
                      <a:gd name="connsiteX10" fmla="*/ 896067 w 926124"/>
                      <a:gd name="connsiteY10" fmla="*/ 324993 h 914400"/>
                      <a:gd name="connsiteX11" fmla="*/ 865025 w 926124"/>
                      <a:gd name="connsiteY11" fmla="*/ 381635 h 914400"/>
                      <a:gd name="connsiteX12" fmla="*/ 821592 w 926124"/>
                      <a:gd name="connsiteY12" fmla="*/ 114850 h 914400"/>
                      <a:gd name="connsiteX13" fmla="*/ 823221 w 926124"/>
                      <a:gd name="connsiteY13" fmla="*/ 141605 h 914400"/>
                      <a:gd name="connsiteX14" fmla="*/ 623375 w 926124"/>
                      <a:gd name="connsiteY14" fmla="*/ 83650 h 914400"/>
                      <a:gd name="connsiteX15" fmla="*/ 639282 w 926124"/>
                      <a:gd name="connsiteY15" fmla="*/ 49530 h 914400"/>
                      <a:gd name="connsiteX16" fmla="*/ 474659 w 926124"/>
                      <a:gd name="connsiteY16" fmla="*/ 99906 h 914400"/>
                      <a:gd name="connsiteX17" fmla="*/ 482356 w 926124"/>
                      <a:gd name="connsiteY17" fmla="*/ 70485 h 914400"/>
                      <a:gd name="connsiteX18" fmla="*/ 300132 w 926124"/>
                      <a:gd name="connsiteY18" fmla="*/ 109897 h 914400"/>
                      <a:gd name="connsiteX19" fmla="*/ 328002 w 926124"/>
                      <a:gd name="connsiteY19" fmla="*/ 138430 h 914400"/>
                      <a:gd name="connsiteX20" fmla="*/ 88474 w 926124"/>
                      <a:gd name="connsiteY20" fmla="*/ 334200 h 914400"/>
                      <a:gd name="connsiteX21" fmla="*/ 83608 w 926124"/>
                      <a:gd name="connsiteY21" fmla="*/ 304165 h 9144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926124" h="914400" fill="none" extrusionOk="0">
                        <a:moveTo>
                          <a:pt x="83608" y="304165"/>
                        </a:moveTo>
                        <a:cubicBezTo>
                          <a:pt x="71337" y="259709"/>
                          <a:pt x="89078" y="185816"/>
                          <a:pt x="120546" y="146198"/>
                        </a:cubicBezTo>
                        <a:cubicBezTo>
                          <a:pt x="180294" y="83133"/>
                          <a:pt x="240544" y="44472"/>
                          <a:pt x="300239" y="110109"/>
                        </a:cubicBezTo>
                        <a:cubicBezTo>
                          <a:pt x="343738" y="24049"/>
                          <a:pt x="411423" y="3865"/>
                          <a:pt x="481412" y="72644"/>
                        </a:cubicBezTo>
                        <a:cubicBezTo>
                          <a:pt x="494012" y="39184"/>
                          <a:pt x="519547" y="3742"/>
                          <a:pt x="552008" y="4233"/>
                        </a:cubicBezTo>
                        <a:cubicBezTo>
                          <a:pt x="591139" y="-6367"/>
                          <a:pt x="621071" y="12742"/>
                          <a:pt x="639561" y="52514"/>
                        </a:cubicBezTo>
                        <a:cubicBezTo>
                          <a:pt x="661000" y="2512"/>
                          <a:pt x="727085" y="-18478"/>
                          <a:pt x="760257" y="14605"/>
                        </a:cubicBezTo>
                        <a:cubicBezTo>
                          <a:pt x="781805" y="39036"/>
                          <a:pt x="816997" y="76594"/>
                          <a:pt x="821463" y="118025"/>
                        </a:cubicBezTo>
                        <a:cubicBezTo>
                          <a:pt x="862700" y="130782"/>
                          <a:pt x="887054" y="172857"/>
                          <a:pt x="900012" y="218397"/>
                        </a:cubicBezTo>
                        <a:cubicBezTo>
                          <a:pt x="911392" y="254804"/>
                          <a:pt x="905949" y="287720"/>
                          <a:pt x="896496" y="327236"/>
                        </a:cubicBezTo>
                        <a:cubicBezTo>
                          <a:pt x="935652" y="374908"/>
                          <a:pt x="941457" y="444601"/>
                          <a:pt x="922179" y="493649"/>
                        </a:cubicBezTo>
                        <a:cubicBezTo>
                          <a:pt x="917821" y="580107"/>
                          <a:pt x="864011" y="637252"/>
                          <a:pt x="801869" y="639318"/>
                        </a:cubicBezTo>
                        <a:cubicBezTo>
                          <a:pt x="807488" y="693136"/>
                          <a:pt x="780739" y="725942"/>
                          <a:pt x="758799" y="764137"/>
                        </a:cubicBezTo>
                        <a:cubicBezTo>
                          <a:pt x="716295" y="813096"/>
                          <a:pt x="670149" y="820532"/>
                          <a:pt x="612163" y="779250"/>
                        </a:cubicBezTo>
                        <a:cubicBezTo>
                          <a:pt x="603395" y="839019"/>
                          <a:pt x="553129" y="888687"/>
                          <a:pt x="507374" y="912410"/>
                        </a:cubicBezTo>
                        <a:cubicBezTo>
                          <a:pt x="436158" y="937157"/>
                          <a:pt x="387522" y="907165"/>
                          <a:pt x="353299" y="831130"/>
                        </a:cubicBezTo>
                        <a:cubicBezTo>
                          <a:pt x="260389" y="880211"/>
                          <a:pt x="191762" y="836405"/>
                          <a:pt x="124426" y="750824"/>
                        </a:cubicBezTo>
                        <a:cubicBezTo>
                          <a:pt x="88896" y="769993"/>
                          <a:pt x="52190" y="722855"/>
                          <a:pt x="23796" y="661458"/>
                        </a:cubicBezTo>
                        <a:cubicBezTo>
                          <a:pt x="5689" y="622220"/>
                          <a:pt x="22538" y="566743"/>
                          <a:pt x="45298" y="540829"/>
                        </a:cubicBezTo>
                        <a:cubicBezTo>
                          <a:pt x="14203" y="506065"/>
                          <a:pt x="-2065" y="459478"/>
                          <a:pt x="-108" y="417068"/>
                        </a:cubicBezTo>
                        <a:cubicBezTo>
                          <a:pt x="3361" y="358891"/>
                          <a:pt x="45535" y="303762"/>
                          <a:pt x="82815" y="307064"/>
                        </a:cubicBezTo>
                        <a:cubicBezTo>
                          <a:pt x="83174" y="306011"/>
                          <a:pt x="83501" y="305126"/>
                          <a:pt x="83608" y="304165"/>
                        </a:cubicBezTo>
                        <a:close/>
                      </a:path>
                      <a:path w="926124" h="914400" fill="none" extrusionOk="0">
                        <a:moveTo>
                          <a:pt x="100608" y="554079"/>
                        </a:moveTo>
                        <a:cubicBezTo>
                          <a:pt x="82473" y="554508"/>
                          <a:pt x="64241" y="548588"/>
                          <a:pt x="46306" y="537210"/>
                        </a:cubicBezTo>
                        <a:moveTo>
                          <a:pt x="148522" y="738695"/>
                        </a:moveTo>
                        <a:cubicBezTo>
                          <a:pt x="142839" y="741453"/>
                          <a:pt x="134619" y="744048"/>
                          <a:pt x="124769" y="746760"/>
                        </a:cubicBezTo>
                        <a:moveTo>
                          <a:pt x="353256" y="827405"/>
                        </a:moveTo>
                        <a:cubicBezTo>
                          <a:pt x="348060" y="818827"/>
                          <a:pt x="343509" y="802778"/>
                          <a:pt x="338935" y="790575"/>
                        </a:cubicBezTo>
                        <a:moveTo>
                          <a:pt x="617994" y="735562"/>
                        </a:moveTo>
                        <a:cubicBezTo>
                          <a:pt x="620346" y="749453"/>
                          <a:pt x="615005" y="760028"/>
                          <a:pt x="612270" y="775970"/>
                        </a:cubicBezTo>
                        <a:moveTo>
                          <a:pt x="731659" y="485859"/>
                        </a:moveTo>
                        <a:cubicBezTo>
                          <a:pt x="767886" y="514709"/>
                          <a:pt x="810093" y="582907"/>
                          <a:pt x="801354" y="636905"/>
                        </a:cubicBezTo>
                        <a:moveTo>
                          <a:pt x="896067" y="324993"/>
                        </a:moveTo>
                        <a:cubicBezTo>
                          <a:pt x="887796" y="350013"/>
                          <a:pt x="882311" y="364882"/>
                          <a:pt x="865025" y="381635"/>
                        </a:cubicBezTo>
                        <a:moveTo>
                          <a:pt x="821592" y="114850"/>
                        </a:moveTo>
                        <a:cubicBezTo>
                          <a:pt x="822863" y="123456"/>
                          <a:pt x="825677" y="133667"/>
                          <a:pt x="823221" y="141605"/>
                        </a:cubicBezTo>
                        <a:moveTo>
                          <a:pt x="623375" y="83650"/>
                        </a:moveTo>
                        <a:cubicBezTo>
                          <a:pt x="628665" y="69366"/>
                          <a:pt x="635344" y="58957"/>
                          <a:pt x="639282" y="49530"/>
                        </a:cubicBezTo>
                        <a:moveTo>
                          <a:pt x="474659" y="99906"/>
                        </a:moveTo>
                        <a:cubicBezTo>
                          <a:pt x="478201" y="90042"/>
                          <a:pt x="479087" y="82159"/>
                          <a:pt x="482356" y="70485"/>
                        </a:cubicBezTo>
                        <a:moveTo>
                          <a:pt x="300132" y="109897"/>
                        </a:moveTo>
                        <a:cubicBezTo>
                          <a:pt x="309763" y="117673"/>
                          <a:pt x="321642" y="127309"/>
                          <a:pt x="328002" y="138430"/>
                        </a:cubicBezTo>
                        <a:moveTo>
                          <a:pt x="88474" y="334200"/>
                        </a:moveTo>
                        <a:cubicBezTo>
                          <a:pt x="86238" y="323175"/>
                          <a:pt x="85815" y="313492"/>
                          <a:pt x="83608" y="304165"/>
                        </a:cubicBezTo>
                      </a:path>
                      <a:path w="926124" h="914400" stroke="0" extrusionOk="0">
                        <a:moveTo>
                          <a:pt x="83608" y="304165"/>
                        </a:moveTo>
                        <a:cubicBezTo>
                          <a:pt x="66932" y="240037"/>
                          <a:pt x="81174" y="192645"/>
                          <a:pt x="120546" y="146198"/>
                        </a:cubicBezTo>
                        <a:cubicBezTo>
                          <a:pt x="186588" y="83058"/>
                          <a:pt x="232151" y="64156"/>
                          <a:pt x="300239" y="110109"/>
                        </a:cubicBezTo>
                        <a:cubicBezTo>
                          <a:pt x="323746" y="31309"/>
                          <a:pt x="422981" y="22222"/>
                          <a:pt x="481412" y="72644"/>
                        </a:cubicBezTo>
                        <a:cubicBezTo>
                          <a:pt x="490727" y="33201"/>
                          <a:pt x="522797" y="10631"/>
                          <a:pt x="552008" y="4233"/>
                        </a:cubicBezTo>
                        <a:cubicBezTo>
                          <a:pt x="590055" y="-1623"/>
                          <a:pt x="623701" y="6671"/>
                          <a:pt x="639561" y="52514"/>
                        </a:cubicBezTo>
                        <a:cubicBezTo>
                          <a:pt x="667761" y="5433"/>
                          <a:pt x="714039" y="-5823"/>
                          <a:pt x="760257" y="14605"/>
                        </a:cubicBezTo>
                        <a:cubicBezTo>
                          <a:pt x="791039" y="21051"/>
                          <a:pt x="813129" y="74968"/>
                          <a:pt x="821463" y="118025"/>
                        </a:cubicBezTo>
                        <a:cubicBezTo>
                          <a:pt x="860627" y="132800"/>
                          <a:pt x="890405" y="169868"/>
                          <a:pt x="900012" y="218397"/>
                        </a:cubicBezTo>
                        <a:cubicBezTo>
                          <a:pt x="905376" y="253498"/>
                          <a:pt x="914442" y="298438"/>
                          <a:pt x="896496" y="327236"/>
                        </a:cubicBezTo>
                        <a:cubicBezTo>
                          <a:pt x="927721" y="380763"/>
                          <a:pt x="934588" y="452437"/>
                          <a:pt x="922179" y="493649"/>
                        </a:cubicBezTo>
                        <a:cubicBezTo>
                          <a:pt x="911761" y="576604"/>
                          <a:pt x="871426" y="641770"/>
                          <a:pt x="801869" y="639318"/>
                        </a:cubicBezTo>
                        <a:cubicBezTo>
                          <a:pt x="804649" y="684623"/>
                          <a:pt x="788286" y="721477"/>
                          <a:pt x="758799" y="764137"/>
                        </a:cubicBezTo>
                        <a:cubicBezTo>
                          <a:pt x="706752" y="813532"/>
                          <a:pt x="644367" y="808290"/>
                          <a:pt x="612163" y="779250"/>
                        </a:cubicBezTo>
                        <a:cubicBezTo>
                          <a:pt x="595019" y="845407"/>
                          <a:pt x="554883" y="891194"/>
                          <a:pt x="507374" y="912410"/>
                        </a:cubicBezTo>
                        <a:cubicBezTo>
                          <a:pt x="449816" y="913121"/>
                          <a:pt x="380720" y="902665"/>
                          <a:pt x="353299" y="831130"/>
                        </a:cubicBezTo>
                        <a:cubicBezTo>
                          <a:pt x="266890" y="907926"/>
                          <a:pt x="175732" y="863187"/>
                          <a:pt x="124426" y="750824"/>
                        </a:cubicBezTo>
                        <a:cubicBezTo>
                          <a:pt x="78787" y="765544"/>
                          <a:pt x="37828" y="719416"/>
                          <a:pt x="23796" y="661458"/>
                        </a:cubicBezTo>
                        <a:cubicBezTo>
                          <a:pt x="13604" y="620487"/>
                          <a:pt x="18510" y="573354"/>
                          <a:pt x="45298" y="540829"/>
                        </a:cubicBezTo>
                        <a:cubicBezTo>
                          <a:pt x="16289" y="521471"/>
                          <a:pt x="-7050" y="468182"/>
                          <a:pt x="-108" y="417068"/>
                        </a:cubicBezTo>
                        <a:cubicBezTo>
                          <a:pt x="7028" y="347859"/>
                          <a:pt x="33266" y="312720"/>
                          <a:pt x="82815" y="307064"/>
                        </a:cubicBezTo>
                        <a:cubicBezTo>
                          <a:pt x="83208" y="306208"/>
                          <a:pt x="83291" y="305318"/>
                          <a:pt x="83608" y="304165"/>
                        </a:cubicBezTo>
                        <a:close/>
                      </a:path>
                      <a:path w="926124" h="914400" fill="none" stroke="0" extrusionOk="0">
                        <a:moveTo>
                          <a:pt x="100608" y="554079"/>
                        </a:moveTo>
                        <a:cubicBezTo>
                          <a:pt x="82651" y="552223"/>
                          <a:pt x="64096" y="544965"/>
                          <a:pt x="46306" y="537210"/>
                        </a:cubicBezTo>
                        <a:moveTo>
                          <a:pt x="148522" y="738695"/>
                        </a:moveTo>
                        <a:cubicBezTo>
                          <a:pt x="140461" y="745022"/>
                          <a:pt x="132318" y="744850"/>
                          <a:pt x="124769" y="746760"/>
                        </a:cubicBezTo>
                        <a:moveTo>
                          <a:pt x="353256" y="827405"/>
                        </a:moveTo>
                        <a:cubicBezTo>
                          <a:pt x="348714" y="816800"/>
                          <a:pt x="342097" y="803684"/>
                          <a:pt x="338935" y="790575"/>
                        </a:cubicBezTo>
                        <a:moveTo>
                          <a:pt x="617994" y="735562"/>
                        </a:moveTo>
                        <a:cubicBezTo>
                          <a:pt x="615161" y="749958"/>
                          <a:pt x="615206" y="761646"/>
                          <a:pt x="612270" y="775970"/>
                        </a:cubicBezTo>
                        <a:moveTo>
                          <a:pt x="731659" y="485859"/>
                        </a:moveTo>
                        <a:cubicBezTo>
                          <a:pt x="757104" y="520467"/>
                          <a:pt x="800960" y="584526"/>
                          <a:pt x="801354" y="636905"/>
                        </a:cubicBezTo>
                        <a:moveTo>
                          <a:pt x="896067" y="324993"/>
                        </a:moveTo>
                        <a:cubicBezTo>
                          <a:pt x="887389" y="345337"/>
                          <a:pt x="880596" y="366416"/>
                          <a:pt x="865025" y="381635"/>
                        </a:cubicBezTo>
                        <a:moveTo>
                          <a:pt x="821592" y="114850"/>
                        </a:moveTo>
                        <a:cubicBezTo>
                          <a:pt x="820128" y="123423"/>
                          <a:pt x="822589" y="132954"/>
                          <a:pt x="823221" y="141605"/>
                        </a:cubicBezTo>
                        <a:moveTo>
                          <a:pt x="623375" y="83650"/>
                        </a:moveTo>
                        <a:cubicBezTo>
                          <a:pt x="626548" y="70286"/>
                          <a:pt x="632875" y="58419"/>
                          <a:pt x="639282" y="49530"/>
                        </a:cubicBezTo>
                        <a:moveTo>
                          <a:pt x="474659" y="99906"/>
                        </a:moveTo>
                        <a:cubicBezTo>
                          <a:pt x="476015" y="90132"/>
                          <a:pt x="478087" y="81859"/>
                          <a:pt x="482356" y="70485"/>
                        </a:cubicBezTo>
                        <a:moveTo>
                          <a:pt x="300132" y="109897"/>
                        </a:moveTo>
                        <a:cubicBezTo>
                          <a:pt x="308469" y="118284"/>
                          <a:pt x="320059" y="128707"/>
                          <a:pt x="328002" y="138430"/>
                        </a:cubicBezTo>
                        <a:moveTo>
                          <a:pt x="88474" y="334200"/>
                        </a:moveTo>
                        <a:cubicBezTo>
                          <a:pt x="84869" y="324137"/>
                          <a:pt x="84568" y="312557"/>
                          <a:pt x="83608" y="304165"/>
                        </a:cubicBezTo>
                      </a:path>
                    </a:pathLst>
                  </a:custGeom>
                  <ask:type>
                    <ask:lineSketchNone/>
                  </ask:type>
                </ask:lineSketchStyleProps>
              </a:ext>
            </a:extLst>
          </a:ln>
          <a:effectLst>
            <a:glow rad="704318">
              <a:srgbClr val="00B050">
                <a:alpha val="45846"/>
              </a:srgbClr>
            </a:glow>
          </a:effectLst>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Nuage 12">
            <a:extLst>
              <a:ext uri="{FF2B5EF4-FFF2-40B4-BE49-F238E27FC236}">
                <a16:creationId xmlns:a16="http://schemas.microsoft.com/office/drawing/2014/main" id="{82972801-C4E8-5892-621C-E64C24AB4F59}"/>
              </a:ext>
            </a:extLst>
          </p:cNvPr>
          <p:cNvSpPr/>
          <p:nvPr/>
        </p:nvSpPr>
        <p:spPr>
          <a:xfrm>
            <a:off x="5751956" y="3756767"/>
            <a:ext cx="926124" cy="914400"/>
          </a:xfrm>
          <a:prstGeom prst="cloud">
            <a:avLst/>
          </a:prstGeom>
          <a:solidFill>
            <a:schemeClr val="accent1"/>
          </a:solidFill>
          <a:ln>
            <a:noFill/>
            <a:extLst>
              <a:ext uri="{C807C97D-BFC1-408E-A445-0C87EB9F89A2}">
                <ask:lineSketchStyleProps xmlns:ask="http://schemas.microsoft.com/office/drawing/2018/sketchyshapes" sd="1219033472">
                  <a:custGeom>
                    <a:avLst/>
                    <a:gdLst>
                      <a:gd name="connsiteX0" fmla="*/ 83608 w 926124"/>
                      <a:gd name="connsiteY0" fmla="*/ 304165 h 914400"/>
                      <a:gd name="connsiteX1" fmla="*/ 120546 w 926124"/>
                      <a:gd name="connsiteY1" fmla="*/ 146198 h 914400"/>
                      <a:gd name="connsiteX2" fmla="*/ 300239 w 926124"/>
                      <a:gd name="connsiteY2" fmla="*/ 110109 h 914400"/>
                      <a:gd name="connsiteX3" fmla="*/ 481412 w 926124"/>
                      <a:gd name="connsiteY3" fmla="*/ 72644 h 914400"/>
                      <a:gd name="connsiteX4" fmla="*/ 552008 w 926124"/>
                      <a:gd name="connsiteY4" fmla="*/ 4233 h 914400"/>
                      <a:gd name="connsiteX5" fmla="*/ 639561 w 926124"/>
                      <a:gd name="connsiteY5" fmla="*/ 52514 h 914400"/>
                      <a:gd name="connsiteX6" fmla="*/ 760257 w 926124"/>
                      <a:gd name="connsiteY6" fmla="*/ 14605 h 914400"/>
                      <a:gd name="connsiteX7" fmla="*/ 821463 w 926124"/>
                      <a:gd name="connsiteY7" fmla="*/ 118025 h 914400"/>
                      <a:gd name="connsiteX8" fmla="*/ 900012 w 926124"/>
                      <a:gd name="connsiteY8" fmla="*/ 218397 h 914400"/>
                      <a:gd name="connsiteX9" fmla="*/ 896496 w 926124"/>
                      <a:gd name="connsiteY9" fmla="*/ 327236 h 914400"/>
                      <a:gd name="connsiteX10" fmla="*/ 922179 w 926124"/>
                      <a:gd name="connsiteY10" fmla="*/ 493649 h 914400"/>
                      <a:gd name="connsiteX11" fmla="*/ 801869 w 926124"/>
                      <a:gd name="connsiteY11" fmla="*/ 639318 h 914400"/>
                      <a:gd name="connsiteX12" fmla="*/ 758799 w 926124"/>
                      <a:gd name="connsiteY12" fmla="*/ 764137 h 914400"/>
                      <a:gd name="connsiteX13" fmla="*/ 612163 w 926124"/>
                      <a:gd name="connsiteY13" fmla="*/ 779250 h 914400"/>
                      <a:gd name="connsiteX14" fmla="*/ 507374 w 926124"/>
                      <a:gd name="connsiteY14" fmla="*/ 912410 h 914400"/>
                      <a:gd name="connsiteX15" fmla="*/ 353299 w 926124"/>
                      <a:gd name="connsiteY15" fmla="*/ 831130 h 914400"/>
                      <a:gd name="connsiteX16" fmla="*/ 124426 w 926124"/>
                      <a:gd name="connsiteY16" fmla="*/ 750824 h 914400"/>
                      <a:gd name="connsiteX17" fmla="*/ 23796 w 926124"/>
                      <a:gd name="connsiteY17" fmla="*/ 661458 h 914400"/>
                      <a:gd name="connsiteX18" fmla="*/ 45298 w 926124"/>
                      <a:gd name="connsiteY18" fmla="*/ 540829 h 914400"/>
                      <a:gd name="connsiteX19" fmla="*/ -108 w 926124"/>
                      <a:gd name="connsiteY19" fmla="*/ 417068 h 914400"/>
                      <a:gd name="connsiteX20" fmla="*/ 82815 w 926124"/>
                      <a:gd name="connsiteY20" fmla="*/ 307064 h 914400"/>
                      <a:gd name="connsiteX21" fmla="*/ 83608 w 926124"/>
                      <a:gd name="connsiteY21" fmla="*/ 304165 h 914400"/>
                      <a:gd name="connsiteX0" fmla="*/ 100608 w 926124"/>
                      <a:gd name="connsiteY0" fmla="*/ 554079 h 914400"/>
                      <a:gd name="connsiteX1" fmla="*/ 46306 w 926124"/>
                      <a:gd name="connsiteY1" fmla="*/ 537210 h 914400"/>
                      <a:gd name="connsiteX2" fmla="*/ 148522 w 926124"/>
                      <a:gd name="connsiteY2" fmla="*/ 738695 h 914400"/>
                      <a:gd name="connsiteX3" fmla="*/ 124769 w 926124"/>
                      <a:gd name="connsiteY3" fmla="*/ 746760 h 914400"/>
                      <a:gd name="connsiteX4" fmla="*/ 353256 w 926124"/>
                      <a:gd name="connsiteY4" fmla="*/ 827405 h 914400"/>
                      <a:gd name="connsiteX5" fmla="*/ 338935 w 926124"/>
                      <a:gd name="connsiteY5" fmla="*/ 790575 h 914400"/>
                      <a:gd name="connsiteX6" fmla="*/ 617994 w 926124"/>
                      <a:gd name="connsiteY6" fmla="*/ 735562 h 914400"/>
                      <a:gd name="connsiteX7" fmla="*/ 612270 w 926124"/>
                      <a:gd name="connsiteY7" fmla="*/ 775970 h 914400"/>
                      <a:gd name="connsiteX8" fmla="*/ 731659 w 926124"/>
                      <a:gd name="connsiteY8" fmla="*/ 485859 h 914400"/>
                      <a:gd name="connsiteX9" fmla="*/ 801354 w 926124"/>
                      <a:gd name="connsiteY9" fmla="*/ 636905 h 914400"/>
                      <a:gd name="connsiteX10" fmla="*/ 896067 w 926124"/>
                      <a:gd name="connsiteY10" fmla="*/ 324993 h 914400"/>
                      <a:gd name="connsiteX11" fmla="*/ 865025 w 926124"/>
                      <a:gd name="connsiteY11" fmla="*/ 381635 h 914400"/>
                      <a:gd name="connsiteX12" fmla="*/ 821592 w 926124"/>
                      <a:gd name="connsiteY12" fmla="*/ 114850 h 914400"/>
                      <a:gd name="connsiteX13" fmla="*/ 823221 w 926124"/>
                      <a:gd name="connsiteY13" fmla="*/ 141605 h 914400"/>
                      <a:gd name="connsiteX14" fmla="*/ 623375 w 926124"/>
                      <a:gd name="connsiteY14" fmla="*/ 83650 h 914400"/>
                      <a:gd name="connsiteX15" fmla="*/ 639282 w 926124"/>
                      <a:gd name="connsiteY15" fmla="*/ 49530 h 914400"/>
                      <a:gd name="connsiteX16" fmla="*/ 474659 w 926124"/>
                      <a:gd name="connsiteY16" fmla="*/ 99906 h 914400"/>
                      <a:gd name="connsiteX17" fmla="*/ 482356 w 926124"/>
                      <a:gd name="connsiteY17" fmla="*/ 70485 h 914400"/>
                      <a:gd name="connsiteX18" fmla="*/ 300132 w 926124"/>
                      <a:gd name="connsiteY18" fmla="*/ 109897 h 914400"/>
                      <a:gd name="connsiteX19" fmla="*/ 328002 w 926124"/>
                      <a:gd name="connsiteY19" fmla="*/ 138430 h 914400"/>
                      <a:gd name="connsiteX20" fmla="*/ 88474 w 926124"/>
                      <a:gd name="connsiteY20" fmla="*/ 334200 h 914400"/>
                      <a:gd name="connsiteX21" fmla="*/ 83608 w 926124"/>
                      <a:gd name="connsiteY21" fmla="*/ 304165 h 9144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926124" h="914400" fill="none" extrusionOk="0">
                        <a:moveTo>
                          <a:pt x="83608" y="304165"/>
                        </a:moveTo>
                        <a:cubicBezTo>
                          <a:pt x="71337" y="259709"/>
                          <a:pt x="89078" y="185816"/>
                          <a:pt x="120546" y="146198"/>
                        </a:cubicBezTo>
                        <a:cubicBezTo>
                          <a:pt x="180294" y="83133"/>
                          <a:pt x="240544" y="44472"/>
                          <a:pt x="300239" y="110109"/>
                        </a:cubicBezTo>
                        <a:cubicBezTo>
                          <a:pt x="343738" y="24049"/>
                          <a:pt x="411423" y="3865"/>
                          <a:pt x="481412" y="72644"/>
                        </a:cubicBezTo>
                        <a:cubicBezTo>
                          <a:pt x="494012" y="39184"/>
                          <a:pt x="519547" y="3742"/>
                          <a:pt x="552008" y="4233"/>
                        </a:cubicBezTo>
                        <a:cubicBezTo>
                          <a:pt x="591139" y="-6367"/>
                          <a:pt x="621071" y="12742"/>
                          <a:pt x="639561" y="52514"/>
                        </a:cubicBezTo>
                        <a:cubicBezTo>
                          <a:pt x="661000" y="2512"/>
                          <a:pt x="727085" y="-18478"/>
                          <a:pt x="760257" y="14605"/>
                        </a:cubicBezTo>
                        <a:cubicBezTo>
                          <a:pt x="781805" y="39036"/>
                          <a:pt x="816997" y="76594"/>
                          <a:pt x="821463" y="118025"/>
                        </a:cubicBezTo>
                        <a:cubicBezTo>
                          <a:pt x="862700" y="130782"/>
                          <a:pt x="887054" y="172857"/>
                          <a:pt x="900012" y="218397"/>
                        </a:cubicBezTo>
                        <a:cubicBezTo>
                          <a:pt x="911392" y="254804"/>
                          <a:pt x="905949" y="287720"/>
                          <a:pt x="896496" y="327236"/>
                        </a:cubicBezTo>
                        <a:cubicBezTo>
                          <a:pt x="935652" y="374908"/>
                          <a:pt x="941457" y="444601"/>
                          <a:pt x="922179" y="493649"/>
                        </a:cubicBezTo>
                        <a:cubicBezTo>
                          <a:pt x="917821" y="580107"/>
                          <a:pt x="864011" y="637252"/>
                          <a:pt x="801869" y="639318"/>
                        </a:cubicBezTo>
                        <a:cubicBezTo>
                          <a:pt x="807488" y="693136"/>
                          <a:pt x="780739" y="725942"/>
                          <a:pt x="758799" y="764137"/>
                        </a:cubicBezTo>
                        <a:cubicBezTo>
                          <a:pt x="716295" y="813096"/>
                          <a:pt x="670149" y="820532"/>
                          <a:pt x="612163" y="779250"/>
                        </a:cubicBezTo>
                        <a:cubicBezTo>
                          <a:pt x="603395" y="839019"/>
                          <a:pt x="553129" y="888687"/>
                          <a:pt x="507374" y="912410"/>
                        </a:cubicBezTo>
                        <a:cubicBezTo>
                          <a:pt x="436158" y="937157"/>
                          <a:pt x="387522" y="907165"/>
                          <a:pt x="353299" y="831130"/>
                        </a:cubicBezTo>
                        <a:cubicBezTo>
                          <a:pt x="260389" y="880211"/>
                          <a:pt x="191762" y="836405"/>
                          <a:pt x="124426" y="750824"/>
                        </a:cubicBezTo>
                        <a:cubicBezTo>
                          <a:pt x="88896" y="769993"/>
                          <a:pt x="52190" y="722855"/>
                          <a:pt x="23796" y="661458"/>
                        </a:cubicBezTo>
                        <a:cubicBezTo>
                          <a:pt x="5689" y="622220"/>
                          <a:pt x="22538" y="566743"/>
                          <a:pt x="45298" y="540829"/>
                        </a:cubicBezTo>
                        <a:cubicBezTo>
                          <a:pt x="14203" y="506065"/>
                          <a:pt x="-2065" y="459478"/>
                          <a:pt x="-108" y="417068"/>
                        </a:cubicBezTo>
                        <a:cubicBezTo>
                          <a:pt x="3361" y="358891"/>
                          <a:pt x="45535" y="303762"/>
                          <a:pt x="82815" y="307064"/>
                        </a:cubicBezTo>
                        <a:cubicBezTo>
                          <a:pt x="83174" y="306011"/>
                          <a:pt x="83501" y="305126"/>
                          <a:pt x="83608" y="304165"/>
                        </a:cubicBezTo>
                        <a:close/>
                      </a:path>
                      <a:path w="926124" h="914400" fill="none" extrusionOk="0">
                        <a:moveTo>
                          <a:pt x="100608" y="554079"/>
                        </a:moveTo>
                        <a:cubicBezTo>
                          <a:pt x="82473" y="554508"/>
                          <a:pt x="64241" y="548588"/>
                          <a:pt x="46306" y="537210"/>
                        </a:cubicBezTo>
                        <a:moveTo>
                          <a:pt x="148522" y="738695"/>
                        </a:moveTo>
                        <a:cubicBezTo>
                          <a:pt x="142839" y="741453"/>
                          <a:pt x="134619" y="744048"/>
                          <a:pt x="124769" y="746760"/>
                        </a:cubicBezTo>
                        <a:moveTo>
                          <a:pt x="353256" y="827405"/>
                        </a:moveTo>
                        <a:cubicBezTo>
                          <a:pt x="348060" y="818827"/>
                          <a:pt x="343509" y="802778"/>
                          <a:pt x="338935" y="790575"/>
                        </a:cubicBezTo>
                        <a:moveTo>
                          <a:pt x="617994" y="735562"/>
                        </a:moveTo>
                        <a:cubicBezTo>
                          <a:pt x="620346" y="749453"/>
                          <a:pt x="615005" y="760028"/>
                          <a:pt x="612270" y="775970"/>
                        </a:cubicBezTo>
                        <a:moveTo>
                          <a:pt x="731659" y="485859"/>
                        </a:moveTo>
                        <a:cubicBezTo>
                          <a:pt x="767886" y="514709"/>
                          <a:pt x="810093" y="582907"/>
                          <a:pt x="801354" y="636905"/>
                        </a:cubicBezTo>
                        <a:moveTo>
                          <a:pt x="896067" y="324993"/>
                        </a:moveTo>
                        <a:cubicBezTo>
                          <a:pt x="887796" y="350013"/>
                          <a:pt x="882311" y="364882"/>
                          <a:pt x="865025" y="381635"/>
                        </a:cubicBezTo>
                        <a:moveTo>
                          <a:pt x="821592" y="114850"/>
                        </a:moveTo>
                        <a:cubicBezTo>
                          <a:pt x="822863" y="123456"/>
                          <a:pt x="825677" y="133667"/>
                          <a:pt x="823221" y="141605"/>
                        </a:cubicBezTo>
                        <a:moveTo>
                          <a:pt x="623375" y="83650"/>
                        </a:moveTo>
                        <a:cubicBezTo>
                          <a:pt x="628665" y="69366"/>
                          <a:pt x="635344" y="58957"/>
                          <a:pt x="639282" y="49530"/>
                        </a:cubicBezTo>
                        <a:moveTo>
                          <a:pt x="474659" y="99906"/>
                        </a:moveTo>
                        <a:cubicBezTo>
                          <a:pt x="478201" y="90042"/>
                          <a:pt x="479087" y="82159"/>
                          <a:pt x="482356" y="70485"/>
                        </a:cubicBezTo>
                        <a:moveTo>
                          <a:pt x="300132" y="109897"/>
                        </a:moveTo>
                        <a:cubicBezTo>
                          <a:pt x="309763" y="117673"/>
                          <a:pt x="321642" y="127309"/>
                          <a:pt x="328002" y="138430"/>
                        </a:cubicBezTo>
                        <a:moveTo>
                          <a:pt x="88474" y="334200"/>
                        </a:moveTo>
                        <a:cubicBezTo>
                          <a:pt x="86238" y="323175"/>
                          <a:pt x="85815" y="313492"/>
                          <a:pt x="83608" y="304165"/>
                        </a:cubicBezTo>
                      </a:path>
                      <a:path w="926124" h="914400" stroke="0" extrusionOk="0">
                        <a:moveTo>
                          <a:pt x="83608" y="304165"/>
                        </a:moveTo>
                        <a:cubicBezTo>
                          <a:pt x="66932" y="240037"/>
                          <a:pt x="81174" y="192645"/>
                          <a:pt x="120546" y="146198"/>
                        </a:cubicBezTo>
                        <a:cubicBezTo>
                          <a:pt x="186588" y="83058"/>
                          <a:pt x="232151" y="64156"/>
                          <a:pt x="300239" y="110109"/>
                        </a:cubicBezTo>
                        <a:cubicBezTo>
                          <a:pt x="323746" y="31309"/>
                          <a:pt x="422981" y="22222"/>
                          <a:pt x="481412" y="72644"/>
                        </a:cubicBezTo>
                        <a:cubicBezTo>
                          <a:pt x="490727" y="33201"/>
                          <a:pt x="522797" y="10631"/>
                          <a:pt x="552008" y="4233"/>
                        </a:cubicBezTo>
                        <a:cubicBezTo>
                          <a:pt x="590055" y="-1623"/>
                          <a:pt x="623701" y="6671"/>
                          <a:pt x="639561" y="52514"/>
                        </a:cubicBezTo>
                        <a:cubicBezTo>
                          <a:pt x="667761" y="5433"/>
                          <a:pt x="714039" y="-5823"/>
                          <a:pt x="760257" y="14605"/>
                        </a:cubicBezTo>
                        <a:cubicBezTo>
                          <a:pt x="791039" y="21051"/>
                          <a:pt x="813129" y="74968"/>
                          <a:pt x="821463" y="118025"/>
                        </a:cubicBezTo>
                        <a:cubicBezTo>
                          <a:pt x="860627" y="132800"/>
                          <a:pt x="890405" y="169868"/>
                          <a:pt x="900012" y="218397"/>
                        </a:cubicBezTo>
                        <a:cubicBezTo>
                          <a:pt x="905376" y="253498"/>
                          <a:pt x="914442" y="298438"/>
                          <a:pt x="896496" y="327236"/>
                        </a:cubicBezTo>
                        <a:cubicBezTo>
                          <a:pt x="927721" y="380763"/>
                          <a:pt x="934588" y="452437"/>
                          <a:pt x="922179" y="493649"/>
                        </a:cubicBezTo>
                        <a:cubicBezTo>
                          <a:pt x="911761" y="576604"/>
                          <a:pt x="871426" y="641770"/>
                          <a:pt x="801869" y="639318"/>
                        </a:cubicBezTo>
                        <a:cubicBezTo>
                          <a:pt x="804649" y="684623"/>
                          <a:pt x="788286" y="721477"/>
                          <a:pt x="758799" y="764137"/>
                        </a:cubicBezTo>
                        <a:cubicBezTo>
                          <a:pt x="706752" y="813532"/>
                          <a:pt x="644367" y="808290"/>
                          <a:pt x="612163" y="779250"/>
                        </a:cubicBezTo>
                        <a:cubicBezTo>
                          <a:pt x="595019" y="845407"/>
                          <a:pt x="554883" y="891194"/>
                          <a:pt x="507374" y="912410"/>
                        </a:cubicBezTo>
                        <a:cubicBezTo>
                          <a:pt x="449816" y="913121"/>
                          <a:pt x="380720" y="902665"/>
                          <a:pt x="353299" y="831130"/>
                        </a:cubicBezTo>
                        <a:cubicBezTo>
                          <a:pt x="266890" y="907926"/>
                          <a:pt x="175732" y="863187"/>
                          <a:pt x="124426" y="750824"/>
                        </a:cubicBezTo>
                        <a:cubicBezTo>
                          <a:pt x="78787" y="765544"/>
                          <a:pt x="37828" y="719416"/>
                          <a:pt x="23796" y="661458"/>
                        </a:cubicBezTo>
                        <a:cubicBezTo>
                          <a:pt x="13604" y="620487"/>
                          <a:pt x="18510" y="573354"/>
                          <a:pt x="45298" y="540829"/>
                        </a:cubicBezTo>
                        <a:cubicBezTo>
                          <a:pt x="16289" y="521471"/>
                          <a:pt x="-7050" y="468182"/>
                          <a:pt x="-108" y="417068"/>
                        </a:cubicBezTo>
                        <a:cubicBezTo>
                          <a:pt x="7028" y="347859"/>
                          <a:pt x="33266" y="312720"/>
                          <a:pt x="82815" y="307064"/>
                        </a:cubicBezTo>
                        <a:cubicBezTo>
                          <a:pt x="83208" y="306208"/>
                          <a:pt x="83291" y="305318"/>
                          <a:pt x="83608" y="304165"/>
                        </a:cubicBezTo>
                        <a:close/>
                      </a:path>
                      <a:path w="926124" h="914400" fill="none" stroke="0" extrusionOk="0">
                        <a:moveTo>
                          <a:pt x="100608" y="554079"/>
                        </a:moveTo>
                        <a:cubicBezTo>
                          <a:pt x="82651" y="552223"/>
                          <a:pt x="64096" y="544965"/>
                          <a:pt x="46306" y="537210"/>
                        </a:cubicBezTo>
                        <a:moveTo>
                          <a:pt x="148522" y="738695"/>
                        </a:moveTo>
                        <a:cubicBezTo>
                          <a:pt x="140461" y="745022"/>
                          <a:pt x="132318" y="744850"/>
                          <a:pt x="124769" y="746760"/>
                        </a:cubicBezTo>
                        <a:moveTo>
                          <a:pt x="353256" y="827405"/>
                        </a:moveTo>
                        <a:cubicBezTo>
                          <a:pt x="348714" y="816800"/>
                          <a:pt x="342097" y="803684"/>
                          <a:pt x="338935" y="790575"/>
                        </a:cubicBezTo>
                        <a:moveTo>
                          <a:pt x="617994" y="735562"/>
                        </a:moveTo>
                        <a:cubicBezTo>
                          <a:pt x="615161" y="749958"/>
                          <a:pt x="615206" y="761646"/>
                          <a:pt x="612270" y="775970"/>
                        </a:cubicBezTo>
                        <a:moveTo>
                          <a:pt x="731659" y="485859"/>
                        </a:moveTo>
                        <a:cubicBezTo>
                          <a:pt x="757104" y="520467"/>
                          <a:pt x="800960" y="584526"/>
                          <a:pt x="801354" y="636905"/>
                        </a:cubicBezTo>
                        <a:moveTo>
                          <a:pt x="896067" y="324993"/>
                        </a:moveTo>
                        <a:cubicBezTo>
                          <a:pt x="887389" y="345337"/>
                          <a:pt x="880596" y="366416"/>
                          <a:pt x="865025" y="381635"/>
                        </a:cubicBezTo>
                        <a:moveTo>
                          <a:pt x="821592" y="114850"/>
                        </a:moveTo>
                        <a:cubicBezTo>
                          <a:pt x="820128" y="123423"/>
                          <a:pt x="822589" y="132954"/>
                          <a:pt x="823221" y="141605"/>
                        </a:cubicBezTo>
                        <a:moveTo>
                          <a:pt x="623375" y="83650"/>
                        </a:moveTo>
                        <a:cubicBezTo>
                          <a:pt x="626548" y="70286"/>
                          <a:pt x="632875" y="58419"/>
                          <a:pt x="639282" y="49530"/>
                        </a:cubicBezTo>
                        <a:moveTo>
                          <a:pt x="474659" y="99906"/>
                        </a:moveTo>
                        <a:cubicBezTo>
                          <a:pt x="476015" y="90132"/>
                          <a:pt x="478087" y="81859"/>
                          <a:pt x="482356" y="70485"/>
                        </a:cubicBezTo>
                        <a:moveTo>
                          <a:pt x="300132" y="109897"/>
                        </a:moveTo>
                        <a:cubicBezTo>
                          <a:pt x="308469" y="118284"/>
                          <a:pt x="320059" y="128707"/>
                          <a:pt x="328002" y="138430"/>
                        </a:cubicBezTo>
                        <a:moveTo>
                          <a:pt x="88474" y="334200"/>
                        </a:moveTo>
                        <a:cubicBezTo>
                          <a:pt x="84869" y="324137"/>
                          <a:pt x="84568" y="312557"/>
                          <a:pt x="83608" y="304165"/>
                        </a:cubicBezTo>
                      </a:path>
                    </a:pathLst>
                  </a:custGeom>
                  <ask:type>
                    <ask:lineSketchNone/>
                  </ask:type>
                </ask:lineSketchStyleProps>
              </a:ext>
            </a:extLst>
          </a:ln>
          <a:effectLst/>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latin typeface="Arial" panose="020B0604020202020204" pitchFamily="34" charset="0"/>
                <a:cs typeface="Arial" panose="020B0604020202020204" pitchFamily="34" charset="0"/>
              </a:rPr>
              <a:t>POI</a:t>
            </a:r>
          </a:p>
        </p:txBody>
      </p:sp>
      <p:sp>
        <p:nvSpPr>
          <p:cNvPr id="14" name="Arc 13">
            <a:extLst>
              <a:ext uri="{FF2B5EF4-FFF2-40B4-BE49-F238E27FC236}">
                <a16:creationId xmlns:a16="http://schemas.microsoft.com/office/drawing/2014/main" id="{BAF24E22-AC68-4DAC-4DB8-F1CF327A4325}"/>
              </a:ext>
            </a:extLst>
          </p:cNvPr>
          <p:cNvSpPr/>
          <p:nvPr/>
        </p:nvSpPr>
        <p:spPr>
          <a:xfrm rot="12068907">
            <a:off x="6674388" y="3485269"/>
            <a:ext cx="950093" cy="1320944"/>
          </a:xfrm>
          <a:prstGeom prst="arc">
            <a:avLst>
              <a:gd name="adj1" fmla="val 16200000"/>
              <a:gd name="adj2" fmla="val 3448526"/>
            </a:avLst>
          </a:prstGeom>
          <a:ln w="152400">
            <a:solidFill>
              <a:schemeClr val="accent2">
                <a:lumMod val="7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5" name="ZoneTexte 14">
            <a:extLst>
              <a:ext uri="{FF2B5EF4-FFF2-40B4-BE49-F238E27FC236}">
                <a16:creationId xmlns:a16="http://schemas.microsoft.com/office/drawing/2014/main" id="{19A59890-05A1-741F-92D4-0C44DBFCE55E}"/>
              </a:ext>
            </a:extLst>
          </p:cNvPr>
          <p:cNvSpPr txBox="1"/>
          <p:nvPr/>
        </p:nvSpPr>
        <p:spPr>
          <a:xfrm>
            <a:off x="6313494" y="1978610"/>
            <a:ext cx="1984838" cy="584775"/>
          </a:xfrm>
          <a:prstGeom prst="rect">
            <a:avLst/>
          </a:prstGeom>
          <a:noFill/>
        </p:spPr>
        <p:txBody>
          <a:bodyPr wrap="none" rtlCol="0">
            <a:spAutoFit/>
          </a:bodyPr>
          <a:lstStyle/>
          <a:p>
            <a:pPr algn="ctr"/>
            <a:r>
              <a:rPr lang="en-US" sz="1600" i="1" dirty="0">
                <a:solidFill>
                  <a:srgbClr val="FF0000"/>
                </a:solidFill>
                <a:latin typeface="Arial" panose="020B0604020202020204" pitchFamily="34" charset="0"/>
                <a:cs typeface="Arial" panose="020B0604020202020204" pitchFamily="34" charset="0"/>
              </a:rPr>
              <a:t>in situ</a:t>
            </a:r>
            <a:r>
              <a:rPr lang="en-US" sz="1600" dirty="0">
                <a:solidFill>
                  <a:srgbClr val="FF0000"/>
                </a:solidFill>
                <a:latin typeface="Arial" panose="020B0604020202020204" pitchFamily="34" charset="0"/>
                <a:cs typeface="Arial" panose="020B0604020202020204" pitchFamily="34" charset="0"/>
              </a:rPr>
              <a:t> hybridization </a:t>
            </a:r>
          </a:p>
          <a:p>
            <a:pPr algn="ctr"/>
            <a:r>
              <a:rPr lang="en-US" sz="1600" dirty="0">
                <a:solidFill>
                  <a:srgbClr val="FF0000"/>
                </a:solidFill>
                <a:latin typeface="Arial" panose="020B0604020202020204" pitchFamily="34" charset="0"/>
                <a:cs typeface="Arial" panose="020B0604020202020204" pitchFamily="34" charset="0"/>
              </a:rPr>
              <a:t>MS2 tag</a:t>
            </a:r>
          </a:p>
        </p:txBody>
      </p:sp>
      <p:sp>
        <p:nvSpPr>
          <p:cNvPr id="21" name="ZoneTexte 20">
            <a:extLst>
              <a:ext uri="{FF2B5EF4-FFF2-40B4-BE49-F238E27FC236}">
                <a16:creationId xmlns:a16="http://schemas.microsoft.com/office/drawing/2014/main" id="{32943D76-656C-2C21-B523-F5B18DC473DA}"/>
              </a:ext>
            </a:extLst>
          </p:cNvPr>
          <p:cNvSpPr txBox="1"/>
          <p:nvPr/>
        </p:nvSpPr>
        <p:spPr>
          <a:xfrm>
            <a:off x="5916465" y="1152310"/>
            <a:ext cx="1457450" cy="338554"/>
          </a:xfrm>
          <a:prstGeom prst="rect">
            <a:avLst/>
          </a:prstGeom>
          <a:noFill/>
        </p:spPr>
        <p:txBody>
          <a:bodyPr wrap="none" rtlCol="0">
            <a:spAutoFit/>
          </a:bodyPr>
          <a:lstStyle/>
          <a:p>
            <a:pPr algn="ctr"/>
            <a:r>
              <a:rPr lang="en-US" sz="1600" i="1" dirty="0">
                <a:latin typeface="Arial" panose="020B0604020202020204" pitchFamily="34" charset="0"/>
                <a:cs typeface="Arial" panose="020B0604020202020204" pitchFamily="34" charset="0"/>
              </a:rPr>
              <a:t>range &lt; 30nm</a:t>
            </a:r>
          </a:p>
        </p:txBody>
      </p:sp>
      <p:sp>
        <p:nvSpPr>
          <p:cNvPr id="22" name="ZoneTexte 21">
            <a:extLst>
              <a:ext uri="{FF2B5EF4-FFF2-40B4-BE49-F238E27FC236}">
                <a16:creationId xmlns:a16="http://schemas.microsoft.com/office/drawing/2014/main" id="{866957BF-11CF-98BE-E9BB-6319494BA763}"/>
              </a:ext>
            </a:extLst>
          </p:cNvPr>
          <p:cNvSpPr txBox="1"/>
          <p:nvPr/>
        </p:nvSpPr>
        <p:spPr>
          <a:xfrm>
            <a:off x="1974299" y="1146169"/>
            <a:ext cx="1024639" cy="338554"/>
          </a:xfrm>
          <a:prstGeom prst="rect">
            <a:avLst/>
          </a:prstGeom>
          <a:noFill/>
        </p:spPr>
        <p:txBody>
          <a:bodyPr wrap="none" rtlCol="0">
            <a:spAutoFit/>
          </a:bodyPr>
          <a:lstStyle/>
          <a:p>
            <a:pPr algn="ctr"/>
            <a:r>
              <a:rPr lang="en-US" sz="1600" i="1" dirty="0">
                <a:latin typeface="Arial" panose="020B0604020202020204" pitchFamily="34" charset="0"/>
                <a:cs typeface="Arial" panose="020B0604020202020204" pitchFamily="34" charset="0"/>
              </a:rPr>
              <a:t>&lt; few nm</a:t>
            </a:r>
          </a:p>
        </p:txBody>
      </p:sp>
      <p:sp>
        <p:nvSpPr>
          <p:cNvPr id="23" name="ZoneTexte 22">
            <a:extLst>
              <a:ext uri="{FF2B5EF4-FFF2-40B4-BE49-F238E27FC236}">
                <a16:creationId xmlns:a16="http://schemas.microsoft.com/office/drawing/2014/main" id="{3E442BA5-91C4-1832-6871-791B0332CCD0}"/>
              </a:ext>
            </a:extLst>
          </p:cNvPr>
          <p:cNvSpPr txBox="1"/>
          <p:nvPr/>
        </p:nvSpPr>
        <p:spPr>
          <a:xfrm>
            <a:off x="9554086" y="1152310"/>
            <a:ext cx="2180405" cy="338554"/>
          </a:xfrm>
          <a:prstGeom prst="rect">
            <a:avLst/>
          </a:prstGeom>
          <a:noFill/>
        </p:spPr>
        <p:txBody>
          <a:bodyPr wrap="none" rtlCol="0">
            <a:spAutoFit/>
          </a:bodyPr>
          <a:lstStyle/>
          <a:p>
            <a:pPr algn="ctr"/>
            <a:r>
              <a:rPr lang="en-US" sz="1600" i="1" dirty="0">
                <a:latin typeface="Arial" panose="020B0604020202020204" pitchFamily="34" charset="0"/>
                <a:cs typeface="Arial" panose="020B0604020202020204" pitchFamily="34" charset="0"/>
              </a:rPr>
              <a:t>No range requirement</a:t>
            </a:r>
          </a:p>
        </p:txBody>
      </p:sp>
      <p:sp>
        <p:nvSpPr>
          <p:cNvPr id="10" name="Forme en L 9">
            <a:extLst>
              <a:ext uri="{FF2B5EF4-FFF2-40B4-BE49-F238E27FC236}">
                <a16:creationId xmlns:a16="http://schemas.microsoft.com/office/drawing/2014/main" id="{B6B21ECE-66F1-AA90-B7B8-7CEA220271B7}"/>
              </a:ext>
            </a:extLst>
          </p:cNvPr>
          <p:cNvSpPr>
            <a:spLocks noChangeAspect="1"/>
          </p:cNvSpPr>
          <p:nvPr/>
        </p:nvSpPr>
        <p:spPr>
          <a:xfrm rot="6465036">
            <a:off x="5676322" y="3527313"/>
            <a:ext cx="730859" cy="730859"/>
          </a:xfrm>
          <a:prstGeom prst="corner">
            <a:avLst>
              <a:gd name="adj1" fmla="val 35264"/>
              <a:gd name="adj2" fmla="val 37106"/>
            </a:avLst>
          </a:prstGeom>
          <a:solidFill>
            <a:schemeClr val="bg1">
              <a:lumMod val="65000"/>
            </a:schemeClr>
          </a:solidFill>
          <a:ln>
            <a:noFill/>
          </a:ln>
          <a:effectLst/>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Nuage 10">
            <a:extLst>
              <a:ext uri="{FF2B5EF4-FFF2-40B4-BE49-F238E27FC236}">
                <a16:creationId xmlns:a16="http://schemas.microsoft.com/office/drawing/2014/main" id="{EDDD9469-4404-1970-BE11-1E369B58E8A1}"/>
              </a:ext>
            </a:extLst>
          </p:cNvPr>
          <p:cNvSpPr/>
          <p:nvPr/>
        </p:nvSpPr>
        <p:spPr>
          <a:xfrm>
            <a:off x="5502143" y="3138947"/>
            <a:ext cx="487336" cy="381803"/>
          </a:xfrm>
          <a:prstGeom prst="cloud">
            <a:avLst/>
          </a:prstGeom>
          <a:solidFill>
            <a:srgbClr val="00B050"/>
          </a:solidFill>
          <a:ln>
            <a:noFill/>
            <a:extLst>
              <a:ext uri="{C807C97D-BFC1-408E-A445-0C87EB9F89A2}">
                <ask:lineSketchStyleProps xmlns:ask="http://schemas.microsoft.com/office/drawing/2018/sketchyshapes" sd="1219033472">
                  <a:custGeom>
                    <a:avLst/>
                    <a:gdLst>
                      <a:gd name="connsiteX0" fmla="*/ 83608 w 926124"/>
                      <a:gd name="connsiteY0" fmla="*/ 304165 h 914400"/>
                      <a:gd name="connsiteX1" fmla="*/ 120546 w 926124"/>
                      <a:gd name="connsiteY1" fmla="*/ 146198 h 914400"/>
                      <a:gd name="connsiteX2" fmla="*/ 300239 w 926124"/>
                      <a:gd name="connsiteY2" fmla="*/ 110109 h 914400"/>
                      <a:gd name="connsiteX3" fmla="*/ 481412 w 926124"/>
                      <a:gd name="connsiteY3" fmla="*/ 72644 h 914400"/>
                      <a:gd name="connsiteX4" fmla="*/ 552008 w 926124"/>
                      <a:gd name="connsiteY4" fmla="*/ 4233 h 914400"/>
                      <a:gd name="connsiteX5" fmla="*/ 639561 w 926124"/>
                      <a:gd name="connsiteY5" fmla="*/ 52514 h 914400"/>
                      <a:gd name="connsiteX6" fmla="*/ 760257 w 926124"/>
                      <a:gd name="connsiteY6" fmla="*/ 14605 h 914400"/>
                      <a:gd name="connsiteX7" fmla="*/ 821463 w 926124"/>
                      <a:gd name="connsiteY7" fmla="*/ 118025 h 914400"/>
                      <a:gd name="connsiteX8" fmla="*/ 900012 w 926124"/>
                      <a:gd name="connsiteY8" fmla="*/ 218397 h 914400"/>
                      <a:gd name="connsiteX9" fmla="*/ 896496 w 926124"/>
                      <a:gd name="connsiteY9" fmla="*/ 327236 h 914400"/>
                      <a:gd name="connsiteX10" fmla="*/ 922179 w 926124"/>
                      <a:gd name="connsiteY10" fmla="*/ 493649 h 914400"/>
                      <a:gd name="connsiteX11" fmla="*/ 801869 w 926124"/>
                      <a:gd name="connsiteY11" fmla="*/ 639318 h 914400"/>
                      <a:gd name="connsiteX12" fmla="*/ 758799 w 926124"/>
                      <a:gd name="connsiteY12" fmla="*/ 764137 h 914400"/>
                      <a:gd name="connsiteX13" fmla="*/ 612163 w 926124"/>
                      <a:gd name="connsiteY13" fmla="*/ 779250 h 914400"/>
                      <a:gd name="connsiteX14" fmla="*/ 507374 w 926124"/>
                      <a:gd name="connsiteY14" fmla="*/ 912410 h 914400"/>
                      <a:gd name="connsiteX15" fmla="*/ 353299 w 926124"/>
                      <a:gd name="connsiteY15" fmla="*/ 831130 h 914400"/>
                      <a:gd name="connsiteX16" fmla="*/ 124426 w 926124"/>
                      <a:gd name="connsiteY16" fmla="*/ 750824 h 914400"/>
                      <a:gd name="connsiteX17" fmla="*/ 23796 w 926124"/>
                      <a:gd name="connsiteY17" fmla="*/ 661458 h 914400"/>
                      <a:gd name="connsiteX18" fmla="*/ 45298 w 926124"/>
                      <a:gd name="connsiteY18" fmla="*/ 540829 h 914400"/>
                      <a:gd name="connsiteX19" fmla="*/ -108 w 926124"/>
                      <a:gd name="connsiteY19" fmla="*/ 417068 h 914400"/>
                      <a:gd name="connsiteX20" fmla="*/ 82815 w 926124"/>
                      <a:gd name="connsiteY20" fmla="*/ 307064 h 914400"/>
                      <a:gd name="connsiteX21" fmla="*/ 83608 w 926124"/>
                      <a:gd name="connsiteY21" fmla="*/ 304165 h 914400"/>
                      <a:gd name="connsiteX0" fmla="*/ 100608 w 926124"/>
                      <a:gd name="connsiteY0" fmla="*/ 554079 h 914400"/>
                      <a:gd name="connsiteX1" fmla="*/ 46306 w 926124"/>
                      <a:gd name="connsiteY1" fmla="*/ 537210 h 914400"/>
                      <a:gd name="connsiteX2" fmla="*/ 148522 w 926124"/>
                      <a:gd name="connsiteY2" fmla="*/ 738695 h 914400"/>
                      <a:gd name="connsiteX3" fmla="*/ 124769 w 926124"/>
                      <a:gd name="connsiteY3" fmla="*/ 746760 h 914400"/>
                      <a:gd name="connsiteX4" fmla="*/ 353256 w 926124"/>
                      <a:gd name="connsiteY4" fmla="*/ 827405 h 914400"/>
                      <a:gd name="connsiteX5" fmla="*/ 338935 w 926124"/>
                      <a:gd name="connsiteY5" fmla="*/ 790575 h 914400"/>
                      <a:gd name="connsiteX6" fmla="*/ 617994 w 926124"/>
                      <a:gd name="connsiteY6" fmla="*/ 735562 h 914400"/>
                      <a:gd name="connsiteX7" fmla="*/ 612270 w 926124"/>
                      <a:gd name="connsiteY7" fmla="*/ 775970 h 914400"/>
                      <a:gd name="connsiteX8" fmla="*/ 731659 w 926124"/>
                      <a:gd name="connsiteY8" fmla="*/ 485859 h 914400"/>
                      <a:gd name="connsiteX9" fmla="*/ 801354 w 926124"/>
                      <a:gd name="connsiteY9" fmla="*/ 636905 h 914400"/>
                      <a:gd name="connsiteX10" fmla="*/ 896067 w 926124"/>
                      <a:gd name="connsiteY10" fmla="*/ 324993 h 914400"/>
                      <a:gd name="connsiteX11" fmla="*/ 865025 w 926124"/>
                      <a:gd name="connsiteY11" fmla="*/ 381635 h 914400"/>
                      <a:gd name="connsiteX12" fmla="*/ 821592 w 926124"/>
                      <a:gd name="connsiteY12" fmla="*/ 114850 h 914400"/>
                      <a:gd name="connsiteX13" fmla="*/ 823221 w 926124"/>
                      <a:gd name="connsiteY13" fmla="*/ 141605 h 914400"/>
                      <a:gd name="connsiteX14" fmla="*/ 623375 w 926124"/>
                      <a:gd name="connsiteY14" fmla="*/ 83650 h 914400"/>
                      <a:gd name="connsiteX15" fmla="*/ 639282 w 926124"/>
                      <a:gd name="connsiteY15" fmla="*/ 49530 h 914400"/>
                      <a:gd name="connsiteX16" fmla="*/ 474659 w 926124"/>
                      <a:gd name="connsiteY16" fmla="*/ 99906 h 914400"/>
                      <a:gd name="connsiteX17" fmla="*/ 482356 w 926124"/>
                      <a:gd name="connsiteY17" fmla="*/ 70485 h 914400"/>
                      <a:gd name="connsiteX18" fmla="*/ 300132 w 926124"/>
                      <a:gd name="connsiteY18" fmla="*/ 109897 h 914400"/>
                      <a:gd name="connsiteX19" fmla="*/ 328002 w 926124"/>
                      <a:gd name="connsiteY19" fmla="*/ 138430 h 914400"/>
                      <a:gd name="connsiteX20" fmla="*/ 88474 w 926124"/>
                      <a:gd name="connsiteY20" fmla="*/ 334200 h 914400"/>
                      <a:gd name="connsiteX21" fmla="*/ 83608 w 926124"/>
                      <a:gd name="connsiteY21" fmla="*/ 304165 h 9144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926124" h="914400" fill="none" extrusionOk="0">
                        <a:moveTo>
                          <a:pt x="83608" y="304165"/>
                        </a:moveTo>
                        <a:cubicBezTo>
                          <a:pt x="71337" y="259709"/>
                          <a:pt x="89078" y="185816"/>
                          <a:pt x="120546" y="146198"/>
                        </a:cubicBezTo>
                        <a:cubicBezTo>
                          <a:pt x="180294" y="83133"/>
                          <a:pt x="240544" y="44472"/>
                          <a:pt x="300239" y="110109"/>
                        </a:cubicBezTo>
                        <a:cubicBezTo>
                          <a:pt x="343738" y="24049"/>
                          <a:pt x="411423" y="3865"/>
                          <a:pt x="481412" y="72644"/>
                        </a:cubicBezTo>
                        <a:cubicBezTo>
                          <a:pt x="494012" y="39184"/>
                          <a:pt x="519547" y="3742"/>
                          <a:pt x="552008" y="4233"/>
                        </a:cubicBezTo>
                        <a:cubicBezTo>
                          <a:pt x="591139" y="-6367"/>
                          <a:pt x="621071" y="12742"/>
                          <a:pt x="639561" y="52514"/>
                        </a:cubicBezTo>
                        <a:cubicBezTo>
                          <a:pt x="661000" y="2512"/>
                          <a:pt x="727085" y="-18478"/>
                          <a:pt x="760257" y="14605"/>
                        </a:cubicBezTo>
                        <a:cubicBezTo>
                          <a:pt x="781805" y="39036"/>
                          <a:pt x="816997" y="76594"/>
                          <a:pt x="821463" y="118025"/>
                        </a:cubicBezTo>
                        <a:cubicBezTo>
                          <a:pt x="862700" y="130782"/>
                          <a:pt x="887054" y="172857"/>
                          <a:pt x="900012" y="218397"/>
                        </a:cubicBezTo>
                        <a:cubicBezTo>
                          <a:pt x="911392" y="254804"/>
                          <a:pt x="905949" y="287720"/>
                          <a:pt x="896496" y="327236"/>
                        </a:cubicBezTo>
                        <a:cubicBezTo>
                          <a:pt x="935652" y="374908"/>
                          <a:pt x="941457" y="444601"/>
                          <a:pt x="922179" y="493649"/>
                        </a:cubicBezTo>
                        <a:cubicBezTo>
                          <a:pt x="917821" y="580107"/>
                          <a:pt x="864011" y="637252"/>
                          <a:pt x="801869" y="639318"/>
                        </a:cubicBezTo>
                        <a:cubicBezTo>
                          <a:pt x="807488" y="693136"/>
                          <a:pt x="780739" y="725942"/>
                          <a:pt x="758799" y="764137"/>
                        </a:cubicBezTo>
                        <a:cubicBezTo>
                          <a:pt x="716295" y="813096"/>
                          <a:pt x="670149" y="820532"/>
                          <a:pt x="612163" y="779250"/>
                        </a:cubicBezTo>
                        <a:cubicBezTo>
                          <a:pt x="603395" y="839019"/>
                          <a:pt x="553129" y="888687"/>
                          <a:pt x="507374" y="912410"/>
                        </a:cubicBezTo>
                        <a:cubicBezTo>
                          <a:pt x="436158" y="937157"/>
                          <a:pt x="387522" y="907165"/>
                          <a:pt x="353299" y="831130"/>
                        </a:cubicBezTo>
                        <a:cubicBezTo>
                          <a:pt x="260389" y="880211"/>
                          <a:pt x="191762" y="836405"/>
                          <a:pt x="124426" y="750824"/>
                        </a:cubicBezTo>
                        <a:cubicBezTo>
                          <a:pt x="88896" y="769993"/>
                          <a:pt x="52190" y="722855"/>
                          <a:pt x="23796" y="661458"/>
                        </a:cubicBezTo>
                        <a:cubicBezTo>
                          <a:pt x="5689" y="622220"/>
                          <a:pt x="22538" y="566743"/>
                          <a:pt x="45298" y="540829"/>
                        </a:cubicBezTo>
                        <a:cubicBezTo>
                          <a:pt x="14203" y="506065"/>
                          <a:pt x="-2065" y="459478"/>
                          <a:pt x="-108" y="417068"/>
                        </a:cubicBezTo>
                        <a:cubicBezTo>
                          <a:pt x="3361" y="358891"/>
                          <a:pt x="45535" y="303762"/>
                          <a:pt x="82815" y="307064"/>
                        </a:cubicBezTo>
                        <a:cubicBezTo>
                          <a:pt x="83174" y="306011"/>
                          <a:pt x="83501" y="305126"/>
                          <a:pt x="83608" y="304165"/>
                        </a:cubicBezTo>
                        <a:close/>
                      </a:path>
                      <a:path w="926124" h="914400" fill="none" extrusionOk="0">
                        <a:moveTo>
                          <a:pt x="100608" y="554079"/>
                        </a:moveTo>
                        <a:cubicBezTo>
                          <a:pt x="82473" y="554508"/>
                          <a:pt x="64241" y="548588"/>
                          <a:pt x="46306" y="537210"/>
                        </a:cubicBezTo>
                        <a:moveTo>
                          <a:pt x="148522" y="738695"/>
                        </a:moveTo>
                        <a:cubicBezTo>
                          <a:pt x="142839" y="741453"/>
                          <a:pt x="134619" y="744048"/>
                          <a:pt x="124769" y="746760"/>
                        </a:cubicBezTo>
                        <a:moveTo>
                          <a:pt x="353256" y="827405"/>
                        </a:moveTo>
                        <a:cubicBezTo>
                          <a:pt x="348060" y="818827"/>
                          <a:pt x="343509" y="802778"/>
                          <a:pt x="338935" y="790575"/>
                        </a:cubicBezTo>
                        <a:moveTo>
                          <a:pt x="617994" y="735562"/>
                        </a:moveTo>
                        <a:cubicBezTo>
                          <a:pt x="620346" y="749453"/>
                          <a:pt x="615005" y="760028"/>
                          <a:pt x="612270" y="775970"/>
                        </a:cubicBezTo>
                        <a:moveTo>
                          <a:pt x="731659" y="485859"/>
                        </a:moveTo>
                        <a:cubicBezTo>
                          <a:pt x="767886" y="514709"/>
                          <a:pt x="810093" y="582907"/>
                          <a:pt x="801354" y="636905"/>
                        </a:cubicBezTo>
                        <a:moveTo>
                          <a:pt x="896067" y="324993"/>
                        </a:moveTo>
                        <a:cubicBezTo>
                          <a:pt x="887796" y="350013"/>
                          <a:pt x="882311" y="364882"/>
                          <a:pt x="865025" y="381635"/>
                        </a:cubicBezTo>
                        <a:moveTo>
                          <a:pt x="821592" y="114850"/>
                        </a:moveTo>
                        <a:cubicBezTo>
                          <a:pt x="822863" y="123456"/>
                          <a:pt x="825677" y="133667"/>
                          <a:pt x="823221" y="141605"/>
                        </a:cubicBezTo>
                        <a:moveTo>
                          <a:pt x="623375" y="83650"/>
                        </a:moveTo>
                        <a:cubicBezTo>
                          <a:pt x="628665" y="69366"/>
                          <a:pt x="635344" y="58957"/>
                          <a:pt x="639282" y="49530"/>
                        </a:cubicBezTo>
                        <a:moveTo>
                          <a:pt x="474659" y="99906"/>
                        </a:moveTo>
                        <a:cubicBezTo>
                          <a:pt x="478201" y="90042"/>
                          <a:pt x="479087" y="82159"/>
                          <a:pt x="482356" y="70485"/>
                        </a:cubicBezTo>
                        <a:moveTo>
                          <a:pt x="300132" y="109897"/>
                        </a:moveTo>
                        <a:cubicBezTo>
                          <a:pt x="309763" y="117673"/>
                          <a:pt x="321642" y="127309"/>
                          <a:pt x="328002" y="138430"/>
                        </a:cubicBezTo>
                        <a:moveTo>
                          <a:pt x="88474" y="334200"/>
                        </a:moveTo>
                        <a:cubicBezTo>
                          <a:pt x="86238" y="323175"/>
                          <a:pt x="85815" y="313492"/>
                          <a:pt x="83608" y="304165"/>
                        </a:cubicBezTo>
                      </a:path>
                      <a:path w="926124" h="914400" stroke="0" extrusionOk="0">
                        <a:moveTo>
                          <a:pt x="83608" y="304165"/>
                        </a:moveTo>
                        <a:cubicBezTo>
                          <a:pt x="66932" y="240037"/>
                          <a:pt x="81174" y="192645"/>
                          <a:pt x="120546" y="146198"/>
                        </a:cubicBezTo>
                        <a:cubicBezTo>
                          <a:pt x="186588" y="83058"/>
                          <a:pt x="232151" y="64156"/>
                          <a:pt x="300239" y="110109"/>
                        </a:cubicBezTo>
                        <a:cubicBezTo>
                          <a:pt x="323746" y="31309"/>
                          <a:pt x="422981" y="22222"/>
                          <a:pt x="481412" y="72644"/>
                        </a:cubicBezTo>
                        <a:cubicBezTo>
                          <a:pt x="490727" y="33201"/>
                          <a:pt x="522797" y="10631"/>
                          <a:pt x="552008" y="4233"/>
                        </a:cubicBezTo>
                        <a:cubicBezTo>
                          <a:pt x="590055" y="-1623"/>
                          <a:pt x="623701" y="6671"/>
                          <a:pt x="639561" y="52514"/>
                        </a:cubicBezTo>
                        <a:cubicBezTo>
                          <a:pt x="667761" y="5433"/>
                          <a:pt x="714039" y="-5823"/>
                          <a:pt x="760257" y="14605"/>
                        </a:cubicBezTo>
                        <a:cubicBezTo>
                          <a:pt x="791039" y="21051"/>
                          <a:pt x="813129" y="74968"/>
                          <a:pt x="821463" y="118025"/>
                        </a:cubicBezTo>
                        <a:cubicBezTo>
                          <a:pt x="860627" y="132800"/>
                          <a:pt x="890405" y="169868"/>
                          <a:pt x="900012" y="218397"/>
                        </a:cubicBezTo>
                        <a:cubicBezTo>
                          <a:pt x="905376" y="253498"/>
                          <a:pt x="914442" y="298438"/>
                          <a:pt x="896496" y="327236"/>
                        </a:cubicBezTo>
                        <a:cubicBezTo>
                          <a:pt x="927721" y="380763"/>
                          <a:pt x="934588" y="452437"/>
                          <a:pt x="922179" y="493649"/>
                        </a:cubicBezTo>
                        <a:cubicBezTo>
                          <a:pt x="911761" y="576604"/>
                          <a:pt x="871426" y="641770"/>
                          <a:pt x="801869" y="639318"/>
                        </a:cubicBezTo>
                        <a:cubicBezTo>
                          <a:pt x="804649" y="684623"/>
                          <a:pt x="788286" y="721477"/>
                          <a:pt x="758799" y="764137"/>
                        </a:cubicBezTo>
                        <a:cubicBezTo>
                          <a:pt x="706752" y="813532"/>
                          <a:pt x="644367" y="808290"/>
                          <a:pt x="612163" y="779250"/>
                        </a:cubicBezTo>
                        <a:cubicBezTo>
                          <a:pt x="595019" y="845407"/>
                          <a:pt x="554883" y="891194"/>
                          <a:pt x="507374" y="912410"/>
                        </a:cubicBezTo>
                        <a:cubicBezTo>
                          <a:pt x="449816" y="913121"/>
                          <a:pt x="380720" y="902665"/>
                          <a:pt x="353299" y="831130"/>
                        </a:cubicBezTo>
                        <a:cubicBezTo>
                          <a:pt x="266890" y="907926"/>
                          <a:pt x="175732" y="863187"/>
                          <a:pt x="124426" y="750824"/>
                        </a:cubicBezTo>
                        <a:cubicBezTo>
                          <a:pt x="78787" y="765544"/>
                          <a:pt x="37828" y="719416"/>
                          <a:pt x="23796" y="661458"/>
                        </a:cubicBezTo>
                        <a:cubicBezTo>
                          <a:pt x="13604" y="620487"/>
                          <a:pt x="18510" y="573354"/>
                          <a:pt x="45298" y="540829"/>
                        </a:cubicBezTo>
                        <a:cubicBezTo>
                          <a:pt x="16289" y="521471"/>
                          <a:pt x="-7050" y="468182"/>
                          <a:pt x="-108" y="417068"/>
                        </a:cubicBezTo>
                        <a:cubicBezTo>
                          <a:pt x="7028" y="347859"/>
                          <a:pt x="33266" y="312720"/>
                          <a:pt x="82815" y="307064"/>
                        </a:cubicBezTo>
                        <a:cubicBezTo>
                          <a:pt x="83208" y="306208"/>
                          <a:pt x="83291" y="305318"/>
                          <a:pt x="83608" y="304165"/>
                        </a:cubicBezTo>
                        <a:close/>
                      </a:path>
                      <a:path w="926124" h="914400" fill="none" stroke="0" extrusionOk="0">
                        <a:moveTo>
                          <a:pt x="100608" y="554079"/>
                        </a:moveTo>
                        <a:cubicBezTo>
                          <a:pt x="82651" y="552223"/>
                          <a:pt x="64096" y="544965"/>
                          <a:pt x="46306" y="537210"/>
                        </a:cubicBezTo>
                        <a:moveTo>
                          <a:pt x="148522" y="738695"/>
                        </a:moveTo>
                        <a:cubicBezTo>
                          <a:pt x="140461" y="745022"/>
                          <a:pt x="132318" y="744850"/>
                          <a:pt x="124769" y="746760"/>
                        </a:cubicBezTo>
                        <a:moveTo>
                          <a:pt x="353256" y="827405"/>
                        </a:moveTo>
                        <a:cubicBezTo>
                          <a:pt x="348714" y="816800"/>
                          <a:pt x="342097" y="803684"/>
                          <a:pt x="338935" y="790575"/>
                        </a:cubicBezTo>
                        <a:moveTo>
                          <a:pt x="617994" y="735562"/>
                        </a:moveTo>
                        <a:cubicBezTo>
                          <a:pt x="615161" y="749958"/>
                          <a:pt x="615206" y="761646"/>
                          <a:pt x="612270" y="775970"/>
                        </a:cubicBezTo>
                        <a:moveTo>
                          <a:pt x="731659" y="485859"/>
                        </a:moveTo>
                        <a:cubicBezTo>
                          <a:pt x="757104" y="520467"/>
                          <a:pt x="800960" y="584526"/>
                          <a:pt x="801354" y="636905"/>
                        </a:cubicBezTo>
                        <a:moveTo>
                          <a:pt x="896067" y="324993"/>
                        </a:moveTo>
                        <a:cubicBezTo>
                          <a:pt x="887389" y="345337"/>
                          <a:pt x="880596" y="366416"/>
                          <a:pt x="865025" y="381635"/>
                        </a:cubicBezTo>
                        <a:moveTo>
                          <a:pt x="821592" y="114850"/>
                        </a:moveTo>
                        <a:cubicBezTo>
                          <a:pt x="820128" y="123423"/>
                          <a:pt x="822589" y="132954"/>
                          <a:pt x="823221" y="141605"/>
                        </a:cubicBezTo>
                        <a:moveTo>
                          <a:pt x="623375" y="83650"/>
                        </a:moveTo>
                        <a:cubicBezTo>
                          <a:pt x="626548" y="70286"/>
                          <a:pt x="632875" y="58419"/>
                          <a:pt x="639282" y="49530"/>
                        </a:cubicBezTo>
                        <a:moveTo>
                          <a:pt x="474659" y="99906"/>
                        </a:moveTo>
                        <a:cubicBezTo>
                          <a:pt x="476015" y="90132"/>
                          <a:pt x="478087" y="81859"/>
                          <a:pt x="482356" y="70485"/>
                        </a:cubicBezTo>
                        <a:moveTo>
                          <a:pt x="300132" y="109897"/>
                        </a:moveTo>
                        <a:cubicBezTo>
                          <a:pt x="308469" y="118284"/>
                          <a:pt x="320059" y="128707"/>
                          <a:pt x="328002" y="138430"/>
                        </a:cubicBezTo>
                        <a:moveTo>
                          <a:pt x="88474" y="334200"/>
                        </a:moveTo>
                        <a:cubicBezTo>
                          <a:pt x="84869" y="324137"/>
                          <a:pt x="84568" y="312557"/>
                          <a:pt x="83608" y="304165"/>
                        </a:cubicBezTo>
                      </a:path>
                    </a:pathLst>
                  </a:custGeom>
                  <ask:type>
                    <ask:lineSketchNone/>
                  </ask:type>
                </ask:lineSketchStyleProps>
              </a:ext>
            </a:extLst>
          </a:ln>
          <a:effectLst>
            <a:glow rad="704318">
              <a:srgbClr val="00B050">
                <a:alpha val="45846"/>
              </a:srgbClr>
            </a:glow>
          </a:effectLst>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ZoneTexte 23">
            <a:extLst>
              <a:ext uri="{FF2B5EF4-FFF2-40B4-BE49-F238E27FC236}">
                <a16:creationId xmlns:a16="http://schemas.microsoft.com/office/drawing/2014/main" id="{BC2422F3-0926-8B66-D1C9-8367DA02154D}"/>
              </a:ext>
            </a:extLst>
          </p:cNvPr>
          <p:cNvSpPr txBox="1"/>
          <p:nvPr/>
        </p:nvSpPr>
        <p:spPr>
          <a:xfrm>
            <a:off x="10057030" y="1694218"/>
            <a:ext cx="1927130" cy="338554"/>
          </a:xfrm>
          <a:prstGeom prst="rect">
            <a:avLst/>
          </a:prstGeom>
          <a:noFill/>
        </p:spPr>
        <p:txBody>
          <a:bodyPr wrap="none" rtlCol="0">
            <a:spAutoFit/>
          </a:bodyPr>
          <a:lstStyle/>
          <a:p>
            <a:pPr algn="ctr"/>
            <a:r>
              <a:rPr lang="en-US" sz="1600" i="1" dirty="0">
                <a:solidFill>
                  <a:srgbClr val="FF0000"/>
                </a:solidFill>
                <a:latin typeface="Arial" panose="020B0604020202020204" pitchFamily="34" charset="0"/>
                <a:cs typeface="Arial" panose="020B0604020202020204" pitchFamily="34" charset="0"/>
              </a:rPr>
              <a:t>in situ</a:t>
            </a:r>
            <a:r>
              <a:rPr lang="en-US" sz="1600" dirty="0">
                <a:solidFill>
                  <a:srgbClr val="FF0000"/>
                </a:solidFill>
                <a:latin typeface="Arial" panose="020B0604020202020204" pitchFamily="34" charset="0"/>
                <a:cs typeface="Arial" panose="020B0604020202020204" pitchFamily="34" charset="0"/>
              </a:rPr>
              <a:t> hybridization</a:t>
            </a:r>
          </a:p>
        </p:txBody>
      </p:sp>
      <p:sp>
        <p:nvSpPr>
          <p:cNvPr id="25" name="Forme en L 24">
            <a:extLst>
              <a:ext uri="{FF2B5EF4-FFF2-40B4-BE49-F238E27FC236}">
                <a16:creationId xmlns:a16="http://schemas.microsoft.com/office/drawing/2014/main" id="{2C49B0FB-E4BF-8486-D100-7A3545C18DE3}"/>
              </a:ext>
            </a:extLst>
          </p:cNvPr>
          <p:cNvSpPr>
            <a:spLocks noChangeAspect="1"/>
          </p:cNvSpPr>
          <p:nvPr/>
        </p:nvSpPr>
        <p:spPr>
          <a:xfrm rot="10436648">
            <a:off x="6595670" y="3322740"/>
            <a:ext cx="730859" cy="730859"/>
          </a:xfrm>
          <a:prstGeom prst="corner">
            <a:avLst>
              <a:gd name="adj1" fmla="val 35264"/>
              <a:gd name="adj2" fmla="val 37106"/>
            </a:avLst>
          </a:prstGeom>
          <a:solidFill>
            <a:schemeClr val="bg1">
              <a:lumMod val="65000"/>
            </a:schemeClr>
          </a:solidFill>
          <a:ln>
            <a:noFill/>
          </a:ln>
          <a:effectLst/>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Nuage 8">
            <a:extLst>
              <a:ext uri="{FF2B5EF4-FFF2-40B4-BE49-F238E27FC236}">
                <a16:creationId xmlns:a16="http://schemas.microsoft.com/office/drawing/2014/main" id="{E3B622A3-87D5-DDBC-E1F1-D8226E4E6A1D}"/>
              </a:ext>
            </a:extLst>
          </p:cNvPr>
          <p:cNvSpPr/>
          <p:nvPr/>
        </p:nvSpPr>
        <p:spPr>
          <a:xfrm>
            <a:off x="7158913" y="2968359"/>
            <a:ext cx="492409" cy="444537"/>
          </a:xfrm>
          <a:prstGeom prst="cloud">
            <a:avLst/>
          </a:prstGeom>
          <a:solidFill>
            <a:srgbClr val="FF0000"/>
          </a:solidFill>
          <a:ln>
            <a:noFill/>
            <a:extLst>
              <a:ext uri="{C807C97D-BFC1-408E-A445-0C87EB9F89A2}">
                <ask:lineSketchStyleProps xmlns:ask="http://schemas.microsoft.com/office/drawing/2018/sketchyshapes" sd="1219033472">
                  <a:custGeom>
                    <a:avLst/>
                    <a:gdLst>
                      <a:gd name="connsiteX0" fmla="*/ 83608 w 926124"/>
                      <a:gd name="connsiteY0" fmla="*/ 304165 h 914400"/>
                      <a:gd name="connsiteX1" fmla="*/ 120546 w 926124"/>
                      <a:gd name="connsiteY1" fmla="*/ 146198 h 914400"/>
                      <a:gd name="connsiteX2" fmla="*/ 300239 w 926124"/>
                      <a:gd name="connsiteY2" fmla="*/ 110109 h 914400"/>
                      <a:gd name="connsiteX3" fmla="*/ 481412 w 926124"/>
                      <a:gd name="connsiteY3" fmla="*/ 72644 h 914400"/>
                      <a:gd name="connsiteX4" fmla="*/ 552008 w 926124"/>
                      <a:gd name="connsiteY4" fmla="*/ 4233 h 914400"/>
                      <a:gd name="connsiteX5" fmla="*/ 639561 w 926124"/>
                      <a:gd name="connsiteY5" fmla="*/ 52514 h 914400"/>
                      <a:gd name="connsiteX6" fmla="*/ 760257 w 926124"/>
                      <a:gd name="connsiteY6" fmla="*/ 14605 h 914400"/>
                      <a:gd name="connsiteX7" fmla="*/ 821463 w 926124"/>
                      <a:gd name="connsiteY7" fmla="*/ 118025 h 914400"/>
                      <a:gd name="connsiteX8" fmla="*/ 900012 w 926124"/>
                      <a:gd name="connsiteY8" fmla="*/ 218397 h 914400"/>
                      <a:gd name="connsiteX9" fmla="*/ 896496 w 926124"/>
                      <a:gd name="connsiteY9" fmla="*/ 327236 h 914400"/>
                      <a:gd name="connsiteX10" fmla="*/ 922179 w 926124"/>
                      <a:gd name="connsiteY10" fmla="*/ 493649 h 914400"/>
                      <a:gd name="connsiteX11" fmla="*/ 801869 w 926124"/>
                      <a:gd name="connsiteY11" fmla="*/ 639318 h 914400"/>
                      <a:gd name="connsiteX12" fmla="*/ 758799 w 926124"/>
                      <a:gd name="connsiteY12" fmla="*/ 764137 h 914400"/>
                      <a:gd name="connsiteX13" fmla="*/ 612163 w 926124"/>
                      <a:gd name="connsiteY13" fmla="*/ 779250 h 914400"/>
                      <a:gd name="connsiteX14" fmla="*/ 507374 w 926124"/>
                      <a:gd name="connsiteY14" fmla="*/ 912410 h 914400"/>
                      <a:gd name="connsiteX15" fmla="*/ 353299 w 926124"/>
                      <a:gd name="connsiteY15" fmla="*/ 831130 h 914400"/>
                      <a:gd name="connsiteX16" fmla="*/ 124426 w 926124"/>
                      <a:gd name="connsiteY16" fmla="*/ 750824 h 914400"/>
                      <a:gd name="connsiteX17" fmla="*/ 23796 w 926124"/>
                      <a:gd name="connsiteY17" fmla="*/ 661458 h 914400"/>
                      <a:gd name="connsiteX18" fmla="*/ 45298 w 926124"/>
                      <a:gd name="connsiteY18" fmla="*/ 540829 h 914400"/>
                      <a:gd name="connsiteX19" fmla="*/ -108 w 926124"/>
                      <a:gd name="connsiteY19" fmla="*/ 417068 h 914400"/>
                      <a:gd name="connsiteX20" fmla="*/ 82815 w 926124"/>
                      <a:gd name="connsiteY20" fmla="*/ 307064 h 914400"/>
                      <a:gd name="connsiteX21" fmla="*/ 83608 w 926124"/>
                      <a:gd name="connsiteY21" fmla="*/ 304165 h 914400"/>
                      <a:gd name="connsiteX0" fmla="*/ 100608 w 926124"/>
                      <a:gd name="connsiteY0" fmla="*/ 554079 h 914400"/>
                      <a:gd name="connsiteX1" fmla="*/ 46306 w 926124"/>
                      <a:gd name="connsiteY1" fmla="*/ 537210 h 914400"/>
                      <a:gd name="connsiteX2" fmla="*/ 148522 w 926124"/>
                      <a:gd name="connsiteY2" fmla="*/ 738695 h 914400"/>
                      <a:gd name="connsiteX3" fmla="*/ 124769 w 926124"/>
                      <a:gd name="connsiteY3" fmla="*/ 746760 h 914400"/>
                      <a:gd name="connsiteX4" fmla="*/ 353256 w 926124"/>
                      <a:gd name="connsiteY4" fmla="*/ 827405 h 914400"/>
                      <a:gd name="connsiteX5" fmla="*/ 338935 w 926124"/>
                      <a:gd name="connsiteY5" fmla="*/ 790575 h 914400"/>
                      <a:gd name="connsiteX6" fmla="*/ 617994 w 926124"/>
                      <a:gd name="connsiteY6" fmla="*/ 735562 h 914400"/>
                      <a:gd name="connsiteX7" fmla="*/ 612270 w 926124"/>
                      <a:gd name="connsiteY7" fmla="*/ 775970 h 914400"/>
                      <a:gd name="connsiteX8" fmla="*/ 731659 w 926124"/>
                      <a:gd name="connsiteY8" fmla="*/ 485859 h 914400"/>
                      <a:gd name="connsiteX9" fmla="*/ 801354 w 926124"/>
                      <a:gd name="connsiteY9" fmla="*/ 636905 h 914400"/>
                      <a:gd name="connsiteX10" fmla="*/ 896067 w 926124"/>
                      <a:gd name="connsiteY10" fmla="*/ 324993 h 914400"/>
                      <a:gd name="connsiteX11" fmla="*/ 865025 w 926124"/>
                      <a:gd name="connsiteY11" fmla="*/ 381635 h 914400"/>
                      <a:gd name="connsiteX12" fmla="*/ 821592 w 926124"/>
                      <a:gd name="connsiteY12" fmla="*/ 114850 h 914400"/>
                      <a:gd name="connsiteX13" fmla="*/ 823221 w 926124"/>
                      <a:gd name="connsiteY13" fmla="*/ 141605 h 914400"/>
                      <a:gd name="connsiteX14" fmla="*/ 623375 w 926124"/>
                      <a:gd name="connsiteY14" fmla="*/ 83650 h 914400"/>
                      <a:gd name="connsiteX15" fmla="*/ 639282 w 926124"/>
                      <a:gd name="connsiteY15" fmla="*/ 49530 h 914400"/>
                      <a:gd name="connsiteX16" fmla="*/ 474659 w 926124"/>
                      <a:gd name="connsiteY16" fmla="*/ 99906 h 914400"/>
                      <a:gd name="connsiteX17" fmla="*/ 482356 w 926124"/>
                      <a:gd name="connsiteY17" fmla="*/ 70485 h 914400"/>
                      <a:gd name="connsiteX18" fmla="*/ 300132 w 926124"/>
                      <a:gd name="connsiteY18" fmla="*/ 109897 h 914400"/>
                      <a:gd name="connsiteX19" fmla="*/ 328002 w 926124"/>
                      <a:gd name="connsiteY19" fmla="*/ 138430 h 914400"/>
                      <a:gd name="connsiteX20" fmla="*/ 88474 w 926124"/>
                      <a:gd name="connsiteY20" fmla="*/ 334200 h 914400"/>
                      <a:gd name="connsiteX21" fmla="*/ 83608 w 926124"/>
                      <a:gd name="connsiteY21" fmla="*/ 304165 h 9144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926124" h="914400" fill="none" extrusionOk="0">
                        <a:moveTo>
                          <a:pt x="83608" y="304165"/>
                        </a:moveTo>
                        <a:cubicBezTo>
                          <a:pt x="71337" y="259709"/>
                          <a:pt x="89078" y="185816"/>
                          <a:pt x="120546" y="146198"/>
                        </a:cubicBezTo>
                        <a:cubicBezTo>
                          <a:pt x="180294" y="83133"/>
                          <a:pt x="240544" y="44472"/>
                          <a:pt x="300239" y="110109"/>
                        </a:cubicBezTo>
                        <a:cubicBezTo>
                          <a:pt x="343738" y="24049"/>
                          <a:pt x="411423" y="3865"/>
                          <a:pt x="481412" y="72644"/>
                        </a:cubicBezTo>
                        <a:cubicBezTo>
                          <a:pt x="494012" y="39184"/>
                          <a:pt x="519547" y="3742"/>
                          <a:pt x="552008" y="4233"/>
                        </a:cubicBezTo>
                        <a:cubicBezTo>
                          <a:pt x="591139" y="-6367"/>
                          <a:pt x="621071" y="12742"/>
                          <a:pt x="639561" y="52514"/>
                        </a:cubicBezTo>
                        <a:cubicBezTo>
                          <a:pt x="661000" y="2512"/>
                          <a:pt x="727085" y="-18478"/>
                          <a:pt x="760257" y="14605"/>
                        </a:cubicBezTo>
                        <a:cubicBezTo>
                          <a:pt x="781805" y="39036"/>
                          <a:pt x="816997" y="76594"/>
                          <a:pt x="821463" y="118025"/>
                        </a:cubicBezTo>
                        <a:cubicBezTo>
                          <a:pt x="862700" y="130782"/>
                          <a:pt x="887054" y="172857"/>
                          <a:pt x="900012" y="218397"/>
                        </a:cubicBezTo>
                        <a:cubicBezTo>
                          <a:pt x="911392" y="254804"/>
                          <a:pt x="905949" y="287720"/>
                          <a:pt x="896496" y="327236"/>
                        </a:cubicBezTo>
                        <a:cubicBezTo>
                          <a:pt x="935652" y="374908"/>
                          <a:pt x="941457" y="444601"/>
                          <a:pt x="922179" y="493649"/>
                        </a:cubicBezTo>
                        <a:cubicBezTo>
                          <a:pt x="917821" y="580107"/>
                          <a:pt x="864011" y="637252"/>
                          <a:pt x="801869" y="639318"/>
                        </a:cubicBezTo>
                        <a:cubicBezTo>
                          <a:pt x="807488" y="693136"/>
                          <a:pt x="780739" y="725942"/>
                          <a:pt x="758799" y="764137"/>
                        </a:cubicBezTo>
                        <a:cubicBezTo>
                          <a:pt x="716295" y="813096"/>
                          <a:pt x="670149" y="820532"/>
                          <a:pt x="612163" y="779250"/>
                        </a:cubicBezTo>
                        <a:cubicBezTo>
                          <a:pt x="603395" y="839019"/>
                          <a:pt x="553129" y="888687"/>
                          <a:pt x="507374" y="912410"/>
                        </a:cubicBezTo>
                        <a:cubicBezTo>
                          <a:pt x="436158" y="937157"/>
                          <a:pt x="387522" y="907165"/>
                          <a:pt x="353299" y="831130"/>
                        </a:cubicBezTo>
                        <a:cubicBezTo>
                          <a:pt x="260389" y="880211"/>
                          <a:pt x="191762" y="836405"/>
                          <a:pt x="124426" y="750824"/>
                        </a:cubicBezTo>
                        <a:cubicBezTo>
                          <a:pt x="88896" y="769993"/>
                          <a:pt x="52190" y="722855"/>
                          <a:pt x="23796" y="661458"/>
                        </a:cubicBezTo>
                        <a:cubicBezTo>
                          <a:pt x="5689" y="622220"/>
                          <a:pt x="22538" y="566743"/>
                          <a:pt x="45298" y="540829"/>
                        </a:cubicBezTo>
                        <a:cubicBezTo>
                          <a:pt x="14203" y="506065"/>
                          <a:pt x="-2065" y="459478"/>
                          <a:pt x="-108" y="417068"/>
                        </a:cubicBezTo>
                        <a:cubicBezTo>
                          <a:pt x="3361" y="358891"/>
                          <a:pt x="45535" y="303762"/>
                          <a:pt x="82815" y="307064"/>
                        </a:cubicBezTo>
                        <a:cubicBezTo>
                          <a:pt x="83174" y="306011"/>
                          <a:pt x="83501" y="305126"/>
                          <a:pt x="83608" y="304165"/>
                        </a:cubicBezTo>
                        <a:close/>
                      </a:path>
                      <a:path w="926124" h="914400" fill="none" extrusionOk="0">
                        <a:moveTo>
                          <a:pt x="100608" y="554079"/>
                        </a:moveTo>
                        <a:cubicBezTo>
                          <a:pt x="82473" y="554508"/>
                          <a:pt x="64241" y="548588"/>
                          <a:pt x="46306" y="537210"/>
                        </a:cubicBezTo>
                        <a:moveTo>
                          <a:pt x="148522" y="738695"/>
                        </a:moveTo>
                        <a:cubicBezTo>
                          <a:pt x="142839" y="741453"/>
                          <a:pt x="134619" y="744048"/>
                          <a:pt x="124769" y="746760"/>
                        </a:cubicBezTo>
                        <a:moveTo>
                          <a:pt x="353256" y="827405"/>
                        </a:moveTo>
                        <a:cubicBezTo>
                          <a:pt x="348060" y="818827"/>
                          <a:pt x="343509" y="802778"/>
                          <a:pt x="338935" y="790575"/>
                        </a:cubicBezTo>
                        <a:moveTo>
                          <a:pt x="617994" y="735562"/>
                        </a:moveTo>
                        <a:cubicBezTo>
                          <a:pt x="620346" y="749453"/>
                          <a:pt x="615005" y="760028"/>
                          <a:pt x="612270" y="775970"/>
                        </a:cubicBezTo>
                        <a:moveTo>
                          <a:pt x="731659" y="485859"/>
                        </a:moveTo>
                        <a:cubicBezTo>
                          <a:pt x="767886" y="514709"/>
                          <a:pt x="810093" y="582907"/>
                          <a:pt x="801354" y="636905"/>
                        </a:cubicBezTo>
                        <a:moveTo>
                          <a:pt x="896067" y="324993"/>
                        </a:moveTo>
                        <a:cubicBezTo>
                          <a:pt x="887796" y="350013"/>
                          <a:pt x="882311" y="364882"/>
                          <a:pt x="865025" y="381635"/>
                        </a:cubicBezTo>
                        <a:moveTo>
                          <a:pt x="821592" y="114850"/>
                        </a:moveTo>
                        <a:cubicBezTo>
                          <a:pt x="822863" y="123456"/>
                          <a:pt x="825677" y="133667"/>
                          <a:pt x="823221" y="141605"/>
                        </a:cubicBezTo>
                        <a:moveTo>
                          <a:pt x="623375" y="83650"/>
                        </a:moveTo>
                        <a:cubicBezTo>
                          <a:pt x="628665" y="69366"/>
                          <a:pt x="635344" y="58957"/>
                          <a:pt x="639282" y="49530"/>
                        </a:cubicBezTo>
                        <a:moveTo>
                          <a:pt x="474659" y="99906"/>
                        </a:moveTo>
                        <a:cubicBezTo>
                          <a:pt x="478201" y="90042"/>
                          <a:pt x="479087" y="82159"/>
                          <a:pt x="482356" y="70485"/>
                        </a:cubicBezTo>
                        <a:moveTo>
                          <a:pt x="300132" y="109897"/>
                        </a:moveTo>
                        <a:cubicBezTo>
                          <a:pt x="309763" y="117673"/>
                          <a:pt x="321642" y="127309"/>
                          <a:pt x="328002" y="138430"/>
                        </a:cubicBezTo>
                        <a:moveTo>
                          <a:pt x="88474" y="334200"/>
                        </a:moveTo>
                        <a:cubicBezTo>
                          <a:pt x="86238" y="323175"/>
                          <a:pt x="85815" y="313492"/>
                          <a:pt x="83608" y="304165"/>
                        </a:cubicBezTo>
                      </a:path>
                      <a:path w="926124" h="914400" stroke="0" extrusionOk="0">
                        <a:moveTo>
                          <a:pt x="83608" y="304165"/>
                        </a:moveTo>
                        <a:cubicBezTo>
                          <a:pt x="66932" y="240037"/>
                          <a:pt x="81174" y="192645"/>
                          <a:pt x="120546" y="146198"/>
                        </a:cubicBezTo>
                        <a:cubicBezTo>
                          <a:pt x="186588" y="83058"/>
                          <a:pt x="232151" y="64156"/>
                          <a:pt x="300239" y="110109"/>
                        </a:cubicBezTo>
                        <a:cubicBezTo>
                          <a:pt x="323746" y="31309"/>
                          <a:pt x="422981" y="22222"/>
                          <a:pt x="481412" y="72644"/>
                        </a:cubicBezTo>
                        <a:cubicBezTo>
                          <a:pt x="490727" y="33201"/>
                          <a:pt x="522797" y="10631"/>
                          <a:pt x="552008" y="4233"/>
                        </a:cubicBezTo>
                        <a:cubicBezTo>
                          <a:pt x="590055" y="-1623"/>
                          <a:pt x="623701" y="6671"/>
                          <a:pt x="639561" y="52514"/>
                        </a:cubicBezTo>
                        <a:cubicBezTo>
                          <a:pt x="667761" y="5433"/>
                          <a:pt x="714039" y="-5823"/>
                          <a:pt x="760257" y="14605"/>
                        </a:cubicBezTo>
                        <a:cubicBezTo>
                          <a:pt x="791039" y="21051"/>
                          <a:pt x="813129" y="74968"/>
                          <a:pt x="821463" y="118025"/>
                        </a:cubicBezTo>
                        <a:cubicBezTo>
                          <a:pt x="860627" y="132800"/>
                          <a:pt x="890405" y="169868"/>
                          <a:pt x="900012" y="218397"/>
                        </a:cubicBezTo>
                        <a:cubicBezTo>
                          <a:pt x="905376" y="253498"/>
                          <a:pt x="914442" y="298438"/>
                          <a:pt x="896496" y="327236"/>
                        </a:cubicBezTo>
                        <a:cubicBezTo>
                          <a:pt x="927721" y="380763"/>
                          <a:pt x="934588" y="452437"/>
                          <a:pt x="922179" y="493649"/>
                        </a:cubicBezTo>
                        <a:cubicBezTo>
                          <a:pt x="911761" y="576604"/>
                          <a:pt x="871426" y="641770"/>
                          <a:pt x="801869" y="639318"/>
                        </a:cubicBezTo>
                        <a:cubicBezTo>
                          <a:pt x="804649" y="684623"/>
                          <a:pt x="788286" y="721477"/>
                          <a:pt x="758799" y="764137"/>
                        </a:cubicBezTo>
                        <a:cubicBezTo>
                          <a:pt x="706752" y="813532"/>
                          <a:pt x="644367" y="808290"/>
                          <a:pt x="612163" y="779250"/>
                        </a:cubicBezTo>
                        <a:cubicBezTo>
                          <a:pt x="595019" y="845407"/>
                          <a:pt x="554883" y="891194"/>
                          <a:pt x="507374" y="912410"/>
                        </a:cubicBezTo>
                        <a:cubicBezTo>
                          <a:pt x="449816" y="913121"/>
                          <a:pt x="380720" y="902665"/>
                          <a:pt x="353299" y="831130"/>
                        </a:cubicBezTo>
                        <a:cubicBezTo>
                          <a:pt x="266890" y="907926"/>
                          <a:pt x="175732" y="863187"/>
                          <a:pt x="124426" y="750824"/>
                        </a:cubicBezTo>
                        <a:cubicBezTo>
                          <a:pt x="78787" y="765544"/>
                          <a:pt x="37828" y="719416"/>
                          <a:pt x="23796" y="661458"/>
                        </a:cubicBezTo>
                        <a:cubicBezTo>
                          <a:pt x="13604" y="620487"/>
                          <a:pt x="18510" y="573354"/>
                          <a:pt x="45298" y="540829"/>
                        </a:cubicBezTo>
                        <a:cubicBezTo>
                          <a:pt x="16289" y="521471"/>
                          <a:pt x="-7050" y="468182"/>
                          <a:pt x="-108" y="417068"/>
                        </a:cubicBezTo>
                        <a:cubicBezTo>
                          <a:pt x="7028" y="347859"/>
                          <a:pt x="33266" y="312720"/>
                          <a:pt x="82815" y="307064"/>
                        </a:cubicBezTo>
                        <a:cubicBezTo>
                          <a:pt x="83208" y="306208"/>
                          <a:pt x="83291" y="305318"/>
                          <a:pt x="83608" y="304165"/>
                        </a:cubicBezTo>
                        <a:close/>
                      </a:path>
                      <a:path w="926124" h="914400" fill="none" stroke="0" extrusionOk="0">
                        <a:moveTo>
                          <a:pt x="100608" y="554079"/>
                        </a:moveTo>
                        <a:cubicBezTo>
                          <a:pt x="82651" y="552223"/>
                          <a:pt x="64096" y="544965"/>
                          <a:pt x="46306" y="537210"/>
                        </a:cubicBezTo>
                        <a:moveTo>
                          <a:pt x="148522" y="738695"/>
                        </a:moveTo>
                        <a:cubicBezTo>
                          <a:pt x="140461" y="745022"/>
                          <a:pt x="132318" y="744850"/>
                          <a:pt x="124769" y="746760"/>
                        </a:cubicBezTo>
                        <a:moveTo>
                          <a:pt x="353256" y="827405"/>
                        </a:moveTo>
                        <a:cubicBezTo>
                          <a:pt x="348714" y="816800"/>
                          <a:pt x="342097" y="803684"/>
                          <a:pt x="338935" y="790575"/>
                        </a:cubicBezTo>
                        <a:moveTo>
                          <a:pt x="617994" y="735562"/>
                        </a:moveTo>
                        <a:cubicBezTo>
                          <a:pt x="615161" y="749958"/>
                          <a:pt x="615206" y="761646"/>
                          <a:pt x="612270" y="775970"/>
                        </a:cubicBezTo>
                        <a:moveTo>
                          <a:pt x="731659" y="485859"/>
                        </a:moveTo>
                        <a:cubicBezTo>
                          <a:pt x="757104" y="520467"/>
                          <a:pt x="800960" y="584526"/>
                          <a:pt x="801354" y="636905"/>
                        </a:cubicBezTo>
                        <a:moveTo>
                          <a:pt x="896067" y="324993"/>
                        </a:moveTo>
                        <a:cubicBezTo>
                          <a:pt x="887389" y="345337"/>
                          <a:pt x="880596" y="366416"/>
                          <a:pt x="865025" y="381635"/>
                        </a:cubicBezTo>
                        <a:moveTo>
                          <a:pt x="821592" y="114850"/>
                        </a:moveTo>
                        <a:cubicBezTo>
                          <a:pt x="820128" y="123423"/>
                          <a:pt x="822589" y="132954"/>
                          <a:pt x="823221" y="141605"/>
                        </a:cubicBezTo>
                        <a:moveTo>
                          <a:pt x="623375" y="83650"/>
                        </a:moveTo>
                        <a:cubicBezTo>
                          <a:pt x="626548" y="70286"/>
                          <a:pt x="632875" y="58419"/>
                          <a:pt x="639282" y="49530"/>
                        </a:cubicBezTo>
                        <a:moveTo>
                          <a:pt x="474659" y="99906"/>
                        </a:moveTo>
                        <a:cubicBezTo>
                          <a:pt x="476015" y="90132"/>
                          <a:pt x="478087" y="81859"/>
                          <a:pt x="482356" y="70485"/>
                        </a:cubicBezTo>
                        <a:moveTo>
                          <a:pt x="300132" y="109897"/>
                        </a:moveTo>
                        <a:cubicBezTo>
                          <a:pt x="308469" y="118284"/>
                          <a:pt x="320059" y="128707"/>
                          <a:pt x="328002" y="138430"/>
                        </a:cubicBezTo>
                        <a:moveTo>
                          <a:pt x="88474" y="334200"/>
                        </a:moveTo>
                        <a:cubicBezTo>
                          <a:pt x="84869" y="324137"/>
                          <a:pt x="84568" y="312557"/>
                          <a:pt x="83608" y="304165"/>
                        </a:cubicBezTo>
                      </a:path>
                    </a:pathLst>
                  </a:custGeom>
                  <ask:type>
                    <ask:lineSketchNone/>
                  </ask:type>
                </ask:lineSketchStyleProps>
              </a:ext>
            </a:extLst>
          </a:ln>
          <a:effectLst>
            <a:glow rad="704318">
              <a:srgbClr val="FF0000">
                <a:alpha val="46000"/>
              </a:srgbClr>
            </a:glow>
          </a:effectLst>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ZoneTexte 26">
            <a:extLst>
              <a:ext uri="{FF2B5EF4-FFF2-40B4-BE49-F238E27FC236}">
                <a16:creationId xmlns:a16="http://schemas.microsoft.com/office/drawing/2014/main" id="{B0CC8822-B69D-36B4-69DA-BF94F9C216B3}"/>
              </a:ext>
            </a:extLst>
          </p:cNvPr>
          <p:cNvSpPr txBox="1"/>
          <p:nvPr/>
        </p:nvSpPr>
        <p:spPr>
          <a:xfrm>
            <a:off x="9972629" y="874945"/>
            <a:ext cx="1457450" cy="338554"/>
          </a:xfrm>
          <a:prstGeom prst="rect">
            <a:avLst/>
          </a:prstGeom>
          <a:noFill/>
        </p:spPr>
        <p:txBody>
          <a:bodyPr wrap="none" rtlCol="0">
            <a:spAutoFit/>
          </a:bodyPr>
          <a:lstStyle/>
          <a:p>
            <a:pPr algn="ctr"/>
            <a:r>
              <a:rPr lang="en-US" sz="1600" i="1" dirty="0">
                <a:latin typeface="Arial" panose="020B0604020202020204" pitchFamily="34" charset="0"/>
                <a:cs typeface="Arial" panose="020B0604020202020204" pitchFamily="34" charset="0"/>
              </a:rPr>
              <a:t>Colocalization</a:t>
            </a:r>
          </a:p>
        </p:txBody>
      </p:sp>
      <p:sp>
        <p:nvSpPr>
          <p:cNvPr id="28" name="ZoneTexte 27">
            <a:extLst>
              <a:ext uri="{FF2B5EF4-FFF2-40B4-BE49-F238E27FC236}">
                <a16:creationId xmlns:a16="http://schemas.microsoft.com/office/drawing/2014/main" id="{FE29D525-501B-D2F6-D012-47DD10B14260}"/>
              </a:ext>
            </a:extLst>
          </p:cNvPr>
          <p:cNvSpPr txBox="1"/>
          <p:nvPr/>
        </p:nvSpPr>
        <p:spPr>
          <a:xfrm>
            <a:off x="5325726" y="880056"/>
            <a:ext cx="2597186" cy="338554"/>
          </a:xfrm>
          <a:prstGeom prst="rect">
            <a:avLst/>
          </a:prstGeom>
          <a:noFill/>
        </p:spPr>
        <p:txBody>
          <a:bodyPr wrap="none" rtlCol="0">
            <a:spAutoFit/>
          </a:bodyPr>
          <a:lstStyle/>
          <a:p>
            <a:pPr algn="ctr"/>
            <a:r>
              <a:rPr lang="en-US" sz="1600" i="1" dirty="0">
                <a:latin typeface="Arial" panose="020B0604020202020204" pitchFamily="34" charset="0"/>
                <a:cs typeface="Arial" panose="020B0604020202020204" pitchFamily="34" charset="0"/>
              </a:rPr>
              <a:t>Rolling circle amplification </a:t>
            </a:r>
          </a:p>
        </p:txBody>
      </p:sp>
      <p:sp>
        <p:nvSpPr>
          <p:cNvPr id="29" name="ZoneTexte 28">
            <a:extLst>
              <a:ext uri="{FF2B5EF4-FFF2-40B4-BE49-F238E27FC236}">
                <a16:creationId xmlns:a16="http://schemas.microsoft.com/office/drawing/2014/main" id="{6183A155-7D7B-A773-1942-3854C80342D9}"/>
              </a:ext>
            </a:extLst>
          </p:cNvPr>
          <p:cNvSpPr txBox="1"/>
          <p:nvPr/>
        </p:nvSpPr>
        <p:spPr>
          <a:xfrm>
            <a:off x="2127385" y="881233"/>
            <a:ext cx="718465" cy="338554"/>
          </a:xfrm>
          <a:prstGeom prst="rect">
            <a:avLst/>
          </a:prstGeom>
          <a:noFill/>
        </p:spPr>
        <p:txBody>
          <a:bodyPr wrap="none" rtlCol="0">
            <a:spAutoFit/>
          </a:bodyPr>
          <a:lstStyle/>
          <a:p>
            <a:pPr algn="ctr"/>
            <a:r>
              <a:rPr lang="en-US" sz="1600" i="1" dirty="0">
                <a:latin typeface="Arial" panose="020B0604020202020204" pitchFamily="34" charset="0"/>
                <a:cs typeface="Arial" panose="020B0604020202020204" pitchFamily="34" charset="0"/>
              </a:rPr>
              <a:t>FRET</a:t>
            </a:r>
          </a:p>
        </p:txBody>
      </p:sp>
      <p:sp>
        <p:nvSpPr>
          <p:cNvPr id="30" name="ZoneTexte 29">
            <a:extLst>
              <a:ext uri="{FF2B5EF4-FFF2-40B4-BE49-F238E27FC236}">
                <a16:creationId xmlns:a16="http://schemas.microsoft.com/office/drawing/2014/main" id="{0BF45466-5A08-F1F0-AD8C-2A0C0DCE0556}"/>
              </a:ext>
            </a:extLst>
          </p:cNvPr>
          <p:cNvSpPr txBox="1"/>
          <p:nvPr/>
        </p:nvSpPr>
        <p:spPr>
          <a:xfrm>
            <a:off x="21831" y="882112"/>
            <a:ext cx="1495923" cy="338554"/>
          </a:xfrm>
          <a:prstGeom prst="rect">
            <a:avLst/>
          </a:prstGeom>
          <a:noFill/>
        </p:spPr>
        <p:txBody>
          <a:bodyPr wrap="none" rtlCol="0">
            <a:spAutoFit/>
          </a:bodyPr>
          <a:lstStyle/>
          <a:p>
            <a:r>
              <a:rPr lang="en-US" sz="1600" i="1" dirty="0">
                <a:latin typeface="Arial" panose="020B0604020202020204" pitchFamily="34" charset="0"/>
                <a:cs typeface="Arial" panose="020B0604020202020204" pitchFamily="34" charset="0"/>
              </a:rPr>
              <a:t>Detection type</a:t>
            </a:r>
          </a:p>
        </p:txBody>
      </p:sp>
      <p:sp>
        <p:nvSpPr>
          <p:cNvPr id="31" name="ZoneTexte 30">
            <a:extLst>
              <a:ext uri="{FF2B5EF4-FFF2-40B4-BE49-F238E27FC236}">
                <a16:creationId xmlns:a16="http://schemas.microsoft.com/office/drawing/2014/main" id="{FA5BBCD2-28E7-4A28-E161-04F6FD51A822}"/>
              </a:ext>
            </a:extLst>
          </p:cNvPr>
          <p:cNvSpPr txBox="1"/>
          <p:nvPr/>
        </p:nvSpPr>
        <p:spPr>
          <a:xfrm>
            <a:off x="21831" y="1146169"/>
            <a:ext cx="1906291" cy="338554"/>
          </a:xfrm>
          <a:prstGeom prst="rect">
            <a:avLst/>
          </a:prstGeom>
          <a:noFill/>
        </p:spPr>
        <p:txBody>
          <a:bodyPr wrap="none" rtlCol="0">
            <a:spAutoFit/>
          </a:bodyPr>
          <a:lstStyle/>
          <a:p>
            <a:r>
              <a:rPr lang="en-US" sz="1600" i="1" dirty="0">
                <a:latin typeface="Arial" panose="020B0604020202020204" pitchFamily="34" charset="0"/>
                <a:cs typeface="Arial" panose="020B0604020202020204" pitchFamily="34" charset="0"/>
              </a:rPr>
              <a:t>Range of detection</a:t>
            </a:r>
          </a:p>
        </p:txBody>
      </p:sp>
    </p:spTree>
    <p:extLst>
      <p:ext uri="{BB962C8B-B14F-4D97-AF65-F5344CB8AC3E}">
        <p14:creationId xmlns:p14="http://schemas.microsoft.com/office/powerpoint/2010/main" val="755148117"/>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txDef>
      <a:spPr>
        <a:noFill/>
      </a:spPr>
      <a:bodyPr wrap="none" rtlCol="0">
        <a:spAutoFit/>
      </a:bodyPr>
      <a:lstStyle>
        <a:defPPr algn="ctr">
          <a:defRPr smtClean="0">
            <a:latin typeface="Arial" panose="020B0604020202020204" pitchFamily="34" charset="0"/>
            <a:cs typeface="Arial" panose="020B0604020202020204" pitchFamily="34" charset="0"/>
          </a:defRPr>
        </a:defPPr>
      </a:lstStyle>
    </a:txDef>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074</TotalTime>
  <Words>345</Words>
  <Application>Microsoft Macintosh PowerPoint</Application>
  <PresentationFormat>Grand écran</PresentationFormat>
  <Paragraphs>151</Paragraphs>
  <Slides>7</Slides>
  <Notes>7</Notes>
  <HiddenSlides>0</HiddenSlides>
  <MMClips>0</MMClips>
  <ScaleCrop>false</ScaleCrop>
  <HeadingPairs>
    <vt:vector size="6" baseType="variant">
      <vt:variant>
        <vt:lpstr>Polices utilisées</vt:lpstr>
      </vt:variant>
      <vt:variant>
        <vt:i4>3</vt:i4>
      </vt:variant>
      <vt:variant>
        <vt:lpstr>Thème</vt:lpstr>
      </vt:variant>
      <vt:variant>
        <vt:i4>1</vt:i4>
      </vt:variant>
      <vt:variant>
        <vt:lpstr>Titres des diapositives</vt:lpstr>
      </vt:variant>
      <vt:variant>
        <vt:i4>7</vt:i4>
      </vt:variant>
    </vt:vector>
  </HeadingPairs>
  <TitlesOfParts>
    <vt:vector size="11" baseType="lpstr">
      <vt:lpstr>Arial</vt:lpstr>
      <vt:lpstr>Calibri</vt:lpstr>
      <vt:lpstr>Calibri Light</vt:lpstr>
      <vt:lpstr>Thème Office</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Guillaume BOLLOT SYNSIGHT</dc:creator>
  <cp:lastModifiedBy>Guillaume BOLLOT SYNSIGHT</cp:lastModifiedBy>
  <cp:revision>99</cp:revision>
  <dcterms:created xsi:type="dcterms:W3CDTF">2023-08-01T13:49:31Z</dcterms:created>
  <dcterms:modified xsi:type="dcterms:W3CDTF">2023-10-12T08:30:37Z</dcterms:modified>
</cp:coreProperties>
</file>